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  <p:sldId id="268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 showGuides="1">
      <p:cViewPr varScale="1">
        <p:scale>
          <a:sx n="104" d="100"/>
          <a:sy n="104" d="100"/>
        </p:scale>
        <p:origin x="870" y="11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271A5B3-B501-51F1-E00D-154EBA91FDF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92B104BA-A6E7-AD75-9F71-35DE5B19C39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74B6680-41A7-2044-C4AB-61E1DB81C8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6D8CE-9C5E-472B-8C94-0E603132A6B1}" type="datetimeFigureOut">
              <a:rPr kumimoji="1" lang="ja-JP" altLang="en-US" smtClean="0"/>
              <a:t>2026/2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6DD8B31-F554-CA7F-8879-5FA40C40BD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8F1C9F1-9CE4-ED5A-1B35-64AE4F27B8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A8125-779F-4B61-9271-390BD150BD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04655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A6FFF9D-5074-9E05-F41E-08881F8BCF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0890D09-13C5-2200-C005-4860707F6A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21830AC-F80D-890F-F542-AC2529EDEA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6D8CE-9C5E-472B-8C94-0E603132A6B1}" type="datetimeFigureOut">
              <a:rPr kumimoji="1" lang="ja-JP" altLang="en-US" smtClean="0"/>
              <a:t>2026/2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2616F6D-1CCE-F2BD-8126-CC6F51C5F6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92F6FD3-8DA9-46E2-F2C4-9831FE7C3E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A8125-779F-4B61-9271-390BD150BD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76919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6FC30994-6885-28D2-1C25-DFCCFFC9462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612E09E-EE1E-2703-158D-2BAEAC64AE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0A429AD-27D6-F50F-FE91-148DACC049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6D8CE-9C5E-472B-8C94-0E603132A6B1}" type="datetimeFigureOut">
              <a:rPr kumimoji="1" lang="ja-JP" altLang="en-US" smtClean="0"/>
              <a:t>2026/2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5CC8873-12F8-27F3-A039-933815239D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1F3EB76-C7B1-603B-28E8-7E3A837586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A8125-779F-4B61-9271-390BD150BD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79862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A080B08-BB4E-6FE7-63C5-87699AFFC4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80AEE8C-2182-B08E-632A-7C8890D2DEF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293D191-2598-F6C5-BEF3-1AC901ABC6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6D8CE-9C5E-472B-8C94-0E603132A6B1}" type="datetimeFigureOut">
              <a:rPr kumimoji="1" lang="ja-JP" altLang="en-US" smtClean="0"/>
              <a:t>2026/2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A23FB90-EF91-8F82-2B75-3DC805EC45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490C44A-EFCF-E963-93BF-84B8C0CF6B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A8125-779F-4B61-9271-390BD150BD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54378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EC530E7-E43E-3528-C0A0-53271A3BA7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F1CA6B7-966F-32CB-A28F-DF2CBCB15F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9F7D6AD-215A-3F21-1A27-238DC9EF4C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6D8CE-9C5E-472B-8C94-0E603132A6B1}" type="datetimeFigureOut">
              <a:rPr kumimoji="1" lang="ja-JP" altLang="en-US" smtClean="0"/>
              <a:t>2026/2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7EC08E3-9991-C6B9-BA14-6CCE3DA805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3092451-EA1A-9087-50A3-60D72178D4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A8125-779F-4B61-9271-390BD150BD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7837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EBBCE4C-9116-C534-6FA6-03FF2797CE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E88402C-AFCE-CD61-5949-9464368DFB1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7A4B90D-F539-0548-E996-C933139F8D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31A8C94-E245-3D21-B932-ADA08D73B7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6D8CE-9C5E-472B-8C94-0E603132A6B1}" type="datetimeFigureOut">
              <a:rPr kumimoji="1" lang="ja-JP" altLang="en-US" smtClean="0"/>
              <a:t>2026/2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50C8519-DAD7-026E-1B21-6AED19C471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D3353AC-CEBD-ADB0-6B88-D408D2085F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A8125-779F-4B61-9271-390BD150BD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26523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C409124-A303-AAFF-2D58-6267C34B9B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879269C-9711-6E9C-D684-97E12ECD5A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82482E2-CB50-BDB9-24BB-BEC1DBDF42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35C2CD9C-D667-8146-542B-F447BD5B9AC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6A05188-07D2-5658-DB76-C3601C858B0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1312036D-AD31-497A-CAF2-01E663E047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6D8CE-9C5E-472B-8C94-0E603132A6B1}" type="datetimeFigureOut">
              <a:rPr kumimoji="1" lang="ja-JP" altLang="en-US" smtClean="0"/>
              <a:t>2026/2/2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612CD0A-2DF9-967F-4436-8DA272AE34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877B149-0F83-AC3A-9F59-88319F0EE7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A8125-779F-4B61-9271-390BD150BD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10002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3555D8E-6438-2198-F5CC-28B4DFA033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FEE2ED48-5C77-2E85-5094-285EFADB3D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6D8CE-9C5E-472B-8C94-0E603132A6B1}" type="datetimeFigureOut">
              <a:rPr kumimoji="1" lang="ja-JP" altLang="en-US" smtClean="0"/>
              <a:t>2026/2/2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338C59C-F99F-5DF6-4129-C10F6B0AE6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F087663-EE68-2A9B-075C-F9638B34D0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A8125-779F-4B61-9271-390BD150BD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56194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773E76FE-46B3-90DC-7E10-0AEB91D45F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6D8CE-9C5E-472B-8C94-0E603132A6B1}" type="datetimeFigureOut">
              <a:rPr kumimoji="1" lang="ja-JP" altLang="en-US" smtClean="0"/>
              <a:t>2026/2/2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4FE0878-8D8B-3272-312D-2420FC3865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F4B8E7E1-F7F6-B401-7573-258F4A2C75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A8125-779F-4B61-9271-390BD150BD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82224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0101530-7B01-B307-271E-1EB832CCA0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9E46B11-BED9-04A7-6597-6EAE34FDAB4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BD2C1B9-6460-A4CD-36C9-B7634A35C1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49BD679-4F31-104C-F313-A00ED197C4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6D8CE-9C5E-472B-8C94-0E603132A6B1}" type="datetimeFigureOut">
              <a:rPr kumimoji="1" lang="ja-JP" altLang="en-US" smtClean="0"/>
              <a:t>2026/2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EDF4FBA-290B-451D-86E9-994B3FBDE8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613A4D5-D2E7-F007-18DE-C32F19A433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A8125-779F-4B61-9271-390BD150BD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05671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CA9E7E2-2D91-809C-08DB-E5C0183237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954E9635-88EF-06AF-0A31-42F60EA9E6D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EE5CE61-691B-4A74-9E68-03245F4D46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E3B1909-74E8-D98C-13B8-EB5B188841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6D8CE-9C5E-472B-8C94-0E603132A6B1}" type="datetimeFigureOut">
              <a:rPr kumimoji="1" lang="ja-JP" altLang="en-US" smtClean="0"/>
              <a:t>2026/2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B963753-8F60-86CF-A317-794C4601D5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B2D48B0-66D9-244E-0A23-60E156EFA6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A8125-779F-4B61-9271-390BD150BD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34224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6BF1024F-BAEE-FBC6-34C0-8AFB418FD5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7BAEEF9-101A-DBA5-DC38-918CC4F4D3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A52C51D-A42F-0349-EE98-4A7600AE039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16D8CE-9C5E-472B-8C94-0E603132A6B1}" type="datetimeFigureOut">
              <a:rPr kumimoji="1" lang="ja-JP" altLang="en-US" smtClean="0"/>
              <a:t>2026/2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27F14C1-5A77-3AE7-CE5E-E466B1DB655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D8DE4E1-4E06-DF86-AD5E-2429AB9690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CA8125-779F-4B61-9271-390BD150BD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76801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x40"/>
          <p:cNvSpPr/>
          <p:nvPr/>
        </p:nvSpPr>
        <p:spPr>
          <a:xfrm>
            <a:off x="2200486" y="1172424"/>
            <a:ext cx="7791028" cy="238373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2000"/>
              </a:lnSpc>
            </a:pPr>
            <a:r>
              <a:rPr sz="1600" dirty="0">
                <a:solidFill>
                  <a:srgbClr val="000000">
                    <a:alpha val="100000"/>
                  </a:srgbClr>
                </a:solidFill>
                <a:latin typeface="Times"/>
                <a:cs typeface="Times"/>
              </a:rPr>
              <a:t>Standardized survival (population-averaged): </a:t>
            </a:r>
            <a:r>
              <a:rPr lang="en-US" sz="1600" dirty="0">
                <a:solidFill>
                  <a:srgbClr val="000000">
                    <a:alpha val="100000"/>
                  </a:srgbClr>
                </a:solidFill>
                <a:latin typeface="Times"/>
                <a:cs typeface="Times"/>
              </a:rPr>
              <a:t>(A) </a:t>
            </a:r>
            <a:r>
              <a:rPr sz="1600" dirty="0">
                <a:solidFill>
                  <a:srgbClr val="000000">
                    <a:alpha val="100000"/>
                  </a:srgbClr>
                </a:solidFill>
                <a:latin typeface="Times"/>
                <a:cs typeface="Times"/>
              </a:rPr>
              <a:t>All-cause mortality</a:t>
            </a:r>
          </a:p>
        </p:txBody>
      </p:sp>
      <p:sp>
        <p:nvSpPr>
          <p:cNvPr id="32" name="tx32"/>
          <p:cNvSpPr/>
          <p:nvPr/>
        </p:nvSpPr>
        <p:spPr>
          <a:xfrm rot="16200000">
            <a:off x="2219636" y="3020360"/>
            <a:ext cx="1604470" cy="188444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2000"/>
              </a:lnSpc>
            </a:pPr>
            <a:r>
              <a:rPr sz="1400" dirty="0">
                <a:solidFill>
                  <a:srgbClr val="000000">
                    <a:alpha val="100000"/>
                  </a:srgbClr>
                </a:solidFill>
                <a:latin typeface="Times"/>
                <a:cs typeface="Times"/>
              </a:rPr>
              <a:t>Survival probability</a:t>
            </a:r>
          </a:p>
        </p:txBody>
      </p:sp>
      <p:sp>
        <p:nvSpPr>
          <p:cNvPr id="7" name="pl7"/>
          <p:cNvSpPr/>
          <p:nvPr/>
        </p:nvSpPr>
        <p:spPr>
          <a:xfrm>
            <a:off x="3705722" y="3535158"/>
            <a:ext cx="5062639" cy="0"/>
          </a:xfrm>
          <a:custGeom>
            <a:avLst/>
            <a:gdLst/>
            <a:ahLst/>
            <a:cxnLst/>
            <a:rect l="0" t="0" r="0" b="0"/>
            <a:pathLst>
              <a:path w="7950467">
                <a:moveTo>
                  <a:pt x="0" y="0"/>
                </a:moveTo>
                <a:lnTo>
                  <a:pt x="7950467" y="0"/>
                </a:lnTo>
                <a:lnTo>
                  <a:pt x="7950467" y="0"/>
                </a:lnTo>
              </a:path>
            </a:pathLst>
          </a:custGeom>
          <a:ln w="6775" cap="flat">
            <a:solidFill>
              <a:srgbClr val="EBEBEB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8" name="pl8"/>
          <p:cNvSpPr/>
          <p:nvPr/>
        </p:nvSpPr>
        <p:spPr>
          <a:xfrm>
            <a:off x="3705722" y="2655095"/>
            <a:ext cx="5062639" cy="0"/>
          </a:xfrm>
          <a:custGeom>
            <a:avLst/>
            <a:gdLst/>
            <a:ahLst/>
            <a:cxnLst/>
            <a:rect l="0" t="0" r="0" b="0"/>
            <a:pathLst>
              <a:path w="7950467">
                <a:moveTo>
                  <a:pt x="0" y="0"/>
                </a:moveTo>
                <a:lnTo>
                  <a:pt x="7950467" y="0"/>
                </a:lnTo>
                <a:lnTo>
                  <a:pt x="7950467" y="0"/>
                </a:lnTo>
              </a:path>
            </a:pathLst>
          </a:custGeom>
          <a:ln w="6775" cap="flat">
            <a:solidFill>
              <a:srgbClr val="EBEBEB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9" name="pl9"/>
          <p:cNvSpPr/>
          <p:nvPr/>
        </p:nvSpPr>
        <p:spPr>
          <a:xfrm>
            <a:off x="3705722" y="1775030"/>
            <a:ext cx="5062639" cy="0"/>
          </a:xfrm>
          <a:custGeom>
            <a:avLst/>
            <a:gdLst/>
            <a:ahLst/>
            <a:cxnLst/>
            <a:rect l="0" t="0" r="0" b="0"/>
            <a:pathLst>
              <a:path w="7950467">
                <a:moveTo>
                  <a:pt x="0" y="0"/>
                </a:moveTo>
                <a:lnTo>
                  <a:pt x="7950467" y="0"/>
                </a:lnTo>
                <a:lnTo>
                  <a:pt x="7950467" y="0"/>
                </a:lnTo>
              </a:path>
            </a:pathLst>
          </a:custGeom>
          <a:ln w="6775" cap="flat">
            <a:solidFill>
              <a:srgbClr val="EBEBEB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10" name="pl10"/>
          <p:cNvSpPr/>
          <p:nvPr/>
        </p:nvSpPr>
        <p:spPr>
          <a:xfrm>
            <a:off x="4958828" y="1622407"/>
            <a:ext cx="0" cy="3402988"/>
          </a:xfrm>
          <a:custGeom>
            <a:avLst/>
            <a:gdLst/>
            <a:ahLst/>
            <a:cxnLst/>
            <a:rect l="0" t="0" r="0" b="0"/>
            <a:pathLst>
              <a:path h="5734648">
                <a:moveTo>
                  <a:pt x="0" y="573464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ln w="6775" cap="flat">
            <a:solidFill>
              <a:srgbClr val="EBEBEB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11" name="pl11"/>
          <p:cNvSpPr/>
          <p:nvPr/>
        </p:nvSpPr>
        <p:spPr>
          <a:xfrm>
            <a:off x="6353494" y="1622407"/>
            <a:ext cx="0" cy="3402988"/>
          </a:xfrm>
          <a:custGeom>
            <a:avLst/>
            <a:gdLst/>
            <a:ahLst/>
            <a:cxnLst/>
            <a:rect l="0" t="0" r="0" b="0"/>
            <a:pathLst>
              <a:path h="5734648">
                <a:moveTo>
                  <a:pt x="0" y="573464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ln w="6775" cap="flat">
            <a:solidFill>
              <a:srgbClr val="EBEBEB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12" name="pl12"/>
          <p:cNvSpPr/>
          <p:nvPr/>
        </p:nvSpPr>
        <p:spPr>
          <a:xfrm>
            <a:off x="7748162" y="1622407"/>
            <a:ext cx="0" cy="3402988"/>
          </a:xfrm>
          <a:custGeom>
            <a:avLst/>
            <a:gdLst/>
            <a:ahLst/>
            <a:cxnLst/>
            <a:rect l="0" t="0" r="0" b="0"/>
            <a:pathLst>
              <a:path h="5734648">
                <a:moveTo>
                  <a:pt x="0" y="573464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ln w="6775" cap="flat">
            <a:solidFill>
              <a:srgbClr val="EBEBEB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13" name="pl13"/>
          <p:cNvSpPr/>
          <p:nvPr/>
        </p:nvSpPr>
        <p:spPr>
          <a:xfrm>
            <a:off x="3935842" y="1778702"/>
            <a:ext cx="4602399" cy="2200654"/>
          </a:xfrm>
          <a:custGeom>
            <a:avLst/>
            <a:gdLst/>
            <a:ahLst/>
            <a:cxnLst/>
            <a:rect l="0" t="0" r="0" b="0"/>
            <a:pathLst>
              <a:path w="7227697" h="3708499">
                <a:moveTo>
                  <a:pt x="0" y="0"/>
                </a:moveTo>
                <a:lnTo>
                  <a:pt x="170836" y="0"/>
                </a:lnTo>
                <a:lnTo>
                  <a:pt x="170836" y="6189"/>
                </a:lnTo>
                <a:lnTo>
                  <a:pt x="203689" y="6189"/>
                </a:lnTo>
                <a:lnTo>
                  <a:pt x="203689" y="6189"/>
                </a:lnTo>
                <a:lnTo>
                  <a:pt x="261730" y="6189"/>
                </a:lnTo>
                <a:lnTo>
                  <a:pt x="261730" y="12413"/>
                </a:lnTo>
                <a:lnTo>
                  <a:pt x="279251" y="12413"/>
                </a:lnTo>
                <a:lnTo>
                  <a:pt x="279251" y="18664"/>
                </a:lnTo>
                <a:lnTo>
                  <a:pt x="316485" y="18664"/>
                </a:lnTo>
                <a:lnTo>
                  <a:pt x="316485" y="24918"/>
                </a:lnTo>
                <a:lnTo>
                  <a:pt x="342768" y="24918"/>
                </a:lnTo>
                <a:lnTo>
                  <a:pt x="342768" y="31179"/>
                </a:lnTo>
                <a:lnTo>
                  <a:pt x="372335" y="31179"/>
                </a:lnTo>
                <a:lnTo>
                  <a:pt x="372335" y="37447"/>
                </a:lnTo>
                <a:lnTo>
                  <a:pt x="430376" y="37447"/>
                </a:lnTo>
                <a:lnTo>
                  <a:pt x="430376" y="37447"/>
                </a:lnTo>
                <a:lnTo>
                  <a:pt x="504843" y="37447"/>
                </a:lnTo>
                <a:lnTo>
                  <a:pt x="504843" y="43760"/>
                </a:lnTo>
                <a:lnTo>
                  <a:pt x="548647" y="43760"/>
                </a:lnTo>
                <a:lnTo>
                  <a:pt x="548647" y="50080"/>
                </a:lnTo>
                <a:lnTo>
                  <a:pt x="780810" y="50080"/>
                </a:lnTo>
                <a:lnTo>
                  <a:pt x="780810" y="56448"/>
                </a:lnTo>
                <a:lnTo>
                  <a:pt x="790666" y="56448"/>
                </a:lnTo>
                <a:lnTo>
                  <a:pt x="790666" y="56448"/>
                </a:lnTo>
                <a:lnTo>
                  <a:pt x="805997" y="56448"/>
                </a:lnTo>
                <a:lnTo>
                  <a:pt x="805997" y="62828"/>
                </a:lnTo>
                <a:lnTo>
                  <a:pt x="816948" y="62828"/>
                </a:lnTo>
                <a:lnTo>
                  <a:pt x="816948" y="69209"/>
                </a:lnTo>
                <a:lnTo>
                  <a:pt x="839946" y="69209"/>
                </a:lnTo>
                <a:lnTo>
                  <a:pt x="839946" y="69209"/>
                </a:lnTo>
                <a:lnTo>
                  <a:pt x="853087" y="69209"/>
                </a:lnTo>
                <a:lnTo>
                  <a:pt x="853087" y="75616"/>
                </a:lnTo>
                <a:lnTo>
                  <a:pt x="919888" y="75616"/>
                </a:lnTo>
                <a:lnTo>
                  <a:pt x="919888" y="82034"/>
                </a:lnTo>
                <a:lnTo>
                  <a:pt x="962597" y="82034"/>
                </a:lnTo>
                <a:lnTo>
                  <a:pt x="962597" y="88454"/>
                </a:lnTo>
                <a:lnTo>
                  <a:pt x="1008592" y="88454"/>
                </a:lnTo>
                <a:lnTo>
                  <a:pt x="1008592" y="94889"/>
                </a:lnTo>
                <a:lnTo>
                  <a:pt x="1090725" y="94889"/>
                </a:lnTo>
                <a:lnTo>
                  <a:pt x="1090725" y="94889"/>
                </a:lnTo>
                <a:lnTo>
                  <a:pt x="1137814" y="94889"/>
                </a:lnTo>
                <a:lnTo>
                  <a:pt x="1137814" y="101347"/>
                </a:lnTo>
                <a:lnTo>
                  <a:pt x="1153146" y="101347"/>
                </a:lnTo>
                <a:lnTo>
                  <a:pt x="1153146" y="107825"/>
                </a:lnTo>
                <a:lnTo>
                  <a:pt x="1167382" y="107825"/>
                </a:lnTo>
                <a:lnTo>
                  <a:pt x="1167382" y="114311"/>
                </a:lnTo>
                <a:lnTo>
                  <a:pt x="1226518" y="114311"/>
                </a:lnTo>
                <a:lnTo>
                  <a:pt x="1226518" y="120818"/>
                </a:lnTo>
                <a:lnTo>
                  <a:pt x="1245135" y="120818"/>
                </a:lnTo>
                <a:lnTo>
                  <a:pt x="1245135" y="127330"/>
                </a:lnTo>
                <a:lnTo>
                  <a:pt x="1260466" y="127330"/>
                </a:lnTo>
                <a:lnTo>
                  <a:pt x="1260466" y="133865"/>
                </a:lnTo>
                <a:lnTo>
                  <a:pt x="1325077" y="133865"/>
                </a:lnTo>
                <a:lnTo>
                  <a:pt x="1325077" y="140409"/>
                </a:lnTo>
                <a:lnTo>
                  <a:pt x="1326172" y="140409"/>
                </a:lnTo>
                <a:lnTo>
                  <a:pt x="1326172" y="146957"/>
                </a:lnTo>
                <a:lnTo>
                  <a:pt x="1397354" y="146957"/>
                </a:lnTo>
                <a:lnTo>
                  <a:pt x="1397354" y="153534"/>
                </a:lnTo>
                <a:lnTo>
                  <a:pt x="1408305" y="153534"/>
                </a:lnTo>
                <a:lnTo>
                  <a:pt x="1408305" y="160117"/>
                </a:lnTo>
                <a:lnTo>
                  <a:pt x="1422542" y="160117"/>
                </a:lnTo>
                <a:lnTo>
                  <a:pt x="1422542" y="166707"/>
                </a:lnTo>
                <a:lnTo>
                  <a:pt x="1424732" y="166707"/>
                </a:lnTo>
                <a:lnTo>
                  <a:pt x="1424732" y="173298"/>
                </a:lnTo>
                <a:lnTo>
                  <a:pt x="1464156" y="173298"/>
                </a:lnTo>
                <a:lnTo>
                  <a:pt x="1464156" y="179897"/>
                </a:lnTo>
                <a:lnTo>
                  <a:pt x="1489343" y="179897"/>
                </a:lnTo>
                <a:lnTo>
                  <a:pt x="1489343" y="186497"/>
                </a:lnTo>
                <a:lnTo>
                  <a:pt x="1506865" y="186497"/>
                </a:lnTo>
                <a:lnTo>
                  <a:pt x="1506865" y="193111"/>
                </a:lnTo>
                <a:lnTo>
                  <a:pt x="1529862" y="193111"/>
                </a:lnTo>
                <a:lnTo>
                  <a:pt x="1529862" y="199737"/>
                </a:lnTo>
                <a:lnTo>
                  <a:pt x="1536433" y="199737"/>
                </a:lnTo>
                <a:lnTo>
                  <a:pt x="1536433" y="206375"/>
                </a:lnTo>
                <a:lnTo>
                  <a:pt x="1583522" y="206375"/>
                </a:lnTo>
                <a:lnTo>
                  <a:pt x="1583522" y="213036"/>
                </a:lnTo>
                <a:lnTo>
                  <a:pt x="1608710" y="213036"/>
                </a:lnTo>
                <a:lnTo>
                  <a:pt x="1608710" y="219703"/>
                </a:lnTo>
                <a:lnTo>
                  <a:pt x="1670036" y="219703"/>
                </a:lnTo>
                <a:lnTo>
                  <a:pt x="1670036" y="226398"/>
                </a:lnTo>
                <a:lnTo>
                  <a:pt x="1730266" y="226398"/>
                </a:lnTo>
                <a:lnTo>
                  <a:pt x="1730266" y="233098"/>
                </a:lnTo>
                <a:lnTo>
                  <a:pt x="1737932" y="233098"/>
                </a:lnTo>
                <a:lnTo>
                  <a:pt x="1737932" y="239804"/>
                </a:lnTo>
                <a:lnTo>
                  <a:pt x="1757644" y="239804"/>
                </a:lnTo>
                <a:lnTo>
                  <a:pt x="1757644" y="246515"/>
                </a:lnTo>
                <a:lnTo>
                  <a:pt x="1766405" y="246515"/>
                </a:lnTo>
                <a:lnTo>
                  <a:pt x="1766405" y="253234"/>
                </a:lnTo>
                <a:lnTo>
                  <a:pt x="1786117" y="253234"/>
                </a:lnTo>
                <a:lnTo>
                  <a:pt x="1786117" y="259959"/>
                </a:lnTo>
                <a:lnTo>
                  <a:pt x="1810209" y="259959"/>
                </a:lnTo>
                <a:lnTo>
                  <a:pt x="1810209" y="266699"/>
                </a:lnTo>
                <a:lnTo>
                  <a:pt x="1845253" y="266699"/>
                </a:lnTo>
                <a:lnTo>
                  <a:pt x="1845253" y="273439"/>
                </a:lnTo>
                <a:lnTo>
                  <a:pt x="1863869" y="273439"/>
                </a:lnTo>
                <a:lnTo>
                  <a:pt x="1863869" y="280185"/>
                </a:lnTo>
                <a:lnTo>
                  <a:pt x="1866060" y="280185"/>
                </a:lnTo>
                <a:lnTo>
                  <a:pt x="1866060" y="286939"/>
                </a:lnTo>
                <a:lnTo>
                  <a:pt x="1896723" y="286939"/>
                </a:lnTo>
                <a:lnTo>
                  <a:pt x="1896723" y="293694"/>
                </a:lnTo>
                <a:lnTo>
                  <a:pt x="1909864" y="293694"/>
                </a:lnTo>
                <a:lnTo>
                  <a:pt x="1909864" y="300458"/>
                </a:lnTo>
                <a:lnTo>
                  <a:pt x="1935051" y="300458"/>
                </a:lnTo>
                <a:lnTo>
                  <a:pt x="1935051" y="307251"/>
                </a:lnTo>
                <a:lnTo>
                  <a:pt x="1986521" y="307251"/>
                </a:lnTo>
                <a:lnTo>
                  <a:pt x="1986521" y="314058"/>
                </a:lnTo>
                <a:lnTo>
                  <a:pt x="2017184" y="314058"/>
                </a:lnTo>
                <a:lnTo>
                  <a:pt x="2017184" y="320877"/>
                </a:lnTo>
                <a:lnTo>
                  <a:pt x="2122314" y="320877"/>
                </a:lnTo>
                <a:lnTo>
                  <a:pt x="2122314" y="327707"/>
                </a:lnTo>
                <a:lnTo>
                  <a:pt x="2123409" y="327707"/>
                </a:lnTo>
                <a:lnTo>
                  <a:pt x="2123409" y="334537"/>
                </a:lnTo>
                <a:lnTo>
                  <a:pt x="2131075" y="334537"/>
                </a:lnTo>
                <a:lnTo>
                  <a:pt x="2131075" y="334537"/>
                </a:lnTo>
                <a:lnTo>
                  <a:pt x="2159548" y="334537"/>
                </a:lnTo>
                <a:lnTo>
                  <a:pt x="2159548" y="334537"/>
                </a:lnTo>
                <a:lnTo>
                  <a:pt x="2178165" y="334537"/>
                </a:lnTo>
                <a:lnTo>
                  <a:pt x="2178165" y="341412"/>
                </a:lnTo>
                <a:lnTo>
                  <a:pt x="2189116" y="341412"/>
                </a:lnTo>
                <a:lnTo>
                  <a:pt x="2189116" y="341412"/>
                </a:lnTo>
                <a:lnTo>
                  <a:pt x="2201162" y="341412"/>
                </a:lnTo>
                <a:lnTo>
                  <a:pt x="2201162" y="348324"/>
                </a:lnTo>
                <a:lnTo>
                  <a:pt x="2208828" y="348324"/>
                </a:lnTo>
                <a:lnTo>
                  <a:pt x="2208828" y="355251"/>
                </a:lnTo>
                <a:lnTo>
                  <a:pt x="2213208" y="355251"/>
                </a:lnTo>
                <a:lnTo>
                  <a:pt x="2213208" y="355251"/>
                </a:lnTo>
                <a:lnTo>
                  <a:pt x="2227444" y="355251"/>
                </a:lnTo>
                <a:lnTo>
                  <a:pt x="2227444" y="355251"/>
                </a:lnTo>
                <a:lnTo>
                  <a:pt x="2269058" y="355251"/>
                </a:lnTo>
                <a:lnTo>
                  <a:pt x="2269058" y="362238"/>
                </a:lnTo>
                <a:lnTo>
                  <a:pt x="2273439" y="362238"/>
                </a:lnTo>
                <a:lnTo>
                  <a:pt x="2273439" y="369240"/>
                </a:lnTo>
                <a:lnTo>
                  <a:pt x="2306292" y="369240"/>
                </a:lnTo>
                <a:lnTo>
                  <a:pt x="2306292" y="376275"/>
                </a:lnTo>
                <a:lnTo>
                  <a:pt x="2310673" y="376275"/>
                </a:lnTo>
                <a:lnTo>
                  <a:pt x="2310673" y="383334"/>
                </a:lnTo>
                <a:lnTo>
                  <a:pt x="2430039" y="383334"/>
                </a:lnTo>
                <a:lnTo>
                  <a:pt x="2430039" y="390401"/>
                </a:lnTo>
                <a:lnTo>
                  <a:pt x="2447561" y="390401"/>
                </a:lnTo>
                <a:lnTo>
                  <a:pt x="2447561" y="397477"/>
                </a:lnTo>
                <a:lnTo>
                  <a:pt x="2481509" y="397477"/>
                </a:lnTo>
                <a:lnTo>
                  <a:pt x="2481509" y="404566"/>
                </a:lnTo>
                <a:lnTo>
                  <a:pt x="2517647" y="404566"/>
                </a:lnTo>
                <a:lnTo>
                  <a:pt x="2517647" y="411801"/>
                </a:lnTo>
                <a:lnTo>
                  <a:pt x="2546120" y="411801"/>
                </a:lnTo>
                <a:lnTo>
                  <a:pt x="2546120" y="419059"/>
                </a:lnTo>
                <a:lnTo>
                  <a:pt x="2558166" y="419059"/>
                </a:lnTo>
                <a:lnTo>
                  <a:pt x="2558166" y="426319"/>
                </a:lnTo>
                <a:lnTo>
                  <a:pt x="2592115" y="426319"/>
                </a:lnTo>
                <a:lnTo>
                  <a:pt x="2592115" y="433609"/>
                </a:lnTo>
                <a:lnTo>
                  <a:pt x="2639204" y="433609"/>
                </a:lnTo>
                <a:lnTo>
                  <a:pt x="2639204" y="440909"/>
                </a:lnTo>
                <a:lnTo>
                  <a:pt x="2651250" y="440909"/>
                </a:lnTo>
                <a:lnTo>
                  <a:pt x="2651250" y="448251"/>
                </a:lnTo>
                <a:lnTo>
                  <a:pt x="2808946" y="448251"/>
                </a:lnTo>
                <a:lnTo>
                  <a:pt x="2808946" y="455674"/>
                </a:lnTo>
                <a:lnTo>
                  <a:pt x="2826467" y="455674"/>
                </a:lnTo>
                <a:lnTo>
                  <a:pt x="2826467" y="463101"/>
                </a:lnTo>
                <a:lnTo>
                  <a:pt x="2836323" y="463101"/>
                </a:lnTo>
                <a:lnTo>
                  <a:pt x="2836323" y="470532"/>
                </a:lnTo>
                <a:lnTo>
                  <a:pt x="2843989" y="470532"/>
                </a:lnTo>
                <a:lnTo>
                  <a:pt x="2843989" y="477999"/>
                </a:lnTo>
                <a:lnTo>
                  <a:pt x="2883413" y="477999"/>
                </a:lnTo>
                <a:lnTo>
                  <a:pt x="2883413" y="485468"/>
                </a:lnTo>
                <a:lnTo>
                  <a:pt x="2888888" y="485468"/>
                </a:lnTo>
                <a:lnTo>
                  <a:pt x="2888888" y="492949"/>
                </a:lnTo>
                <a:lnTo>
                  <a:pt x="2898744" y="492949"/>
                </a:lnTo>
                <a:lnTo>
                  <a:pt x="2898744" y="500455"/>
                </a:lnTo>
                <a:lnTo>
                  <a:pt x="2900934" y="500455"/>
                </a:lnTo>
                <a:lnTo>
                  <a:pt x="2900934" y="507961"/>
                </a:lnTo>
                <a:lnTo>
                  <a:pt x="2930502" y="507961"/>
                </a:lnTo>
                <a:lnTo>
                  <a:pt x="2930502" y="515479"/>
                </a:lnTo>
                <a:lnTo>
                  <a:pt x="2951309" y="515479"/>
                </a:lnTo>
                <a:lnTo>
                  <a:pt x="2951309" y="523008"/>
                </a:lnTo>
                <a:lnTo>
                  <a:pt x="2974307" y="523008"/>
                </a:lnTo>
                <a:lnTo>
                  <a:pt x="2974307" y="530538"/>
                </a:lnTo>
                <a:lnTo>
                  <a:pt x="2980877" y="530538"/>
                </a:lnTo>
                <a:lnTo>
                  <a:pt x="2980877" y="538068"/>
                </a:lnTo>
                <a:lnTo>
                  <a:pt x="3064105" y="538068"/>
                </a:lnTo>
                <a:lnTo>
                  <a:pt x="3064105" y="545713"/>
                </a:lnTo>
                <a:lnTo>
                  <a:pt x="3103529" y="545713"/>
                </a:lnTo>
                <a:lnTo>
                  <a:pt x="3103529" y="553359"/>
                </a:lnTo>
                <a:lnTo>
                  <a:pt x="3104624" y="553359"/>
                </a:lnTo>
                <a:lnTo>
                  <a:pt x="3104624" y="561020"/>
                </a:lnTo>
                <a:lnTo>
                  <a:pt x="3110100" y="561020"/>
                </a:lnTo>
                <a:lnTo>
                  <a:pt x="3110100" y="568687"/>
                </a:lnTo>
                <a:lnTo>
                  <a:pt x="3130907" y="568687"/>
                </a:lnTo>
                <a:lnTo>
                  <a:pt x="3130907" y="576364"/>
                </a:lnTo>
                <a:lnTo>
                  <a:pt x="3186757" y="576364"/>
                </a:lnTo>
                <a:lnTo>
                  <a:pt x="3186757" y="584056"/>
                </a:lnTo>
                <a:lnTo>
                  <a:pt x="3203184" y="584056"/>
                </a:lnTo>
                <a:lnTo>
                  <a:pt x="3203184" y="584056"/>
                </a:lnTo>
                <a:lnTo>
                  <a:pt x="3242607" y="584056"/>
                </a:lnTo>
                <a:lnTo>
                  <a:pt x="3242607" y="591762"/>
                </a:lnTo>
                <a:lnTo>
                  <a:pt x="3282031" y="591762"/>
                </a:lnTo>
                <a:lnTo>
                  <a:pt x="3282031" y="599489"/>
                </a:lnTo>
                <a:lnTo>
                  <a:pt x="3366354" y="599489"/>
                </a:lnTo>
                <a:lnTo>
                  <a:pt x="3366354" y="607270"/>
                </a:lnTo>
                <a:lnTo>
                  <a:pt x="3388257" y="607270"/>
                </a:lnTo>
                <a:lnTo>
                  <a:pt x="3388257" y="615058"/>
                </a:lnTo>
                <a:lnTo>
                  <a:pt x="3432061" y="615058"/>
                </a:lnTo>
                <a:lnTo>
                  <a:pt x="3432061" y="622854"/>
                </a:lnTo>
                <a:lnTo>
                  <a:pt x="3458343" y="622854"/>
                </a:lnTo>
                <a:lnTo>
                  <a:pt x="3458343" y="630663"/>
                </a:lnTo>
                <a:lnTo>
                  <a:pt x="3459438" y="630663"/>
                </a:lnTo>
                <a:lnTo>
                  <a:pt x="3459438" y="638526"/>
                </a:lnTo>
                <a:lnTo>
                  <a:pt x="3475865" y="638526"/>
                </a:lnTo>
                <a:lnTo>
                  <a:pt x="3475865" y="646397"/>
                </a:lnTo>
                <a:lnTo>
                  <a:pt x="3526240" y="646397"/>
                </a:lnTo>
                <a:lnTo>
                  <a:pt x="3526240" y="654283"/>
                </a:lnTo>
                <a:lnTo>
                  <a:pt x="3541571" y="654283"/>
                </a:lnTo>
                <a:lnTo>
                  <a:pt x="3541571" y="662172"/>
                </a:lnTo>
                <a:lnTo>
                  <a:pt x="3548142" y="662172"/>
                </a:lnTo>
                <a:lnTo>
                  <a:pt x="3548142" y="670064"/>
                </a:lnTo>
                <a:lnTo>
                  <a:pt x="3551427" y="670064"/>
                </a:lnTo>
                <a:lnTo>
                  <a:pt x="3551427" y="677987"/>
                </a:lnTo>
                <a:lnTo>
                  <a:pt x="3552522" y="677987"/>
                </a:lnTo>
                <a:lnTo>
                  <a:pt x="3552522" y="685967"/>
                </a:lnTo>
                <a:lnTo>
                  <a:pt x="3562378" y="685967"/>
                </a:lnTo>
                <a:lnTo>
                  <a:pt x="3562378" y="693959"/>
                </a:lnTo>
                <a:lnTo>
                  <a:pt x="3564569" y="693959"/>
                </a:lnTo>
                <a:lnTo>
                  <a:pt x="3564569" y="701953"/>
                </a:lnTo>
                <a:lnTo>
                  <a:pt x="3609468" y="701953"/>
                </a:lnTo>
                <a:lnTo>
                  <a:pt x="3609468" y="701953"/>
                </a:lnTo>
                <a:lnTo>
                  <a:pt x="3611658" y="701953"/>
                </a:lnTo>
                <a:lnTo>
                  <a:pt x="3611658" y="709965"/>
                </a:lnTo>
                <a:lnTo>
                  <a:pt x="3620419" y="709965"/>
                </a:lnTo>
                <a:lnTo>
                  <a:pt x="3620419" y="717982"/>
                </a:lnTo>
                <a:lnTo>
                  <a:pt x="3630275" y="717982"/>
                </a:lnTo>
                <a:lnTo>
                  <a:pt x="3630275" y="717982"/>
                </a:lnTo>
                <a:lnTo>
                  <a:pt x="3636846" y="717982"/>
                </a:lnTo>
                <a:lnTo>
                  <a:pt x="3636846" y="717982"/>
                </a:lnTo>
                <a:lnTo>
                  <a:pt x="3637941" y="717982"/>
                </a:lnTo>
                <a:lnTo>
                  <a:pt x="3637941" y="726056"/>
                </a:lnTo>
                <a:lnTo>
                  <a:pt x="3655462" y="726056"/>
                </a:lnTo>
                <a:lnTo>
                  <a:pt x="3655462" y="742302"/>
                </a:lnTo>
                <a:lnTo>
                  <a:pt x="3660938" y="742302"/>
                </a:lnTo>
                <a:lnTo>
                  <a:pt x="3660938" y="758613"/>
                </a:lnTo>
                <a:lnTo>
                  <a:pt x="3701457" y="758613"/>
                </a:lnTo>
                <a:lnTo>
                  <a:pt x="3701457" y="766787"/>
                </a:lnTo>
                <a:lnTo>
                  <a:pt x="3703647" y="766787"/>
                </a:lnTo>
                <a:lnTo>
                  <a:pt x="3703647" y="774974"/>
                </a:lnTo>
                <a:lnTo>
                  <a:pt x="3758402" y="774974"/>
                </a:lnTo>
                <a:lnTo>
                  <a:pt x="3758402" y="783179"/>
                </a:lnTo>
                <a:lnTo>
                  <a:pt x="3770448" y="783179"/>
                </a:lnTo>
                <a:lnTo>
                  <a:pt x="3770448" y="791386"/>
                </a:lnTo>
                <a:lnTo>
                  <a:pt x="3783590" y="791386"/>
                </a:lnTo>
                <a:lnTo>
                  <a:pt x="3783590" y="799596"/>
                </a:lnTo>
                <a:lnTo>
                  <a:pt x="3792351" y="799596"/>
                </a:lnTo>
                <a:lnTo>
                  <a:pt x="3792351" y="807844"/>
                </a:lnTo>
                <a:lnTo>
                  <a:pt x="3809872" y="807844"/>
                </a:lnTo>
                <a:lnTo>
                  <a:pt x="3809872" y="816128"/>
                </a:lnTo>
                <a:lnTo>
                  <a:pt x="3817538" y="816128"/>
                </a:lnTo>
                <a:lnTo>
                  <a:pt x="3817538" y="824412"/>
                </a:lnTo>
                <a:lnTo>
                  <a:pt x="3828489" y="824412"/>
                </a:lnTo>
                <a:lnTo>
                  <a:pt x="3828489" y="832717"/>
                </a:lnTo>
                <a:lnTo>
                  <a:pt x="3836155" y="832717"/>
                </a:lnTo>
                <a:lnTo>
                  <a:pt x="3836155" y="841036"/>
                </a:lnTo>
                <a:lnTo>
                  <a:pt x="3861342" y="841036"/>
                </a:lnTo>
                <a:lnTo>
                  <a:pt x="3861342" y="849374"/>
                </a:lnTo>
                <a:lnTo>
                  <a:pt x="3896386" y="849374"/>
                </a:lnTo>
                <a:lnTo>
                  <a:pt x="3896386" y="857743"/>
                </a:lnTo>
                <a:lnTo>
                  <a:pt x="3906242" y="857743"/>
                </a:lnTo>
                <a:lnTo>
                  <a:pt x="3906242" y="866151"/>
                </a:lnTo>
                <a:lnTo>
                  <a:pt x="3912812" y="866151"/>
                </a:lnTo>
                <a:lnTo>
                  <a:pt x="3912812" y="882995"/>
                </a:lnTo>
                <a:lnTo>
                  <a:pt x="3913907" y="882995"/>
                </a:lnTo>
                <a:lnTo>
                  <a:pt x="3913907" y="891456"/>
                </a:lnTo>
                <a:lnTo>
                  <a:pt x="3915002" y="891456"/>
                </a:lnTo>
                <a:lnTo>
                  <a:pt x="3915002" y="891456"/>
                </a:lnTo>
                <a:lnTo>
                  <a:pt x="3923763" y="891456"/>
                </a:lnTo>
                <a:lnTo>
                  <a:pt x="3923763" y="899944"/>
                </a:lnTo>
                <a:lnTo>
                  <a:pt x="3930334" y="899944"/>
                </a:lnTo>
                <a:lnTo>
                  <a:pt x="3930334" y="908456"/>
                </a:lnTo>
                <a:lnTo>
                  <a:pt x="3931429" y="908456"/>
                </a:lnTo>
                <a:lnTo>
                  <a:pt x="3931429" y="917034"/>
                </a:lnTo>
                <a:lnTo>
                  <a:pt x="3939095" y="917034"/>
                </a:lnTo>
                <a:lnTo>
                  <a:pt x="3939095" y="925628"/>
                </a:lnTo>
                <a:lnTo>
                  <a:pt x="3944570" y="925628"/>
                </a:lnTo>
                <a:lnTo>
                  <a:pt x="3944570" y="934239"/>
                </a:lnTo>
                <a:lnTo>
                  <a:pt x="3947856" y="934239"/>
                </a:lnTo>
                <a:lnTo>
                  <a:pt x="3947856" y="942861"/>
                </a:lnTo>
                <a:lnTo>
                  <a:pt x="3953331" y="942861"/>
                </a:lnTo>
                <a:lnTo>
                  <a:pt x="3953331" y="951499"/>
                </a:lnTo>
                <a:lnTo>
                  <a:pt x="3954426" y="951499"/>
                </a:lnTo>
                <a:lnTo>
                  <a:pt x="3954426" y="960162"/>
                </a:lnTo>
                <a:lnTo>
                  <a:pt x="3956616" y="960162"/>
                </a:lnTo>
                <a:lnTo>
                  <a:pt x="3956616" y="968831"/>
                </a:lnTo>
                <a:lnTo>
                  <a:pt x="3980709" y="968831"/>
                </a:lnTo>
                <a:lnTo>
                  <a:pt x="3980709" y="977504"/>
                </a:lnTo>
                <a:lnTo>
                  <a:pt x="3986184" y="977504"/>
                </a:lnTo>
                <a:lnTo>
                  <a:pt x="3986184" y="986193"/>
                </a:lnTo>
                <a:lnTo>
                  <a:pt x="3987279" y="986193"/>
                </a:lnTo>
                <a:lnTo>
                  <a:pt x="3987279" y="986193"/>
                </a:lnTo>
                <a:lnTo>
                  <a:pt x="3993850" y="986193"/>
                </a:lnTo>
                <a:lnTo>
                  <a:pt x="3993850" y="994906"/>
                </a:lnTo>
                <a:lnTo>
                  <a:pt x="3994945" y="994906"/>
                </a:lnTo>
                <a:lnTo>
                  <a:pt x="3994945" y="1003637"/>
                </a:lnTo>
                <a:lnTo>
                  <a:pt x="4016847" y="1003637"/>
                </a:lnTo>
                <a:lnTo>
                  <a:pt x="4016847" y="1012380"/>
                </a:lnTo>
                <a:lnTo>
                  <a:pt x="4054081" y="1012380"/>
                </a:lnTo>
                <a:lnTo>
                  <a:pt x="4054081" y="1021138"/>
                </a:lnTo>
                <a:lnTo>
                  <a:pt x="4068317" y="1021138"/>
                </a:lnTo>
                <a:lnTo>
                  <a:pt x="4068317" y="1029913"/>
                </a:lnTo>
                <a:lnTo>
                  <a:pt x="4072698" y="1029913"/>
                </a:lnTo>
                <a:lnTo>
                  <a:pt x="4072698" y="1029913"/>
                </a:lnTo>
                <a:lnTo>
                  <a:pt x="4077078" y="1029913"/>
                </a:lnTo>
                <a:lnTo>
                  <a:pt x="4077078" y="1038690"/>
                </a:lnTo>
                <a:lnTo>
                  <a:pt x="4095695" y="1038690"/>
                </a:lnTo>
                <a:lnTo>
                  <a:pt x="4095695" y="1038690"/>
                </a:lnTo>
                <a:lnTo>
                  <a:pt x="4111026" y="1038690"/>
                </a:lnTo>
                <a:lnTo>
                  <a:pt x="4111026" y="1047512"/>
                </a:lnTo>
                <a:lnTo>
                  <a:pt x="4245724" y="1047512"/>
                </a:lnTo>
                <a:lnTo>
                  <a:pt x="4245724" y="1056431"/>
                </a:lnTo>
                <a:lnTo>
                  <a:pt x="4269817" y="1056431"/>
                </a:lnTo>
                <a:lnTo>
                  <a:pt x="4269817" y="1065354"/>
                </a:lnTo>
                <a:lnTo>
                  <a:pt x="4304860" y="1065354"/>
                </a:lnTo>
                <a:lnTo>
                  <a:pt x="4304860" y="1074336"/>
                </a:lnTo>
                <a:lnTo>
                  <a:pt x="4318001" y="1074336"/>
                </a:lnTo>
                <a:lnTo>
                  <a:pt x="4318001" y="1083321"/>
                </a:lnTo>
                <a:lnTo>
                  <a:pt x="4334428" y="1083321"/>
                </a:lnTo>
                <a:lnTo>
                  <a:pt x="4334428" y="1092310"/>
                </a:lnTo>
                <a:lnTo>
                  <a:pt x="4354140" y="1092310"/>
                </a:lnTo>
                <a:lnTo>
                  <a:pt x="4354140" y="1101309"/>
                </a:lnTo>
                <a:lnTo>
                  <a:pt x="4358520" y="1101309"/>
                </a:lnTo>
                <a:lnTo>
                  <a:pt x="4358520" y="1110332"/>
                </a:lnTo>
                <a:lnTo>
                  <a:pt x="4383708" y="1110332"/>
                </a:lnTo>
                <a:lnTo>
                  <a:pt x="4383708" y="1119358"/>
                </a:lnTo>
                <a:lnTo>
                  <a:pt x="4393564" y="1119358"/>
                </a:lnTo>
                <a:lnTo>
                  <a:pt x="4393564" y="1128385"/>
                </a:lnTo>
                <a:lnTo>
                  <a:pt x="4396849" y="1128385"/>
                </a:lnTo>
                <a:lnTo>
                  <a:pt x="4396849" y="1137432"/>
                </a:lnTo>
                <a:lnTo>
                  <a:pt x="4429702" y="1137432"/>
                </a:lnTo>
                <a:lnTo>
                  <a:pt x="4429702" y="1146509"/>
                </a:lnTo>
                <a:lnTo>
                  <a:pt x="4432987" y="1146509"/>
                </a:lnTo>
                <a:lnTo>
                  <a:pt x="4432987" y="1155599"/>
                </a:lnTo>
                <a:lnTo>
                  <a:pt x="4437368" y="1155599"/>
                </a:lnTo>
                <a:lnTo>
                  <a:pt x="4437368" y="1164727"/>
                </a:lnTo>
                <a:lnTo>
                  <a:pt x="4460365" y="1164727"/>
                </a:lnTo>
                <a:lnTo>
                  <a:pt x="4460365" y="1173864"/>
                </a:lnTo>
                <a:lnTo>
                  <a:pt x="4504169" y="1173864"/>
                </a:lnTo>
                <a:lnTo>
                  <a:pt x="4504169" y="1183014"/>
                </a:lnTo>
                <a:lnTo>
                  <a:pt x="4507455" y="1183014"/>
                </a:lnTo>
                <a:lnTo>
                  <a:pt x="4507455" y="1192196"/>
                </a:lnTo>
                <a:lnTo>
                  <a:pt x="4510740" y="1192196"/>
                </a:lnTo>
                <a:lnTo>
                  <a:pt x="4510740" y="1201392"/>
                </a:lnTo>
                <a:lnTo>
                  <a:pt x="4568780" y="1201392"/>
                </a:lnTo>
                <a:lnTo>
                  <a:pt x="4568780" y="1210612"/>
                </a:lnTo>
                <a:lnTo>
                  <a:pt x="4589587" y="1210612"/>
                </a:lnTo>
                <a:lnTo>
                  <a:pt x="4589587" y="1219900"/>
                </a:lnTo>
                <a:lnTo>
                  <a:pt x="4607109" y="1219900"/>
                </a:lnTo>
                <a:lnTo>
                  <a:pt x="4607109" y="1229213"/>
                </a:lnTo>
                <a:lnTo>
                  <a:pt x="4609299" y="1229213"/>
                </a:lnTo>
                <a:lnTo>
                  <a:pt x="4609299" y="1238533"/>
                </a:lnTo>
                <a:lnTo>
                  <a:pt x="4624631" y="1238533"/>
                </a:lnTo>
                <a:lnTo>
                  <a:pt x="4624631" y="1257257"/>
                </a:lnTo>
                <a:lnTo>
                  <a:pt x="4639962" y="1257257"/>
                </a:lnTo>
                <a:lnTo>
                  <a:pt x="4639962" y="1266627"/>
                </a:lnTo>
                <a:lnTo>
                  <a:pt x="4647628" y="1266627"/>
                </a:lnTo>
                <a:lnTo>
                  <a:pt x="4647628" y="1266627"/>
                </a:lnTo>
                <a:lnTo>
                  <a:pt x="4653104" y="1266627"/>
                </a:lnTo>
                <a:lnTo>
                  <a:pt x="4653104" y="1276048"/>
                </a:lnTo>
                <a:lnTo>
                  <a:pt x="4679386" y="1276048"/>
                </a:lnTo>
                <a:lnTo>
                  <a:pt x="4679386" y="1276048"/>
                </a:lnTo>
                <a:lnTo>
                  <a:pt x="4701288" y="1276048"/>
                </a:lnTo>
                <a:lnTo>
                  <a:pt x="4701288" y="1285500"/>
                </a:lnTo>
                <a:lnTo>
                  <a:pt x="4727571" y="1285500"/>
                </a:lnTo>
                <a:lnTo>
                  <a:pt x="4727571" y="1294962"/>
                </a:lnTo>
                <a:lnTo>
                  <a:pt x="4754948" y="1294962"/>
                </a:lnTo>
                <a:lnTo>
                  <a:pt x="4754948" y="1304479"/>
                </a:lnTo>
                <a:lnTo>
                  <a:pt x="4759329" y="1304479"/>
                </a:lnTo>
                <a:lnTo>
                  <a:pt x="4759329" y="1314004"/>
                </a:lnTo>
                <a:lnTo>
                  <a:pt x="4768090" y="1314004"/>
                </a:lnTo>
                <a:lnTo>
                  <a:pt x="4768090" y="1323542"/>
                </a:lnTo>
                <a:lnTo>
                  <a:pt x="4769185" y="1323542"/>
                </a:lnTo>
                <a:lnTo>
                  <a:pt x="4769185" y="1333122"/>
                </a:lnTo>
                <a:lnTo>
                  <a:pt x="4771375" y="1333122"/>
                </a:lnTo>
                <a:lnTo>
                  <a:pt x="4771375" y="1342721"/>
                </a:lnTo>
                <a:lnTo>
                  <a:pt x="4774660" y="1342721"/>
                </a:lnTo>
                <a:lnTo>
                  <a:pt x="4774660" y="1352334"/>
                </a:lnTo>
                <a:lnTo>
                  <a:pt x="4784516" y="1352334"/>
                </a:lnTo>
                <a:lnTo>
                  <a:pt x="4784516" y="1361956"/>
                </a:lnTo>
                <a:lnTo>
                  <a:pt x="4786706" y="1361956"/>
                </a:lnTo>
                <a:lnTo>
                  <a:pt x="4786706" y="1371596"/>
                </a:lnTo>
                <a:lnTo>
                  <a:pt x="4803133" y="1371596"/>
                </a:lnTo>
                <a:lnTo>
                  <a:pt x="4803133" y="1381272"/>
                </a:lnTo>
                <a:lnTo>
                  <a:pt x="4809704" y="1381272"/>
                </a:lnTo>
                <a:lnTo>
                  <a:pt x="4809704" y="1390955"/>
                </a:lnTo>
                <a:lnTo>
                  <a:pt x="4821750" y="1390955"/>
                </a:lnTo>
                <a:lnTo>
                  <a:pt x="4821750" y="1400653"/>
                </a:lnTo>
                <a:lnTo>
                  <a:pt x="4829416" y="1400653"/>
                </a:lnTo>
                <a:lnTo>
                  <a:pt x="4829416" y="1400653"/>
                </a:lnTo>
                <a:lnTo>
                  <a:pt x="4831606" y="1400653"/>
                </a:lnTo>
                <a:lnTo>
                  <a:pt x="4831606" y="1400653"/>
                </a:lnTo>
                <a:lnTo>
                  <a:pt x="4838176" y="1400653"/>
                </a:lnTo>
                <a:lnTo>
                  <a:pt x="4838176" y="1410369"/>
                </a:lnTo>
                <a:lnTo>
                  <a:pt x="4842557" y="1410369"/>
                </a:lnTo>
                <a:lnTo>
                  <a:pt x="4842557" y="1420115"/>
                </a:lnTo>
                <a:lnTo>
                  <a:pt x="4845842" y="1420115"/>
                </a:lnTo>
                <a:lnTo>
                  <a:pt x="4845842" y="1429873"/>
                </a:lnTo>
                <a:lnTo>
                  <a:pt x="4849128" y="1429873"/>
                </a:lnTo>
                <a:lnTo>
                  <a:pt x="4849128" y="1439728"/>
                </a:lnTo>
                <a:lnTo>
                  <a:pt x="4875410" y="1439728"/>
                </a:lnTo>
                <a:lnTo>
                  <a:pt x="4875410" y="1449588"/>
                </a:lnTo>
                <a:lnTo>
                  <a:pt x="4912644" y="1449588"/>
                </a:lnTo>
                <a:lnTo>
                  <a:pt x="4912644" y="1459525"/>
                </a:lnTo>
                <a:lnTo>
                  <a:pt x="4942211" y="1459525"/>
                </a:lnTo>
                <a:lnTo>
                  <a:pt x="4942211" y="1469506"/>
                </a:lnTo>
                <a:lnTo>
                  <a:pt x="4959733" y="1469506"/>
                </a:lnTo>
                <a:lnTo>
                  <a:pt x="4959733" y="1479512"/>
                </a:lnTo>
                <a:lnTo>
                  <a:pt x="4970684" y="1479512"/>
                </a:lnTo>
                <a:lnTo>
                  <a:pt x="4970684" y="1489540"/>
                </a:lnTo>
                <a:lnTo>
                  <a:pt x="4996967" y="1489540"/>
                </a:lnTo>
                <a:lnTo>
                  <a:pt x="4996967" y="1489540"/>
                </a:lnTo>
                <a:lnTo>
                  <a:pt x="5013393" y="1489540"/>
                </a:lnTo>
                <a:lnTo>
                  <a:pt x="5013393" y="1499583"/>
                </a:lnTo>
                <a:lnTo>
                  <a:pt x="5030915" y="1499583"/>
                </a:lnTo>
                <a:lnTo>
                  <a:pt x="5030915" y="1509630"/>
                </a:lnTo>
                <a:lnTo>
                  <a:pt x="5044056" y="1509630"/>
                </a:lnTo>
                <a:lnTo>
                  <a:pt x="5044056" y="1519694"/>
                </a:lnTo>
                <a:lnTo>
                  <a:pt x="5053912" y="1519694"/>
                </a:lnTo>
                <a:lnTo>
                  <a:pt x="5053912" y="1529780"/>
                </a:lnTo>
                <a:lnTo>
                  <a:pt x="5057198" y="1529780"/>
                </a:lnTo>
                <a:lnTo>
                  <a:pt x="5057198" y="1539879"/>
                </a:lnTo>
                <a:lnTo>
                  <a:pt x="5094431" y="1539879"/>
                </a:lnTo>
                <a:lnTo>
                  <a:pt x="5094431" y="1549983"/>
                </a:lnTo>
                <a:lnTo>
                  <a:pt x="5097716" y="1549983"/>
                </a:lnTo>
                <a:lnTo>
                  <a:pt x="5097716" y="1549983"/>
                </a:lnTo>
                <a:lnTo>
                  <a:pt x="5109763" y="1549983"/>
                </a:lnTo>
                <a:lnTo>
                  <a:pt x="5109763" y="1560136"/>
                </a:lnTo>
                <a:lnTo>
                  <a:pt x="5113048" y="1560136"/>
                </a:lnTo>
                <a:lnTo>
                  <a:pt x="5113048" y="1570320"/>
                </a:lnTo>
                <a:lnTo>
                  <a:pt x="5125094" y="1570320"/>
                </a:lnTo>
                <a:lnTo>
                  <a:pt x="5125094" y="1580540"/>
                </a:lnTo>
                <a:lnTo>
                  <a:pt x="5137140" y="1580540"/>
                </a:lnTo>
                <a:lnTo>
                  <a:pt x="5137140" y="1590779"/>
                </a:lnTo>
                <a:lnTo>
                  <a:pt x="5165613" y="1590779"/>
                </a:lnTo>
                <a:lnTo>
                  <a:pt x="5165613" y="1601049"/>
                </a:lnTo>
                <a:lnTo>
                  <a:pt x="5169993" y="1601049"/>
                </a:lnTo>
                <a:lnTo>
                  <a:pt x="5169993" y="1611325"/>
                </a:lnTo>
                <a:lnTo>
                  <a:pt x="5173279" y="1611325"/>
                </a:lnTo>
                <a:lnTo>
                  <a:pt x="5173279" y="1621634"/>
                </a:lnTo>
                <a:lnTo>
                  <a:pt x="5177659" y="1621634"/>
                </a:lnTo>
                <a:lnTo>
                  <a:pt x="5177659" y="1621634"/>
                </a:lnTo>
                <a:lnTo>
                  <a:pt x="5210512" y="1621634"/>
                </a:lnTo>
                <a:lnTo>
                  <a:pt x="5210512" y="1631965"/>
                </a:lnTo>
                <a:lnTo>
                  <a:pt x="5219273" y="1631965"/>
                </a:lnTo>
                <a:lnTo>
                  <a:pt x="5219273" y="1642349"/>
                </a:lnTo>
                <a:lnTo>
                  <a:pt x="5258697" y="1642349"/>
                </a:lnTo>
                <a:lnTo>
                  <a:pt x="5258697" y="1642349"/>
                </a:lnTo>
                <a:lnTo>
                  <a:pt x="5264173" y="1642349"/>
                </a:lnTo>
                <a:lnTo>
                  <a:pt x="5264173" y="1652751"/>
                </a:lnTo>
                <a:lnTo>
                  <a:pt x="5282789" y="1652751"/>
                </a:lnTo>
                <a:lnTo>
                  <a:pt x="5282789" y="1663171"/>
                </a:lnTo>
                <a:lnTo>
                  <a:pt x="5286075" y="1663171"/>
                </a:lnTo>
                <a:lnTo>
                  <a:pt x="5286075" y="1673611"/>
                </a:lnTo>
                <a:lnTo>
                  <a:pt x="5293740" y="1673611"/>
                </a:lnTo>
                <a:lnTo>
                  <a:pt x="5293740" y="1673611"/>
                </a:lnTo>
                <a:lnTo>
                  <a:pt x="5297026" y="1673611"/>
                </a:lnTo>
                <a:lnTo>
                  <a:pt x="5297026" y="1684074"/>
                </a:lnTo>
                <a:lnTo>
                  <a:pt x="5300311" y="1684074"/>
                </a:lnTo>
                <a:lnTo>
                  <a:pt x="5300311" y="1694559"/>
                </a:lnTo>
                <a:lnTo>
                  <a:pt x="5323308" y="1694559"/>
                </a:lnTo>
                <a:lnTo>
                  <a:pt x="5323308" y="1705088"/>
                </a:lnTo>
                <a:lnTo>
                  <a:pt x="5345210" y="1705088"/>
                </a:lnTo>
                <a:lnTo>
                  <a:pt x="5345210" y="1715656"/>
                </a:lnTo>
                <a:lnTo>
                  <a:pt x="5357257" y="1715656"/>
                </a:lnTo>
                <a:lnTo>
                  <a:pt x="5357257" y="1726230"/>
                </a:lnTo>
                <a:lnTo>
                  <a:pt x="5362732" y="1726230"/>
                </a:lnTo>
                <a:lnTo>
                  <a:pt x="5362732" y="1736896"/>
                </a:lnTo>
                <a:lnTo>
                  <a:pt x="5403251" y="1736896"/>
                </a:lnTo>
                <a:lnTo>
                  <a:pt x="5403251" y="1747643"/>
                </a:lnTo>
                <a:lnTo>
                  <a:pt x="5426248" y="1747643"/>
                </a:lnTo>
                <a:lnTo>
                  <a:pt x="5426248" y="1758421"/>
                </a:lnTo>
                <a:lnTo>
                  <a:pt x="5429534" y="1758421"/>
                </a:lnTo>
                <a:lnTo>
                  <a:pt x="5429534" y="1769249"/>
                </a:lnTo>
                <a:lnTo>
                  <a:pt x="5459101" y="1769249"/>
                </a:lnTo>
                <a:lnTo>
                  <a:pt x="5459101" y="1780084"/>
                </a:lnTo>
                <a:lnTo>
                  <a:pt x="5464577" y="1780084"/>
                </a:lnTo>
                <a:lnTo>
                  <a:pt x="5464577" y="1790938"/>
                </a:lnTo>
                <a:lnTo>
                  <a:pt x="5475528" y="1790938"/>
                </a:lnTo>
                <a:lnTo>
                  <a:pt x="5475528" y="1801821"/>
                </a:lnTo>
                <a:lnTo>
                  <a:pt x="5491955" y="1801821"/>
                </a:lnTo>
                <a:lnTo>
                  <a:pt x="5491955" y="1812757"/>
                </a:lnTo>
                <a:lnTo>
                  <a:pt x="5497430" y="1812757"/>
                </a:lnTo>
                <a:lnTo>
                  <a:pt x="5497430" y="1823735"/>
                </a:lnTo>
                <a:lnTo>
                  <a:pt x="5498525" y="1823735"/>
                </a:lnTo>
                <a:lnTo>
                  <a:pt x="5498525" y="1834783"/>
                </a:lnTo>
                <a:lnTo>
                  <a:pt x="5504001" y="1834783"/>
                </a:lnTo>
                <a:lnTo>
                  <a:pt x="5504001" y="1845863"/>
                </a:lnTo>
                <a:lnTo>
                  <a:pt x="5521522" y="1845863"/>
                </a:lnTo>
                <a:lnTo>
                  <a:pt x="5521522" y="1856967"/>
                </a:lnTo>
                <a:lnTo>
                  <a:pt x="5522618" y="1856967"/>
                </a:lnTo>
                <a:lnTo>
                  <a:pt x="5522618" y="1868094"/>
                </a:lnTo>
                <a:lnTo>
                  <a:pt x="5528093" y="1868094"/>
                </a:lnTo>
                <a:lnTo>
                  <a:pt x="5528093" y="1879237"/>
                </a:lnTo>
                <a:lnTo>
                  <a:pt x="5591609" y="1879237"/>
                </a:lnTo>
                <a:lnTo>
                  <a:pt x="5591609" y="1890398"/>
                </a:lnTo>
                <a:lnTo>
                  <a:pt x="5603655" y="1890398"/>
                </a:lnTo>
                <a:lnTo>
                  <a:pt x="5603655" y="1901568"/>
                </a:lnTo>
                <a:lnTo>
                  <a:pt x="5634318" y="1901568"/>
                </a:lnTo>
                <a:lnTo>
                  <a:pt x="5634318" y="1912770"/>
                </a:lnTo>
                <a:lnTo>
                  <a:pt x="5637604" y="1912770"/>
                </a:lnTo>
                <a:lnTo>
                  <a:pt x="5637604" y="1912770"/>
                </a:lnTo>
                <a:lnTo>
                  <a:pt x="5656220" y="1912770"/>
                </a:lnTo>
                <a:lnTo>
                  <a:pt x="5656220" y="1924037"/>
                </a:lnTo>
                <a:lnTo>
                  <a:pt x="5657316" y="1924037"/>
                </a:lnTo>
                <a:lnTo>
                  <a:pt x="5657316" y="1935320"/>
                </a:lnTo>
                <a:lnTo>
                  <a:pt x="5667171" y="1935320"/>
                </a:lnTo>
                <a:lnTo>
                  <a:pt x="5667171" y="1946614"/>
                </a:lnTo>
                <a:lnTo>
                  <a:pt x="5696739" y="1946614"/>
                </a:lnTo>
                <a:lnTo>
                  <a:pt x="5696739" y="1957922"/>
                </a:lnTo>
                <a:lnTo>
                  <a:pt x="5709881" y="1957922"/>
                </a:lnTo>
                <a:lnTo>
                  <a:pt x="5709881" y="1969256"/>
                </a:lnTo>
                <a:lnTo>
                  <a:pt x="5758065" y="1969256"/>
                </a:lnTo>
                <a:lnTo>
                  <a:pt x="5758065" y="1980593"/>
                </a:lnTo>
                <a:lnTo>
                  <a:pt x="5781062" y="1980593"/>
                </a:lnTo>
                <a:lnTo>
                  <a:pt x="5781062" y="1991985"/>
                </a:lnTo>
                <a:lnTo>
                  <a:pt x="5784348" y="1991985"/>
                </a:lnTo>
                <a:lnTo>
                  <a:pt x="5784348" y="1991985"/>
                </a:lnTo>
                <a:lnTo>
                  <a:pt x="5821581" y="1991985"/>
                </a:lnTo>
                <a:lnTo>
                  <a:pt x="5821581" y="2003418"/>
                </a:lnTo>
                <a:lnTo>
                  <a:pt x="5827057" y="2003418"/>
                </a:lnTo>
                <a:lnTo>
                  <a:pt x="5827057" y="2014865"/>
                </a:lnTo>
                <a:lnTo>
                  <a:pt x="5828152" y="2014865"/>
                </a:lnTo>
                <a:lnTo>
                  <a:pt x="5828152" y="2026332"/>
                </a:lnTo>
                <a:lnTo>
                  <a:pt x="5836913" y="2026332"/>
                </a:lnTo>
                <a:lnTo>
                  <a:pt x="5836913" y="2037810"/>
                </a:lnTo>
                <a:lnTo>
                  <a:pt x="5850054" y="2037810"/>
                </a:lnTo>
                <a:lnTo>
                  <a:pt x="5850054" y="2049300"/>
                </a:lnTo>
                <a:lnTo>
                  <a:pt x="5855530" y="2049300"/>
                </a:lnTo>
                <a:lnTo>
                  <a:pt x="5855530" y="2060881"/>
                </a:lnTo>
                <a:lnTo>
                  <a:pt x="5859910" y="2060881"/>
                </a:lnTo>
                <a:lnTo>
                  <a:pt x="5859910" y="2072476"/>
                </a:lnTo>
                <a:lnTo>
                  <a:pt x="5865386" y="2072476"/>
                </a:lnTo>
                <a:lnTo>
                  <a:pt x="5865386" y="2084091"/>
                </a:lnTo>
                <a:lnTo>
                  <a:pt x="5869766" y="2084091"/>
                </a:lnTo>
                <a:lnTo>
                  <a:pt x="5869766" y="2095711"/>
                </a:lnTo>
                <a:lnTo>
                  <a:pt x="5870861" y="2095711"/>
                </a:lnTo>
                <a:lnTo>
                  <a:pt x="5870861" y="2118971"/>
                </a:lnTo>
                <a:lnTo>
                  <a:pt x="5878527" y="2118971"/>
                </a:lnTo>
                <a:lnTo>
                  <a:pt x="5878527" y="2130623"/>
                </a:lnTo>
                <a:lnTo>
                  <a:pt x="5891668" y="2130623"/>
                </a:lnTo>
                <a:lnTo>
                  <a:pt x="5891668" y="2142306"/>
                </a:lnTo>
                <a:lnTo>
                  <a:pt x="5898239" y="2142306"/>
                </a:lnTo>
                <a:lnTo>
                  <a:pt x="5898239" y="2154041"/>
                </a:lnTo>
                <a:lnTo>
                  <a:pt x="5916856" y="2154041"/>
                </a:lnTo>
                <a:lnTo>
                  <a:pt x="5916856" y="2165803"/>
                </a:lnTo>
                <a:lnTo>
                  <a:pt x="5942043" y="2165803"/>
                </a:lnTo>
                <a:lnTo>
                  <a:pt x="5942043" y="2177574"/>
                </a:lnTo>
                <a:lnTo>
                  <a:pt x="5954089" y="2177574"/>
                </a:lnTo>
                <a:lnTo>
                  <a:pt x="5954089" y="2189377"/>
                </a:lnTo>
                <a:lnTo>
                  <a:pt x="5957374" y="2189377"/>
                </a:lnTo>
                <a:lnTo>
                  <a:pt x="5957374" y="2201220"/>
                </a:lnTo>
                <a:lnTo>
                  <a:pt x="5980372" y="2201220"/>
                </a:lnTo>
                <a:lnTo>
                  <a:pt x="5980372" y="2213104"/>
                </a:lnTo>
                <a:lnTo>
                  <a:pt x="5982562" y="2213104"/>
                </a:lnTo>
                <a:lnTo>
                  <a:pt x="5982562" y="2225022"/>
                </a:lnTo>
                <a:lnTo>
                  <a:pt x="5996798" y="2225022"/>
                </a:lnTo>
                <a:lnTo>
                  <a:pt x="5996798" y="2236943"/>
                </a:lnTo>
                <a:lnTo>
                  <a:pt x="6001179" y="2236943"/>
                </a:lnTo>
                <a:lnTo>
                  <a:pt x="6001179" y="2248874"/>
                </a:lnTo>
                <a:lnTo>
                  <a:pt x="6006654" y="2248874"/>
                </a:lnTo>
                <a:lnTo>
                  <a:pt x="6006654" y="2260834"/>
                </a:lnTo>
                <a:lnTo>
                  <a:pt x="6028556" y="2260834"/>
                </a:lnTo>
                <a:lnTo>
                  <a:pt x="6028556" y="2260834"/>
                </a:lnTo>
                <a:lnTo>
                  <a:pt x="6038412" y="2260834"/>
                </a:lnTo>
                <a:lnTo>
                  <a:pt x="6038412" y="2272814"/>
                </a:lnTo>
                <a:lnTo>
                  <a:pt x="6040602" y="2272814"/>
                </a:lnTo>
                <a:lnTo>
                  <a:pt x="6040602" y="2284816"/>
                </a:lnTo>
                <a:lnTo>
                  <a:pt x="6044983" y="2284816"/>
                </a:lnTo>
                <a:lnTo>
                  <a:pt x="6044983" y="2296853"/>
                </a:lnTo>
                <a:lnTo>
                  <a:pt x="6089882" y="2296853"/>
                </a:lnTo>
                <a:lnTo>
                  <a:pt x="6089882" y="2308918"/>
                </a:lnTo>
                <a:lnTo>
                  <a:pt x="6104119" y="2308918"/>
                </a:lnTo>
                <a:lnTo>
                  <a:pt x="6104119" y="2320985"/>
                </a:lnTo>
                <a:lnTo>
                  <a:pt x="6121640" y="2320985"/>
                </a:lnTo>
                <a:lnTo>
                  <a:pt x="6121640" y="2333071"/>
                </a:lnTo>
                <a:lnTo>
                  <a:pt x="6161064" y="2333071"/>
                </a:lnTo>
                <a:lnTo>
                  <a:pt x="6161064" y="2345198"/>
                </a:lnTo>
                <a:lnTo>
                  <a:pt x="6164349" y="2345198"/>
                </a:lnTo>
                <a:lnTo>
                  <a:pt x="6164349" y="2357351"/>
                </a:lnTo>
                <a:lnTo>
                  <a:pt x="6166540" y="2357351"/>
                </a:lnTo>
                <a:lnTo>
                  <a:pt x="6166540" y="2369537"/>
                </a:lnTo>
                <a:lnTo>
                  <a:pt x="6170920" y="2369537"/>
                </a:lnTo>
                <a:lnTo>
                  <a:pt x="6170920" y="2381759"/>
                </a:lnTo>
                <a:lnTo>
                  <a:pt x="6235531" y="2381759"/>
                </a:lnTo>
                <a:lnTo>
                  <a:pt x="6235531" y="2393991"/>
                </a:lnTo>
                <a:lnTo>
                  <a:pt x="6239912" y="2393991"/>
                </a:lnTo>
                <a:lnTo>
                  <a:pt x="6239912" y="2406261"/>
                </a:lnTo>
                <a:lnTo>
                  <a:pt x="6259624" y="2406261"/>
                </a:lnTo>
                <a:lnTo>
                  <a:pt x="6259624" y="2418655"/>
                </a:lnTo>
                <a:lnTo>
                  <a:pt x="6270575" y="2418655"/>
                </a:lnTo>
                <a:lnTo>
                  <a:pt x="6270575" y="2431072"/>
                </a:lnTo>
                <a:lnTo>
                  <a:pt x="6272765" y="2431072"/>
                </a:lnTo>
                <a:lnTo>
                  <a:pt x="6272765" y="2443530"/>
                </a:lnTo>
                <a:lnTo>
                  <a:pt x="6285906" y="2443530"/>
                </a:lnTo>
                <a:lnTo>
                  <a:pt x="6285906" y="2456046"/>
                </a:lnTo>
                <a:lnTo>
                  <a:pt x="6288096" y="2456046"/>
                </a:lnTo>
                <a:lnTo>
                  <a:pt x="6288096" y="2468574"/>
                </a:lnTo>
                <a:lnTo>
                  <a:pt x="6308903" y="2468574"/>
                </a:lnTo>
                <a:lnTo>
                  <a:pt x="6308903" y="2481164"/>
                </a:lnTo>
                <a:lnTo>
                  <a:pt x="6316569" y="2481164"/>
                </a:lnTo>
                <a:lnTo>
                  <a:pt x="6316569" y="2493772"/>
                </a:lnTo>
                <a:lnTo>
                  <a:pt x="6331901" y="2493772"/>
                </a:lnTo>
                <a:lnTo>
                  <a:pt x="6331901" y="2506384"/>
                </a:lnTo>
                <a:lnTo>
                  <a:pt x="6339566" y="2506384"/>
                </a:lnTo>
                <a:lnTo>
                  <a:pt x="6339566" y="2518999"/>
                </a:lnTo>
                <a:lnTo>
                  <a:pt x="6342852" y="2518999"/>
                </a:lnTo>
                <a:lnTo>
                  <a:pt x="6342852" y="2531631"/>
                </a:lnTo>
                <a:lnTo>
                  <a:pt x="6346137" y="2531631"/>
                </a:lnTo>
                <a:lnTo>
                  <a:pt x="6346137" y="2544292"/>
                </a:lnTo>
                <a:lnTo>
                  <a:pt x="6358183" y="2544292"/>
                </a:lnTo>
                <a:lnTo>
                  <a:pt x="6358183" y="2556957"/>
                </a:lnTo>
                <a:lnTo>
                  <a:pt x="6384466" y="2556957"/>
                </a:lnTo>
                <a:lnTo>
                  <a:pt x="6384466" y="2582385"/>
                </a:lnTo>
                <a:lnTo>
                  <a:pt x="6391036" y="2582385"/>
                </a:lnTo>
                <a:lnTo>
                  <a:pt x="6391036" y="2595202"/>
                </a:lnTo>
                <a:lnTo>
                  <a:pt x="6397607" y="2595202"/>
                </a:lnTo>
                <a:lnTo>
                  <a:pt x="6397607" y="2608048"/>
                </a:lnTo>
                <a:lnTo>
                  <a:pt x="6412938" y="2608048"/>
                </a:lnTo>
                <a:lnTo>
                  <a:pt x="6412938" y="2620905"/>
                </a:lnTo>
                <a:lnTo>
                  <a:pt x="6426080" y="2620905"/>
                </a:lnTo>
                <a:lnTo>
                  <a:pt x="6426080" y="2633835"/>
                </a:lnTo>
                <a:lnTo>
                  <a:pt x="6427175" y="2633835"/>
                </a:lnTo>
                <a:lnTo>
                  <a:pt x="6427175" y="2646776"/>
                </a:lnTo>
                <a:lnTo>
                  <a:pt x="6430460" y="2646776"/>
                </a:lnTo>
                <a:lnTo>
                  <a:pt x="6430460" y="2659770"/>
                </a:lnTo>
                <a:lnTo>
                  <a:pt x="6442506" y="2659770"/>
                </a:lnTo>
                <a:lnTo>
                  <a:pt x="6442506" y="2672779"/>
                </a:lnTo>
                <a:lnTo>
                  <a:pt x="6445792" y="2672779"/>
                </a:lnTo>
                <a:lnTo>
                  <a:pt x="6445792" y="2685796"/>
                </a:lnTo>
                <a:lnTo>
                  <a:pt x="6446887" y="2685796"/>
                </a:lnTo>
                <a:lnTo>
                  <a:pt x="6446887" y="2698841"/>
                </a:lnTo>
                <a:lnTo>
                  <a:pt x="6450172" y="2698841"/>
                </a:lnTo>
                <a:lnTo>
                  <a:pt x="6450172" y="2711944"/>
                </a:lnTo>
                <a:lnTo>
                  <a:pt x="6452362" y="2711944"/>
                </a:lnTo>
                <a:lnTo>
                  <a:pt x="6452362" y="2711944"/>
                </a:lnTo>
                <a:lnTo>
                  <a:pt x="6456743" y="2711944"/>
                </a:lnTo>
                <a:lnTo>
                  <a:pt x="6456743" y="2725059"/>
                </a:lnTo>
                <a:lnTo>
                  <a:pt x="6463313" y="2725059"/>
                </a:lnTo>
                <a:lnTo>
                  <a:pt x="6463313" y="2738181"/>
                </a:lnTo>
                <a:lnTo>
                  <a:pt x="6466599" y="2738181"/>
                </a:lnTo>
                <a:lnTo>
                  <a:pt x="6466599" y="2751398"/>
                </a:lnTo>
                <a:lnTo>
                  <a:pt x="6475359" y="2751398"/>
                </a:lnTo>
                <a:lnTo>
                  <a:pt x="6475359" y="2764617"/>
                </a:lnTo>
                <a:lnTo>
                  <a:pt x="6495071" y="2764617"/>
                </a:lnTo>
                <a:lnTo>
                  <a:pt x="6495071" y="2777873"/>
                </a:lnTo>
                <a:lnTo>
                  <a:pt x="6496166" y="2777873"/>
                </a:lnTo>
                <a:lnTo>
                  <a:pt x="6496166" y="2791236"/>
                </a:lnTo>
                <a:lnTo>
                  <a:pt x="6497262" y="2791236"/>
                </a:lnTo>
                <a:lnTo>
                  <a:pt x="6497262" y="2804658"/>
                </a:lnTo>
                <a:lnTo>
                  <a:pt x="6523544" y="2804658"/>
                </a:lnTo>
                <a:lnTo>
                  <a:pt x="6523544" y="2818095"/>
                </a:lnTo>
                <a:lnTo>
                  <a:pt x="6525734" y="2818095"/>
                </a:lnTo>
                <a:lnTo>
                  <a:pt x="6525734" y="2831627"/>
                </a:lnTo>
                <a:lnTo>
                  <a:pt x="6570634" y="2831627"/>
                </a:lnTo>
                <a:lnTo>
                  <a:pt x="6570634" y="2858714"/>
                </a:lnTo>
                <a:lnTo>
                  <a:pt x="6589250" y="2858714"/>
                </a:lnTo>
                <a:lnTo>
                  <a:pt x="6589250" y="2872286"/>
                </a:lnTo>
                <a:lnTo>
                  <a:pt x="6616628" y="2872286"/>
                </a:lnTo>
                <a:lnTo>
                  <a:pt x="6616628" y="2885884"/>
                </a:lnTo>
                <a:lnTo>
                  <a:pt x="6648386" y="2885884"/>
                </a:lnTo>
                <a:lnTo>
                  <a:pt x="6648386" y="2899496"/>
                </a:lnTo>
                <a:lnTo>
                  <a:pt x="6658242" y="2899496"/>
                </a:lnTo>
                <a:lnTo>
                  <a:pt x="6658242" y="2913155"/>
                </a:lnTo>
                <a:lnTo>
                  <a:pt x="6675764" y="2913155"/>
                </a:lnTo>
                <a:lnTo>
                  <a:pt x="6675764" y="2926821"/>
                </a:lnTo>
                <a:lnTo>
                  <a:pt x="6695476" y="2926821"/>
                </a:lnTo>
                <a:lnTo>
                  <a:pt x="6695476" y="2940509"/>
                </a:lnTo>
                <a:lnTo>
                  <a:pt x="6696571" y="2940509"/>
                </a:lnTo>
                <a:lnTo>
                  <a:pt x="6696571" y="2954261"/>
                </a:lnTo>
                <a:lnTo>
                  <a:pt x="6698761" y="2954261"/>
                </a:lnTo>
                <a:lnTo>
                  <a:pt x="6698761" y="2968060"/>
                </a:lnTo>
                <a:lnTo>
                  <a:pt x="6700951" y="2968060"/>
                </a:lnTo>
                <a:lnTo>
                  <a:pt x="6700951" y="2981879"/>
                </a:lnTo>
                <a:lnTo>
                  <a:pt x="6703141" y="2981879"/>
                </a:lnTo>
                <a:lnTo>
                  <a:pt x="6703141" y="2995763"/>
                </a:lnTo>
                <a:lnTo>
                  <a:pt x="6710807" y="2995763"/>
                </a:lnTo>
                <a:lnTo>
                  <a:pt x="6710807" y="3009673"/>
                </a:lnTo>
                <a:lnTo>
                  <a:pt x="6752421" y="3009673"/>
                </a:lnTo>
                <a:lnTo>
                  <a:pt x="6752421" y="3023604"/>
                </a:lnTo>
                <a:lnTo>
                  <a:pt x="6755707" y="3023604"/>
                </a:lnTo>
                <a:lnTo>
                  <a:pt x="6755707" y="3051646"/>
                </a:lnTo>
                <a:lnTo>
                  <a:pt x="6765562" y="3051646"/>
                </a:lnTo>
                <a:lnTo>
                  <a:pt x="6765562" y="3065734"/>
                </a:lnTo>
                <a:lnTo>
                  <a:pt x="6789655" y="3065734"/>
                </a:lnTo>
                <a:lnTo>
                  <a:pt x="6789655" y="3079835"/>
                </a:lnTo>
                <a:lnTo>
                  <a:pt x="6791845" y="3079835"/>
                </a:lnTo>
                <a:lnTo>
                  <a:pt x="6791845" y="3094002"/>
                </a:lnTo>
                <a:lnTo>
                  <a:pt x="6796225" y="3094002"/>
                </a:lnTo>
                <a:lnTo>
                  <a:pt x="6796225" y="3108196"/>
                </a:lnTo>
                <a:lnTo>
                  <a:pt x="6797321" y="3108196"/>
                </a:lnTo>
                <a:lnTo>
                  <a:pt x="6797321" y="3122410"/>
                </a:lnTo>
                <a:lnTo>
                  <a:pt x="6800606" y="3122410"/>
                </a:lnTo>
                <a:lnTo>
                  <a:pt x="6800606" y="3136631"/>
                </a:lnTo>
                <a:lnTo>
                  <a:pt x="6820318" y="3136631"/>
                </a:lnTo>
                <a:lnTo>
                  <a:pt x="6820318" y="3150867"/>
                </a:lnTo>
                <a:lnTo>
                  <a:pt x="6827983" y="3150867"/>
                </a:lnTo>
                <a:lnTo>
                  <a:pt x="6827983" y="3165150"/>
                </a:lnTo>
                <a:lnTo>
                  <a:pt x="6855361" y="3165150"/>
                </a:lnTo>
                <a:lnTo>
                  <a:pt x="6855361" y="3179458"/>
                </a:lnTo>
                <a:lnTo>
                  <a:pt x="6860837" y="3179458"/>
                </a:lnTo>
                <a:lnTo>
                  <a:pt x="6860837" y="3193777"/>
                </a:lnTo>
                <a:lnTo>
                  <a:pt x="6869598" y="3193777"/>
                </a:lnTo>
                <a:lnTo>
                  <a:pt x="6869598" y="3208120"/>
                </a:lnTo>
                <a:lnTo>
                  <a:pt x="6881644" y="3208120"/>
                </a:lnTo>
                <a:lnTo>
                  <a:pt x="6881644" y="3222515"/>
                </a:lnTo>
                <a:lnTo>
                  <a:pt x="6899165" y="3222515"/>
                </a:lnTo>
                <a:lnTo>
                  <a:pt x="6899165" y="3236985"/>
                </a:lnTo>
                <a:lnTo>
                  <a:pt x="6903546" y="3236985"/>
                </a:lnTo>
                <a:lnTo>
                  <a:pt x="6903546" y="3251472"/>
                </a:lnTo>
                <a:lnTo>
                  <a:pt x="6930923" y="3251472"/>
                </a:lnTo>
                <a:lnTo>
                  <a:pt x="6930923" y="3266008"/>
                </a:lnTo>
                <a:lnTo>
                  <a:pt x="6934209" y="3266008"/>
                </a:lnTo>
                <a:lnTo>
                  <a:pt x="6934209" y="3280562"/>
                </a:lnTo>
                <a:lnTo>
                  <a:pt x="6944065" y="3280562"/>
                </a:lnTo>
                <a:lnTo>
                  <a:pt x="6944065" y="3295208"/>
                </a:lnTo>
                <a:lnTo>
                  <a:pt x="6951730" y="3295208"/>
                </a:lnTo>
                <a:lnTo>
                  <a:pt x="6951730" y="3309907"/>
                </a:lnTo>
                <a:lnTo>
                  <a:pt x="6952826" y="3309907"/>
                </a:lnTo>
                <a:lnTo>
                  <a:pt x="6952826" y="3324618"/>
                </a:lnTo>
                <a:lnTo>
                  <a:pt x="6960491" y="3324618"/>
                </a:lnTo>
                <a:lnTo>
                  <a:pt x="6960491" y="3339330"/>
                </a:lnTo>
                <a:lnTo>
                  <a:pt x="6970347" y="3339330"/>
                </a:lnTo>
                <a:lnTo>
                  <a:pt x="6970347" y="3354084"/>
                </a:lnTo>
                <a:lnTo>
                  <a:pt x="6978013" y="3354084"/>
                </a:lnTo>
                <a:lnTo>
                  <a:pt x="6978013" y="3368890"/>
                </a:lnTo>
                <a:lnTo>
                  <a:pt x="6993344" y="3368890"/>
                </a:lnTo>
                <a:lnTo>
                  <a:pt x="6993344" y="3383731"/>
                </a:lnTo>
                <a:lnTo>
                  <a:pt x="7006486" y="3383731"/>
                </a:lnTo>
                <a:lnTo>
                  <a:pt x="7006486" y="3383731"/>
                </a:lnTo>
                <a:lnTo>
                  <a:pt x="7017437" y="3383731"/>
                </a:lnTo>
                <a:lnTo>
                  <a:pt x="7017437" y="3398618"/>
                </a:lnTo>
                <a:lnTo>
                  <a:pt x="7024007" y="3398618"/>
                </a:lnTo>
                <a:lnTo>
                  <a:pt x="7024007" y="3413565"/>
                </a:lnTo>
                <a:lnTo>
                  <a:pt x="7037149" y="3413565"/>
                </a:lnTo>
                <a:lnTo>
                  <a:pt x="7037149" y="3428545"/>
                </a:lnTo>
                <a:lnTo>
                  <a:pt x="7042624" y="3428545"/>
                </a:lnTo>
                <a:lnTo>
                  <a:pt x="7042624" y="3443548"/>
                </a:lnTo>
                <a:lnTo>
                  <a:pt x="7054670" y="3443548"/>
                </a:lnTo>
                <a:lnTo>
                  <a:pt x="7054670" y="3458585"/>
                </a:lnTo>
                <a:lnTo>
                  <a:pt x="7056861" y="3458585"/>
                </a:lnTo>
                <a:lnTo>
                  <a:pt x="7056861" y="3473689"/>
                </a:lnTo>
                <a:lnTo>
                  <a:pt x="7060146" y="3473689"/>
                </a:lnTo>
                <a:lnTo>
                  <a:pt x="7060146" y="3488811"/>
                </a:lnTo>
                <a:lnTo>
                  <a:pt x="7066717" y="3488811"/>
                </a:lnTo>
                <a:lnTo>
                  <a:pt x="7066717" y="3503964"/>
                </a:lnTo>
                <a:lnTo>
                  <a:pt x="7071097" y="3503964"/>
                </a:lnTo>
                <a:lnTo>
                  <a:pt x="7071097" y="3503964"/>
                </a:lnTo>
                <a:lnTo>
                  <a:pt x="7080953" y="3503964"/>
                </a:lnTo>
                <a:lnTo>
                  <a:pt x="7080953" y="3520177"/>
                </a:lnTo>
                <a:lnTo>
                  <a:pt x="7092999" y="3520177"/>
                </a:lnTo>
                <a:lnTo>
                  <a:pt x="7092999" y="3520177"/>
                </a:lnTo>
                <a:lnTo>
                  <a:pt x="7097379" y="3520177"/>
                </a:lnTo>
                <a:lnTo>
                  <a:pt x="7097379" y="3520177"/>
                </a:lnTo>
                <a:lnTo>
                  <a:pt x="7103950" y="3520177"/>
                </a:lnTo>
                <a:lnTo>
                  <a:pt x="7103950" y="3538497"/>
                </a:lnTo>
                <a:lnTo>
                  <a:pt x="7107235" y="3538497"/>
                </a:lnTo>
                <a:lnTo>
                  <a:pt x="7107235" y="3538497"/>
                </a:lnTo>
                <a:lnTo>
                  <a:pt x="7110521" y="3538497"/>
                </a:lnTo>
                <a:lnTo>
                  <a:pt x="7110521" y="3557533"/>
                </a:lnTo>
                <a:lnTo>
                  <a:pt x="7112711" y="3557533"/>
                </a:lnTo>
                <a:lnTo>
                  <a:pt x="7112711" y="3557533"/>
                </a:lnTo>
                <a:lnTo>
                  <a:pt x="7122567" y="3557533"/>
                </a:lnTo>
                <a:lnTo>
                  <a:pt x="7122567" y="3577488"/>
                </a:lnTo>
                <a:lnTo>
                  <a:pt x="7128042" y="3577488"/>
                </a:lnTo>
                <a:lnTo>
                  <a:pt x="7128042" y="3597542"/>
                </a:lnTo>
                <a:lnTo>
                  <a:pt x="7129138" y="3597542"/>
                </a:lnTo>
                <a:lnTo>
                  <a:pt x="7129138" y="3597542"/>
                </a:lnTo>
                <a:lnTo>
                  <a:pt x="7130233" y="3597542"/>
                </a:lnTo>
                <a:lnTo>
                  <a:pt x="7130233" y="3619659"/>
                </a:lnTo>
                <a:lnTo>
                  <a:pt x="7135708" y="3619659"/>
                </a:lnTo>
                <a:lnTo>
                  <a:pt x="7135708" y="3619659"/>
                </a:lnTo>
                <a:lnTo>
                  <a:pt x="7140089" y="3619659"/>
                </a:lnTo>
                <a:lnTo>
                  <a:pt x="7140089" y="3643303"/>
                </a:lnTo>
                <a:lnTo>
                  <a:pt x="7149945" y="3643303"/>
                </a:lnTo>
                <a:lnTo>
                  <a:pt x="7149945" y="3643303"/>
                </a:lnTo>
                <a:lnTo>
                  <a:pt x="7151040" y="3643303"/>
                </a:lnTo>
                <a:lnTo>
                  <a:pt x="7151040" y="3643303"/>
                </a:lnTo>
                <a:lnTo>
                  <a:pt x="7152135" y="3643303"/>
                </a:lnTo>
                <a:lnTo>
                  <a:pt x="7152135" y="3643303"/>
                </a:lnTo>
                <a:lnTo>
                  <a:pt x="7154325" y="3643303"/>
                </a:lnTo>
                <a:lnTo>
                  <a:pt x="7154325" y="3674406"/>
                </a:lnTo>
                <a:lnTo>
                  <a:pt x="7159801" y="3674406"/>
                </a:lnTo>
                <a:lnTo>
                  <a:pt x="7159801" y="3674406"/>
                </a:lnTo>
                <a:lnTo>
                  <a:pt x="7169656" y="3674406"/>
                </a:lnTo>
                <a:lnTo>
                  <a:pt x="7169656" y="3708499"/>
                </a:lnTo>
                <a:lnTo>
                  <a:pt x="7179512" y="3708499"/>
                </a:lnTo>
                <a:lnTo>
                  <a:pt x="7179512" y="3708499"/>
                </a:lnTo>
                <a:lnTo>
                  <a:pt x="7181703" y="3708499"/>
                </a:lnTo>
                <a:lnTo>
                  <a:pt x="7181703" y="3708499"/>
                </a:lnTo>
                <a:lnTo>
                  <a:pt x="7182798" y="3708499"/>
                </a:lnTo>
                <a:lnTo>
                  <a:pt x="7182798" y="3708499"/>
                </a:lnTo>
                <a:lnTo>
                  <a:pt x="7202510" y="3708499"/>
                </a:lnTo>
                <a:lnTo>
                  <a:pt x="7202510" y="3708499"/>
                </a:lnTo>
                <a:lnTo>
                  <a:pt x="7203605" y="3708499"/>
                </a:lnTo>
                <a:lnTo>
                  <a:pt x="7203605" y="3708499"/>
                </a:lnTo>
                <a:lnTo>
                  <a:pt x="7205795" y="3708499"/>
                </a:lnTo>
                <a:lnTo>
                  <a:pt x="7205795" y="3708499"/>
                </a:lnTo>
                <a:lnTo>
                  <a:pt x="7212366" y="3708499"/>
                </a:lnTo>
                <a:lnTo>
                  <a:pt x="7212366" y="3708499"/>
                </a:lnTo>
                <a:lnTo>
                  <a:pt x="7220031" y="3708499"/>
                </a:lnTo>
                <a:lnTo>
                  <a:pt x="7220031" y="3708499"/>
                </a:lnTo>
                <a:lnTo>
                  <a:pt x="7221126" y="3708499"/>
                </a:lnTo>
                <a:lnTo>
                  <a:pt x="7221126" y="3708499"/>
                </a:lnTo>
                <a:lnTo>
                  <a:pt x="7227697" y="3708499"/>
                </a:lnTo>
                <a:lnTo>
                  <a:pt x="7227697" y="3708499"/>
                </a:lnTo>
              </a:path>
            </a:pathLst>
          </a:custGeom>
          <a:ln w="21681" cap="flat">
            <a:solidFill>
              <a:srgbClr val="000000">
                <a:alpha val="100000"/>
              </a:srgbClr>
            </a:solidFill>
            <a:prstDash val="sysDash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14" name="pl14"/>
          <p:cNvSpPr/>
          <p:nvPr/>
        </p:nvSpPr>
        <p:spPr>
          <a:xfrm>
            <a:off x="3935842" y="1780201"/>
            <a:ext cx="4602399" cy="3090514"/>
          </a:xfrm>
          <a:custGeom>
            <a:avLst/>
            <a:gdLst/>
            <a:ahLst/>
            <a:cxnLst/>
            <a:rect l="0" t="0" r="0" b="0"/>
            <a:pathLst>
              <a:path w="7227697" h="5208072">
                <a:moveTo>
                  <a:pt x="0" y="0"/>
                </a:moveTo>
                <a:lnTo>
                  <a:pt x="170836" y="0"/>
                </a:lnTo>
                <a:lnTo>
                  <a:pt x="170836" y="8716"/>
                </a:lnTo>
                <a:lnTo>
                  <a:pt x="203689" y="8716"/>
                </a:lnTo>
                <a:lnTo>
                  <a:pt x="203689" y="8716"/>
                </a:lnTo>
                <a:lnTo>
                  <a:pt x="261730" y="8716"/>
                </a:lnTo>
                <a:lnTo>
                  <a:pt x="261730" y="17481"/>
                </a:lnTo>
                <a:lnTo>
                  <a:pt x="279251" y="17481"/>
                </a:lnTo>
                <a:lnTo>
                  <a:pt x="279251" y="26284"/>
                </a:lnTo>
                <a:lnTo>
                  <a:pt x="316485" y="26284"/>
                </a:lnTo>
                <a:lnTo>
                  <a:pt x="316485" y="35090"/>
                </a:lnTo>
                <a:lnTo>
                  <a:pt x="342768" y="35090"/>
                </a:lnTo>
                <a:lnTo>
                  <a:pt x="342768" y="43907"/>
                </a:lnTo>
                <a:lnTo>
                  <a:pt x="372335" y="43907"/>
                </a:lnTo>
                <a:lnTo>
                  <a:pt x="372335" y="52734"/>
                </a:lnTo>
                <a:lnTo>
                  <a:pt x="430376" y="52734"/>
                </a:lnTo>
                <a:lnTo>
                  <a:pt x="430376" y="52734"/>
                </a:lnTo>
                <a:lnTo>
                  <a:pt x="504843" y="52734"/>
                </a:lnTo>
                <a:lnTo>
                  <a:pt x="504843" y="61623"/>
                </a:lnTo>
                <a:lnTo>
                  <a:pt x="548647" y="61623"/>
                </a:lnTo>
                <a:lnTo>
                  <a:pt x="548647" y="70523"/>
                </a:lnTo>
                <a:lnTo>
                  <a:pt x="780810" y="70523"/>
                </a:lnTo>
                <a:lnTo>
                  <a:pt x="780810" y="79490"/>
                </a:lnTo>
                <a:lnTo>
                  <a:pt x="790666" y="79490"/>
                </a:lnTo>
                <a:lnTo>
                  <a:pt x="790666" y="79490"/>
                </a:lnTo>
                <a:lnTo>
                  <a:pt x="805997" y="79490"/>
                </a:lnTo>
                <a:lnTo>
                  <a:pt x="805997" y="88474"/>
                </a:lnTo>
                <a:lnTo>
                  <a:pt x="816948" y="88474"/>
                </a:lnTo>
                <a:lnTo>
                  <a:pt x="816948" y="97459"/>
                </a:lnTo>
                <a:lnTo>
                  <a:pt x="839946" y="97459"/>
                </a:lnTo>
                <a:lnTo>
                  <a:pt x="839946" y="97459"/>
                </a:lnTo>
                <a:lnTo>
                  <a:pt x="853087" y="97459"/>
                </a:lnTo>
                <a:lnTo>
                  <a:pt x="853087" y="106480"/>
                </a:lnTo>
                <a:lnTo>
                  <a:pt x="919888" y="106480"/>
                </a:lnTo>
                <a:lnTo>
                  <a:pt x="919888" y="115518"/>
                </a:lnTo>
                <a:lnTo>
                  <a:pt x="962597" y="115518"/>
                </a:lnTo>
                <a:lnTo>
                  <a:pt x="962597" y="124557"/>
                </a:lnTo>
                <a:lnTo>
                  <a:pt x="1008592" y="124557"/>
                </a:lnTo>
                <a:lnTo>
                  <a:pt x="1008592" y="133619"/>
                </a:lnTo>
                <a:lnTo>
                  <a:pt x="1090725" y="133619"/>
                </a:lnTo>
                <a:lnTo>
                  <a:pt x="1090725" y="133619"/>
                </a:lnTo>
                <a:lnTo>
                  <a:pt x="1137814" y="133619"/>
                </a:lnTo>
                <a:lnTo>
                  <a:pt x="1137814" y="142712"/>
                </a:lnTo>
                <a:lnTo>
                  <a:pt x="1153146" y="142712"/>
                </a:lnTo>
                <a:lnTo>
                  <a:pt x="1153146" y="151833"/>
                </a:lnTo>
                <a:lnTo>
                  <a:pt x="1167382" y="151833"/>
                </a:lnTo>
                <a:lnTo>
                  <a:pt x="1167382" y="160966"/>
                </a:lnTo>
                <a:lnTo>
                  <a:pt x="1226518" y="160966"/>
                </a:lnTo>
                <a:lnTo>
                  <a:pt x="1226518" y="170127"/>
                </a:lnTo>
                <a:lnTo>
                  <a:pt x="1245135" y="170127"/>
                </a:lnTo>
                <a:lnTo>
                  <a:pt x="1245135" y="179296"/>
                </a:lnTo>
                <a:lnTo>
                  <a:pt x="1260466" y="179296"/>
                </a:lnTo>
                <a:lnTo>
                  <a:pt x="1260466" y="188498"/>
                </a:lnTo>
                <a:lnTo>
                  <a:pt x="1325077" y="188498"/>
                </a:lnTo>
                <a:lnTo>
                  <a:pt x="1325077" y="197712"/>
                </a:lnTo>
                <a:lnTo>
                  <a:pt x="1326172" y="197712"/>
                </a:lnTo>
                <a:lnTo>
                  <a:pt x="1326172" y="206931"/>
                </a:lnTo>
                <a:lnTo>
                  <a:pt x="1397354" y="206931"/>
                </a:lnTo>
                <a:lnTo>
                  <a:pt x="1397354" y="216190"/>
                </a:lnTo>
                <a:lnTo>
                  <a:pt x="1408305" y="216190"/>
                </a:lnTo>
                <a:lnTo>
                  <a:pt x="1408305" y="225459"/>
                </a:lnTo>
                <a:lnTo>
                  <a:pt x="1422542" y="225459"/>
                </a:lnTo>
                <a:lnTo>
                  <a:pt x="1422542" y="234736"/>
                </a:lnTo>
                <a:lnTo>
                  <a:pt x="1424732" y="234736"/>
                </a:lnTo>
                <a:lnTo>
                  <a:pt x="1424732" y="244016"/>
                </a:lnTo>
                <a:lnTo>
                  <a:pt x="1464156" y="244016"/>
                </a:lnTo>
                <a:lnTo>
                  <a:pt x="1464156" y="253307"/>
                </a:lnTo>
                <a:lnTo>
                  <a:pt x="1489343" y="253307"/>
                </a:lnTo>
                <a:lnTo>
                  <a:pt x="1489343" y="262599"/>
                </a:lnTo>
                <a:lnTo>
                  <a:pt x="1506865" y="262599"/>
                </a:lnTo>
                <a:lnTo>
                  <a:pt x="1506865" y="271911"/>
                </a:lnTo>
                <a:lnTo>
                  <a:pt x="1529862" y="271911"/>
                </a:lnTo>
                <a:lnTo>
                  <a:pt x="1529862" y="281239"/>
                </a:lnTo>
                <a:lnTo>
                  <a:pt x="1536433" y="281239"/>
                </a:lnTo>
                <a:lnTo>
                  <a:pt x="1536433" y="290584"/>
                </a:lnTo>
                <a:lnTo>
                  <a:pt x="1583522" y="290584"/>
                </a:lnTo>
                <a:lnTo>
                  <a:pt x="1583522" y="299961"/>
                </a:lnTo>
                <a:lnTo>
                  <a:pt x="1608710" y="299961"/>
                </a:lnTo>
                <a:lnTo>
                  <a:pt x="1608710" y="309347"/>
                </a:lnTo>
                <a:lnTo>
                  <a:pt x="1670036" y="309347"/>
                </a:lnTo>
                <a:lnTo>
                  <a:pt x="1670036" y="318772"/>
                </a:lnTo>
                <a:lnTo>
                  <a:pt x="1730266" y="318772"/>
                </a:lnTo>
                <a:lnTo>
                  <a:pt x="1730266" y="328204"/>
                </a:lnTo>
                <a:lnTo>
                  <a:pt x="1737932" y="328204"/>
                </a:lnTo>
                <a:lnTo>
                  <a:pt x="1737932" y="337644"/>
                </a:lnTo>
                <a:lnTo>
                  <a:pt x="1757644" y="337644"/>
                </a:lnTo>
                <a:lnTo>
                  <a:pt x="1757644" y="347092"/>
                </a:lnTo>
                <a:lnTo>
                  <a:pt x="1766405" y="347092"/>
                </a:lnTo>
                <a:lnTo>
                  <a:pt x="1766405" y="356550"/>
                </a:lnTo>
                <a:lnTo>
                  <a:pt x="1786117" y="356550"/>
                </a:lnTo>
                <a:lnTo>
                  <a:pt x="1786117" y="366018"/>
                </a:lnTo>
                <a:lnTo>
                  <a:pt x="1810209" y="366018"/>
                </a:lnTo>
                <a:lnTo>
                  <a:pt x="1810209" y="375505"/>
                </a:lnTo>
                <a:lnTo>
                  <a:pt x="1845253" y="375505"/>
                </a:lnTo>
                <a:lnTo>
                  <a:pt x="1845253" y="384993"/>
                </a:lnTo>
                <a:lnTo>
                  <a:pt x="1863869" y="384993"/>
                </a:lnTo>
                <a:lnTo>
                  <a:pt x="1863869" y="394489"/>
                </a:lnTo>
                <a:lnTo>
                  <a:pt x="1866060" y="394489"/>
                </a:lnTo>
                <a:lnTo>
                  <a:pt x="1866060" y="403996"/>
                </a:lnTo>
                <a:lnTo>
                  <a:pt x="1896723" y="403996"/>
                </a:lnTo>
                <a:lnTo>
                  <a:pt x="1896723" y="413505"/>
                </a:lnTo>
                <a:lnTo>
                  <a:pt x="1909864" y="413505"/>
                </a:lnTo>
                <a:lnTo>
                  <a:pt x="1909864" y="423026"/>
                </a:lnTo>
                <a:lnTo>
                  <a:pt x="1935051" y="423026"/>
                </a:lnTo>
                <a:lnTo>
                  <a:pt x="1935051" y="432587"/>
                </a:lnTo>
                <a:lnTo>
                  <a:pt x="1986521" y="432587"/>
                </a:lnTo>
                <a:lnTo>
                  <a:pt x="1986521" y="442169"/>
                </a:lnTo>
                <a:lnTo>
                  <a:pt x="2017184" y="442169"/>
                </a:lnTo>
                <a:lnTo>
                  <a:pt x="2017184" y="451768"/>
                </a:lnTo>
                <a:lnTo>
                  <a:pt x="2122314" y="451768"/>
                </a:lnTo>
                <a:lnTo>
                  <a:pt x="2122314" y="461381"/>
                </a:lnTo>
                <a:lnTo>
                  <a:pt x="2123409" y="461381"/>
                </a:lnTo>
                <a:lnTo>
                  <a:pt x="2123409" y="470995"/>
                </a:lnTo>
                <a:lnTo>
                  <a:pt x="2131075" y="470995"/>
                </a:lnTo>
                <a:lnTo>
                  <a:pt x="2131075" y="470995"/>
                </a:lnTo>
                <a:lnTo>
                  <a:pt x="2159548" y="470995"/>
                </a:lnTo>
                <a:lnTo>
                  <a:pt x="2159548" y="470995"/>
                </a:lnTo>
                <a:lnTo>
                  <a:pt x="2178165" y="470995"/>
                </a:lnTo>
                <a:lnTo>
                  <a:pt x="2178165" y="480671"/>
                </a:lnTo>
                <a:lnTo>
                  <a:pt x="2189116" y="480671"/>
                </a:lnTo>
                <a:lnTo>
                  <a:pt x="2189116" y="480671"/>
                </a:lnTo>
                <a:lnTo>
                  <a:pt x="2201162" y="480671"/>
                </a:lnTo>
                <a:lnTo>
                  <a:pt x="2201162" y="490400"/>
                </a:lnTo>
                <a:lnTo>
                  <a:pt x="2208828" y="490400"/>
                </a:lnTo>
                <a:lnTo>
                  <a:pt x="2208828" y="500150"/>
                </a:lnTo>
                <a:lnTo>
                  <a:pt x="2213208" y="500150"/>
                </a:lnTo>
                <a:lnTo>
                  <a:pt x="2213208" y="500150"/>
                </a:lnTo>
                <a:lnTo>
                  <a:pt x="2227444" y="500150"/>
                </a:lnTo>
                <a:lnTo>
                  <a:pt x="2227444" y="500150"/>
                </a:lnTo>
                <a:lnTo>
                  <a:pt x="2269058" y="500150"/>
                </a:lnTo>
                <a:lnTo>
                  <a:pt x="2269058" y="509985"/>
                </a:lnTo>
                <a:lnTo>
                  <a:pt x="2273439" y="509985"/>
                </a:lnTo>
                <a:lnTo>
                  <a:pt x="2273439" y="519839"/>
                </a:lnTo>
                <a:lnTo>
                  <a:pt x="2306292" y="519839"/>
                </a:lnTo>
                <a:lnTo>
                  <a:pt x="2306292" y="529740"/>
                </a:lnTo>
                <a:lnTo>
                  <a:pt x="2310673" y="529740"/>
                </a:lnTo>
                <a:lnTo>
                  <a:pt x="2310673" y="539677"/>
                </a:lnTo>
                <a:lnTo>
                  <a:pt x="2430039" y="539677"/>
                </a:lnTo>
                <a:lnTo>
                  <a:pt x="2430039" y="549623"/>
                </a:lnTo>
                <a:lnTo>
                  <a:pt x="2447561" y="549623"/>
                </a:lnTo>
                <a:lnTo>
                  <a:pt x="2447561" y="559582"/>
                </a:lnTo>
                <a:lnTo>
                  <a:pt x="2481509" y="559582"/>
                </a:lnTo>
                <a:lnTo>
                  <a:pt x="2481509" y="569559"/>
                </a:lnTo>
                <a:lnTo>
                  <a:pt x="2517647" y="569559"/>
                </a:lnTo>
                <a:lnTo>
                  <a:pt x="2517647" y="579741"/>
                </a:lnTo>
                <a:lnTo>
                  <a:pt x="2546120" y="579741"/>
                </a:lnTo>
                <a:lnTo>
                  <a:pt x="2546120" y="589955"/>
                </a:lnTo>
                <a:lnTo>
                  <a:pt x="2558166" y="589955"/>
                </a:lnTo>
                <a:lnTo>
                  <a:pt x="2558166" y="600174"/>
                </a:lnTo>
                <a:lnTo>
                  <a:pt x="2592115" y="600174"/>
                </a:lnTo>
                <a:lnTo>
                  <a:pt x="2592115" y="610433"/>
                </a:lnTo>
                <a:lnTo>
                  <a:pt x="2639204" y="610433"/>
                </a:lnTo>
                <a:lnTo>
                  <a:pt x="2639204" y="620706"/>
                </a:lnTo>
                <a:lnTo>
                  <a:pt x="2651250" y="620706"/>
                </a:lnTo>
                <a:lnTo>
                  <a:pt x="2651250" y="631039"/>
                </a:lnTo>
                <a:lnTo>
                  <a:pt x="2808946" y="631039"/>
                </a:lnTo>
                <a:lnTo>
                  <a:pt x="2808946" y="641486"/>
                </a:lnTo>
                <a:lnTo>
                  <a:pt x="2826467" y="641486"/>
                </a:lnTo>
                <a:lnTo>
                  <a:pt x="2826467" y="651937"/>
                </a:lnTo>
                <a:lnTo>
                  <a:pt x="2836323" y="651937"/>
                </a:lnTo>
                <a:lnTo>
                  <a:pt x="2836323" y="662394"/>
                </a:lnTo>
                <a:lnTo>
                  <a:pt x="2843989" y="662394"/>
                </a:lnTo>
                <a:lnTo>
                  <a:pt x="2843989" y="672903"/>
                </a:lnTo>
                <a:lnTo>
                  <a:pt x="2883413" y="672903"/>
                </a:lnTo>
                <a:lnTo>
                  <a:pt x="2883413" y="683413"/>
                </a:lnTo>
                <a:lnTo>
                  <a:pt x="2888888" y="683413"/>
                </a:lnTo>
                <a:lnTo>
                  <a:pt x="2888888" y="693941"/>
                </a:lnTo>
                <a:lnTo>
                  <a:pt x="2898744" y="693941"/>
                </a:lnTo>
                <a:lnTo>
                  <a:pt x="2898744" y="704502"/>
                </a:lnTo>
                <a:lnTo>
                  <a:pt x="2900934" y="704502"/>
                </a:lnTo>
                <a:lnTo>
                  <a:pt x="2900934" y="715066"/>
                </a:lnTo>
                <a:lnTo>
                  <a:pt x="2930502" y="715066"/>
                </a:lnTo>
                <a:lnTo>
                  <a:pt x="2930502" y="725645"/>
                </a:lnTo>
                <a:lnTo>
                  <a:pt x="2951309" y="725645"/>
                </a:lnTo>
                <a:lnTo>
                  <a:pt x="2951309" y="736238"/>
                </a:lnTo>
                <a:lnTo>
                  <a:pt x="2974307" y="736238"/>
                </a:lnTo>
                <a:lnTo>
                  <a:pt x="2974307" y="746834"/>
                </a:lnTo>
                <a:lnTo>
                  <a:pt x="2980877" y="746834"/>
                </a:lnTo>
                <a:lnTo>
                  <a:pt x="2980877" y="757431"/>
                </a:lnTo>
                <a:lnTo>
                  <a:pt x="3064105" y="757431"/>
                </a:lnTo>
                <a:lnTo>
                  <a:pt x="3064105" y="768188"/>
                </a:lnTo>
                <a:lnTo>
                  <a:pt x="3103529" y="768188"/>
                </a:lnTo>
                <a:lnTo>
                  <a:pt x="3103529" y="778946"/>
                </a:lnTo>
                <a:lnTo>
                  <a:pt x="3104624" y="778946"/>
                </a:lnTo>
                <a:lnTo>
                  <a:pt x="3104624" y="789726"/>
                </a:lnTo>
                <a:lnTo>
                  <a:pt x="3110100" y="789726"/>
                </a:lnTo>
                <a:lnTo>
                  <a:pt x="3110100" y="800514"/>
                </a:lnTo>
                <a:lnTo>
                  <a:pt x="3130907" y="800514"/>
                </a:lnTo>
                <a:lnTo>
                  <a:pt x="3130907" y="811315"/>
                </a:lnTo>
                <a:lnTo>
                  <a:pt x="3186757" y="811315"/>
                </a:lnTo>
                <a:lnTo>
                  <a:pt x="3186757" y="822138"/>
                </a:lnTo>
                <a:lnTo>
                  <a:pt x="3203184" y="822138"/>
                </a:lnTo>
                <a:lnTo>
                  <a:pt x="3203184" y="822138"/>
                </a:lnTo>
                <a:lnTo>
                  <a:pt x="3242607" y="822138"/>
                </a:lnTo>
                <a:lnTo>
                  <a:pt x="3242607" y="832981"/>
                </a:lnTo>
                <a:lnTo>
                  <a:pt x="3282031" y="832981"/>
                </a:lnTo>
                <a:lnTo>
                  <a:pt x="3282031" y="843853"/>
                </a:lnTo>
                <a:lnTo>
                  <a:pt x="3366354" y="843853"/>
                </a:lnTo>
                <a:lnTo>
                  <a:pt x="3366354" y="854800"/>
                </a:lnTo>
                <a:lnTo>
                  <a:pt x="3388257" y="854800"/>
                </a:lnTo>
                <a:lnTo>
                  <a:pt x="3388257" y="865758"/>
                </a:lnTo>
                <a:lnTo>
                  <a:pt x="3432061" y="865758"/>
                </a:lnTo>
                <a:lnTo>
                  <a:pt x="3432061" y="876726"/>
                </a:lnTo>
                <a:lnTo>
                  <a:pt x="3458343" y="876726"/>
                </a:lnTo>
                <a:lnTo>
                  <a:pt x="3458343" y="887714"/>
                </a:lnTo>
                <a:lnTo>
                  <a:pt x="3459438" y="887714"/>
                </a:lnTo>
                <a:lnTo>
                  <a:pt x="3459438" y="898776"/>
                </a:lnTo>
                <a:lnTo>
                  <a:pt x="3475865" y="898776"/>
                </a:lnTo>
                <a:lnTo>
                  <a:pt x="3475865" y="909850"/>
                </a:lnTo>
                <a:lnTo>
                  <a:pt x="3526240" y="909850"/>
                </a:lnTo>
                <a:lnTo>
                  <a:pt x="3526240" y="920944"/>
                </a:lnTo>
                <a:lnTo>
                  <a:pt x="3541571" y="920944"/>
                </a:lnTo>
                <a:lnTo>
                  <a:pt x="3541571" y="932042"/>
                </a:lnTo>
                <a:lnTo>
                  <a:pt x="3548142" y="932042"/>
                </a:lnTo>
                <a:lnTo>
                  <a:pt x="3548142" y="943146"/>
                </a:lnTo>
                <a:lnTo>
                  <a:pt x="3551427" y="943146"/>
                </a:lnTo>
                <a:lnTo>
                  <a:pt x="3551427" y="954292"/>
                </a:lnTo>
                <a:lnTo>
                  <a:pt x="3552522" y="954292"/>
                </a:lnTo>
                <a:lnTo>
                  <a:pt x="3552522" y="965518"/>
                </a:lnTo>
                <a:lnTo>
                  <a:pt x="3562378" y="965518"/>
                </a:lnTo>
                <a:lnTo>
                  <a:pt x="3562378" y="976761"/>
                </a:lnTo>
                <a:lnTo>
                  <a:pt x="3564569" y="976761"/>
                </a:lnTo>
                <a:lnTo>
                  <a:pt x="3564569" y="988007"/>
                </a:lnTo>
                <a:lnTo>
                  <a:pt x="3609468" y="988007"/>
                </a:lnTo>
                <a:lnTo>
                  <a:pt x="3609468" y="988007"/>
                </a:lnTo>
                <a:lnTo>
                  <a:pt x="3611658" y="988007"/>
                </a:lnTo>
                <a:lnTo>
                  <a:pt x="3611658" y="999279"/>
                </a:lnTo>
                <a:lnTo>
                  <a:pt x="3620419" y="999279"/>
                </a:lnTo>
                <a:lnTo>
                  <a:pt x="3620419" y="1010556"/>
                </a:lnTo>
                <a:lnTo>
                  <a:pt x="3630275" y="1010556"/>
                </a:lnTo>
                <a:lnTo>
                  <a:pt x="3630275" y="1010556"/>
                </a:lnTo>
                <a:lnTo>
                  <a:pt x="3636846" y="1010556"/>
                </a:lnTo>
                <a:lnTo>
                  <a:pt x="3636846" y="1010556"/>
                </a:lnTo>
                <a:lnTo>
                  <a:pt x="3637941" y="1010556"/>
                </a:lnTo>
                <a:lnTo>
                  <a:pt x="3637941" y="1021914"/>
                </a:lnTo>
                <a:lnTo>
                  <a:pt x="3655462" y="1021914"/>
                </a:lnTo>
                <a:lnTo>
                  <a:pt x="3655462" y="1044768"/>
                </a:lnTo>
                <a:lnTo>
                  <a:pt x="3660938" y="1044768"/>
                </a:lnTo>
                <a:lnTo>
                  <a:pt x="3660938" y="1067712"/>
                </a:lnTo>
                <a:lnTo>
                  <a:pt x="3701457" y="1067712"/>
                </a:lnTo>
                <a:lnTo>
                  <a:pt x="3701457" y="1079210"/>
                </a:lnTo>
                <a:lnTo>
                  <a:pt x="3703647" y="1079210"/>
                </a:lnTo>
                <a:lnTo>
                  <a:pt x="3703647" y="1090725"/>
                </a:lnTo>
                <a:lnTo>
                  <a:pt x="3758402" y="1090725"/>
                </a:lnTo>
                <a:lnTo>
                  <a:pt x="3758402" y="1102267"/>
                </a:lnTo>
                <a:lnTo>
                  <a:pt x="3770448" y="1102267"/>
                </a:lnTo>
                <a:lnTo>
                  <a:pt x="3770448" y="1113811"/>
                </a:lnTo>
                <a:lnTo>
                  <a:pt x="3783590" y="1113811"/>
                </a:lnTo>
                <a:lnTo>
                  <a:pt x="3783590" y="1125358"/>
                </a:lnTo>
                <a:lnTo>
                  <a:pt x="3792351" y="1125358"/>
                </a:lnTo>
                <a:lnTo>
                  <a:pt x="3792351" y="1136959"/>
                </a:lnTo>
                <a:lnTo>
                  <a:pt x="3809872" y="1136959"/>
                </a:lnTo>
                <a:lnTo>
                  <a:pt x="3809872" y="1148611"/>
                </a:lnTo>
                <a:lnTo>
                  <a:pt x="3817538" y="1148611"/>
                </a:lnTo>
                <a:lnTo>
                  <a:pt x="3817538" y="1160263"/>
                </a:lnTo>
                <a:lnTo>
                  <a:pt x="3828489" y="1160263"/>
                </a:lnTo>
                <a:lnTo>
                  <a:pt x="3828489" y="1171944"/>
                </a:lnTo>
                <a:lnTo>
                  <a:pt x="3836155" y="1171944"/>
                </a:lnTo>
                <a:lnTo>
                  <a:pt x="3836155" y="1183645"/>
                </a:lnTo>
                <a:lnTo>
                  <a:pt x="3861342" y="1183645"/>
                </a:lnTo>
                <a:lnTo>
                  <a:pt x="3861342" y="1195372"/>
                </a:lnTo>
                <a:lnTo>
                  <a:pt x="3896386" y="1195372"/>
                </a:lnTo>
                <a:lnTo>
                  <a:pt x="3896386" y="1207142"/>
                </a:lnTo>
                <a:lnTo>
                  <a:pt x="3906242" y="1207142"/>
                </a:lnTo>
                <a:lnTo>
                  <a:pt x="3906242" y="1218967"/>
                </a:lnTo>
                <a:lnTo>
                  <a:pt x="3912812" y="1218967"/>
                </a:lnTo>
                <a:lnTo>
                  <a:pt x="3912812" y="1242657"/>
                </a:lnTo>
                <a:lnTo>
                  <a:pt x="3913907" y="1242657"/>
                </a:lnTo>
                <a:lnTo>
                  <a:pt x="3913907" y="1254557"/>
                </a:lnTo>
                <a:lnTo>
                  <a:pt x="3915002" y="1254557"/>
                </a:lnTo>
                <a:lnTo>
                  <a:pt x="3915002" y="1254557"/>
                </a:lnTo>
                <a:lnTo>
                  <a:pt x="3923763" y="1254557"/>
                </a:lnTo>
                <a:lnTo>
                  <a:pt x="3923763" y="1266493"/>
                </a:lnTo>
                <a:lnTo>
                  <a:pt x="3930334" y="1266493"/>
                </a:lnTo>
                <a:lnTo>
                  <a:pt x="3930334" y="1278464"/>
                </a:lnTo>
                <a:lnTo>
                  <a:pt x="3931429" y="1278464"/>
                </a:lnTo>
                <a:lnTo>
                  <a:pt x="3931429" y="1290528"/>
                </a:lnTo>
                <a:lnTo>
                  <a:pt x="3939095" y="1290528"/>
                </a:lnTo>
                <a:lnTo>
                  <a:pt x="3939095" y="1302614"/>
                </a:lnTo>
                <a:lnTo>
                  <a:pt x="3944570" y="1302614"/>
                </a:lnTo>
                <a:lnTo>
                  <a:pt x="3944570" y="1314723"/>
                </a:lnTo>
                <a:lnTo>
                  <a:pt x="3947856" y="1314723"/>
                </a:lnTo>
                <a:lnTo>
                  <a:pt x="3947856" y="1326848"/>
                </a:lnTo>
                <a:lnTo>
                  <a:pt x="3953331" y="1326848"/>
                </a:lnTo>
                <a:lnTo>
                  <a:pt x="3953331" y="1338996"/>
                </a:lnTo>
                <a:lnTo>
                  <a:pt x="3954426" y="1338996"/>
                </a:lnTo>
                <a:lnTo>
                  <a:pt x="3954426" y="1351178"/>
                </a:lnTo>
                <a:lnTo>
                  <a:pt x="3956616" y="1351178"/>
                </a:lnTo>
                <a:lnTo>
                  <a:pt x="3956616" y="1363369"/>
                </a:lnTo>
                <a:lnTo>
                  <a:pt x="3980709" y="1363369"/>
                </a:lnTo>
                <a:lnTo>
                  <a:pt x="3980709" y="1375564"/>
                </a:lnTo>
                <a:lnTo>
                  <a:pt x="3986184" y="1375564"/>
                </a:lnTo>
                <a:lnTo>
                  <a:pt x="3986184" y="1387783"/>
                </a:lnTo>
                <a:lnTo>
                  <a:pt x="3987279" y="1387783"/>
                </a:lnTo>
                <a:lnTo>
                  <a:pt x="3987279" y="1387783"/>
                </a:lnTo>
                <a:lnTo>
                  <a:pt x="3993850" y="1387783"/>
                </a:lnTo>
                <a:lnTo>
                  <a:pt x="3993850" y="1400034"/>
                </a:lnTo>
                <a:lnTo>
                  <a:pt x="3994945" y="1400034"/>
                </a:lnTo>
                <a:lnTo>
                  <a:pt x="3994945" y="1412311"/>
                </a:lnTo>
                <a:lnTo>
                  <a:pt x="4016847" y="1412311"/>
                </a:lnTo>
                <a:lnTo>
                  <a:pt x="4016847" y="1424606"/>
                </a:lnTo>
                <a:lnTo>
                  <a:pt x="4054081" y="1424606"/>
                </a:lnTo>
                <a:lnTo>
                  <a:pt x="4054081" y="1436920"/>
                </a:lnTo>
                <a:lnTo>
                  <a:pt x="4068317" y="1436920"/>
                </a:lnTo>
                <a:lnTo>
                  <a:pt x="4068317" y="1449258"/>
                </a:lnTo>
                <a:lnTo>
                  <a:pt x="4072698" y="1449258"/>
                </a:lnTo>
                <a:lnTo>
                  <a:pt x="4072698" y="1449258"/>
                </a:lnTo>
                <a:lnTo>
                  <a:pt x="4077078" y="1449258"/>
                </a:lnTo>
                <a:lnTo>
                  <a:pt x="4077078" y="1461599"/>
                </a:lnTo>
                <a:lnTo>
                  <a:pt x="4095695" y="1461599"/>
                </a:lnTo>
                <a:lnTo>
                  <a:pt x="4095695" y="1461599"/>
                </a:lnTo>
                <a:lnTo>
                  <a:pt x="4111026" y="1461599"/>
                </a:lnTo>
                <a:lnTo>
                  <a:pt x="4111026" y="1474003"/>
                </a:lnTo>
                <a:lnTo>
                  <a:pt x="4245724" y="1474003"/>
                </a:lnTo>
                <a:lnTo>
                  <a:pt x="4245724" y="1486543"/>
                </a:lnTo>
                <a:lnTo>
                  <a:pt x="4269817" y="1486543"/>
                </a:lnTo>
                <a:lnTo>
                  <a:pt x="4269817" y="1499090"/>
                </a:lnTo>
                <a:lnTo>
                  <a:pt x="4304860" y="1499090"/>
                </a:lnTo>
                <a:lnTo>
                  <a:pt x="4304860" y="1511719"/>
                </a:lnTo>
                <a:lnTo>
                  <a:pt x="4318001" y="1511719"/>
                </a:lnTo>
                <a:lnTo>
                  <a:pt x="4318001" y="1524351"/>
                </a:lnTo>
                <a:lnTo>
                  <a:pt x="4334428" y="1524351"/>
                </a:lnTo>
                <a:lnTo>
                  <a:pt x="4334428" y="1536989"/>
                </a:lnTo>
                <a:lnTo>
                  <a:pt x="4354140" y="1536989"/>
                </a:lnTo>
                <a:lnTo>
                  <a:pt x="4354140" y="1549641"/>
                </a:lnTo>
                <a:lnTo>
                  <a:pt x="4358520" y="1549641"/>
                </a:lnTo>
                <a:lnTo>
                  <a:pt x="4358520" y="1562327"/>
                </a:lnTo>
                <a:lnTo>
                  <a:pt x="4383708" y="1562327"/>
                </a:lnTo>
                <a:lnTo>
                  <a:pt x="4383708" y="1575016"/>
                </a:lnTo>
                <a:lnTo>
                  <a:pt x="4393564" y="1575016"/>
                </a:lnTo>
                <a:lnTo>
                  <a:pt x="4393564" y="1587707"/>
                </a:lnTo>
                <a:lnTo>
                  <a:pt x="4396849" y="1587707"/>
                </a:lnTo>
                <a:lnTo>
                  <a:pt x="4396849" y="1600426"/>
                </a:lnTo>
                <a:lnTo>
                  <a:pt x="4429702" y="1600426"/>
                </a:lnTo>
                <a:lnTo>
                  <a:pt x="4429702" y="1613188"/>
                </a:lnTo>
                <a:lnTo>
                  <a:pt x="4432987" y="1613188"/>
                </a:lnTo>
                <a:lnTo>
                  <a:pt x="4432987" y="1625966"/>
                </a:lnTo>
                <a:lnTo>
                  <a:pt x="4437368" y="1625966"/>
                </a:lnTo>
                <a:lnTo>
                  <a:pt x="4437368" y="1638799"/>
                </a:lnTo>
                <a:lnTo>
                  <a:pt x="4460365" y="1638799"/>
                </a:lnTo>
                <a:lnTo>
                  <a:pt x="4460365" y="1651643"/>
                </a:lnTo>
                <a:lnTo>
                  <a:pt x="4504169" y="1651643"/>
                </a:lnTo>
                <a:lnTo>
                  <a:pt x="4504169" y="1664506"/>
                </a:lnTo>
                <a:lnTo>
                  <a:pt x="4507455" y="1664506"/>
                </a:lnTo>
                <a:lnTo>
                  <a:pt x="4507455" y="1677414"/>
                </a:lnTo>
                <a:lnTo>
                  <a:pt x="4510740" y="1677414"/>
                </a:lnTo>
                <a:lnTo>
                  <a:pt x="4510740" y="1690341"/>
                </a:lnTo>
                <a:lnTo>
                  <a:pt x="4568780" y="1690341"/>
                </a:lnTo>
                <a:lnTo>
                  <a:pt x="4568780" y="1703301"/>
                </a:lnTo>
                <a:lnTo>
                  <a:pt x="4589587" y="1703301"/>
                </a:lnTo>
                <a:lnTo>
                  <a:pt x="4589587" y="1716358"/>
                </a:lnTo>
                <a:lnTo>
                  <a:pt x="4607109" y="1716358"/>
                </a:lnTo>
                <a:lnTo>
                  <a:pt x="4607109" y="1729449"/>
                </a:lnTo>
                <a:lnTo>
                  <a:pt x="4609299" y="1729449"/>
                </a:lnTo>
                <a:lnTo>
                  <a:pt x="4609299" y="1742548"/>
                </a:lnTo>
                <a:lnTo>
                  <a:pt x="4624631" y="1742548"/>
                </a:lnTo>
                <a:lnTo>
                  <a:pt x="4624631" y="1768868"/>
                </a:lnTo>
                <a:lnTo>
                  <a:pt x="4639962" y="1768868"/>
                </a:lnTo>
                <a:lnTo>
                  <a:pt x="4639962" y="1782038"/>
                </a:lnTo>
                <a:lnTo>
                  <a:pt x="4647628" y="1782038"/>
                </a:lnTo>
                <a:lnTo>
                  <a:pt x="4647628" y="1782038"/>
                </a:lnTo>
                <a:lnTo>
                  <a:pt x="4653104" y="1782038"/>
                </a:lnTo>
                <a:lnTo>
                  <a:pt x="4653104" y="1795280"/>
                </a:lnTo>
                <a:lnTo>
                  <a:pt x="4679386" y="1795280"/>
                </a:lnTo>
                <a:lnTo>
                  <a:pt x="4679386" y="1795280"/>
                </a:lnTo>
                <a:lnTo>
                  <a:pt x="4701288" y="1795280"/>
                </a:lnTo>
                <a:lnTo>
                  <a:pt x="4701288" y="1808565"/>
                </a:lnTo>
                <a:lnTo>
                  <a:pt x="4727571" y="1808565"/>
                </a:lnTo>
                <a:lnTo>
                  <a:pt x="4727571" y="1821864"/>
                </a:lnTo>
                <a:lnTo>
                  <a:pt x="4754948" y="1821864"/>
                </a:lnTo>
                <a:lnTo>
                  <a:pt x="4754948" y="1835241"/>
                </a:lnTo>
                <a:lnTo>
                  <a:pt x="4759329" y="1835241"/>
                </a:lnTo>
                <a:lnTo>
                  <a:pt x="4759329" y="1848628"/>
                </a:lnTo>
                <a:lnTo>
                  <a:pt x="4768090" y="1848628"/>
                </a:lnTo>
                <a:lnTo>
                  <a:pt x="4768090" y="1862033"/>
                </a:lnTo>
                <a:lnTo>
                  <a:pt x="4769185" y="1862033"/>
                </a:lnTo>
                <a:lnTo>
                  <a:pt x="4769185" y="1875498"/>
                </a:lnTo>
                <a:lnTo>
                  <a:pt x="4771375" y="1875498"/>
                </a:lnTo>
                <a:lnTo>
                  <a:pt x="4771375" y="1888989"/>
                </a:lnTo>
                <a:lnTo>
                  <a:pt x="4774660" y="1888989"/>
                </a:lnTo>
                <a:lnTo>
                  <a:pt x="4774660" y="1902498"/>
                </a:lnTo>
                <a:lnTo>
                  <a:pt x="4784516" y="1902498"/>
                </a:lnTo>
                <a:lnTo>
                  <a:pt x="4784516" y="1916022"/>
                </a:lnTo>
                <a:lnTo>
                  <a:pt x="4786706" y="1916022"/>
                </a:lnTo>
                <a:lnTo>
                  <a:pt x="4786706" y="1929569"/>
                </a:lnTo>
                <a:lnTo>
                  <a:pt x="4803133" y="1929569"/>
                </a:lnTo>
                <a:lnTo>
                  <a:pt x="4803133" y="1943168"/>
                </a:lnTo>
                <a:lnTo>
                  <a:pt x="4809704" y="1943168"/>
                </a:lnTo>
                <a:lnTo>
                  <a:pt x="4809704" y="1956775"/>
                </a:lnTo>
                <a:lnTo>
                  <a:pt x="4821750" y="1956775"/>
                </a:lnTo>
                <a:lnTo>
                  <a:pt x="4821750" y="1970404"/>
                </a:lnTo>
                <a:lnTo>
                  <a:pt x="4829416" y="1970404"/>
                </a:lnTo>
                <a:lnTo>
                  <a:pt x="4829416" y="1970404"/>
                </a:lnTo>
                <a:lnTo>
                  <a:pt x="4831606" y="1970404"/>
                </a:lnTo>
                <a:lnTo>
                  <a:pt x="4831606" y="1970404"/>
                </a:lnTo>
                <a:lnTo>
                  <a:pt x="4838176" y="1970404"/>
                </a:lnTo>
                <a:lnTo>
                  <a:pt x="4838176" y="1984057"/>
                </a:lnTo>
                <a:lnTo>
                  <a:pt x="4842557" y="1984057"/>
                </a:lnTo>
                <a:lnTo>
                  <a:pt x="4842557" y="1997753"/>
                </a:lnTo>
                <a:lnTo>
                  <a:pt x="4845842" y="1997753"/>
                </a:lnTo>
                <a:lnTo>
                  <a:pt x="4845842" y="2011466"/>
                </a:lnTo>
                <a:lnTo>
                  <a:pt x="4849128" y="2011466"/>
                </a:lnTo>
                <a:lnTo>
                  <a:pt x="4849128" y="2025314"/>
                </a:lnTo>
                <a:lnTo>
                  <a:pt x="4875410" y="2025314"/>
                </a:lnTo>
                <a:lnTo>
                  <a:pt x="4875410" y="2039170"/>
                </a:lnTo>
                <a:lnTo>
                  <a:pt x="4912644" y="2039170"/>
                </a:lnTo>
                <a:lnTo>
                  <a:pt x="4912644" y="2053133"/>
                </a:lnTo>
                <a:lnTo>
                  <a:pt x="4942211" y="2053133"/>
                </a:lnTo>
                <a:lnTo>
                  <a:pt x="4942211" y="2067158"/>
                </a:lnTo>
                <a:lnTo>
                  <a:pt x="4959733" y="2067158"/>
                </a:lnTo>
                <a:lnTo>
                  <a:pt x="4959733" y="2081218"/>
                </a:lnTo>
                <a:lnTo>
                  <a:pt x="4970684" y="2081218"/>
                </a:lnTo>
                <a:lnTo>
                  <a:pt x="4970684" y="2095309"/>
                </a:lnTo>
                <a:lnTo>
                  <a:pt x="4996967" y="2095309"/>
                </a:lnTo>
                <a:lnTo>
                  <a:pt x="4996967" y="2095309"/>
                </a:lnTo>
                <a:lnTo>
                  <a:pt x="5013393" y="2095309"/>
                </a:lnTo>
                <a:lnTo>
                  <a:pt x="5013393" y="2109420"/>
                </a:lnTo>
                <a:lnTo>
                  <a:pt x="5030915" y="2109420"/>
                </a:lnTo>
                <a:lnTo>
                  <a:pt x="5030915" y="2123537"/>
                </a:lnTo>
                <a:lnTo>
                  <a:pt x="5044056" y="2123537"/>
                </a:lnTo>
                <a:lnTo>
                  <a:pt x="5044056" y="2137678"/>
                </a:lnTo>
                <a:lnTo>
                  <a:pt x="5053912" y="2137678"/>
                </a:lnTo>
                <a:lnTo>
                  <a:pt x="5053912" y="2151849"/>
                </a:lnTo>
                <a:lnTo>
                  <a:pt x="5057198" y="2151849"/>
                </a:lnTo>
                <a:lnTo>
                  <a:pt x="5057198" y="2166038"/>
                </a:lnTo>
                <a:lnTo>
                  <a:pt x="5094431" y="2166038"/>
                </a:lnTo>
                <a:lnTo>
                  <a:pt x="5094431" y="2180233"/>
                </a:lnTo>
                <a:lnTo>
                  <a:pt x="5097716" y="2180233"/>
                </a:lnTo>
                <a:lnTo>
                  <a:pt x="5097716" y="2180233"/>
                </a:lnTo>
                <a:lnTo>
                  <a:pt x="5109763" y="2180233"/>
                </a:lnTo>
                <a:lnTo>
                  <a:pt x="5109763" y="2194498"/>
                </a:lnTo>
                <a:lnTo>
                  <a:pt x="5113048" y="2194498"/>
                </a:lnTo>
                <a:lnTo>
                  <a:pt x="5113048" y="2208806"/>
                </a:lnTo>
                <a:lnTo>
                  <a:pt x="5125094" y="2208806"/>
                </a:lnTo>
                <a:lnTo>
                  <a:pt x="5125094" y="2223165"/>
                </a:lnTo>
                <a:lnTo>
                  <a:pt x="5137140" y="2223165"/>
                </a:lnTo>
                <a:lnTo>
                  <a:pt x="5137140" y="2237550"/>
                </a:lnTo>
                <a:lnTo>
                  <a:pt x="5165613" y="2237550"/>
                </a:lnTo>
                <a:lnTo>
                  <a:pt x="5165613" y="2251979"/>
                </a:lnTo>
                <a:lnTo>
                  <a:pt x="5169993" y="2251979"/>
                </a:lnTo>
                <a:lnTo>
                  <a:pt x="5169993" y="2266414"/>
                </a:lnTo>
                <a:lnTo>
                  <a:pt x="5173279" y="2266414"/>
                </a:lnTo>
                <a:lnTo>
                  <a:pt x="5173279" y="2280898"/>
                </a:lnTo>
                <a:lnTo>
                  <a:pt x="5177659" y="2280898"/>
                </a:lnTo>
                <a:lnTo>
                  <a:pt x="5177659" y="2280898"/>
                </a:lnTo>
                <a:lnTo>
                  <a:pt x="5210512" y="2280898"/>
                </a:lnTo>
                <a:lnTo>
                  <a:pt x="5210512" y="2295411"/>
                </a:lnTo>
                <a:lnTo>
                  <a:pt x="5219273" y="2295411"/>
                </a:lnTo>
                <a:lnTo>
                  <a:pt x="5219273" y="2309998"/>
                </a:lnTo>
                <a:lnTo>
                  <a:pt x="5258697" y="2309998"/>
                </a:lnTo>
                <a:lnTo>
                  <a:pt x="5258697" y="2309998"/>
                </a:lnTo>
                <a:lnTo>
                  <a:pt x="5264173" y="2309998"/>
                </a:lnTo>
                <a:lnTo>
                  <a:pt x="5264173" y="2324611"/>
                </a:lnTo>
                <a:lnTo>
                  <a:pt x="5282789" y="2324611"/>
                </a:lnTo>
                <a:lnTo>
                  <a:pt x="5282789" y="2339249"/>
                </a:lnTo>
                <a:lnTo>
                  <a:pt x="5286075" y="2339249"/>
                </a:lnTo>
                <a:lnTo>
                  <a:pt x="5286075" y="2353914"/>
                </a:lnTo>
                <a:lnTo>
                  <a:pt x="5293740" y="2353914"/>
                </a:lnTo>
                <a:lnTo>
                  <a:pt x="5293740" y="2353914"/>
                </a:lnTo>
                <a:lnTo>
                  <a:pt x="5297026" y="2353914"/>
                </a:lnTo>
                <a:lnTo>
                  <a:pt x="5297026" y="2368612"/>
                </a:lnTo>
                <a:lnTo>
                  <a:pt x="5300311" y="2368612"/>
                </a:lnTo>
                <a:lnTo>
                  <a:pt x="5300311" y="2383340"/>
                </a:lnTo>
                <a:lnTo>
                  <a:pt x="5323308" y="2383340"/>
                </a:lnTo>
                <a:lnTo>
                  <a:pt x="5323308" y="2398130"/>
                </a:lnTo>
                <a:lnTo>
                  <a:pt x="5345210" y="2398130"/>
                </a:lnTo>
                <a:lnTo>
                  <a:pt x="5345210" y="2412973"/>
                </a:lnTo>
                <a:lnTo>
                  <a:pt x="5357257" y="2412973"/>
                </a:lnTo>
                <a:lnTo>
                  <a:pt x="5357257" y="2427826"/>
                </a:lnTo>
                <a:lnTo>
                  <a:pt x="5362732" y="2427826"/>
                </a:lnTo>
                <a:lnTo>
                  <a:pt x="5362732" y="2442808"/>
                </a:lnTo>
                <a:lnTo>
                  <a:pt x="5403251" y="2442808"/>
                </a:lnTo>
                <a:lnTo>
                  <a:pt x="5403251" y="2457902"/>
                </a:lnTo>
                <a:lnTo>
                  <a:pt x="5426248" y="2457902"/>
                </a:lnTo>
                <a:lnTo>
                  <a:pt x="5426248" y="2473042"/>
                </a:lnTo>
                <a:lnTo>
                  <a:pt x="5429534" y="2473042"/>
                </a:lnTo>
                <a:lnTo>
                  <a:pt x="5429534" y="2488250"/>
                </a:lnTo>
                <a:lnTo>
                  <a:pt x="5459101" y="2488250"/>
                </a:lnTo>
                <a:lnTo>
                  <a:pt x="5459101" y="2503468"/>
                </a:lnTo>
                <a:lnTo>
                  <a:pt x="5464577" y="2503468"/>
                </a:lnTo>
                <a:lnTo>
                  <a:pt x="5464577" y="2518713"/>
                </a:lnTo>
                <a:lnTo>
                  <a:pt x="5475528" y="2518713"/>
                </a:lnTo>
                <a:lnTo>
                  <a:pt x="5475528" y="2533997"/>
                </a:lnTo>
                <a:lnTo>
                  <a:pt x="5491955" y="2533997"/>
                </a:lnTo>
                <a:lnTo>
                  <a:pt x="5491955" y="2549356"/>
                </a:lnTo>
                <a:lnTo>
                  <a:pt x="5497430" y="2549356"/>
                </a:lnTo>
                <a:lnTo>
                  <a:pt x="5497430" y="2564774"/>
                </a:lnTo>
                <a:lnTo>
                  <a:pt x="5498525" y="2564774"/>
                </a:lnTo>
                <a:lnTo>
                  <a:pt x="5498525" y="2580289"/>
                </a:lnTo>
                <a:lnTo>
                  <a:pt x="5504001" y="2580289"/>
                </a:lnTo>
                <a:lnTo>
                  <a:pt x="5504001" y="2595850"/>
                </a:lnTo>
                <a:lnTo>
                  <a:pt x="5521522" y="2595850"/>
                </a:lnTo>
                <a:lnTo>
                  <a:pt x="5521522" y="2611445"/>
                </a:lnTo>
                <a:lnTo>
                  <a:pt x="5522618" y="2611445"/>
                </a:lnTo>
                <a:lnTo>
                  <a:pt x="5522618" y="2627070"/>
                </a:lnTo>
                <a:lnTo>
                  <a:pt x="5528093" y="2627070"/>
                </a:lnTo>
                <a:lnTo>
                  <a:pt x="5528093" y="2642718"/>
                </a:lnTo>
                <a:lnTo>
                  <a:pt x="5591609" y="2642718"/>
                </a:lnTo>
                <a:lnTo>
                  <a:pt x="5591609" y="2658392"/>
                </a:lnTo>
                <a:lnTo>
                  <a:pt x="5603655" y="2658392"/>
                </a:lnTo>
                <a:lnTo>
                  <a:pt x="5603655" y="2674078"/>
                </a:lnTo>
                <a:lnTo>
                  <a:pt x="5634318" y="2674078"/>
                </a:lnTo>
                <a:lnTo>
                  <a:pt x="5634318" y="2689808"/>
                </a:lnTo>
                <a:lnTo>
                  <a:pt x="5637604" y="2689808"/>
                </a:lnTo>
                <a:lnTo>
                  <a:pt x="5637604" y="2689808"/>
                </a:lnTo>
                <a:lnTo>
                  <a:pt x="5656220" y="2689808"/>
                </a:lnTo>
                <a:lnTo>
                  <a:pt x="5656220" y="2705629"/>
                </a:lnTo>
                <a:lnTo>
                  <a:pt x="5657316" y="2705629"/>
                </a:lnTo>
                <a:lnTo>
                  <a:pt x="5657316" y="2721473"/>
                </a:lnTo>
                <a:lnTo>
                  <a:pt x="5667171" y="2721473"/>
                </a:lnTo>
                <a:lnTo>
                  <a:pt x="5667171" y="2737332"/>
                </a:lnTo>
                <a:lnTo>
                  <a:pt x="5696739" y="2737332"/>
                </a:lnTo>
                <a:lnTo>
                  <a:pt x="5696739" y="2753209"/>
                </a:lnTo>
                <a:lnTo>
                  <a:pt x="5709881" y="2753209"/>
                </a:lnTo>
                <a:lnTo>
                  <a:pt x="5709881" y="2769124"/>
                </a:lnTo>
                <a:lnTo>
                  <a:pt x="5758065" y="2769124"/>
                </a:lnTo>
                <a:lnTo>
                  <a:pt x="5758065" y="2785042"/>
                </a:lnTo>
                <a:lnTo>
                  <a:pt x="5781062" y="2785042"/>
                </a:lnTo>
                <a:lnTo>
                  <a:pt x="5781062" y="2801038"/>
                </a:lnTo>
                <a:lnTo>
                  <a:pt x="5784348" y="2801038"/>
                </a:lnTo>
                <a:lnTo>
                  <a:pt x="5784348" y="2801038"/>
                </a:lnTo>
                <a:lnTo>
                  <a:pt x="5821581" y="2801038"/>
                </a:lnTo>
                <a:lnTo>
                  <a:pt x="5821581" y="2817089"/>
                </a:lnTo>
                <a:lnTo>
                  <a:pt x="5827057" y="2817089"/>
                </a:lnTo>
                <a:lnTo>
                  <a:pt x="5827057" y="2833161"/>
                </a:lnTo>
                <a:lnTo>
                  <a:pt x="5828152" y="2833161"/>
                </a:lnTo>
                <a:lnTo>
                  <a:pt x="5828152" y="2849261"/>
                </a:lnTo>
                <a:lnTo>
                  <a:pt x="5836913" y="2849261"/>
                </a:lnTo>
                <a:lnTo>
                  <a:pt x="5836913" y="2865377"/>
                </a:lnTo>
                <a:lnTo>
                  <a:pt x="5850054" y="2865377"/>
                </a:lnTo>
                <a:lnTo>
                  <a:pt x="5850054" y="2881508"/>
                </a:lnTo>
                <a:lnTo>
                  <a:pt x="5855530" y="2881508"/>
                </a:lnTo>
                <a:lnTo>
                  <a:pt x="5855530" y="2897767"/>
                </a:lnTo>
                <a:lnTo>
                  <a:pt x="5859910" y="2897767"/>
                </a:lnTo>
                <a:lnTo>
                  <a:pt x="5859910" y="2914046"/>
                </a:lnTo>
                <a:lnTo>
                  <a:pt x="5865386" y="2914046"/>
                </a:lnTo>
                <a:lnTo>
                  <a:pt x="5865386" y="2930351"/>
                </a:lnTo>
                <a:lnTo>
                  <a:pt x="5869766" y="2930351"/>
                </a:lnTo>
                <a:lnTo>
                  <a:pt x="5869766" y="2946665"/>
                </a:lnTo>
                <a:lnTo>
                  <a:pt x="5870861" y="2946665"/>
                </a:lnTo>
                <a:lnTo>
                  <a:pt x="5870861" y="2979317"/>
                </a:lnTo>
                <a:lnTo>
                  <a:pt x="5878527" y="2979317"/>
                </a:lnTo>
                <a:lnTo>
                  <a:pt x="5878527" y="2995674"/>
                </a:lnTo>
                <a:lnTo>
                  <a:pt x="5891668" y="2995674"/>
                </a:lnTo>
                <a:lnTo>
                  <a:pt x="5891668" y="3012074"/>
                </a:lnTo>
                <a:lnTo>
                  <a:pt x="5898239" y="3012074"/>
                </a:lnTo>
                <a:lnTo>
                  <a:pt x="5898239" y="3028547"/>
                </a:lnTo>
                <a:lnTo>
                  <a:pt x="5916856" y="3028547"/>
                </a:lnTo>
                <a:lnTo>
                  <a:pt x="5916856" y="3045057"/>
                </a:lnTo>
                <a:lnTo>
                  <a:pt x="5942043" y="3045057"/>
                </a:lnTo>
                <a:lnTo>
                  <a:pt x="5942043" y="3061581"/>
                </a:lnTo>
                <a:lnTo>
                  <a:pt x="5954089" y="3061581"/>
                </a:lnTo>
                <a:lnTo>
                  <a:pt x="5954089" y="3078147"/>
                </a:lnTo>
                <a:lnTo>
                  <a:pt x="5957374" y="3078147"/>
                </a:lnTo>
                <a:lnTo>
                  <a:pt x="5957374" y="3094772"/>
                </a:lnTo>
                <a:lnTo>
                  <a:pt x="5980372" y="3094772"/>
                </a:lnTo>
                <a:lnTo>
                  <a:pt x="5980372" y="3111452"/>
                </a:lnTo>
                <a:lnTo>
                  <a:pt x="5982562" y="3111452"/>
                </a:lnTo>
                <a:lnTo>
                  <a:pt x="5982562" y="3128179"/>
                </a:lnTo>
                <a:lnTo>
                  <a:pt x="5996798" y="3128179"/>
                </a:lnTo>
                <a:lnTo>
                  <a:pt x="5996798" y="3144911"/>
                </a:lnTo>
                <a:lnTo>
                  <a:pt x="6001179" y="3144911"/>
                </a:lnTo>
                <a:lnTo>
                  <a:pt x="6001179" y="3161658"/>
                </a:lnTo>
                <a:lnTo>
                  <a:pt x="6006654" y="3161658"/>
                </a:lnTo>
                <a:lnTo>
                  <a:pt x="6006654" y="3178443"/>
                </a:lnTo>
                <a:lnTo>
                  <a:pt x="6028556" y="3178443"/>
                </a:lnTo>
                <a:lnTo>
                  <a:pt x="6028556" y="3178443"/>
                </a:lnTo>
                <a:lnTo>
                  <a:pt x="6038412" y="3178443"/>
                </a:lnTo>
                <a:lnTo>
                  <a:pt x="6038412" y="3195257"/>
                </a:lnTo>
                <a:lnTo>
                  <a:pt x="6040602" y="3195257"/>
                </a:lnTo>
                <a:lnTo>
                  <a:pt x="6040602" y="3212102"/>
                </a:lnTo>
                <a:lnTo>
                  <a:pt x="6044983" y="3212102"/>
                </a:lnTo>
                <a:lnTo>
                  <a:pt x="6044983" y="3228994"/>
                </a:lnTo>
                <a:lnTo>
                  <a:pt x="6089882" y="3228994"/>
                </a:lnTo>
                <a:lnTo>
                  <a:pt x="6089882" y="3245927"/>
                </a:lnTo>
                <a:lnTo>
                  <a:pt x="6104119" y="3245927"/>
                </a:lnTo>
                <a:lnTo>
                  <a:pt x="6104119" y="3262862"/>
                </a:lnTo>
                <a:lnTo>
                  <a:pt x="6121640" y="3262862"/>
                </a:lnTo>
                <a:lnTo>
                  <a:pt x="6121640" y="3279823"/>
                </a:lnTo>
                <a:lnTo>
                  <a:pt x="6161064" y="3279823"/>
                </a:lnTo>
                <a:lnTo>
                  <a:pt x="6161064" y="3296840"/>
                </a:lnTo>
                <a:lnTo>
                  <a:pt x="6164349" y="3296840"/>
                </a:lnTo>
                <a:lnTo>
                  <a:pt x="6164349" y="3313896"/>
                </a:lnTo>
                <a:lnTo>
                  <a:pt x="6166540" y="3313896"/>
                </a:lnTo>
                <a:lnTo>
                  <a:pt x="6166540" y="3330995"/>
                </a:lnTo>
                <a:lnTo>
                  <a:pt x="6170920" y="3330995"/>
                </a:lnTo>
                <a:lnTo>
                  <a:pt x="6170920" y="3348147"/>
                </a:lnTo>
                <a:lnTo>
                  <a:pt x="6235531" y="3348147"/>
                </a:lnTo>
                <a:lnTo>
                  <a:pt x="6235531" y="3365312"/>
                </a:lnTo>
                <a:lnTo>
                  <a:pt x="6239912" y="3365312"/>
                </a:lnTo>
                <a:lnTo>
                  <a:pt x="6239912" y="3382529"/>
                </a:lnTo>
                <a:lnTo>
                  <a:pt x="6259624" y="3382529"/>
                </a:lnTo>
                <a:lnTo>
                  <a:pt x="6259624" y="3399920"/>
                </a:lnTo>
                <a:lnTo>
                  <a:pt x="6270575" y="3399920"/>
                </a:lnTo>
                <a:lnTo>
                  <a:pt x="6270575" y="3417343"/>
                </a:lnTo>
                <a:lnTo>
                  <a:pt x="6272765" y="3417343"/>
                </a:lnTo>
                <a:lnTo>
                  <a:pt x="6272765" y="3434822"/>
                </a:lnTo>
                <a:lnTo>
                  <a:pt x="6285906" y="3434822"/>
                </a:lnTo>
                <a:lnTo>
                  <a:pt x="6285906" y="3452384"/>
                </a:lnTo>
                <a:lnTo>
                  <a:pt x="6288096" y="3452384"/>
                </a:lnTo>
                <a:lnTo>
                  <a:pt x="6288096" y="3469962"/>
                </a:lnTo>
                <a:lnTo>
                  <a:pt x="6308903" y="3469962"/>
                </a:lnTo>
                <a:lnTo>
                  <a:pt x="6308903" y="3487627"/>
                </a:lnTo>
                <a:lnTo>
                  <a:pt x="6316569" y="3487627"/>
                </a:lnTo>
                <a:lnTo>
                  <a:pt x="6316569" y="3505316"/>
                </a:lnTo>
                <a:lnTo>
                  <a:pt x="6331901" y="3505316"/>
                </a:lnTo>
                <a:lnTo>
                  <a:pt x="6331901" y="3523010"/>
                </a:lnTo>
                <a:lnTo>
                  <a:pt x="6339566" y="3523010"/>
                </a:lnTo>
                <a:lnTo>
                  <a:pt x="6339566" y="3540710"/>
                </a:lnTo>
                <a:lnTo>
                  <a:pt x="6342852" y="3540710"/>
                </a:lnTo>
                <a:lnTo>
                  <a:pt x="6342852" y="3558431"/>
                </a:lnTo>
                <a:lnTo>
                  <a:pt x="6346137" y="3558431"/>
                </a:lnTo>
                <a:lnTo>
                  <a:pt x="6346137" y="3576193"/>
                </a:lnTo>
                <a:lnTo>
                  <a:pt x="6358183" y="3576193"/>
                </a:lnTo>
                <a:lnTo>
                  <a:pt x="6358183" y="3593961"/>
                </a:lnTo>
                <a:lnTo>
                  <a:pt x="6384466" y="3593961"/>
                </a:lnTo>
                <a:lnTo>
                  <a:pt x="6384466" y="3629634"/>
                </a:lnTo>
                <a:lnTo>
                  <a:pt x="6391036" y="3629634"/>
                </a:lnTo>
                <a:lnTo>
                  <a:pt x="6391036" y="3647613"/>
                </a:lnTo>
                <a:lnTo>
                  <a:pt x="6397607" y="3647613"/>
                </a:lnTo>
                <a:lnTo>
                  <a:pt x="6397607" y="3665633"/>
                </a:lnTo>
                <a:lnTo>
                  <a:pt x="6412938" y="3665633"/>
                </a:lnTo>
                <a:lnTo>
                  <a:pt x="6412938" y="3683670"/>
                </a:lnTo>
                <a:lnTo>
                  <a:pt x="6426080" y="3683670"/>
                </a:lnTo>
                <a:lnTo>
                  <a:pt x="6426080" y="3701807"/>
                </a:lnTo>
                <a:lnTo>
                  <a:pt x="6427175" y="3701807"/>
                </a:lnTo>
                <a:lnTo>
                  <a:pt x="6427175" y="3719959"/>
                </a:lnTo>
                <a:lnTo>
                  <a:pt x="6430460" y="3719959"/>
                </a:lnTo>
                <a:lnTo>
                  <a:pt x="6430460" y="3738185"/>
                </a:lnTo>
                <a:lnTo>
                  <a:pt x="6442506" y="3738185"/>
                </a:lnTo>
                <a:lnTo>
                  <a:pt x="6442506" y="3756433"/>
                </a:lnTo>
                <a:lnTo>
                  <a:pt x="6445792" y="3756433"/>
                </a:lnTo>
                <a:lnTo>
                  <a:pt x="6445792" y="3774691"/>
                </a:lnTo>
                <a:lnTo>
                  <a:pt x="6446887" y="3774691"/>
                </a:lnTo>
                <a:lnTo>
                  <a:pt x="6446887" y="3792988"/>
                </a:lnTo>
                <a:lnTo>
                  <a:pt x="6450172" y="3792988"/>
                </a:lnTo>
                <a:lnTo>
                  <a:pt x="6450172" y="3811366"/>
                </a:lnTo>
                <a:lnTo>
                  <a:pt x="6452362" y="3811366"/>
                </a:lnTo>
                <a:lnTo>
                  <a:pt x="6452362" y="3811366"/>
                </a:lnTo>
                <a:lnTo>
                  <a:pt x="6456743" y="3811366"/>
                </a:lnTo>
                <a:lnTo>
                  <a:pt x="6456743" y="3829761"/>
                </a:lnTo>
                <a:lnTo>
                  <a:pt x="6463313" y="3829761"/>
                </a:lnTo>
                <a:lnTo>
                  <a:pt x="6463313" y="3848164"/>
                </a:lnTo>
                <a:lnTo>
                  <a:pt x="6466599" y="3848164"/>
                </a:lnTo>
                <a:lnTo>
                  <a:pt x="6466599" y="3866701"/>
                </a:lnTo>
                <a:lnTo>
                  <a:pt x="6475359" y="3866701"/>
                </a:lnTo>
                <a:lnTo>
                  <a:pt x="6475359" y="3885240"/>
                </a:lnTo>
                <a:lnTo>
                  <a:pt x="6495071" y="3885240"/>
                </a:lnTo>
                <a:lnTo>
                  <a:pt x="6495071" y="3903831"/>
                </a:lnTo>
                <a:lnTo>
                  <a:pt x="6496166" y="3903831"/>
                </a:lnTo>
                <a:lnTo>
                  <a:pt x="6496166" y="3922571"/>
                </a:lnTo>
                <a:lnTo>
                  <a:pt x="6497262" y="3922571"/>
                </a:lnTo>
                <a:lnTo>
                  <a:pt x="6497262" y="3941395"/>
                </a:lnTo>
                <a:lnTo>
                  <a:pt x="6523544" y="3941395"/>
                </a:lnTo>
                <a:lnTo>
                  <a:pt x="6523544" y="3960239"/>
                </a:lnTo>
                <a:lnTo>
                  <a:pt x="6525734" y="3960239"/>
                </a:lnTo>
                <a:lnTo>
                  <a:pt x="6525734" y="3979214"/>
                </a:lnTo>
                <a:lnTo>
                  <a:pt x="6570634" y="3979214"/>
                </a:lnTo>
                <a:lnTo>
                  <a:pt x="6570634" y="4017198"/>
                </a:lnTo>
                <a:lnTo>
                  <a:pt x="6589250" y="4017198"/>
                </a:lnTo>
                <a:lnTo>
                  <a:pt x="6589250" y="4036229"/>
                </a:lnTo>
                <a:lnTo>
                  <a:pt x="6616628" y="4036229"/>
                </a:lnTo>
                <a:lnTo>
                  <a:pt x="6616628" y="4055296"/>
                </a:lnTo>
                <a:lnTo>
                  <a:pt x="6648386" y="4055296"/>
                </a:lnTo>
                <a:lnTo>
                  <a:pt x="6648386" y="4074383"/>
                </a:lnTo>
                <a:lnTo>
                  <a:pt x="6658242" y="4074383"/>
                </a:lnTo>
                <a:lnTo>
                  <a:pt x="6658242" y="4093535"/>
                </a:lnTo>
                <a:lnTo>
                  <a:pt x="6675764" y="4093535"/>
                </a:lnTo>
                <a:lnTo>
                  <a:pt x="6675764" y="4112697"/>
                </a:lnTo>
                <a:lnTo>
                  <a:pt x="6695476" y="4112697"/>
                </a:lnTo>
                <a:lnTo>
                  <a:pt x="6695476" y="4131889"/>
                </a:lnTo>
                <a:lnTo>
                  <a:pt x="6696571" y="4131889"/>
                </a:lnTo>
                <a:lnTo>
                  <a:pt x="6696571" y="4151171"/>
                </a:lnTo>
                <a:lnTo>
                  <a:pt x="6698761" y="4151171"/>
                </a:lnTo>
                <a:lnTo>
                  <a:pt x="6698761" y="4170517"/>
                </a:lnTo>
                <a:lnTo>
                  <a:pt x="6700951" y="4170517"/>
                </a:lnTo>
                <a:lnTo>
                  <a:pt x="6700951" y="4189892"/>
                </a:lnTo>
                <a:lnTo>
                  <a:pt x="6703141" y="4189892"/>
                </a:lnTo>
                <a:lnTo>
                  <a:pt x="6703141" y="4209357"/>
                </a:lnTo>
                <a:lnTo>
                  <a:pt x="6710807" y="4209357"/>
                </a:lnTo>
                <a:lnTo>
                  <a:pt x="6710807" y="4228859"/>
                </a:lnTo>
                <a:lnTo>
                  <a:pt x="6752421" y="4228859"/>
                </a:lnTo>
                <a:lnTo>
                  <a:pt x="6752421" y="4248389"/>
                </a:lnTo>
                <a:lnTo>
                  <a:pt x="6755707" y="4248389"/>
                </a:lnTo>
                <a:lnTo>
                  <a:pt x="6755707" y="4287701"/>
                </a:lnTo>
                <a:lnTo>
                  <a:pt x="6765562" y="4287701"/>
                </a:lnTo>
                <a:lnTo>
                  <a:pt x="6765562" y="4307450"/>
                </a:lnTo>
                <a:lnTo>
                  <a:pt x="6789655" y="4307450"/>
                </a:lnTo>
                <a:lnTo>
                  <a:pt x="6789655" y="4327217"/>
                </a:lnTo>
                <a:lnTo>
                  <a:pt x="6791845" y="4327217"/>
                </a:lnTo>
                <a:lnTo>
                  <a:pt x="6791845" y="4347076"/>
                </a:lnTo>
                <a:lnTo>
                  <a:pt x="6796225" y="4347076"/>
                </a:lnTo>
                <a:lnTo>
                  <a:pt x="6796225" y="4366972"/>
                </a:lnTo>
                <a:lnTo>
                  <a:pt x="6797321" y="4366972"/>
                </a:lnTo>
                <a:lnTo>
                  <a:pt x="6797321" y="4386897"/>
                </a:lnTo>
                <a:lnTo>
                  <a:pt x="6800606" y="4386897"/>
                </a:lnTo>
                <a:lnTo>
                  <a:pt x="6800606" y="4406831"/>
                </a:lnTo>
                <a:lnTo>
                  <a:pt x="6820318" y="4406831"/>
                </a:lnTo>
                <a:lnTo>
                  <a:pt x="6820318" y="4426784"/>
                </a:lnTo>
                <a:lnTo>
                  <a:pt x="6827983" y="4426784"/>
                </a:lnTo>
                <a:lnTo>
                  <a:pt x="6827983" y="4446805"/>
                </a:lnTo>
                <a:lnTo>
                  <a:pt x="6855361" y="4446805"/>
                </a:lnTo>
                <a:lnTo>
                  <a:pt x="6855361" y="4466858"/>
                </a:lnTo>
                <a:lnTo>
                  <a:pt x="6860837" y="4466858"/>
                </a:lnTo>
                <a:lnTo>
                  <a:pt x="6860837" y="4486928"/>
                </a:lnTo>
                <a:lnTo>
                  <a:pt x="6869598" y="4486928"/>
                </a:lnTo>
                <a:lnTo>
                  <a:pt x="6869598" y="4507030"/>
                </a:lnTo>
                <a:lnTo>
                  <a:pt x="6881644" y="4507030"/>
                </a:lnTo>
                <a:lnTo>
                  <a:pt x="6881644" y="4527206"/>
                </a:lnTo>
                <a:lnTo>
                  <a:pt x="6899165" y="4527206"/>
                </a:lnTo>
                <a:lnTo>
                  <a:pt x="6899165" y="4547484"/>
                </a:lnTo>
                <a:lnTo>
                  <a:pt x="6903546" y="4547484"/>
                </a:lnTo>
                <a:lnTo>
                  <a:pt x="6903546" y="4567788"/>
                </a:lnTo>
                <a:lnTo>
                  <a:pt x="6930923" y="4567788"/>
                </a:lnTo>
                <a:lnTo>
                  <a:pt x="6930923" y="4588158"/>
                </a:lnTo>
                <a:lnTo>
                  <a:pt x="6934209" y="4588158"/>
                </a:lnTo>
                <a:lnTo>
                  <a:pt x="6934209" y="4608556"/>
                </a:lnTo>
                <a:lnTo>
                  <a:pt x="6944065" y="4608556"/>
                </a:lnTo>
                <a:lnTo>
                  <a:pt x="6944065" y="4629080"/>
                </a:lnTo>
                <a:lnTo>
                  <a:pt x="6951730" y="4629080"/>
                </a:lnTo>
                <a:lnTo>
                  <a:pt x="6951730" y="4649678"/>
                </a:lnTo>
                <a:lnTo>
                  <a:pt x="6952826" y="4649678"/>
                </a:lnTo>
                <a:lnTo>
                  <a:pt x="6952826" y="4670292"/>
                </a:lnTo>
                <a:lnTo>
                  <a:pt x="6960491" y="4670292"/>
                </a:lnTo>
                <a:lnTo>
                  <a:pt x="6960491" y="4690908"/>
                </a:lnTo>
                <a:lnTo>
                  <a:pt x="6970347" y="4690908"/>
                </a:lnTo>
                <a:lnTo>
                  <a:pt x="6970347" y="4711582"/>
                </a:lnTo>
                <a:lnTo>
                  <a:pt x="6978013" y="4711582"/>
                </a:lnTo>
                <a:lnTo>
                  <a:pt x="6978013" y="4732328"/>
                </a:lnTo>
                <a:lnTo>
                  <a:pt x="6993344" y="4732328"/>
                </a:lnTo>
                <a:lnTo>
                  <a:pt x="6993344" y="4753124"/>
                </a:lnTo>
                <a:lnTo>
                  <a:pt x="7006486" y="4753124"/>
                </a:lnTo>
                <a:lnTo>
                  <a:pt x="7006486" y="4753124"/>
                </a:lnTo>
                <a:lnTo>
                  <a:pt x="7017437" y="4753124"/>
                </a:lnTo>
                <a:lnTo>
                  <a:pt x="7017437" y="4773983"/>
                </a:lnTo>
                <a:lnTo>
                  <a:pt x="7024007" y="4773983"/>
                </a:lnTo>
                <a:lnTo>
                  <a:pt x="7024007" y="4794926"/>
                </a:lnTo>
                <a:lnTo>
                  <a:pt x="7037149" y="4794926"/>
                </a:lnTo>
                <a:lnTo>
                  <a:pt x="7037149" y="4815914"/>
                </a:lnTo>
                <a:lnTo>
                  <a:pt x="7042624" y="4815914"/>
                </a:lnTo>
                <a:lnTo>
                  <a:pt x="7042624" y="4836934"/>
                </a:lnTo>
                <a:lnTo>
                  <a:pt x="7054670" y="4836934"/>
                </a:lnTo>
                <a:lnTo>
                  <a:pt x="7054670" y="4858001"/>
                </a:lnTo>
                <a:lnTo>
                  <a:pt x="7056861" y="4858001"/>
                </a:lnTo>
                <a:lnTo>
                  <a:pt x="7056861" y="4879163"/>
                </a:lnTo>
                <a:lnTo>
                  <a:pt x="7060146" y="4879163"/>
                </a:lnTo>
                <a:lnTo>
                  <a:pt x="7060146" y="4900347"/>
                </a:lnTo>
                <a:lnTo>
                  <a:pt x="7066717" y="4900347"/>
                </a:lnTo>
                <a:lnTo>
                  <a:pt x="7066717" y="4921576"/>
                </a:lnTo>
                <a:lnTo>
                  <a:pt x="7071097" y="4921576"/>
                </a:lnTo>
                <a:lnTo>
                  <a:pt x="7071097" y="4921576"/>
                </a:lnTo>
                <a:lnTo>
                  <a:pt x="7080953" y="4921576"/>
                </a:lnTo>
                <a:lnTo>
                  <a:pt x="7080953" y="4944290"/>
                </a:lnTo>
                <a:lnTo>
                  <a:pt x="7092999" y="4944290"/>
                </a:lnTo>
                <a:lnTo>
                  <a:pt x="7092999" y="4944290"/>
                </a:lnTo>
                <a:lnTo>
                  <a:pt x="7097379" y="4944290"/>
                </a:lnTo>
                <a:lnTo>
                  <a:pt x="7097379" y="4944290"/>
                </a:lnTo>
                <a:lnTo>
                  <a:pt x="7103950" y="4944290"/>
                </a:lnTo>
                <a:lnTo>
                  <a:pt x="7103950" y="4969953"/>
                </a:lnTo>
                <a:lnTo>
                  <a:pt x="7107235" y="4969953"/>
                </a:lnTo>
                <a:lnTo>
                  <a:pt x="7107235" y="4969953"/>
                </a:lnTo>
                <a:lnTo>
                  <a:pt x="7110521" y="4969953"/>
                </a:lnTo>
                <a:lnTo>
                  <a:pt x="7110521" y="4996619"/>
                </a:lnTo>
                <a:lnTo>
                  <a:pt x="7112711" y="4996619"/>
                </a:lnTo>
                <a:lnTo>
                  <a:pt x="7112711" y="4996619"/>
                </a:lnTo>
                <a:lnTo>
                  <a:pt x="7122567" y="4996619"/>
                </a:lnTo>
                <a:lnTo>
                  <a:pt x="7122567" y="5024573"/>
                </a:lnTo>
                <a:lnTo>
                  <a:pt x="7128042" y="5024573"/>
                </a:lnTo>
                <a:lnTo>
                  <a:pt x="7128042" y="5052663"/>
                </a:lnTo>
                <a:lnTo>
                  <a:pt x="7129138" y="5052663"/>
                </a:lnTo>
                <a:lnTo>
                  <a:pt x="7129138" y="5052663"/>
                </a:lnTo>
                <a:lnTo>
                  <a:pt x="7130233" y="5052663"/>
                </a:lnTo>
                <a:lnTo>
                  <a:pt x="7130233" y="5083642"/>
                </a:lnTo>
                <a:lnTo>
                  <a:pt x="7135708" y="5083642"/>
                </a:lnTo>
                <a:lnTo>
                  <a:pt x="7135708" y="5083642"/>
                </a:lnTo>
                <a:lnTo>
                  <a:pt x="7140089" y="5083642"/>
                </a:lnTo>
                <a:lnTo>
                  <a:pt x="7140089" y="5116760"/>
                </a:lnTo>
                <a:lnTo>
                  <a:pt x="7149945" y="5116760"/>
                </a:lnTo>
                <a:lnTo>
                  <a:pt x="7149945" y="5116760"/>
                </a:lnTo>
                <a:lnTo>
                  <a:pt x="7151040" y="5116760"/>
                </a:lnTo>
                <a:lnTo>
                  <a:pt x="7151040" y="5116760"/>
                </a:lnTo>
                <a:lnTo>
                  <a:pt x="7152135" y="5116760"/>
                </a:lnTo>
                <a:lnTo>
                  <a:pt x="7152135" y="5116760"/>
                </a:lnTo>
                <a:lnTo>
                  <a:pt x="7154325" y="5116760"/>
                </a:lnTo>
                <a:lnTo>
                  <a:pt x="7154325" y="5160323"/>
                </a:lnTo>
                <a:lnTo>
                  <a:pt x="7159801" y="5160323"/>
                </a:lnTo>
                <a:lnTo>
                  <a:pt x="7159801" y="5160323"/>
                </a:lnTo>
                <a:lnTo>
                  <a:pt x="7169656" y="5160323"/>
                </a:lnTo>
                <a:lnTo>
                  <a:pt x="7169656" y="5208072"/>
                </a:lnTo>
                <a:lnTo>
                  <a:pt x="7179512" y="5208072"/>
                </a:lnTo>
                <a:lnTo>
                  <a:pt x="7179512" y="5208072"/>
                </a:lnTo>
                <a:lnTo>
                  <a:pt x="7181703" y="5208072"/>
                </a:lnTo>
                <a:lnTo>
                  <a:pt x="7181703" y="5208072"/>
                </a:lnTo>
                <a:lnTo>
                  <a:pt x="7182798" y="5208072"/>
                </a:lnTo>
                <a:lnTo>
                  <a:pt x="7182798" y="5208072"/>
                </a:lnTo>
                <a:lnTo>
                  <a:pt x="7202510" y="5208072"/>
                </a:lnTo>
                <a:lnTo>
                  <a:pt x="7202510" y="5208072"/>
                </a:lnTo>
                <a:lnTo>
                  <a:pt x="7203605" y="5208072"/>
                </a:lnTo>
                <a:lnTo>
                  <a:pt x="7203605" y="5208072"/>
                </a:lnTo>
                <a:lnTo>
                  <a:pt x="7205795" y="5208072"/>
                </a:lnTo>
                <a:lnTo>
                  <a:pt x="7205795" y="5208072"/>
                </a:lnTo>
                <a:lnTo>
                  <a:pt x="7212366" y="5208072"/>
                </a:lnTo>
                <a:lnTo>
                  <a:pt x="7212366" y="5208072"/>
                </a:lnTo>
                <a:lnTo>
                  <a:pt x="7220031" y="5208072"/>
                </a:lnTo>
                <a:lnTo>
                  <a:pt x="7220031" y="5208072"/>
                </a:lnTo>
                <a:lnTo>
                  <a:pt x="7221126" y="5208072"/>
                </a:lnTo>
                <a:lnTo>
                  <a:pt x="7221126" y="5208072"/>
                </a:lnTo>
                <a:lnTo>
                  <a:pt x="7227697" y="5208072"/>
                </a:lnTo>
                <a:lnTo>
                  <a:pt x="7227697" y="5208072"/>
                </a:lnTo>
              </a:path>
            </a:pathLst>
          </a:custGeom>
          <a:ln w="21681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15" name="pl15"/>
          <p:cNvSpPr/>
          <p:nvPr/>
        </p:nvSpPr>
        <p:spPr>
          <a:xfrm>
            <a:off x="3935842" y="1777088"/>
            <a:ext cx="4602399" cy="1237132"/>
          </a:xfrm>
          <a:custGeom>
            <a:avLst/>
            <a:gdLst/>
            <a:ahLst/>
            <a:cxnLst/>
            <a:rect l="0" t="0" r="0" b="0"/>
            <a:pathLst>
              <a:path w="7227697" h="2084791">
                <a:moveTo>
                  <a:pt x="0" y="0"/>
                </a:moveTo>
                <a:lnTo>
                  <a:pt x="170836" y="0"/>
                </a:lnTo>
                <a:lnTo>
                  <a:pt x="170836" y="3469"/>
                </a:lnTo>
                <a:lnTo>
                  <a:pt x="203689" y="3469"/>
                </a:lnTo>
                <a:lnTo>
                  <a:pt x="203689" y="3469"/>
                </a:lnTo>
                <a:lnTo>
                  <a:pt x="261730" y="3469"/>
                </a:lnTo>
                <a:lnTo>
                  <a:pt x="261730" y="6957"/>
                </a:lnTo>
                <a:lnTo>
                  <a:pt x="279251" y="6957"/>
                </a:lnTo>
                <a:lnTo>
                  <a:pt x="279251" y="10461"/>
                </a:lnTo>
                <a:lnTo>
                  <a:pt x="316485" y="10461"/>
                </a:lnTo>
                <a:lnTo>
                  <a:pt x="316485" y="13966"/>
                </a:lnTo>
                <a:lnTo>
                  <a:pt x="342768" y="13966"/>
                </a:lnTo>
                <a:lnTo>
                  <a:pt x="342768" y="17475"/>
                </a:lnTo>
                <a:lnTo>
                  <a:pt x="372335" y="17475"/>
                </a:lnTo>
                <a:lnTo>
                  <a:pt x="372335" y="20989"/>
                </a:lnTo>
                <a:lnTo>
                  <a:pt x="430376" y="20989"/>
                </a:lnTo>
                <a:lnTo>
                  <a:pt x="430376" y="20989"/>
                </a:lnTo>
                <a:lnTo>
                  <a:pt x="504843" y="20989"/>
                </a:lnTo>
                <a:lnTo>
                  <a:pt x="504843" y="24527"/>
                </a:lnTo>
                <a:lnTo>
                  <a:pt x="548647" y="24527"/>
                </a:lnTo>
                <a:lnTo>
                  <a:pt x="548647" y="28070"/>
                </a:lnTo>
                <a:lnTo>
                  <a:pt x="780810" y="28070"/>
                </a:lnTo>
                <a:lnTo>
                  <a:pt x="780810" y="31639"/>
                </a:lnTo>
                <a:lnTo>
                  <a:pt x="790666" y="31639"/>
                </a:lnTo>
                <a:lnTo>
                  <a:pt x="790666" y="31639"/>
                </a:lnTo>
                <a:lnTo>
                  <a:pt x="805997" y="31639"/>
                </a:lnTo>
                <a:lnTo>
                  <a:pt x="805997" y="35216"/>
                </a:lnTo>
                <a:lnTo>
                  <a:pt x="816948" y="35216"/>
                </a:lnTo>
                <a:lnTo>
                  <a:pt x="816948" y="38793"/>
                </a:lnTo>
                <a:lnTo>
                  <a:pt x="839946" y="38793"/>
                </a:lnTo>
                <a:lnTo>
                  <a:pt x="839946" y="38793"/>
                </a:lnTo>
                <a:lnTo>
                  <a:pt x="853087" y="38793"/>
                </a:lnTo>
                <a:lnTo>
                  <a:pt x="853087" y="42384"/>
                </a:lnTo>
                <a:lnTo>
                  <a:pt x="919888" y="42384"/>
                </a:lnTo>
                <a:lnTo>
                  <a:pt x="919888" y="45982"/>
                </a:lnTo>
                <a:lnTo>
                  <a:pt x="962597" y="45982"/>
                </a:lnTo>
                <a:lnTo>
                  <a:pt x="962597" y="49580"/>
                </a:lnTo>
                <a:lnTo>
                  <a:pt x="1008592" y="49580"/>
                </a:lnTo>
                <a:lnTo>
                  <a:pt x="1008592" y="53188"/>
                </a:lnTo>
                <a:lnTo>
                  <a:pt x="1090725" y="53188"/>
                </a:lnTo>
                <a:lnTo>
                  <a:pt x="1090725" y="53188"/>
                </a:lnTo>
                <a:lnTo>
                  <a:pt x="1137814" y="53188"/>
                </a:lnTo>
                <a:lnTo>
                  <a:pt x="1137814" y="56808"/>
                </a:lnTo>
                <a:lnTo>
                  <a:pt x="1153146" y="56808"/>
                </a:lnTo>
                <a:lnTo>
                  <a:pt x="1153146" y="60439"/>
                </a:lnTo>
                <a:lnTo>
                  <a:pt x="1167382" y="60439"/>
                </a:lnTo>
                <a:lnTo>
                  <a:pt x="1167382" y="64075"/>
                </a:lnTo>
                <a:lnTo>
                  <a:pt x="1226518" y="64075"/>
                </a:lnTo>
                <a:lnTo>
                  <a:pt x="1226518" y="67723"/>
                </a:lnTo>
                <a:lnTo>
                  <a:pt x="1245135" y="67723"/>
                </a:lnTo>
                <a:lnTo>
                  <a:pt x="1245135" y="71374"/>
                </a:lnTo>
                <a:lnTo>
                  <a:pt x="1260466" y="71374"/>
                </a:lnTo>
                <a:lnTo>
                  <a:pt x="1260466" y="75037"/>
                </a:lnTo>
                <a:lnTo>
                  <a:pt x="1325077" y="75037"/>
                </a:lnTo>
                <a:lnTo>
                  <a:pt x="1325077" y="78706"/>
                </a:lnTo>
                <a:lnTo>
                  <a:pt x="1326172" y="78706"/>
                </a:lnTo>
                <a:lnTo>
                  <a:pt x="1326172" y="82377"/>
                </a:lnTo>
                <a:lnTo>
                  <a:pt x="1397354" y="82377"/>
                </a:lnTo>
                <a:lnTo>
                  <a:pt x="1397354" y="86064"/>
                </a:lnTo>
                <a:lnTo>
                  <a:pt x="1408305" y="86064"/>
                </a:lnTo>
                <a:lnTo>
                  <a:pt x="1408305" y="89754"/>
                </a:lnTo>
                <a:lnTo>
                  <a:pt x="1422542" y="89754"/>
                </a:lnTo>
                <a:lnTo>
                  <a:pt x="1422542" y="93449"/>
                </a:lnTo>
                <a:lnTo>
                  <a:pt x="1424732" y="93449"/>
                </a:lnTo>
                <a:lnTo>
                  <a:pt x="1424732" y="97144"/>
                </a:lnTo>
                <a:lnTo>
                  <a:pt x="1464156" y="97144"/>
                </a:lnTo>
                <a:lnTo>
                  <a:pt x="1464156" y="100844"/>
                </a:lnTo>
                <a:lnTo>
                  <a:pt x="1489343" y="100844"/>
                </a:lnTo>
                <a:lnTo>
                  <a:pt x="1489343" y="104544"/>
                </a:lnTo>
                <a:lnTo>
                  <a:pt x="1506865" y="104544"/>
                </a:lnTo>
                <a:lnTo>
                  <a:pt x="1506865" y="108253"/>
                </a:lnTo>
                <a:lnTo>
                  <a:pt x="1529862" y="108253"/>
                </a:lnTo>
                <a:lnTo>
                  <a:pt x="1529862" y="111968"/>
                </a:lnTo>
                <a:lnTo>
                  <a:pt x="1536433" y="111968"/>
                </a:lnTo>
                <a:lnTo>
                  <a:pt x="1536433" y="115689"/>
                </a:lnTo>
                <a:lnTo>
                  <a:pt x="1583522" y="115689"/>
                </a:lnTo>
                <a:lnTo>
                  <a:pt x="1583522" y="119424"/>
                </a:lnTo>
                <a:lnTo>
                  <a:pt x="1608710" y="119424"/>
                </a:lnTo>
                <a:lnTo>
                  <a:pt x="1608710" y="123162"/>
                </a:lnTo>
                <a:lnTo>
                  <a:pt x="1670036" y="123162"/>
                </a:lnTo>
                <a:lnTo>
                  <a:pt x="1670036" y="126915"/>
                </a:lnTo>
                <a:lnTo>
                  <a:pt x="1730266" y="126915"/>
                </a:lnTo>
                <a:lnTo>
                  <a:pt x="1730266" y="130672"/>
                </a:lnTo>
                <a:lnTo>
                  <a:pt x="1737932" y="130672"/>
                </a:lnTo>
                <a:lnTo>
                  <a:pt x="1737932" y="134432"/>
                </a:lnTo>
                <a:lnTo>
                  <a:pt x="1757644" y="134432"/>
                </a:lnTo>
                <a:lnTo>
                  <a:pt x="1757644" y="138195"/>
                </a:lnTo>
                <a:lnTo>
                  <a:pt x="1766405" y="138195"/>
                </a:lnTo>
                <a:lnTo>
                  <a:pt x="1766405" y="141963"/>
                </a:lnTo>
                <a:lnTo>
                  <a:pt x="1786117" y="141963"/>
                </a:lnTo>
                <a:lnTo>
                  <a:pt x="1786117" y="145734"/>
                </a:lnTo>
                <a:lnTo>
                  <a:pt x="1810209" y="145734"/>
                </a:lnTo>
                <a:lnTo>
                  <a:pt x="1810209" y="149512"/>
                </a:lnTo>
                <a:lnTo>
                  <a:pt x="1845253" y="149512"/>
                </a:lnTo>
                <a:lnTo>
                  <a:pt x="1845253" y="153292"/>
                </a:lnTo>
                <a:lnTo>
                  <a:pt x="1863869" y="153292"/>
                </a:lnTo>
                <a:lnTo>
                  <a:pt x="1863869" y="157075"/>
                </a:lnTo>
                <a:lnTo>
                  <a:pt x="1866060" y="157075"/>
                </a:lnTo>
                <a:lnTo>
                  <a:pt x="1866060" y="160862"/>
                </a:lnTo>
                <a:lnTo>
                  <a:pt x="1896723" y="160862"/>
                </a:lnTo>
                <a:lnTo>
                  <a:pt x="1896723" y="164650"/>
                </a:lnTo>
                <a:lnTo>
                  <a:pt x="1909864" y="164650"/>
                </a:lnTo>
                <a:lnTo>
                  <a:pt x="1909864" y="168443"/>
                </a:lnTo>
                <a:lnTo>
                  <a:pt x="1935051" y="168443"/>
                </a:lnTo>
                <a:lnTo>
                  <a:pt x="1935051" y="172252"/>
                </a:lnTo>
                <a:lnTo>
                  <a:pt x="1986521" y="172252"/>
                </a:lnTo>
                <a:lnTo>
                  <a:pt x="1986521" y="176069"/>
                </a:lnTo>
                <a:lnTo>
                  <a:pt x="2017184" y="176069"/>
                </a:lnTo>
                <a:lnTo>
                  <a:pt x="2017184" y="179893"/>
                </a:lnTo>
                <a:lnTo>
                  <a:pt x="2122314" y="179893"/>
                </a:lnTo>
                <a:lnTo>
                  <a:pt x="2122314" y="183723"/>
                </a:lnTo>
                <a:lnTo>
                  <a:pt x="2123409" y="183723"/>
                </a:lnTo>
                <a:lnTo>
                  <a:pt x="2123409" y="187553"/>
                </a:lnTo>
                <a:lnTo>
                  <a:pt x="2131075" y="187553"/>
                </a:lnTo>
                <a:lnTo>
                  <a:pt x="2131075" y="187553"/>
                </a:lnTo>
                <a:lnTo>
                  <a:pt x="2159548" y="187553"/>
                </a:lnTo>
                <a:lnTo>
                  <a:pt x="2159548" y="187553"/>
                </a:lnTo>
                <a:lnTo>
                  <a:pt x="2178165" y="187553"/>
                </a:lnTo>
                <a:lnTo>
                  <a:pt x="2178165" y="191408"/>
                </a:lnTo>
                <a:lnTo>
                  <a:pt x="2189116" y="191408"/>
                </a:lnTo>
                <a:lnTo>
                  <a:pt x="2189116" y="191408"/>
                </a:lnTo>
                <a:lnTo>
                  <a:pt x="2201162" y="191408"/>
                </a:lnTo>
                <a:lnTo>
                  <a:pt x="2201162" y="195285"/>
                </a:lnTo>
                <a:lnTo>
                  <a:pt x="2208828" y="195285"/>
                </a:lnTo>
                <a:lnTo>
                  <a:pt x="2208828" y="199170"/>
                </a:lnTo>
                <a:lnTo>
                  <a:pt x="2213208" y="199170"/>
                </a:lnTo>
                <a:lnTo>
                  <a:pt x="2213208" y="199170"/>
                </a:lnTo>
                <a:lnTo>
                  <a:pt x="2227444" y="199170"/>
                </a:lnTo>
                <a:lnTo>
                  <a:pt x="2227444" y="199170"/>
                </a:lnTo>
                <a:lnTo>
                  <a:pt x="2269058" y="199170"/>
                </a:lnTo>
                <a:lnTo>
                  <a:pt x="2269058" y="203088"/>
                </a:lnTo>
                <a:lnTo>
                  <a:pt x="2273439" y="203088"/>
                </a:lnTo>
                <a:lnTo>
                  <a:pt x="2273439" y="207015"/>
                </a:lnTo>
                <a:lnTo>
                  <a:pt x="2306292" y="207015"/>
                </a:lnTo>
                <a:lnTo>
                  <a:pt x="2306292" y="210960"/>
                </a:lnTo>
                <a:lnTo>
                  <a:pt x="2310673" y="210960"/>
                </a:lnTo>
                <a:lnTo>
                  <a:pt x="2310673" y="214919"/>
                </a:lnTo>
                <a:lnTo>
                  <a:pt x="2430039" y="214919"/>
                </a:lnTo>
                <a:lnTo>
                  <a:pt x="2430039" y="218883"/>
                </a:lnTo>
                <a:lnTo>
                  <a:pt x="2447561" y="218883"/>
                </a:lnTo>
                <a:lnTo>
                  <a:pt x="2447561" y="222851"/>
                </a:lnTo>
                <a:lnTo>
                  <a:pt x="2481509" y="222851"/>
                </a:lnTo>
                <a:lnTo>
                  <a:pt x="2481509" y="226827"/>
                </a:lnTo>
                <a:lnTo>
                  <a:pt x="2517647" y="226827"/>
                </a:lnTo>
                <a:lnTo>
                  <a:pt x="2517647" y="230884"/>
                </a:lnTo>
                <a:lnTo>
                  <a:pt x="2546120" y="230884"/>
                </a:lnTo>
                <a:lnTo>
                  <a:pt x="2546120" y="234955"/>
                </a:lnTo>
                <a:lnTo>
                  <a:pt x="2558166" y="234955"/>
                </a:lnTo>
                <a:lnTo>
                  <a:pt x="2558166" y="239028"/>
                </a:lnTo>
                <a:lnTo>
                  <a:pt x="2592115" y="239028"/>
                </a:lnTo>
                <a:lnTo>
                  <a:pt x="2592115" y="243116"/>
                </a:lnTo>
                <a:lnTo>
                  <a:pt x="2639204" y="243116"/>
                </a:lnTo>
                <a:lnTo>
                  <a:pt x="2639204" y="247210"/>
                </a:lnTo>
                <a:lnTo>
                  <a:pt x="2651250" y="247210"/>
                </a:lnTo>
                <a:lnTo>
                  <a:pt x="2651250" y="251329"/>
                </a:lnTo>
                <a:lnTo>
                  <a:pt x="2808946" y="251329"/>
                </a:lnTo>
                <a:lnTo>
                  <a:pt x="2808946" y="255492"/>
                </a:lnTo>
                <a:lnTo>
                  <a:pt x="2826467" y="255492"/>
                </a:lnTo>
                <a:lnTo>
                  <a:pt x="2826467" y="259658"/>
                </a:lnTo>
                <a:lnTo>
                  <a:pt x="2836323" y="259658"/>
                </a:lnTo>
                <a:lnTo>
                  <a:pt x="2836323" y="263826"/>
                </a:lnTo>
                <a:lnTo>
                  <a:pt x="2843989" y="263826"/>
                </a:lnTo>
                <a:lnTo>
                  <a:pt x="2843989" y="268014"/>
                </a:lnTo>
                <a:lnTo>
                  <a:pt x="2883413" y="268014"/>
                </a:lnTo>
                <a:lnTo>
                  <a:pt x="2883413" y="272204"/>
                </a:lnTo>
                <a:lnTo>
                  <a:pt x="2888888" y="272204"/>
                </a:lnTo>
                <a:lnTo>
                  <a:pt x="2888888" y="276400"/>
                </a:lnTo>
                <a:lnTo>
                  <a:pt x="2898744" y="276400"/>
                </a:lnTo>
                <a:lnTo>
                  <a:pt x="2898744" y="280610"/>
                </a:lnTo>
                <a:lnTo>
                  <a:pt x="2900934" y="280610"/>
                </a:lnTo>
                <a:lnTo>
                  <a:pt x="2900934" y="284821"/>
                </a:lnTo>
                <a:lnTo>
                  <a:pt x="2930502" y="284821"/>
                </a:lnTo>
                <a:lnTo>
                  <a:pt x="2930502" y="289038"/>
                </a:lnTo>
                <a:lnTo>
                  <a:pt x="2951309" y="289038"/>
                </a:lnTo>
                <a:lnTo>
                  <a:pt x="2951309" y="293261"/>
                </a:lnTo>
                <a:lnTo>
                  <a:pt x="2974307" y="293261"/>
                </a:lnTo>
                <a:lnTo>
                  <a:pt x="2974307" y="297485"/>
                </a:lnTo>
                <a:lnTo>
                  <a:pt x="2980877" y="297485"/>
                </a:lnTo>
                <a:lnTo>
                  <a:pt x="2980877" y="301710"/>
                </a:lnTo>
                <a:lnTo>
                  <a:pt x="3064105" y="301710"/>
                </a:lnTo>
                <a:lnTo>
                  <a:pt x="3064105" y="305999"/>
                </a:lnTo>
                <a:lnTo>
                  <a:pt x="3103529" y="305999"/>
                </a:lnTo>
                <a:lnTo>
                  <a:pt x="3103529" y="310287"/>
                </a:lnTo>
                <a:lnTo>
                  <a:pt x="3104624" y="310287"/>
                </a:lnTo>
                <a:lnTo>
                  <a:pt x="3104624" y="314585"/>
                </a:lnTo>
                <a:lnTo>
                  <a:pt x="3110100" y="314585"/>
                </a:lnTo>
                <a:lnTo>
                  <a:pt x="3110100" y="318887"/>
                </a:lnTo>
                <a:lnTo>
                  <a:pt x="3130907" y="318887"/>
                </a:lnTo>
                <a:lnTo>
                  <a:pt x="3130907" y="323193"/>
                </a:lnTo>
                <a:lnTo>
                  <a:pt x="3186757" y="323193"/>
                </a:lnTo>
                <a:lnTo>
                  <a:pt x="3186757" y="327509"/>
                </a:lnTo>
                <a:lnTo>
                  <a:pt x="3203184" y="327509"/>
                </a:lnTo>
                <a:lnTo>
                  <a:pt x="3203184" y="327509"/>
                </a:lnTo>
                <a:lnTo>
                  <a:pt x="3242607" y="327509"/>
                </a:lnTo>
                <a:lnTo>
                  <a:pt x="3242607" y="331832"/>
                </a:lnTo>
                <a:lnTo>
                  <a:pt x="3282031" y="331832"/>
                </a:lnTo>
                <a:lnTo>
                  <a:pt x="3282031" y="336167"/>
                </a:lnTo>
                <a:lnTo>
                  <a:pt x="3366354" y="336167"/>
                </a:lnTo>
                <a:lnTo>
                  <a:pt x="3366354" y="340532"/>
                </a:lnTo>
                <a:lnTo>
                  <a:pt x="3388257" y="340532"/>
                </a:lnTo>
                <a:lnTo>
                  <a:pt x="3388257" y="344902"/>
                </a:lnTo>
                <a:lnTo>
                  <a:pt x="3432061" y="344902"/>
                </a:lnTo>
                <a:lnTo>
                  <a:pt x="3432061" y="349275"/>
                </a:lnTo>
                <a:lnTo>
                  <a:pt x="3458343" y="349275"/>
                </a:lnTo>
                <a:lnTo>
                  <a:pt x="3458343" y="353657"/>
                </a:lnTo>
                <a:lnTo>
                  <a:pt x="3459438" y="353657"/>
                </a:lnTo>
                <a:lnTo>
                  <a:pt x="3459438" y="358069"/>
                </a:lnTo>
                <a:lnTo>
                  <a:pt x="3475865" y="358069"/>
                </a:lnTo>
                <a:lnTo>
                  <a:pt x="3475865" y="362485"/>
                </a:lnTo>
                <a:lnTo>
                  <a:pt x="3526240" y="362485"/>
                </a:lnTo>
                <a:lnTo>
                  <a:pt x="3526240" y="366909"/>
                </a:lnTo>
                <a:lnTo>
                  <a:pt x="3541571" y="366909"/>
                </a:lnTo>
                <a:lnTo>
                  <a:pt x="3541571" y="371335"/>
                </a:lnTo>
                <a:lnTo>
                  <a:pt x="3548142" y="371335"/>
                </a:lnTo>
                <a:lnTo>
                  <a:pt x="3548142" y="375764"/>
                </a:lnTo>
                <a:lnTo>
                  <a:pt x="3551427" y="375764"/>
                </a:lnTo>
                <a:lnTo>
                  <a:pt x="3551427" y="380209"/>
                </a:lnTo>
                <a:lnTo>
                  <a:pt x="3552522" y="380209"/>
                </a:lnTo>
                <a:lnTo>
                  <a:pt x="3552522" y="384687"/>
                </a:lnTo>
                <a:lnTo>
                  <a:pt x="3562378" y="384687"/>
                </a:lnTo>
                <a:lnTo>
                  <a:pt x="3562378" y="389171"/>
                </a:lnTo>
                <a:lnTo>
                  <a:pt x="3564569" y="389171"/>
                </a:lnTo>
                <a:lnTo>
                  <a:pt x="3564569" y="393657"/>
                </a:lnTo>
                <a:lnTo>
                  <a:pt x="3609468" y="393657"/>
                </a:lnTo>
                <a:lnTo>
                  <a:pt x="3609468" y="393657"/>
                </a:lnTo>
                <a:lnTo>
                  <a:pt x="3611658" y="393657"/>
                </a:lnTo>
                <a:lnTo>
                  <a:pt x="3611658" y="398153"/>
                </a:lnTo>
                <a:lnTo>
                  <a:pt x="3620419" y="398153"/>
                </a:lnTo>
                <a:lnTo>
                  <a:pt x="3620419" y="402651"/>
                </a:lnTo>
                <a:lnTo>
                  <a:pt x="3630275" y="402651"/>
                </a:lnTo>
                <a:lnTo>
                  <a:pt x="3630275" y="402651"/>
                </a:lnTo>
                <a:lnTo>
                  <a:pt x="3636846" y="402651"/>
                </a:lnTo>
                <a:lnTo>
                  <a:pt x="3636846" y="402651"/>
                </a:lnTo>
                <a:lnTo>
                  <a:pt x="3637941" y="402651"/>
                </a:lnTo>
                <a:lnTo>
                  <a:pt x="3637941" y="407182"/>
                </a:lnTo>
                <a:lnTo>
                  <a:pt x="3655462" y="407182"/>
                </a:lnTo>
                <a:lnTo>
                  <a:pt x="3655462" y="416299"/>
                </a:lnTo>
                <a:lnTo>
                  <a:pt x="3660938" y="416299"/>
                </a:lnTo>
                <a:lnTo>
                  <a:pt x="3660938" y="425452"/>
                </a:lnTo>
                <a:lnTo>
                  <a:pt x="3701457" y="425452"/>
                </a:lnTo>
                <a:lnTo>
                  <a:pt x="3701457" y="430039"/>
                </a:lnTo>
                <a:lnTo>
                  <a:pt x="3703647" y="430039"/>
                </a:lnTo>
                <a:lnTo>
                  <a:pt x="3703647" y="434633"/>
                </a:lnTo>
                <a:lnTo>
                  <a:pt x="3758402" y="434633"/>
                </a:lnTo>
                <a:lnTo>
                  <a:pt x="3758402" y="439238"/>
                </a:lnTo>
                <a:lnTo>
                  <a:pt x="3770448" y="439238"/>
                </a:lnTo>
                <a:lnTo>
                  <a:pt x="3770448" y="443843"/>
                </a:lnTo>
                <a:lnTo>
                  <a:pt x="3783590" y="443843"/>
                </a:lnTo>
                <a:lnTo>
                  <a:pt x="3783590" y="448451"/>
                </a:lnTo>
                <a:lnTo>
                  <a:pt x="3792351" y="448451"/>
                </a:lnTo>
                <a:lnTo>
                  <a:pt x="3792351" y="453080"/>
                </a:lnTo>
                <a:lnTo>
                  <a:pt x="3809872" y="453080"/>
                </a:lnTo>
                <a:lnTo>
                  <a:pt x="3809872" y="457729"/>
                </a:lnTo>
                <a:lnTo>
                  <a:pt x="3817538" y="457729"/>
                </a:lnTo>
                <a:lnTo>
                  <a:pt x="3817538" y="462378"/>
                </a:lnTo>
                <a:lnTo>
                  <a:pt x="3828489" y="462378"/>
                </a:lnTo>
                <a:lnTo>
                  <a:pt x="3828489" y="467039"/>
                </a:lnTo>
                <a:lnTo>
                  <a:pt x="3836155" y="467039"/>
                </a:lnTo>
                <a:lnTo>
                  <a:pt x="3836155" y="471708"/>
                </a:lnTo>
                <a:lnTo>
                  <a:pt x="3861342" y="471708"/>
                </a:lnTo>
                <a:lnTo>
                  <a:pt x="3861342" y="476388"/>
                </a:lnTo>
                <a:lnTo>
                  <a:pt x="3896386" y="476388"/>
                </a:lnTo>
                <a:lnTo>
                  <a:pt x="3896386" y="481085"/>
                </a:lnTo>
                <a:lnTo>
                  <a:pt x="3906242" y="481085"/>
                </a:lnTo>
                <a:lnTo>
                  <a:pt x="3906242" y="485804"/>
                </a:lnTo>
                <a:lnTo>
                  <a:pt x="3912812" y="485804"/>
                </a:lnTo>
                <a:lnTo>
                  <a:pt x="3912812" y="495258"/>
                </a:lnTo>
                <a:lnTo>
                  <a:pt x="3913907" y="495258"/>
                </a:lnTo>
                <a:lnTo>
                  <a:pt x="3913907" y="500007"/>
                </a:lnTo>
                <a:lnTo>
                  <a:pt x="3915002" y="500007"/>
                </a:lnTo>
                <a:lnTo>
                  <a:pt x="3915002" y="500007"/>
                </a:lnTo>
                <a:lnTo>
                  <a:pt x="3923763" y="500007"/>
                </a:lnTo>
                <a:lnTo>
                  <a:pt x="3923763" y="504772"/>
                </a:lnTo>
                <a:lnTo>
                  <a:pt x="3930334" y="504772"/>
                </a:lnTo>
                <a:lnTo>
                  <a:pt x="3930334" y="509549"/>
                </a:lnTo>
                <a:lnTo>
                  <a:pt x="3931429" y="509549"/>
                </a:lnTo>
                <a:lnTo>
                  <a:pt x="3931429" y="514364"/>
                </a:lnTo>
                <a:lnTo>
                  <a:pt x="3939095" y="514364"/>
                </a:lnTo>
                <a:lnTo>
                  <a:pt x="3939095" y="519188"/>
                </a:lnTo>
                <a:lnTo>
                  <a:pt x="3944570" y="519188"/>
                </a:lnTo>
                <a:lnTo>
                  <a:pt x="3944570" y="524022"/>
                </a:lnTo>
                <a:lnTo>
                  <a:pt x="3947856" y="524022"/>
                </a:lnTo>
                <a:lnTo>
                  <a:pt x="3947856" y="528862"/>
                </a:lnTo>
                <a:lnTo>
                  <a:pt x="3953331" y="528862"/>
                </a:lnTo>
                <a:lnTo>
                  <a:pt x="3953331" y="533711"/>
                </a:lnTo>
                <a:lnTo>
                  <a:pt x="3954426" y="533711"/>
                </a:lnTo>
                <a:lnTo>
                  <a:pt x="3954426" y="538574"/>
                </a:lnTo>
                <a:lnTo>
                  <a:pt x="3956616" y="538574"/>
                </a:lnTo>
                <a:lnTo>
                  <a:pt x="3956616" y="543440"/>
                </a:lnTo>
                <a:lnTo>
                  <a:pt x="3980709" y="543440"/>
                </a:lnTo>
                <a:lnTo>
                  <a:pt x="3980709" y="548309"/>
                </a:lnTo>
                <a:lnTo>
                  <a:pt x="3986184" y="548309"/>
                </a:lnTo>
                <a:lnTo>
                  <a:pt x="3986184" y="553187"/>
                </a:lnTo>
                <a:lnTo>
                  <a:pt x="3987279" y="553187"/>
                </a:lnTo>
                <a:lnTo>
                  <a:pt x="3987279" y="553187"/>
                </a:lnTo>
                <a:lnTo>
                  <a:pt x="3993850" y="553187"/>
                </a:lnTo>
                <a:lnTo>
                  <a:pt x="3993850" y="558078"/>
                </a:lnTo>
                <a:lnTo>
                  <a:pt x="3994945" y="558078"/>
                </a:lnTo>
                <a:lnTo>
                  <a:pt x="3994945" y="562980"/>
                </a:lnTo>
                <a:lnTo>
                  <a:pt x="4016847" y="562980"/>
                </a:lnTo>
                <a:lnTo>
                  <a:pt x="4016847" y="567888"/>
                </a:lnTo>
                <a:lnTo>
                  <a:pt x="4054081" y="567888"/>
                </a:lnTo>
                <a:lnTo>
                  <a:pt x="4054081" y="572804"/>
                </a:lnTo>
                <a:lnTo>
                  <a:pt x="4068317" y="572804"/>
                </a:lnTo>
                <a:lnTo>
                  <a:pt x="4068317" y="577731"/>
                </a:lnTo>
                <a:lnTo>
                  <a:pt x="4072698" y="577731"/>
                </a:lnTo>
                <a:lnTo>
                  <a:pt x="4072698" y="577731"/>
                </a:lnTo>
                <a:lnTo>
                  <a:pt x="4077078" y="577731"/>
                </a:lnTo>
                <a:lnTo>
                  <a:pt x="4077078" y="582658"/>
                </a:lnTo>
                <a:lnTo>
                  <a:pt x="4095695" y="582658"/>
                </a:lnTo>
                <a:lnTo>
                  <a:pt x="4095695" y="582658"/>
                </a:lnTo>
                <a:lnTo>
                  <a:pt x="4111026" y="582658"/>
                </a:lnTo>
                <a:lnTo>
                  <a:pt x="4111026" y="587611"/>
                </a:lnTo>
                <a:lnTo>
                  <a:pt x="4245724" y="587611"/>
                </a:lnTo>
                <a:lnTo>
                  <a:pt x="4245724" y="592619"/>
                </a:lnTo>
                <a:lnTo>
                  <a:pt x="4269817" y="592619"/>
                </a:lnTo>
                <a:lnTo>
                  <a:pt x="4269817" y="597629"/>
                </a:lnTo>
                <a:lnTo>
                  <a:pt x="4304860" y="597629"/>
                </a:lnTo>
                <a:lnTo>
                  <a:pt x="4304860" y="602672"/>
                </a:lnTo>
                <a:lnTo>
                  <a:pt x="4318001" y="602672"/>
                </a:lnTo>
                <a:lnTo>
                  <a:pt x="4318001" y="607717"/>
                </a:lnTo>
                <a:lnTo>
                  <a:pt x="4334428" y="607717"/>
                </a:lnTo>
                <a:lnTo>
                  <a:pt x="4334428" y="612763"/>
                </a:lnTo>
                <a:lnTo>
                  <a:pt x="4354140" y="612763"/>
                </a:lnTo>
                <a:lnTo>
                  <a:pt x="4354140" y="617816"/>
                </a:lnTo>
                <a:lnTo>
                  <a:pt x="4358520" y="617816"/>
                </a:lnTo>
                <a:lnTo>
                  <a:pt x="4358520" y="622883"/>
                </a:lnTo>
                <a:lnTo>
                  <a:pt x="4383708" y="622883"/>
                </a:lnTo>
                <a:lnTo>
                  <a:pt x="4383708" y="627951"/>
                </a:lnTo>
                <a:lnTo>
                  <a:pt x="4393564" y="627951"/>
                </a:lnTo>
                <a:lnTo>
                  <a:pt x="4393564" y="633019"/>
                </a:lnTo>
                <a:lnTo>
                  <a:pt x="4396849" y="633019"/>
                </a:lnTo>
                <a:lnTo>
                  <a:pt x="4396849" y="638099"/>
                </a:lnTo>
                <a:lnTo>
                  <a:pt x="4429702" y="638099"/>
                </a:lnTo>
                <a:lnTo>
                  <a:pt x="4429702" y="643197"/>
                </a:lnTo>
                <a:lnTo>
                  <a:pt x="4432987" y="643197"/>
                </a:lnTo>
                <a:lnTo>
                  <a:pt x="4432987" y="648301"/>
                </a:lnTo>
                <a:lnTo>
                  <a:pt x="4437368" y="648301"/>
                </a:lnTo>
                <a:lnTo>
                  <a:pt x="4437368" y="653427"/>
                </a:lnTo>
                <a:lnTo>
                  <a:pt x="4460365" y="653427"/>
                </a:lnTo>
                <a:lnTo>
                  <a:pt x="4460365" y="658557"/>
                </a:lnTo>
                <a:lnTo>
                  <a:pt x="4504169" y="658557"/>
                </a:lnTo>
                <a:lnTo>
                  <a:pt x="4504169" y="663695"/>
                </a:lnTo>
                <a:lnTo>
                  <a:pt x="4507455" y="663695"/>
                </a:lnTo>
                <a:lnTo>
                  <a:pt x="4507455" y="668852"/>
                </a:lnTo>
                <a:lnTo>
                  <a:pt x="4510740" y="668852"/>
                </a:lnTo>
                <a:lnTo>
                  <a:pt x="4510740" y="674016"/>
                </a:lnTo>
                <a:lnTo>
                  <a:pt x="4568780" y="674016"/>
                </a:lnTo>
                <a:lnTo>
                  <a:pt x="4568780" y="679194"/>
                </a:lnTo>
                <a:lnTo>
                  <a:pt x="4589587" y="679194"/>
                </a:lnTo>
                <a:lnTo>
                  <a:pt x="4589587" y="684410"/>
                </a:lnTo>
                <a:lnTo>
                  <a:pt x="4607109" y="684410"/>
                </a:lnTo>
                <a:lnTo>
                  <a:pt x="4607109" y="689640"/>
                </a:lnTo>
                <a:lnTo>
                  <a:pt x="4609299" y="689640"/>
                </a:lnTo>
                <a:lnTo>
                  <a:pt x="4609299" y="694874"/>
                </a:lnTo>
                <a:lnTo>
                  <a:pt x="4624631" y="694874"/>
                </a:lnTo>
                <a:lnTo>
                  <a:pt x="4624631" y="705390"/>
                </a:lnTo>
                <a:lnTo>
                  <a:pt x="4639962" y="705390"/>
                </a:lnTo>
                <a:lnTo>
                  <a:pt x="4639962" y="710652"/>
                </a:lnTo>
                <a:lnTo>
                  <a:pt x="4647628" y="710652"/>
                </a:lnTo>
                <a:lnTo>
                  <a:pt x="4647628" y="710652"/>
                </a:lnTo>
                <a:lnTo>
                  <a:pt x="4653104" y="710652"/>
                </a:lnTo>
                <a:lnTo>
                  <a:pt x="4653104" y="715943"/>
                </a:lnTo>
                <a:lnTo>
                  <a:pt x="4679386" y="715943"/>
                </a:lnTo>
                <a:lnTo>
                  <a:pt x="4679386" y="715943"/>
                </a:lnTo>
                <a:lnTo>
                  <a:pt x="4701288" y="715943"/>
                </a:lnTo>
                <a:lnTo>
                  <a:pt x="4701288" y="721252"/>
                </a:lnTo>
                <a:lnTo>
                  <a:pt x="4727571" y="721252"/>
                </a:lnTo>
                <a:lnTo>
                  <a:pt x="4727571" y="726566"/>
                </a:lnTo>
                <a:lnTo>
                  <a:pt x="4754948" y="726566"/>
                </a:lnTo>
                <a:lnTo>
                  <a:pt x="4754948" y="731912"/>
                </a:lnTo>
                <a:lnTo>
                  <a:pt x="4759329" y="731912"/>
                </a:lnTo>
                <a:lnTo>
                  <a:pt x="4759329" y="737262"/>
                </a:lnTo>
                <a:lnTo>
                  <a:pt x="4768090" y="737262"/>
                </a:lnTo>
                <a:lnTo>
                  <a:pt x="4768090" y="742619"/>
                </a:lnTo>
                <a:lnTo>
                  <a:pt x="4769185" y="742619"/>
                </a:lnTo>
                <a:lnTo>
                  <a:pt x="4769185" y="748000"/>
                </a:lnTo>
                <a:lnTo>
                  <a:pt x="4771375" y="748000"/>
                </a:lnTo>
                <a:lnTo>
                  <a:pt x="4771375" y="753392"/>
                </a:lnTo>
                <a:lnTo>
                  <a:pt x="4774660" y="753392"/>
                </a:lnTo>
                <a:lnTo>
                  <a:pt x="4774660" y="758791"/>
                </a:lnTo>
                <a:lnTo>
                  <a:pt x="4784516" y="758791"/>
                </a:lnTo>
                <a:lnTo>
                  <a:pt x="4784516" y="764196"/>
                </a:lnTo>
                <a:lnTo>
                  <a:pt x="4786706" y="764196"/>
                </a:lnTo>
                <a:lnTo>
                  <a:pt x="4786706" y="769611"/>
                </a:lnTo>
                <a:lnTo>
                  <a:pt x="4803133" y="769611"/>
                </a:lnTo>
                <a:lnTo>
                  <a:pt x="4803133" y="775047"/>
                </a:lnTo>
                <a:lnTo>
                  <a:pt x="4809704" y="775047"/>
                </a:lnTo>
                <a:lnTo>
                  <a:pt x="4809704" y="780486"/>
                </a:lnTo>
                <a:lnTo>
                  <a:pt x="4821750" y="780486"/>
                </a:lnTo>
                <a:lnTo>
                  <a:pt x="4821750" y="785934"/>
                </a:lnTo>
                <a:lnTo>
                  <a:pt x="4829416" y="785934"/>
                </a:lnTo>
                <a:lnTo>
                  <a:pt x="4829416" y="785934"/>
                </a:lnTo>
                <a:lnTo>
                  <a:pt x="4831606" y="785934"/>
                </a:lnTo>
                <a:lnTo>
                  <a:pt x="4831606" y="785934"/>
                </a:lnTo>
                <a:lnTo>
                  <a:pt x="4838176" y="785934"/>
                </a:lnTo>
                <a:lnTo>
                  <a:pt x="4838176" y="791392"/>
                </a:lnTo>
                <a:lnTo>
                  <a:pt x="4842557" y="791392"/>
                </a:lnTo>
                <a:lnTo>
                  <a:pt x="4842557" y="796867"/>
                </a:lnTo>
                <a:lnTo>
                  <a:pt x="4845842" y="796867"/>
                </a:lnTo>
                <a:lnTo>
                  <a:pt x="4845842" y="802349"/>
                </a:lnTo>
                <a:lnTo>
                  <a:pt x="4849128" y="802349"/>
                </a:lnTo>
                <a:lnTo>
                  <a:pt x="4849128" y="807885"/>
                </a:lnTo>
                <a:lnTo>
                  <a:pt x="4875410" y="807885"/>
                </a:lnTo>
                <a:lnTo>
                  <a:pt x="4875410" y="813425"/>
                </a:lnTo>
                <a:lnTo>
                  <a:pt x="4912644" y="813425"/>
                </a:lnTo>
                <a:lnTo>
                  <a:pt x="4912644" y="819007"/>
                </a:lnTo>
                <a:lnTo>
                  <a:pt x="4942211" y="819007"/>
                </a:lnTo>
                <a:lnTo>
                  <a:pt x="4942211" y="824615"/>
                </a:lnTo>
                <a:lnTo>
                  <a:pt x="4959733" y="824615"/>
                </a:lnTo>
                <a:lnTo>
                  <a:pt x="4959733" y="830236"/>
                </a:lnTo>
                <a:lnTo>
                  <a:pt x="4970684" y="830236"/>
                </a:lnTo>
                <a:lnTo>
                  <a:pt x="4970684" y="835870"/>
                </a:lnTo>
                <a:lnTo>
                  <a:pt x="4996967" y="835870"/>
                </a:lnTo>
                <a:lnTo>
                  <a:pt x="4996967" y="835870"/>
                </a:lnTo>
                <a:lnTo>
                  <a:pt x="5013393" y="835870"/>
                </a:lnTo>
                <a:lnTo>
                  <a:pt x="5013393" y="841513"/>
                </a:lnTo>
                <a:lnTo>
                  <a:pt x="5030915" y="841513"/>
                </a:lnTo>
                <a:lnTo>
                  <a:pt x="5030915" y="847158"/>
                </a:lnTo>
                <a:lnTo>
                  <a:pt x="5044056" y="847158"/>
                </a:lnTo>
                <a:lnTo>
                  <a:pt x="5044056" y="852812"/>
                </a:lnTo>
                <a:lnTo>
                  <a:pt x="5053912" y="852812"/>
                </a:lnTo>
                <a:lnTo>
                  <a:pt x="5053912" y="858479"/>
                </a:lnTo>
                <a:lnTo>
                  <a:pt x="5057198" y="858479"/>
                </a:lnTo>
                <a:lnTo>
                  <a:pt x="5057198" y="864153"/>
                </a:lnTo>
                <a:lnTo>
                  <a:pt x="5094431" y="864153"/>
                </a:lnTo>
                <a:lnTo>
                  <a:pt x="5094431" y="869831"/>
                </a:lnTo>
                <a:lnTo>
                  <a:pt x="5097716" y="869831"/>
                </a:lnTo>
                <a:lnTo>
                  <a:pt x="5097716" y="869831"/>
                </a:lnTo>
                <a:lnTo>
                  <a:pt x="5109763" y="869831"/>
                </a:lnTo>
                <a:lnTo>
                  <a:pt x="5109763" y="875535"/>
                </a:lnTo>
                <a:lnTo>
                  <a:pt x="5113048" y="875535"/>
                </a:lnTo>
                <a:lnTo>
                  <a:pt x="5113048" y="881258"/>
                </a:lnTo>
                <a:lnTo>
                  <a:pt x="5125094" y="881258"/>
                </a:lnTo>
                <a:lnTo>
                  <a:pt x="5125094" y="887001"/>
                </a:lnTo>
                <a:lnTo>
                  <a:pt x="5137140" y="887001"/>
                </a:lnTo>
                <a:lnTo>
                  <a:pt x="5137140" y="892754"/>
                </a:lnTo>
                <a:lnTo>
                  <a:pt x="5165613" y="892754"/>
                </a:lnTo>
                <a:lnTo>
                  <a:pt x="5165613" y="898526"/>
                </a:lnTo>
                <a:lnTo>
                  <a:pt x="5169993" y="898526"/>
                </a:lnTo>
                <a:lnTo>
                  <a:pt x="5169993" y="904300"/>
                </a:lnTo>
                <a:lnTo>
                  <a:pt x="5173279" y="904300"/>
                </a:lnTo>
                <a:lnTo>
                  <a:pt x="5173279" y="910093"/>
                </a:lnTo>
                <a:lnTo>
                  <a:pt x="5177659" y="910093"/>
                </a:lnTo>
                <a:lnTo>
                  <a:pt x="5177659" y="910093"/>
                </a:lnTo>
                <a:lnTo>
                  <a:pt x="5210512" y="910093"/>
                </a:lnTo>
                <a:lnTo>
                  <a:pt x="5210512" y="915899"/>
                </a:lnTo>
                <a:lnTo>
                  <a:pt x="5219273" y="915899"/>
                </a:lnTo>
                <a:lnTo>
                  <a:pt x="5219273" y="921734"/>
                </a:lnTo>
                <a:lnTo>
                  <a:pt x="5258697" y="921734"/>
                </a:lnTo>
                <a:lnTo>
                  <a:pt x="5258697" y="921734"/>
                </a:lnTo>
                <a:lnTo>
                  <a:pt x="5264173" y="921734"/>
                </a:lnTo>
                <a:lnTo>
                  <a:pt x="5264173" y="927580"/>
                </a:lnTo>
                <a:lnTo>
                  <a:pt x="5282789" y="927580"/>
                </a:lnTo>
                <a:lnTo>
                  <a:pt x="5282789" y="933436"/>
                </a:lnTo>
                <a:lnTo>
                  <a:pt x="5286075" y="933436"/>
                </a:lnTo>
                <a:lnTo>
                  <a:pt x="5286075" y="939303"/>
                </a:lnTo>
                <a:lnTo>
                  <a:pt x="5293740" y="939303"/>
                </a:lnTo>
                <a:lnTo>
                  <a:pt x="5293740" y="939303"/>
                </a:lnTo>
                <a:lnTo>
                  <a:pt x="5297026" y="939303"/>
                </a:lnTo>
                <a:lnTo>
                  <a:pt x="5297026" y="945183"/>
                </a:lnTo>
                <a:lnTo>
                  <a:pt x="5300311" y="945183"/>
                </a:lnTo>
                <a:lnTo>
                  <a:pt x="5300311" y="951076"/>
                </a:lnTo>
                <a:lnTo>
                  <a:pt x="5323308" y="951076"/>
                </a:lnTo>
                <a:lnTo>
                  <a:pt x="5323308" y="956994"/>
                </a:lnTo>
                <a:lnTo>
                  <a:pt x="5345210" y="956994"/>
                </a:lnTo>
                <a:lnTo>
                  <a:pt x="5345210" y="962933"/>
                </a:lnTo>
                <a:lnTo>
                  <a:pt x="5357257" y="962933"/>
                </a:lnTo>
                <a:lnTo>
                  <a:pt x="5357257" y="968876"/>
                </a:lnTo>
                <a:lnTo>
                  <a:pt x="5362732" y="968876"/>
                </a:lnTo>
                <a:lnTo>
                  <a:pt x="5362732" y="974871"/>
                </a:lnTo>
                <a:lnTo>
                  <a:pt x="5403251" y="974871"/>
                </a:lnTo>
                <a:lnTo>
                  <a:pt x="5403251" y="980912"/>
                </a:lnTo>
                <a:lnTo>
                  <a:pt x="5426248" y="980912"/>
                </a:lnTo>
                <a:lnTo>
                  <a:pt x="5426248" y="986970"/>
                </a:lnTo>
                <a:lnTo>
                  <a:pt x="5429534" y="986970"/>
                </a:lnTo>
                <a:lnTo>
                  <a:pt x="5429534" y="993056"/>
                </a:lnTo>
                <a:lnTo>
                  <a:pt x="5459101" y="993056"/>
                </a:lnTo>
                <a:lnTo>
                  <a:pt x="5459101" y="999146"/>
                </a:lnTo>
                <a:lnTo>
                  <a:pt x="5464577" y="999146"/>
                </a:lnTo>
                <a:lnTo>
                  <a:pt x="5464577" y="1005248"/>
                </a:lnTo>
                <a:lnTo>
                  <a:pt x="5475528" y="1005248"/>
                </a:lnTo>
                <a:lnTo>
                  <a:pt x="5475528" y="1011365"/>
                </a:lnTo>
                <a:lnTo>
                  <a:pt x="5491955" y="1011365"/>
                </a:lnTo>
                <a:lnTo>
                  <a:pt x="5491955" y="1017512"/>
                </a:lnTo>
                <a:lnTo>
                  <a:pt x="5497430" y="1017512"/>
                </a:lnTo>
                <a:lnTo>
                  <a:pt x="5497430" y="1023684"/>
                </a:lnTo>
                <a:lnTo>
                  <a:pt x="5498525" y="1023684"/>
                </a:lnTo>
                <a:lnTo>
                  <a:pt x="5498525" y="1029894"/>
                </a:lnTo>
                <a:lnTo>
                  <a:pt x="5504001" y="1029894"/>
                </a:lnTo>
                <a:lnTo>
                  <a:pt x="5504001" y="1036123"/>
                </a:lnTo>
                <a:lnTo>
                  <a:pt x="5521522" y="1036123"/>
                </a:lnTo>
                <a:lnTo>
                  <a:pt x="5521522" y="1042365"/>
                </a:lnTo>
                <a:lnTo>
                  <a:pt x="5522618" y="1042365"/>
                </a:lnTo>
                <a:lnTo>
                  <a:pt x="5522618" y="1048620"/>
                </a:lnTo>
                <a:lnTo>
                  <a:pt x="5528093" y="1048620"/>
                </a:lnTo>
                <a:lnTo>
                  <a:pt x="5528093" y="1054884"/>
                </a:lnTo>
                <a:lnTo>
                  <a:pt x="5591609" y="1054884"/>
                </a:lnTo>
                <a:lnTo>
                  <a:pt x="5591609" y="1061159"/>
                </a:lnTo>
                <a:lnTo>
                  <a:pt x="5603655" y="1061159"/>
                </a:lnTo>
                <a:lnTo>
                  <a:pt x="5603655" y="1067439"/>
                </a:lnTo>
                <a:lnTo>
                  <a:pt x="5634318" y="1067439"/>
                </a:lnTo>
                <a:lnTo>
                  <a:pt x="5634318" y="1073737"/>
                </a:lnTo>
                <a:lnTo>
                  <a:pt x="5637604" y="1073737"/>
                </a:lnTo>
                <a:lnTo>
                  <a:pt x="5637604" y="1073737"/>
                </a:lnTo>
                <a:lnTo>
                  <a:pt x="5656220" y="1073737"/>
                </a:lnTo>
                <a:lnTo>
                  <a:pt x="5656220" y="1080071"/>
                </a:lnTo>
                <a:lnTo>
                  <a:pt x="5657316" y="1080071"/>
                </a:lnTo>
                <a:lnTo>
                  <a:pt x="5657316" y="1086415"/>
                </a:lnTo>
                <a:lnTo>
                  <a:pt x="5667171" y="1086415"/>
                </a:lnTo>
                <a:lnTo>
                  <a:pt x="5667171" y="1092765"/>
                </a:lnTo>
                <a:lnTo>
                  <a:pt x="5696739" y="1092765"/>
                </a:lnTo>
                <a:lnTo>
                  <a:pt x="5696739" y="1099123"/>
                </a:lnTo>
                <a:lnTo>
                  <a:pt x="5709881" y="1099123"/>
                </a:lnTo>
                <a:lnTo>
                  <a:pt x="5709881" y="1105496"/>
                </a:lnTo>
                <a:lnTo>
                  <a:pt x="5758065" y="1105496"/>
                </a:lnTo>
                <a:lnTo>
                  <a:pt x="5758065" y="1111870"/>
                </a:lnTo>
                <a:lnTo>
                  <a:pt x="5781062" y="1111870"/>
                </a:lnTo>
                <a:lnTo>
                  <a:pt x="5781062" y="1118276"/>
                </a:lnTo>
                <a:lnTo>
                  <a:pt x="5784348" y="1118276"/>
                </a:lnTo>
                <a:lnTo>
                  <a:pt x="5784348" y="1118276"/>
                </a:lnTo>
                <a:lnTo>
                  <a:pt x="5821581" y="1118276"/>
                </a:lnTo>
                <a:lnTo>
                  <a:pt x="5821581" y="1124704"/>
                </a:lnTo>
                <a:lnTo>
                  <a:pt x="5827057" y="1124704"/>
                </a:lnTo>
                <a:lnTo>
                  <a:pt x="5827057" y="1131141"/>
                </a:lnTo>
                <a:lnTo>
                  <a:pt x="5828152" y="1131141"/>
                </a:lnTo>
                <a:lnTo>
                  <a:pt x="5828152" y="1137590"/>
                </a:lnTo>
                <a:lnTo>
                  <a:pt x="5836913" y="1137590"/>
                </a:lnTo>
                <a:lnTo>
                  <a:pt x="5836913" y="1144044"/>
                </a:lnTo>
                <a:lnTo>
                  <a:pt x="5850054" y="1144044"/>
                </a:lnTo>
                <a:lnTo>
                  <a:pt x="5850054" y="1150506"/>
                </a:lnTo>
                <a:lnTo>
                  <a:pt x="5855530" y="1150506"/>
                </a:lnTo>
                <a:lnTo>
                  <a:pt x="5855530" y="1157018"/>
                </a:lnTo>
                <a:lnTo>
                  <a:pt x="5859910" y="1157018"/>
                </a:lnTo>
                <a:lnTo>
                  <a:pt x="5859910" y="1163539"/>
                </a:lnTo>
                <a:lnTo>
                  <a:pt x="5865386" y="1163539"/>
                </a:lnTo>
                <a:lnTo>
                  <a:pt x="5865386" y="1170070"/>
                </a:lnTo>
                <a:lnTo>
                  <a:pt x="5869766" y="1170070"/>
                </a:lnTo>
                <a:lnTo>
                  <a:pt x="5869766" y="1176605"/>
                </a:lnTo>
                <a:lnTo>
                  <a:pt x="5870861" y="1176605"/>
                </a:lnTo>
                <a:lnTo>
                  <a:pt x="5870861" y="1189686"/>
                </a:lnTo>
                <a:lnTo>
                  <a:pt x="5878527" y="1189686"/>
                </a:lnTo>
                <a:lnTo>
                  <a:pt x="5878527" y="1196240"/>
                </a:lnTo>
                <a:lnTo>
                  <a:pt x="5891668" y="1196240"/>
                </a:lnTo>
                <a:lnTo>
                  <a:pt x="5891668" y="1202810"/>
                </a:lnTo>
                <a:lnTo>
                  <a:pt x="5898239" y="1202810"/>
                </a:lnTo>
                <a:lnTo>
                  <a:pt x="5898239" y="1209411"/>
                </a:lnTo>
                <a:lnTo>
                  <a:pt x="5916856" y="1209411"/>
                </a:lnTo>
                <a:lnTo>
                  <a:pt x="5916856" y="1216026"/>
                </a:lnTo>
                <a:lnTo>
                  <a:pt x="5942043" y="1216026"/>
                </a:lnTo>
                <a:lnTo>
                  <a:pt x="5942043" y="1222647"/>
                </a:lnTo>
                <a:lnTo>
                  <a:pt x="5954089" y="1222647"/>
                </a:lnTo>
                <a:lnTo>
                  <a:pt x="5954089" y="1229285"/>
                </a:lnTo>
                <a:lnTo>
                  <a:pt x="5957374" y="1229285"/>
                </a:lnTo>
                <a:lnTo>
                  <a:pt x="5957374" y="1235947"/>
                </a:lnTo>
                <a:lnTo>
                  <a:pt x="5980372" y="1235947"/>
                </a:lnTo>
                <a:lnTo>
                  <a:pt x="5980372" y="1242632"/>
                </a:lnTo>
                <a:lnTo>
                  <a:pt x="5982562" y="1242632"/>
                </a:lnTo>
                <a:lnTo>
                  <a:pt x="5982562" y="1249335"/>
                </a:lnTo>
                <a:lnTo>
                  <a:pt x="5996798" y="1249335"/>
                </a:lnTo>
                <a:lnTo>
                  <a:pt x="5996798" y="1256041"/>
                </a:lnTo>
                <a:lnTo>
                  <a:pt x="6001179" y="1256041"/>
                </a:lnTo>
                <a:lnTo>
                  <a:pt x="6001179" y="1262753"/>
                </a:lnTo>
                <a:lnTo>
                  <a:pt x="6006654" y="1262753"/>
                </a:lnTo>
                <a:lnTo>
                  <a:pt x="6006654" y="1269480"/>
                </a:lnTo>
                <a:lnTo>
                  <a:pt x="6028556" y="1269480"/>
                </a:lnTo>
                <a:lnTo>
                  <a:pt x="6028556" y="1269480"/>
                </a:lnTo>
                <a:lnTo>
                  <a:pt x="6038412" y="1269480"/>
                </a:lnTo>
                <a:lnTo>
                  <a:pt x="6038412" y="1276220"/>
                </a:lnTo>
                <a:lnTo>
                  <a:pt x="6040602" y="1276220"/>
                </a:lnTo>
                <a:lnTo>
                  <a:pt x="6040602" y="1282971"/>
                </a:lnTo>
                <a:lnTo>
                  <a:pt x="6044983" y="1282971"/>
                </a:lnTo>
                <a:lnTo>
                  <a:pt x="6044983" y="1289743"/>
                </a:lnTo>
                <a:lnTo>
                  <a:pt x="6089882" y="1289743"/>
                </a:lnTo>
                <a:lnTo>
                  <a:pt x="6089882" y="1296530"/>
                </a:lnTo>
                <a:lnTo>
                  <a:pt x="6104119" y="1296530"/>
                </a:lnTo>
                <a:lnTo>
                  <a:pt x="6104119" y="1303319"/>
                </a:lnTo>
                <a:lnTo>
                  <a:pt x="6121640" y="1303319"/>
                </a:lnTo>
                <a:lnTo>
                  <a:pt x="6121640" y="1310119"/>
                </a:lnTo>
                <a:lnTo>
                  <a:pt x="6161064" y="1310119"/>
                </a:lnTo>
                <a:lnTo>
                  <a:pt x="6161064" y="1316941"/>
                </a:lnTo>
                <a:lnTo>
                  <a:pt x="6164349" y="1316941"/>
                </a:lnTo>
                <a:lnTo>
                  <a:pt x="6164349" y="1323779"/>
                </a:lnTo>
                <a:lnTo>
                  <a:pt x="6166540" y="1323779"/>
                </a:lnTo>
                <a:lnTo>
                  <a:pt x="6166540" y="1330634"/>
                </a:lnTo>
                <a:lnTo>
                  <a:pt x="6170920" y="1330634"/>
                </a:lnTo>
                <a:lnTo>
                  <a:pt x="6170920" y="1337512"/>
                </a:lnTo>
                <a:lnTo>
                  <a:pt x="6235531" y="1337512"/>
                </a:lnTo>
                <a:lnTo>
                  <a:pt x="6235531" y="1344394"/>
                </a:lnTo>
                <a:lnTo>
                  <a:pt x="6239912" y="1344394"/>
                </a:lnTo>
                <a:lnTo>
                  <a:pt x="6239912" y="1351298"/>
                </a:lnTo>
                <a:lnTo>
                  <a:pt x="6259624" y="1351298"/>
                </a:lnTo>
                <a:lnTo>
                  <a:pt x="6259624" y="1358271"/>
                </a:lnTo>
                <a:lnTo>
                  <a:pt x="6270575" y="1358271"/>
                </a:lnTo>
                <a:lnTo>
                  <a:pt x="6270575" y="1365258"/>
                </a:lnTo>
                <a:lnTo>
                  <a:pt x="6272765" y="1365258"/>
                </a:lnTo>
                <a:lnTo>
                  <a:pt x="6272765" y="1372268"/>
                </a:lnTo>
                <a:lnTo>
                  <a:pt x="6285906" y="1372268"/>
                </a:lnTo>
                <a:lnTo>
                  <a:pt x="6285906" y="1379311"/>
                </a:lnTo>
                <a:lnTo>
                  <a:pt x="6288096" y="1379311"/>
                </a:lnTo>
                <a:lnTo>
                  <a:pt x="6288096" y="1386361"/>
                </a:lnTo>
                <a:lnTo>
                  <a:pt x="6308903" y="1386361"/>
                </a:lnTo>
                <a:lnTo>
                  <a:pt x="6308903" y="1393446"/>
                </a:lnTo>
                <a:lnTo>
                  <a:pt x="6316569" y="1393446"/>
                </a:lnTo>
                <a:lnTo>
                  <a:pt x="6316569" y="1400540"/>
                </a:lnTo>
                <a:lnTo>
                  <a:pt x="6331901" y="1400540"/>
                </a:lnTo>
                <a:lnTo>
                  <a:pt x="6331901" y="1407638"/>
                </a:lnTo>
                <a:lnTo>
                  <a:pt x="6339566" y="1407638"/>
                </a:lnTo>
                <a:lnTo>
                  <a:pt x="6339566" y="1414737"/>
                </a:lnTo>
                <a:lnTo>
                  <a:pt x="6342852" y="1414737"/>
                </a:lnTo>
                <a:lnTo>
                  <a:pt x="6342852" y="1421846"/>
                </a:lnTo>
                <a:lnTo>
                  <a:pt x="6346137" y="1421846"/>
                </a:lnTo>
                <a:lnTo>
                  <a:pt x="6346137" y="1428971"/>
                </a:lnTo>
                <a:lnTo>
                  <a:pt x="6358183" y="1428971"/>
                </a:lnTo>
                <a:lnTo>
                  <a:pt x="6358183" y="1436099"/>
                </a:lnTo>
                <a:lnTo>
                  <a:pt x="6384466" y="1436099"/>
                </a:lnTo>
                <a:lnTo>
                  <a:pt x="6384466" y="1450411"/>
                </a:lnTo>
                <a:lnTo>
                  <a:pt x="6391036" y="1450411"/>
                </a:lnTo>
                <a:lnTo>
                  <a:pt x="6391036" y="1457624"/>
                </a:lnTo>
                <a:lnTo>
                  <a:pt x="6397607" y="1457624"/>
                </a:lnTo>
                <a:lnTo>
                  <a:pt x="6397607" y="1464855"/>
                </a:lnTo>
                <a:lnTo>
                  <a:pt x="6412938" y="1464855"/>
                </a:lnTo>
                <a:lnTo>
                  <a:pt x="6412938" y="1472092"/>
                </a:lnTo>
                <a:lnTo>
                  <a:pt x="6426080" y="1472092"/>
                </a:lnTo>
                <a:lnTo>
                  <a:pt x="6426080" y="1479369"/>
                </a:lnTo>
                <a:lnTo>
                  <a:pt x="6427175" y="1479369"/>
                </a:lnTo>
                <a:lnTo>
                  <a:pt x="6427175" y="1486653"/>
                </a:lnTo>
                <a:lnTo>
                  <a:pt x="6430460" y="1486653"/>
                </a:lnTo>
                <a:lnTo>
                  <a:pt x="6430460" y="1493967"/>
                </a:lnTo>
                <a:lnTo>
                  <a:pt x="6442506" y="1493967"/>
                </a:lnTo>
                <a:lnTo>
                  <a:pt x="6442506" y="1501291"/>
                </a:lnTo>
                <a:lnTo>
                  <a:pt x="6445792" y="1501291"/>
                </a:lnTo>
                <a:lnTo>
                  <a:pt x="6445792" y="1508618"/>
                </a:lnTo>
                <a:lnTo>
                  <a:pt x="6446887" y="1508618"/>
                </a:lnTo>
                <a:lnTo>
                  <a:pt x="6446887" y="1515961"/>
                </a:lnTo>
                <a:lnTo>
                  <a:pt x="6450172" y="1515961"/>
                </a:lnTo>
                <a:lnTo>
                  <a:pt x="6450172" y="1523337"/>
                </a:lnTo>
                <a:lnTo>
                  <a:pt x="6452362" y="1523337"/>
                </a:lnTo>
                <a:lnTo>
                  <a:pt x="6452362" y="1523337"/>
                </a:lnTo>
                <a:lnTo>
                  <a:pt x="6456743" y="1523337"/>
                </a:lnTo>
                <a:lnTo>
                  <a:pt x="6456743" y="1530721"/>
                </a:lnTo>
                <a:lnTo>
                  <a:pt x="6463313" y="1530721"/>
                </a:lnTo>
                <a:lnTo>
                  <a:pt x="6463313" y="1538108"/>
                </a:lnTo>
                <a:lnTo>
                  <a:pt x="6466599" y="1538108"/>
                </a:lnTo>
                <a:lnTo>
                  <a:pt x="6466599" y="1545548"/>
                </a:lnTo>
                <a:lnTo>
                  <a:pt x="6475359" y="1545548"/>
                </a:lnTo>
                <a:lnTo>
                  <a:pt x="6475359" y="1552990"/>
                </a:lnTo>
                <a:lnTo>
                  <a:pt x="6495071" y="1552990"/>
                </a:lnTo>
                <a:lnTo>
                  <a:pt x="6495071" y="1560454"/>
                </a:lnTo>
                <a:lnTo>
                  <a:pt x="6496166" y="1560454"/>
                </a:lnTo>
                <a:lnTo>
                  <a:pt x="6496166" y="1567977"/>
                </a:lnTo>
                <a:lnTo>
                  <a:pt x="6497262" y="1567977"/>
                </a:lnTo>
                <a:lnTo>
                  <a:pt x="6497262" y="1575534"/>
                </a:lnTo>
                <a:lnTo>
                  <a:pt x="6523544" y="1575534"/>
                </a:lnTo>
                <a:lnTo>
                  <a:pt x="6523544" y="1583100"/>
                </a:lnTo>
                <a:lnTo>
                  <a:pt x="6525734" y="1583100"/>
                </a:lnTo>
                <a:lnTo>
                  <a:pt x="6525734" y="1590718"/>
                </a:lnTo>
                <a:lnTo>
                  <a:pt x="6570634" y="1590718"/>
                </a:lnTo>
                <a:lnTo>
                  <a:pt x="6570634" y="1605970"/>
                </a:lnTo>
                <a:lnTo>
                  <a:pt x="6589250" y="1605970"/>
                </a:lnTo>
                <a:lnTo>
                  <a:pt x="6589250" y="1613612"/>
                </a:lnTo>
                <a:lnTo>
                  <a:pt x="6616628" y="1613612"/>
                </a:lnTo>
                <a:lnTo>
                  <a:pt x="6616628" y="1621269"/>
                </a:lnTo>
                <a:lnTo>
                  <a:pt x="6648386" y="1621269"/>
                </a:lnTo>
                <a:lnTo>
                  <a:pt x="6648386" y="1628934"/>
                </a:lnTo>
                <a:lnTo>
                  <a:pt x="6658242" y="1628934"/>
                </a:lnTo>
                <a:lnTo>
                  <a:pt x="6658242" y="1636626"/>
                </a:lnTo>
                <a:lnTo>
                  <a:pt x="6675764" y="1636626"/>
                </a:lnTo>
                <a:lnTo>
                  <a:pt x="6675764" y="1644322"/>
                </a:lnTo>
                <a:lnTo>
                  <a:pt x="6695476" y="1644322"/>
                </a:lnTo>
                <a:lnTo>
                  <a:pt x="6695476" y="1652030"/>
                </a:lnTo>
                <a:lnTo>
                  <a:pt x="6696571" y="1652030"/>
                </a:lnTo>
                <a:lnTo>
                  <a:pt x="6696571" y="1659775"/>
                </a:lnTo>
                <a:lnTo>
                  <a:pt x="6698761" y="1659775"/>
                </a:lnTo>
                <a:lnTo>
                  <a:pt x="6698761" y="1667546"/>
                </a:lnTo>
                <a:lnTo>
                  <a:pt x="6700951" y="1667546"/>
                </a:lnTo>
                <a:lnTo>
                  <a:pt x="6700951" y="1675328"/>
                </a:lnTo>
                <a:lnTo>
                  <a:pt x="6703141" y="1675328"/>
                </a:lnTo>
                <a:lnTo>
                  <a:pt x="6703141" y="1683148"/>
                </a:lnTo>
                <a:lnTo>
                  <a:pt x="6710807" y="1683148"/>
                </a:lnTo>
                <a:lnTo>
                  <a:pt x="6710807" y="1690982"/>
                </a:lnTo>
                <a:lnTo>
                  <a:pt x="6752421" y="1690982"/>
                </a:lnTo>
                <a:lnTo>
                  <a:pt x="6752421" y="1698828"/>
                </a:lnTo>
                <a:lnTo>
                  <a:pt x="6755707" y="1698828"/>
                </a:lnTo>
                <a:lnTo>
                  <a:pt x="6755707" y="1714623"/>
                </a:lnTo>
                <a:lnTo>
                  <a:pt x="6765562" y="1714623"/>
                </a:lnTo>
                <a:lnTo>
                  <a:pt x="6765562" y="1722558"/>
                </a:lnTo>
                <a:lnTo>
                  <a:pt x="6789655" y="1722558"/>
                </a:lnTo>
                <a:lnTo>
                  <a:pt x="6789655" y="1730501"/>
                </a:lnTo>
                <a:lnTo>
                  <a:pt x="6791845" y="1730501"/>
                </a:lnTo>
                <a:lnTo>
                  <a:pt x="6791845" y="1738480"/>
                </a:lnTo>
                <a:lnTo>
                  <a:pt x="6796225" y="1738480"/>
                </a:lnTo>
                <a:lnTo>
                  <a:pt x="6796225" y="1746476"/>
                </a:lnTo>
                <a:lnTo>
                  <a:pt x="6797321" y="1746476"/>
                </a:lnTo>
                <a:lnTo>
                  <a:pt x="6797321" y="1754483"/>
                </a:lnTo>
                <a:lnTo>
                  <a:pt x="6800606" y="1754483"/>
                </a:lnTo>
                <a:lnTo>
                  <a:pt x="6800606" y="1762494"/>
                </a:lnTo>
                <a:lnTo>
                  <a:pt x="6820318" y="1762494"/>
                </a:lnTo>
                <a:lnTo>
                  <a:pt x="6820318" y="1770513"/>
                </a:lnTo>
                <a:lnTo>
                  <a:pt x="6827983" y="1770513"/>
                </a:lnTo>
                <a:lnTo>
                  <a:pt x="6827983" y="1778560"/>
                </a:lnTo>
                <a:lnTo>
                  <a:pt x="6855361" y="1778560"/>
                </a:lnTo>
                <a:lnTo>
                  <a:pt x="6855361" y="1786620"/>
                </a:lnTo>
                <a:lnTo>
                  <a:pt x="6860837" y="1786620"/>
                </a:lnTo>
                <a:lnTo>
                  <a:pt x="6860837" y="1794687"/>
                </a:lnTo>
                <a:lnTo>
                  <a:pt x="6869598" y="1794687"/>
                </a:lnTo>
                <a:lnTo>
                  <a:pt x="6869598" y="1802768"/>
                </a:lnTo>
                <a:lnTo>
                  <a:pt x="6881644" y="1802768"/>
                </a:lnTo>
                <a:lnTo>
                  <a:pt x="6881644" y="1810878"/>
                </a:lnTo>
                <a:lnTo>
                  <a:pt x="6899165" y="1810878"/>
                </a:lnTo>
                <a:lnTo>
                  <a:pt x="6899165" y="1819030"/>
                </a:lnTo>
                <a:lnTo>
                  <a:pt x="6903546" y="1819030"/>
                </a:lnTo>
                <a:lnTo>
                  <a:pt x="6903546" y="1827193"/>
                </a:lnTo>
                <a:lnTo>
                  <a:pt x="6930923" y="1827193"/>
                </a:lnTo>
                <a:lnTo>
                  <a:pt x="6930923" y="1835383"/>
                </a:lnTo>
                <a:lnTo>
                  <a:pt x="6934209" y="1835383"/>
                </a:lnTo>
                <a:lnTo>
                  <a:pt x="6934209" y="1843584"/>
                </a:lnTo>
                <a:lnTo>
                  <a:pt x="6944065" y="1843584"/>
                </a:lnTo>
                <a:lnTo>
                  <a:pt x="6944065" y="1851836"/>
                </a:lnTo>
                <a:lnTo>
                  <a:pt x="6951730" y="1851836"/>
                </a:lnTo>
                <a:lnTo>
                  <a:pt x="6951730" y="1860119"/>
                </a:lnTo>
                <a:lnTo>
                  <a:pt x="6952826" y="1860119"/>
                </a:lnTo>
                <a:lnTo>
                  <a:pt x="6952826" y="1868408"/>
                </a:lnTo>
                <a:lnTo>
                  <a:pt x="6960491" y="1868408"/>
                </a:lnTo>
                <a:lnTo>
                  <a:pt x="6960491" y="1876698"/>
                </a:lnTo>
                <a:lnTo>
                  <a:pt x="6970347" y="1876698"/>
                </a:lnTo>
                <a:lnTo>
                  <a:pt x="6970347" y="1885012"/>
                </a:lnTo>
                <a:lnTo>
                  <a:pt x="6978013" y="1885012"/>
                </a:lnTo>
                <a:lnTo>
                  <a:pt x="6978013" y="1893356"/>
                </a:lnTo>
                <a:lnTo>
                  <a:pt x="6993344" y="1893356"/>
                </a:lnTo>
                <a:lnTo>
                  <a:pt x="6993344" y="1901720"/>
                </a:lnTo>
                <a:lnTo>
                  <a:pt x="7006486" y="1901720"/>
                </a:lnTo>
                <a:lnTo>
                  <a:pt x="7006486" y="1901720"/>
                </a:lnTo>
                <a:lnTo>
                  <a:pt x="7017437" y="1901720"/>
                </a:lnTo>
                <a:lnTo>
                  <a:pt x="7017437" y="1910109"/>
                </a:lnTo>
                <a:lnTo>
                  <a:pt x="7024007" y="1910109"/>
                </a:lnTo>
                <a:lnTo>
                  <a:pt x="7024007" y="1918533"/>
                </a:lnTo>
                <a:lnTo>
                  <a:pt x="7037149" y="1918533"/>
                </a:lnTo>
                <a:lnTo>
                  <a:pt x="7037149" y="1926975"/>
                </a:lnTo>
                <a:lnTo>
                  <a:pt x="7042624" y="1926975"/>
                </a:lnTo>
                <a:lnTo>
                  <a:pt x="7042624" y="1935431"/>
                </a:lnTo>
                <a:lnTo>
                  <a:pt x="7054670" y="1935431"/>
                </a:lnTo>
                <a:lnTo>
                  <a:pt x="7054670" y="1943906"/>
                </a:lnTo>
                <a:lnTo>
                  <a:pt x="7056861" y="1943906"/>
                </a:lnTo>
                <a:lnTo>
                  <a:pt x="7056861" y="1952419"/>
                </a:lnTo>
                <a:lnTo>
                  <a:pt x="7060146" y="1952419"/>
                </a:lnTo>
                <a:lnTo>
                  <a:pt x="7060146" y="1960942"/>
                </a:lnTo>
                <a:lnTo>
                  <a:pt x="7066717" y="1960942"/>
                </a:lnTo>
                <a:lnTo>
                  <a:pt x="7066717" y="1969484"/>
                </a:lnTo>
                <a:lnTo>
                  <a:pt x="7071097" y="1969484"/>
                </a:lnTo>
                <a:lnTo>
                  <a:pt x="7071097" y="1969484"/>
                </a:lnTo>
                <a:lnTo>
                  <a:pt x="7080953" y="1969484"/>
                </a:lnTo>
                <a:lnTo>
                  <a:pt x="7080953" y="1978623"/>
                </a:lnTo>
                <a:lnTo>
                  <a:pt x="7092999" y="1978623"/>
                </a:lnTo>
                <a:lnTo>
                  <a:pt x="7092999" y="1978623"/>
                </a:lnTo>
                <a:lnTo>
                  <a:pt x="7097379" y="1978623"/>
                </a:lnTo>
                <a:lnTo>
                  <a:pt x="7097379" y="1978623"/>
                </a:lnTo>
                <a:lnTo>
                  <a:pt x="7103950" y="1978623"/>
                </a:lnTo>
                <a:lnTo>
                  <a:pt x="7103950" y="1988949"/>
                </a:lnTo>
                <a:lnTo>
                  <a:pt x="7107235" y="1988949"/>
                </a:lnTo>
                <a:lnTo>
                  <a:pt x="7107235" y="1988949"/>
                </a:lnTo>
                <a:lnTo>
                  <a:pt x="7110521" y="1988949"/>
                </a:lnTo>
                <a:lnTo>
                  <a:pt x="7110521" y="1999679"/>
                </a:lnTo>
                <a:lnTo>
                  <a:pt x="7112711" y="1999679"/>
                </a:lnTo>
                <a:lnTo>
                  <a:pt x="7112711" y="1999679"/>
                </a:lnTo>
                <a:lnTo>
                  <a:pt x="7122567" y="1999679"/>
                </a:lnTo>
                <a:lnTo>
                  <a:pt x="7122567" y="2010929"/>
                </a:lnTo>
                <a:lnTo>
                  <a:pt x="7128042" y="2010929"/>
                </a:lnTo>
                <a:lnTo>
                  <a:pt x="7128042" y="2022234"/>
                </a:lnTo>
                <a:lnTo>
                  <a:pt x="7129138" y="2022234"/>
                </a:lnTo>
                <a:lnTo>
                  <a:pt x="7129138" y="2022234"/>
                </a:lnTo>
                <a:lnTo>
                  <a:pt x="7130233" y="2022234"/>
                </a:lnTo>
                <a:lnTo>
                  <a:pt x="7130233" y="2034702"/>
                </a:lnTo>
                <a:lnTo>
                  <a:pt x="7135708" y="2034702"/>
                </a:lnTo>
                <a:lnTo>
                  <a:pt x="7135708" y="2034702"/>
                </a:lnTo>
                <a:lnTo>
                  <a:pt x="7140089" y="2034702"/>
                </a:lnTo>
                <a:lnTo>
                  <a:pt x="7140089" y="2048032"/>
                </a:lnTo>
                <a:lnTo>
                  <a:pt x="7149945" y="2048032"/>
                </a:lnTo>
                <a:lnTo>
                  <a:pt x="7149945" y="2048032"/>
                </a:lnTo>
                <a:lnTo>
                  <a:pt x="7151040" y="2048032"/>
                </a:lnTo>
                <a:lnTo>
                  <a:pt x="7151040" y="2048032"/>
                </a:lnTo>
                <a:lnTo>
                  <a:pt x="7152135" y="2048032"/>
                </a:lnTo>
                <a:lnTo>
                  <a:pt x="7152135" y="2048032"/>
                </a:lnTo>
                <a:lnTo>
                  <a:pt x="7154325" y="2048032"/>
                </a:lnTo>
                <a:lnTo>
                  <a:pt x="7154325" y="2065568"/>
                </a:lnTo>
                <a:lnTo>
                  <a:pt x="7159801" y="2065568"/>
                </a:lnTo>
                <a:lnTo>
                  <a:pt x="7159801" y="2065568"/>
                </a:lnTo>
                <a:lnTo>
                  <a:pt x="7169656" y="2065568"/>
                </a:lnTo>
                <a:lnTo>
                  <a:pt x="7169656" y="2084791"/>
                </a:lnTo>
                <a:lnTo>
                  <a:pt x="7179512" y="2084791"/>
                </a:lnTo>
                <a:lnTo>
                  <a:pt x="7179512" y="2084791"/>
                </a:lnTo>
                <a:lnTo>
                  <a:pt x="7181703" y="2084791"/>
                </a:lnTo>
                <a:lnTo>
                  <a:pt x="7181703" y="2084791"/>
                </a:lnTo>
                <a:lnTo>
                  <a:pt x="7182798" y="2084791"/>
                </a:lnTo>
                <a:lnTo>
                  <a:pt x="7182798" y="2084791"/>
                </a:lnTo>
                <a:lnTo>
                  <a:pt x="7202510" y="2084791"/>
                </a:lnTo>
                <a:lnTo>
                  <a:pt x="7202510" y="2084791"/>
                </a:lnTo>
                <a:lnTo>
                  <a:pt x="7203605" y="2084791"/>
                </a:lnTo>
                <a:lnTo>
                  <a:pt x="7203605" y="2084791"/>
                </a:lnTo>
                <a:lnTo>
                  <a:pt x="7205795" y="2084791"/>
                </a:lnTo>
                <a:lnTo>
                  <a:pt x="7205795" y="2084791"/>
                </a:lnTo>
                <a:lnTo>
                  <a:pt x="7212366" y="2084791"/>
                </a:lnTo>
                <a:lnTo>
                  <a:pt x="7212366" y="2084791"/>
                </a:lnTo>
                <a:lnTo>
                  <a:pt x="7220031" y="2084791"/>
                </a:lnTo>
                <a:lnTo>
                  <a:pt x="7220031" y="2084791"/>
                </a:lnTo>
                <a:lnTo>
                  <a:pt x="7221126" y="2084791"/>
                </a:lnTo>
                <a:lnTo>
                  <a:pt x="7221126" y="2084791"/>
                </a:lnTo>
                <a:lnTo>
                  <a:pt x="7227697" y="2084791"/>
                </a:lnTo>
                <a:lnTo>
                  <a:pt x="7227697" y="2084791"/>
                </a:lnTo>
              </a:path>
            </a:pathLst>
          </a:custGeom>
          <a:ln w="21681" cap="flat">
            <a:solidFill>
              <a:schemeClr val="tx1"/>
            </a:solidFill>
            <a:prstDash val="sysDot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16" name="rc16"/>
          <p:cNvSpPr/>
          <p:nvPr/>
        </p:nvSpPr>
        <p:spPr>
          <a:xfrm>
            <a:off x="3705722" y="1622407"/>
            <a:ext cx="5062639" cy="3402988"/>
          </a:xfrm>
          <a:prstGeom prst="rect">
            <a:avLst/>
          </a:prstGeom>
          <a:ln w="18478" cap="rnd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17" name="tx17"/>
          <p:cNvSpPr/>
          <p:nvPr/>
        </p:nvSpPr>
        <p:spPr>
          <a:xfrm>
            <a:off x="3246591" y="4358995"/>
            <a:ext cx="404746" cy="110174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2000"/>
              </a:lnSpc>
            </a:pPr>
            <a:r>
              <a:rPr sz="1400" dirty="0">
                <a:solidFill>
                  <a:srgbClr val="4D4D4D">
                    <a:alpha val="100000"/>
                  </a:srgbClr>
                </a:solidFill>
                <a:latin typeface="Times"/>
                <a:cs typeface="Times"/>
              </a:rPr>
              <a:t>0.994</a:t>
            </a:r>
          </a:p>
        </p:txBody>
      </p:sp>
      <p:sp>
        <p:nvSpPr>
          <p:cNvPr id="18" name="tx18"/>
          <p:cNvSpPr/>
          <p:nvPr/>
        </p:nvSpPr>
        <p:spPr>
          <a:xfrm>
            <a:off x="3246591" y="3478931"/>
            <a:ext cx="404746" cy="110174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2000"/>
              </a:lnSpc>
            </a:pPr>
            <a:r>
              <a:rPr sz="1400">
                <a:solidFill>
                  <a:srgbClr val="4D4D4D">
                    <a:alpha val="100000"/>
                  </a:srgbClr>
                </a:solidFill>
                <a:latin typeface="Times"/>
                <a:cs typeface="Times"/>
              </a:rPr>
              <a:t>0.996</a:t>
            </a:r>
          </a:p>
        </p:txBody>
      </p:sp>
      <p:sp>
        <p:nvSpPr>
          <p:cNvPr id="19" name="tx19"/>
          <p:cNvSpPr/>
          <p:nvPr/>
        </p:nvSpPr>
        <p:spPr>
          <a:xfrm>
            <a:off x="3246591" y="2598867"/>
            <a:ext cx="404746" cy="110174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2000"/>
              </a:lnSpc>
            </a:pPr>
            <a:r>
              <a:rPr sz="1400">
                <a:solidFill>
                  <a:srgbClr val="4D4D4D">
                    <a:alpha val="100000"/>
                  </a:srgbClr>
                </a:solidFill>
                <a:latin typeface="Times"/>
                <a:cs typeface="Times"/>
              </a:rPr>
              <a:t>0.998</a:t>
            </a:r>
          </a:p>
        </p:txBody>
      </p:sp>
      <p:sp>
        <p:nvSpPr>
          <p:cNvPr id="20" name="tx20"/>
          <p:cNvSpPr/>
          <p:nvPr/>
        </p:nvSpPr>
        <p:spPr>
          <a:xfrm>
            <a:off x="3246591" y="1718803"/>
            <a:ext cx="404746" cy="110174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2000"/>
              </a:lnSpc>
            </a:pPr>
            <a:r>
              <a:rPr sz="1400" dirty="0">
                <a:solidFill>
                  <a:srgbClr val="4D4D4D">
                    <a:alpha val="100000"/>
                  </a:srgbClr>
                </a:solidFill>
                <a:latin typeface="Times"/>
                <a:cs typeface="Times"/>
              </a:rPr>
              <a:t>1.000</a:t>
            </a:r>
          </a:p>
        </p:txBody>
      </p:sp>
      <p:sp>
        <p:nvSpPr>
          <p:cNvPr id="21" name="pl21"/>
          <p:cNvSpPr/>
          <p:nvPr/>
        </p:nvSpPr>
        <p:spPr>
          <a:xfrm>
            <a:off x="3675509" y="4415223"/>
            <a:ext cx="30213" cy="0"/>
          </a:xfrm>
          <a:custGeom>
            <a:avLst/>
            <a:gdLst/>
            <a:ahLst/>
            <a:cxnLst/>
            <a:rect l="0" t="0" r="0" b="0"/>
            <a:pathLst>
              <a:path w="47447">
                <a:moveTo>
                  <a:pt x="0" y="0"/>
                </a:moveTo>
                <a:lnTo>
                  <a:pt x="47447" y="0"/>
                </a:lnTo>
              </a:path>
            </a:pathLst>
          </a:custGeom>
          <a:ln w="18478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22" name="pl22"/>
          <p:cNvSpPr/>
          <p:nvPr/>
        </p:nvSpPr>
        <p:spPr>
          <a:xfrm>
            <a:off x="3675509" y="3535158"/>
            <a:ext cx="30213" cy="0"/>
          </a:xfrm>
          <a:custGeom>
            <a:avLst/>
            <a:gdLst/>
            <a:ahLst/>
            <a:cxnLst/>
            <a:rect l="0" t="0" r="0" b="0"/>
            <a:pathLst>
              <a:path w="47447">
                <a:moveTo>
                  <a:pt x="0" y="0"/>
                </a:moveTo>
                <a:lnTo>
                  <a:pt x="47447" y="0"/>
                </a:lnTo>
              </a:path>
            </a:pathLst>
          </a:custGeom>
          <a:ln w="18478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23" name="pl23"/>
          <p:cNvSpPr/>
          <p:nvPr/>
        </p:nvSpPr>
        <p:spPr>
          <a:xfrm>
            <a:off x="3675509" y="2655095"/>
            <a:ext cx="30213" cy="0"/>
          </a:xfrm>
          <a:custGeom>
            <a:avLst/>
            <a:gdLst/>
            <a:ahLst/>
            <a:cxnLst/>
            <a:rect l="0" t="0" r="0" b="0"/>
            <a:pathLst>
              <a:path w="47447">
                <a:moveTo>
                  <a:pt x="0" y="0"/>
                </a:moveTo>
                <a:lnTo>
                  <a:pt x="47447" y="0"/>
                </a:lnTo>
              </a:path>
            </a:pathLst>
          </a:custGeom>
          <a:ln w="18478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24" name="pl24"/>
          <p:cNvSpPr/>
          <p:nvPr/>
        </p:nvSpPr>
        <p:spPr>
          <a:xfrm>
            <a:off x="3675509" y="1775030"/>
            <a:ext cx="30213" cy="0"/>
          </a:xfrm>
          <a:custGeom>
            <a:avLst/>
            <a:gdLst/>
            <a:ahLst/>
            <a:cxnLst/>
            <a:rect l="0" t="0" r="0" b="0"/>
            <a:pathLst>
              <a:path w="47447">
                <a:moveTo>
                  <a:pt x="0" y="0"/>
                </a:moveTo>
                <a:lnTo>
                  <a:pt x="47447" y="0"/>
                </a:lnTo>
              </a:path>
            </a:pathLst>
          </a:custGeom>
          <a:ln w="18478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25" name="pl25"/>
          <p:cNvSpPr/>
          <p:nvPr/>
        </p:nvSpPr>
        <p:spPr>
          <a:xfrm>
            <a:off x="4958828" y="5025397"/>
            <a:ext cx="0" cy="28155"/>
          </a:xfrm>
          <a:custGeom>
            <a:avLst/>
            <a:gdLst/>
            <a:ahLst/>
            <a:cxnLst/>
            <a:rect l="0" t="0" r="0" b="0"/>
            <a:pathLst>
              <a:path h="47447">
                <a:moveTo>
                  <a:pt x="0" y="47447"/>
                </a:moveTo>
                <a:lnTo>
                  <a:pt x="0" y="0"/>
                </a:lnTo>
              </a:path>
            </a:pathLst>
          </a:custGeom>
          <a:ln w="18478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26" name="pl26"/>
          <p:cNvSpPr/>
          <p:nvPr/>
        </p:nvSpPr>
        <p:spPr>
          <a:xfrm>
            <a:off x="6353494" y="5025397"/>
            <a:ext cx="0" cy="28155"/>
          </a:xfrm>
          <a:custGeom>
            <a:avLst/>
            <a:gdLst/>
            <a:ahLst/>
            <a:cxnLst/>
            <a:rect l="0" t="0" r="0" b="0"/>
            <a:pathLst>
              <a:path h="47447">
                <a:moveTo>
                  <a:pt x="0" y="47447"/>
                </a:moveTo>
                <a:lnTo>
                  <a:pt x="0" y="0"/>
                </a:lnTo>
              </a:path>
            </a:pathLst>
          </a:custGeom>
          <a:ln w="18478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27" name="pl27"/>
          <p:cNvSpPr/>
          <p:nvPr/>
        </p:nvSpPr>
        <p:spPr>
          <a:xfrm>
            <a:off x="7748162" y="5025397"/>
            <a:ext cx="0" cy="28155"/>
          </a:xfrm>
          <a:custGeom>
            <a:avLst/>
            <a:gdLst/>
            <a:ahLst/>
            <a:cxnLst/>
            <a:rect l="0" t="0" r="0" b="0"/>
            <a:pathLst>
              <a:path h="47447">
                <a:moveTo>
                  <a:pt x="0" y="47447"/>
                </a:moveTo>
                <a:lnTo>
                  <a:pt x="0" y="0"/>
                </a:lnTo>
              </a:path>
            </a:pathLst>
          </a:custGeom>
          <a:ln w="18478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28" name="tx28"/>
          <p:cNvSpPr/>
          <p:nvPr/>
        </p:nvSpPr>
        <p:spPr>
          <a:xfrm>
            <a:off x="4778925" y="5099427"/>
            <a:ext cx="359809" cy="110174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2000"/>
              </a:lnSpc>
            </a:pPr>
            <a:r>
              <a:rPr sz="1400" dirty="0">
                <a:solidFill>
                  <a:srgbClr val="4D4D4D">
                    <a:alpha val="100000"/>
                  </a:srgbClr>
                </a:solidFill>
                <a:latin typeface="Times"/>
                <a:cs typeface="Times"/>
              </a:rPr>
              <a:t>2000</a:t>
            </a:r>
          </a:p>
        </p:txBody>
      </p:sp>
      <p:sp>
        <p:nvSpPr>
          <p:cNvPr id="29" name="tx29"/>
          <p:cNvSpPr/>
          <p:nvPr/>
        </p:nvSpPr>
        <p:spPr>
          <a:xfrm>
            <a:off x="6173592" y="5099427"/>
            <a:ext cx="359809" cy="110174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2000"/>
              </a:lnSpc>
            </a:pPr>
            <a:r>
              <a:rPr sz="1400">
                <a:solidFill>
                  <a:srgbClr val="4D4D4D">
                    <a:alpha val="100000"/>
                  </a:srgbClr>
                </a:solidFill>
                <a:latin typeface="Times"/>
                <a:cs typeface="Times"/>
              </a:rPr>
              <a:t>4000</a:t>
            </a:r>
          </a:p>
        </p:txBody>
      </p:sp>
      <p:sp>
        <p:nvSpPr>
          <p:cNvPr id="30" name="tx30"/>
          <p:cNvSpPr/>
          <p:nvPr/>
        </p:nvSpPr>
        <p:spPr>
          <a:xfrm>
            <a:off x="7568257" y="5099427"/>
            <a:ext cx="359809" cy="110174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2000"/>
              </a:lnSpc>
            </a:pPr>
            <a:r>
              <a:rPr sz="1400">
                <a:solidFill>
                  <a:srgbClr val="4D4D4D">
                    <a:alpha val="100000"/>
                  </a:srgbClr>
                </a:solidFill>
                <a:latin typeface="Times"/>
                <a:cs typeface="Times"/>
              </a:rPr>
              <a:t>6000</a:t>
            </a:r>
          </a:p>
        </p:txBody>
      </p:sp>
      <p:sp>
        <p:nvSpPr>
          <p:cNvPr id="31" name="tx31"/>
          <p:cNvSpPr/>
          <p:nvPr/>
        </p:nvSpPr>
        <p:spPr>
          <a:xfrm>
            <a:off x="8538240" y="5045229"/>
            <a:ext cx="368496" cy="13961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2000"/>
              </a:lnSpc>
            </a:pPr>
            <a:r>
              <a:rPr sz="1400" dirty="0">
                <a:solidFill>
                  <a:srgbClr val="000000">
                    <a:alpha val="100000"/>
                  </a:srgbClr>
                </a:solidFill>
                <a:latin typeface="Times"/>
                <a:cs typeface="Times"/>
              </a:rPr>
              <a:t>Days</a:t>
            </a:r>
          </a:p>
        </p:txBody>
      </p:sp>
      <p:sp>
        <p:nvSpPr>
          <p:cNvPr id="79" name="Rectangle 128">
            <a:extLst>
              <a:ext uri="{FF2B5EF4-FFF2-40B4-BE49-F238E27FC236}">
                <a16:creationId xmlns:a16="http://schemas.microsoft.com/office/drawing/2014/main" id="{43832A1E-B4DB-ED59-D386-AC5754D879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60268" y="5073436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sz="140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pl28">
            <a:extLst>
              <a:ext uri="{FF2B5EF4-FFF2-40B4-BE49-F238E27FC236}">
                <a16:creationId xmlns:a16="http://schemas.microsoft.com/office/drawing/2014/main" id="{B5136576-6B76-FCC3-5F99-3C11163953BD}"/>
              </a:ext>
            </a:extLst>
          </p:cNvPr>
          <p:cNvSpPr/>
          <p:nvPr/>
        </p:nvSpPr>
        <p:spPr>
          <a:xfrm>
            <a:off x="3705722" y="5022268"/>
            <a:ext cx="36143" cy="34411"/>
          </a:xfrm>
          <a:custGeom>
            <a:avLst/>
            <a:gdLst/>
            <a:ahLst/>
            <a:cxnLst/>
            <a:rect l="0" t="0" r="0" b="0"/>
            <a:pathLst>
              <a:path h="47447">
                <a:moveTo>
                  <a:pt x="0" y="47447"/>
                </a:moveTo>
                <a:lnTo>
                  <a:pt x="0" y="0"/>
                </a:lnTo>
              </a:path>
            </a:pathLst>
          </a:custGeom>
          <a:ln w="18478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DD45599-6662-C64C-39F9-8C7793450256}"/>
              </a:ext>
            </a:extLst>
          </p:cNvPr>
          <p:cNvSpPr txBox="1"/>
          <p:nvPr/>
        </p:nvSpPr>
        <p:spPr>
          <a:xfrm>
            <a:off x="2217169" y="6043887"/>
            <a:ext cx="8112989" cy="46294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  <a:buNone/>
            </a:pPr>
            <a:r>
              <a:rPr lang="en-US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Supplemental figures. Standardized population-averaged survival curves for (A) all-cause mortality</a:t>
            </a:r>
            <a:endParaRPr lang="ja-JP" altLang="ja-JP" sz="1600" kern="100" dirty="0">
              <a:latin typeface="游明朝" panose="02020400000000000000" pitchFamily="18" charset="-128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grpSp>
        <p:nvGrpSpPr>
          <p:cNvPr id="89" name="グループ化 88">
            <a:extLst>
              <a:ext uri="{FF2B5EF4-FFF2-40B4-BE49-F238E27FC236}">
                <a16:creationId xmlns:a16="http://schemas.microsoft.com/office/drawing/2014/main" id="{C8FB81B9-78F9-7BA7-54D2-40625AFFC25A}"/>
              </a:ext>
            </a:extLst>
          </p:cNvPr>
          <p:cNvGrpSpPr/>
          <p:nvPr/>
        </p:nvGrpSpPr>
        <p:grpSpPr>
          <a:xfrm>
            <a:off x="4013054" y="4001034"/>
            <a:ext cx="1928465" cy="790928"/>
            <a:chOff x="7148661" y="38880"/>
            <a:chExt cx="1928465" cy="790928"/>
          </a:xfrm>
        </p:grpSpPr>
        <p:sp>
          <p:nvSpPr>
            <p:cNvPr id="73" name="Rectangle 233">
              <a:extLst>
                <a:ext uri="{FF2B5EF4-FFF2-40B4-BE49-F238E27FC236}">
                  <a16:creationId xmlns:a16="http://schemas.microsoft.com/office/drawing/2014/main" id="{ACE98342-5B90-517B-C0AB-4EF1921D72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96336" y="38880"/>
              <a:ext cx="111402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ja-JP" altLang="ja-JP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GFRdiff &lt; </a:t>
              </a:r>
              <a:r>
                <a:rPr kumimoji="0" lang="en-US" altLang="ja-JP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ja-JP" altLang="ja-JP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ja-JP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Line 234">
              <a:extLst>
                <a:ext uri="{FF2B5EF4-FFF2-40B4-BE49-F238E27FC236}">
                  <a16:creationId xmlns:a16="http://schemas.microsoft.com/office/drawing/2014/main" id="{A958185A-24B3-77E7-8E0E-1BA0C0AAF98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48661" y="161117"/>
              <a:ext cx="285750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Rectangle 237">
              <a:extLst>
                <a:ext uri="{FF2B5EF4-FFF2-40B4-BE49-F238E27FC236}">
                  <a16:creationId xmlns:a16="http://schemas.microsoft.com/office/drawing/2014/main" id="{BD6A5DDA-1C01-C10C-EF79-484AD8C58A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92809" y="332335"/>
              <a:ext cx="148431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ja-JP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ja-JP" altLang="ja-JP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r>
                <a:rPr kumimoji="0" lang="ja-JP" altLang="ja-JP" sz="1400" u="sng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&lt;</a:t>
              </a:r>
              <a:r>
                <a:rPr kumimoji="0" lang="ja-JP" altLang="ja-JP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eGFRdiff &lt; 10</a:t>
              </a:r>
              <a:endParaRPr kumimoji="0" lang="ja-JP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Freeform 238">
              <a:extLst>
                <a:ext uri="{FF2B5EF4-FFF2-40B4-BE49-F238E27FC236}">
                  <a16:creationId xmlns:a16="http://schemas.microsoft.com/office/drawing/2014/main" id="{B91FA6B3-5149-990F-6D13-CE82C453D27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7148661" y="448222"/>
              <a:ext cx="285750" cy="12700"/>
            </a:xfrm>
            <a:custGeom>
              <a:avLst/>
              <a:gdLst>
                <a:gd name="T0" fmla="*/ 0 w 2048"/>
                <a:gd name="T1" fmla="*/ 0 h 96"/>
                <a:gd name="T2" fmla="*/ 192 w 2048"/>
                <a:gd name="T3" fmla="*/ 0 h 96"/>
                <a:gd name="T4" fmla="*/ 240 w 2048"/>
                <a:gd name="T5" fmla="*/ 48 h 96"/>
                <a:gd name="T6" fmla="*/ 192 w 2048"/>
                <a:gd name="T7" fmla="*/ 96 h 96"/>
                <a:gd name="T8" fmla="*/ 0 w 2048"/>
                <a:gd name="T9" fmla="*/ 96 h 96"/>
                <a:gd name="T10" fmla="*/ 0 w 2048"/>
                <a:gd name="T11" fmla="*/ 0 h 96"/>
                <a:gd name="T12" fmla="*/ 480 w 2048"/>
                <a:gd name="T13" fmla="*/ 0 h 96"/>
                <a:gd name="T14" fmla="*/ 672 w 2048"/>
                <a:gd name="T15" fmla="*/ 0 h 96"/>
                <a:gd name="T16" fmla="*/ 720 w 2048"/>
                <a:gd name="T17" fmla="*/ 48 h 96"/>
                <a:gd name="T18" fmla="*/ 672 w 2048"/>
                <a:gd name="T19" fmla="*/ 96 h 96"/>
                <a:gd name="T20" fmla="*/ 480 w 2048"/>
                <a:gd name="T21" fmla="*/ 96 h 96"/>
                <a:gd name="T22" fmla="*/ 432 w 2048"/>
                <a:gd name="T23" fmla="*/ 48 h 96"/>
                <a:gd name="T24" fmla="*/ 480 w 2048"/>
                <a:gd name="T25" fmla="*/ 0 h 96"/>
                <a:gd name="T26" fmla="*/ 960 w 2048"/>
                <a:gd name="T27" fmla="*/ 0 h 96"/>
                <a:gd name="T28" fmla="*/ 1152 w 2048"/>
                <a:gd name="T29" fmla="*/ 0 h 96"/>
                <a:gd name="T30" fmla="*/ 1200 w 2048"/>
                <a:gd name="T31" fmla="*/ 48 h 96"/>
                <a:gd name="T32" fmla="*/ 1152 w 2048"/>
                <a:gd name="T33" fmla="*/ 96 h 96"/>
                <a:gd name="T34" fmla="*/ 960 w 2048"/>
                <a:gd name="T35" fmla="*/ 96 h 96"/>
                <a:gd name="T36" fmla="*/ 912 w 2048"/>
                <a:gd name="T37" fmla="*/ 48 h 96"/>
                <a:gd name="T38" fmla="*/ 960 w 2048"/>
                <a:gd name="T39" fmla="*/ 0 h 96"/>
                <a:gd name="T40" fmla="*/ 1440 w 2048"/>
                <a:gd name="T41" fmla="*/ 0 h 96"/>
                <a:gd name="T42" fmla="*/ 1632 w 2048"/>
                <a:gd name="T43" fmla="*/ 0 h 96"/>
                <a:gd name="T44" fmla="*/ 1680 w 2048"/>
                <a:gd name="T45" fmla="*/ 48 h 96"/>
                <a:gd name="T46" fmla="*/ 1632 w 2048"/>
                <a:gd name="T47" fmla="*/ 96 h 96"/>
                <a:gd name="T48" fmla="*/ 1440 w 2048"/>
                <a:gd name="T49" fmla="*/ 96 h 96"/>
                <a:gd name="T50" fmla="*/ 1392 w 2048"/>
                <a:gd name="T51" fmla="*/ 48 h 96"/>
                <a:gd name="T52" fmla="*/ 1440 w 2048"/>
                <a:gd name="T53" fmla="*/ 0 h 96"/>
                <a:gd name="T54" fmla="*/ 1920 w 2048"/>
                <a:gd name="T55" fmla="*/ 0 h 96"/>
                <a:gd name="T56" fmla="*/ 2048 w 2048"/>
                <a:gd name="T57" fmla="*/ 0 h 96"/>
                <a:gd name="T58" fmla="*/ 2048 w 2048"/>
                <a:gd name="T59" fmla="*/ 96 h 96"/>
                <a:gd name="T60" fmla="*/ 1920 w 2048"/>
                <a:gd name="T61" fmla="*/ 96 h 96"/>
                <a:gd name="T62" fmla="*/ 1872 w 2048"/>
                <a:gd name="T63" fmla="*/ 48 h 96"/>
                <a:gd name="T64" fmla="*/ 1920 w 2048"/>
                <a:gd name="T65" fmla="*/ 0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2048" h="96">
                  <a:moveTo>
                    <a:pt x="0" y="0"/>
                  </a:moveTo>
                  <a:lnTo>
                    <a:pt x="192" y="0"/>
                  </a:lnTo>
                  <a:cubicBezTo>
                    <a:pt x="219" y="0"/>
                    <a:pt x="240" y="22"/>
                    <a:pt x="240" y="48"/>
                  </a:cubicBezTo>
                  <a:cubicBezTo>
                    <a:pt x="240" y="75"/>
                    <a:pt x="219" y="96"/>
                    <a:pt x="192" y="96"/>
                  </a:cubicBezTo>
                  <a:lnTo>
                    <a:pt x="0" y="96"/>
                  </a:lnTo>
                  <a:lnTo>
                    <a:pt x="0" y="0"/>
                  </a:lnTo>
                  <a:close/>
                  <a:moveTo>
                    <a:pt x="480" y="0"/>
                  </a:moveTo>
                  <a:lnTo>
                    <a:pt x="672" y="0"/>
                  </a:lnTo>
                  <a:cubicBezTo>
                    <a:pt x="699" y="0"/>
                    <a:pt x="720" y="22"/>
                    <a:pt x="720" y="48"/>
                  </a:cubicBezTo>
                  <a:cubicBezTo>
                    <a:pt x="720" y="75"/>
                    <a:pt x="699" y="96"/>
                    <a:pt x="672" y="96"/>
                  </a:cubicBezTo>
                  <a:lnTo>
                    <a:pt x="480" y="96"/>
                  </a:lnTo>
                  <a:cubicBezTo>
                    <a:pt x="454" y="96"/>
                    <a:pt x="432" y="75"/>
                    <a:pt x="432" y="48"/>
                  </a:cubicBezTo>
                  <a:cubicBezTo>
                    <a:pt x="432" y="22"/>
                    <a:pt x="454" y="0"/>
                    <a:pt x="480" y="0"/>
                  </a:cubicBezTo>
                  <a:close/>
                  <a:moveTo>
                    <a:pt x="960" y="0"/>
                  </a:moveTo>
                  <a:lnTo>
                    <a:pt x="1152" y="0"/>
                  </a:lnTo>
                  <a:cubicBezTo>
                    <a:pt x="1179" y="0"/>
                    <a:pt x="1200" y="22"/>
                    <a:pt x="1200" y="48"/>
                  </a:cubicBezTo>
                  <a:cubicBezTo>
                    <a:pt x="1200" y="75"/>
                    <a:pt x="1179" y="96"/>
                    <a:pt x="1152" y="96"/>
                  </a:cubicBezTo>
                  <a:lnTo>
                    <a:pt x="960" y="96"/>
                  </a:lnTo>
                  <a:cubicBezTo>
                    <a:pt x="934" y="96"/>
                    <a:pt x="912" y="75"/>
                    <a:pt x="912" y="48"/>
                  </a:cubicBezTo>
                  <a:cubicBezTo>
                    <a:pt x="912" y="22"/>
                    <a:pt x="934" y="0"/>
                    <a:pt x="960" y="0"/>
                  </a:cubicBezTo>
                  <a:close/>
                  <a:moveTo>
                    <a:pt x="1440" y="0"/>
                  </a:moveTo>
                  <a:lnTo>
                    <a:pt x="1632" y="0"/>
                  </a:lnTo>
                  <a:cubicBezTo>
                    <a:pt x="1659" y="0"/>
                    <a:pt x="1680" y="22"/>
                    <a:pt x="1680" y="48"/>
                  </a:cubicBezTo>
                  <a:cubicBezTo>
                    <a:pt x="1680" y="75"/>
                    <a:pt x="1659" y="96"/>
                    <a:pt x="1632" y="96"/>
                  </a:cubicBezTo>
                  <a:lnTo>
                    <a:pt x="1440" y="96"/>
                  </a:lnTo>
                  <a:cubicBezTo>
                    <a:pt x="1414" y="96"/>
                    <a:pt x="1392" y="75"/>
                    <a:pt x="1392" y="48"/>
                  </a:cubicBezTo>
                  <a:cubicBezTo>
                    <a:pt x="1392" y="22"/>
                    <a:pt x="1414" y="0"/>
                    <a:pt x="1440" y="0"/>
                  </a:cubicBezTo>
                  <a:close/>
                  <a:moveTo>
                    <a:pt x="1920" y="0"/>
                  </a:moveTo>
                  <a:lnTo>
                    <a:pt x="2048" y="0"/>
                  </a:lnTo>
                  <a:lnTo>
                    <a:pt x="2048" y="96"/>
                  </a:lnTo>
                  <a:lnTo>
                    <a:pt x="1920" y="96"/>
                  </a:lnTo>
                  <a:cubicBezTo>
                    <a:pt x="1894" y="96"/>
                    <a:pt x="1872" y="75"/>
                    <a:pt x="1872" y="48"/>
                  </a:cubicBezTo>
                  <a:cubicBezTo>
                    <a:pt x="1872" y="22"/>
                    <a:pt x="1894" y="0"/>
                    <a:pt x="1920" y="0"/>
                  </a:cubicBezTo>
                  <a:close/>
                </a:path>
              </a:pathLst>
            </a:custGeom>
            <a:solidFill>
              <a:srgbClr val="000000"/>
            </a:solidFill>
            <a:ln w="19050" cap="flat">
              <a:solidFill>
                <a:srgbClr val="000000"/>
              </a:solidFill>
              <a:prstDash val="sysDash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Rectangle 240">
              <a:extLst>
                <a:ext uri="{FF2B5EF4-FFF2-40B4-BE49-F238E27FC236}">
                  <a16:creationId xmlns:a16="http://schemas.microsoft.com/office/drawing/2014/main" id="{960D7683-096D-54B7-38A5-CA52F879A2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96336" y="614364"/>
              <a:ext cx="105471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ja-JP" altLang="ja-JP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GFRdiff </a:t>
              </a:r>
              <a:r>
                <a:rPr kumimoji="0" lang="ja-JP" altLang="ja-JP" sz="1400" u="sng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&gt;</a:t>
              </a:r>
              <a:r>
                <a:rPr kumimoji="0" lang="ja-JP" altLang="ja-JP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10</a:t>
              </a:r>
              <a:endParaRPr kumimoji="0" lang="ja-JP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Freeform 241">
              <a:extLst>
                <a:ext uri="{FF2B5EF4-FFF2-40B4-BE49-F238E27FC236}">
                  <a16:creationId xmlns:a16="http://schemas.microsoft.com/office/drawing/2014/main" id="{5AEEEF49-1341-32C3-6620-F1AAE48B019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7148661" y="730251"/>
              <a:ext cx="282575" cy="14288"/>
            </a:xfrm>
            <a:custGeom>
              <a:avLst/>
              <a:gdLst>
                <a:gd name="T0" fmla="*/ 0 w 2017"/>
                <a:gd name="T1" fmla="*/ 0 h 96"/>
                <a:gd name="T2" fmla="*/ 1 w 2017"/>
                <a:gd name="T3" fmla="*/ 0 h 96"/>
                <a:gd name="T4" fmla="*/ 49 w 2017"/>
                <a:gd name="T5" fmla="*/ 48 h 96"/>
                <a:gd name="T6" fmla="*/ 1 w 2017"/>
                <a:gd name="T7" fmla="*/ 96 h 96"/>
                <a:gd name="T8" fmla="*/ 0 w 2017"/>
                <a:gd name="T9" fmla="*/ 96 h 96"/>
                <a:gd name="T10" fmla="*/ 0 w 2017"/>
                <a:gd name="T11" fmla="*/ 0 h 96"/>
                <a:gd name="T12" fmla="*/ 289 w 2017"/>
                <a:gd name="T13" fmla="*/ 0 h 96"/>
                <a:gd name="T14" fmla="*/ 289 w 2017"/>
                <a:gd name="T15" fmla="*/ 0 h 96"/>
                <a:gd name="T16" fmla="*/ 337 w 2017"/>
                <a:gd name="T17" fmla="*/ 48 h 96"/>
                <a:gd name="T18" fmla="*/ 289 w 2017"/>
                <a:gd name="T19" fmla="*/ 96 h 96"/>
                <a:gd name="T20" fmla="*/ 289 w 2017"/>
                <a:gd name="T21" fmla="*/ 96 h 96"/>
                <a:gd name="T22" fmla="*/ 241 w 2017"/>
                <a:gd name="T23" fmla="*/ 48 h 96"/>
                <a:gd name="T24" fmla="*/ 289 w 2017"/>
                <a:gd name="T25" fmla="*/ 0 h 96"/>
                <a:gd name="T26" fmla="*/ 577 w 2017"/>
                <a:gd name="T27" fmla="*/ 0 h 96"/>
                <a:gd name="T28" fmla="*/ 577 w 2017"/>
                <a:gd name="T29" fmla="*/ 0 h 96"/>
                <a:gd name="T30" fmla="*/ 625 w 2017"/>
                <a:gd name="T31" fmla="*/ 48 h 96"/>
                <a:gd name="T32" fmla="*/ 577 w 2017"/>
                <a:gd name="T33" fmla="*/ 96 h 96"/>
                <a:gd name="T34" fmla="*/ 577 w 2017"/>
                <a:gd name="T35" fmla="*/ 96 h 96"/>
                <a:gd name="T36" fmla="*/ 529 w 2017"/>
                <a:gd name="T37" fmla="*/ 48 h 96"/>
                <a:gd name="T38" fmla="*/ 577 w 2017"/>
                <a:gd name="T39" fmla="*/ 0 h 96"/>
                <a:gd name="T40" fmla="*/ 865 w 2017"/>
                <a:gd name="T41" fmla="*/ 0 h 96"/>
                <a:gd name="T42" fmla="*/ 865 w 2017"/>
                <a:gd name="T43" fmla="*/ 0 h 96"/>
                <a:gd name="T44" fmla="*/ 913 w 2017"/>
                <a:gd name="T45" fmla="*/ 48 h 96"/>
                <a:gd name="T46" fmla="*/ 865 w 2017"/>
                <a:gd name="T47" fmla="*/ 96 h 96"/>
                <a:gd name="T48" fmla="*/ 865 w 2017"/>
                <a:gd name="T49" fmla="*/ 96 h 96"/>
                <a:gd name="T50" fmla="*/ 817 w 2017"/>
                <a:gd name="T51" fmla="*/ 48 h 96"/>
                <a:gd name="T52" fmla="*/ 865 w 2017"/>
                <a:gd name="T53" fmla="*/ 0 h 96"/>
                <a:gd name="T54" fmla="*/ 1153 w 2017"/>
                <a:gd name="T55" fmla="*/ 0 h 96"/>
                <a:gd name="T56" fmla="*/ 1153 w 2017"/>
                <a:gd name="T57" fmla="*/ 0 h 96"/>
                <a:gd name="T58" fmla="*/ 1201 w 2017"/>
                <a:gd name="T59" fmla="*/ 48 h 96"/>
                <a:gd name="T60" fmla="*/ 1153 w 2017"/>
                <a:gd name="T61" fmla="*/ 96 h 96"/>
                <a:gd name="T62" fmla="*/ 1153 w 2017"/>
                <a:gd name="T63" fmla="*/ 96 h 96"/>
                <a:gd name="T64" fmla="*/ 1105 w 2017"/>
                <a:gd name="T65" fmla="*/ 48 h 96"/>
                <a:gd name="T66" fmla="*/ 1153 w 2017"/>
                <a:gd name="T67" fmla="*/ 0 h 96"/>
                <a:gd name="T68" fmla="*/ 1441 w 2017"/>
                <a:gd name="T69" fmla="*/ 0 h 96"/>
                <a:gd name="T70" fmla="*/ 1441 w 2017"/>
                <a:gd name="T71" fmla="*/ 0 h 96"/>
                <a:gd name="T72" fmla="*/ 1489 w 2017"/>
                <a:gd name="T73" fmla="*/ 48 h 96"/>
                <a:gd name="T74" fmla="*/ 1441 w 2017"/>
                <a:gd name="T75" fmla="*/ 96 h 96"/>
                <a:gd name="T76" fmla="*/ 1441 w 2017"/>
                <a:gd name="T77" fmla="*/ 96 h 96"/>
                <a:gd name="T78" fmla="*/ 1393 w 2017"/>
                <a:gd name="T79" fmla="*/ 48 h 96"/>
                <a:gd name="T80" fmla="*/ 1441 w 2017"/>
                <a:gd name="T81" fmla="*/ 0 h 96"/>
                <a:gd name="T82" fmla="*/ 1729 w 2017"/>
                <a:gd name="T83" fmla="*/ 0 h 96"/>
                <a:gd name="T84" fmla="*/ 1729 w 2017"/>
                <a:gd name="T85" fmla="*/ 0 h 96"/>
                <a:gd name="T86" fmla="*/ 1777 w 2017"/>
                <a:gd name="T87" fmla="*/ 48 h 96"/>
                <a:gd name="T88" fmla="*/ 1729 w 2017"/>
                <a:gd name="T89" fmla="*/ 96 h 96"/>
                <a:gd name="T90" fmla="*/ 1729 w 2017"/>
                <a:gd name="T91" fmla="*/ 96 h 96"/>
                <a:gd name="T92" fmla="*/ 1681 w 2017"/>
                <a:gd name="T93" fmla="*/ 48 h 96"/>
                <a:gd name="T94" fmla="*/ 1729 w 2017"/>
                <a:gd name="T95" fmla="*/ 0 h 96"/>
                <a:gd name="T96" fmla="*/ 2017 w 2017"/>
                <a:gd name="T97" fmla="*/ 0 h 96"/>
                <a:gd name="T98" fmla="*/ 2017 w 2017"/>
                <a:gd name="T99" fmla="*/ 0 h 96"/>
                <a:gd name="T100" fmla="*/ 2017 w 2017"/>
                <a:gd name="T101" fmla="*/ 96 h 96"/>
                <a:gd name="T102" fmla="*/ 2017 w 2017"/>
                <a:gd name="T103" fmla="*/ 96 h 96"/>
                <a:gd name="T104" fmla="*/ 1969 w 2017"/>
                <a:gd name="T105" fmla="*/ 48 h 96"/>
                <a:gd name="T106" fmla="*/ 2017 w 2017"/>
                <a:gd name="T107" fmla="*/ 0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</a:cxnLst>
              <a:rect l="0" t="0" r="r" b="b"/>
              <a:pathLst>
                <a:path w="2017" h="96">
                  <a:moveTo>
                    <a:pt x="0" y="0"/>
                  </a:moveTo>
                  <a:lnTo>
                    <a:pt x="1" y="0"/>
                  </a:lnTo>
                  <a:cubicBezTo>
                    <a:pt x="27" y="0"/>
                    <a:pt x="49" y="22"/>
                    <a:pt x="49" y="48"/>
                  </a:cubicBezTo>
                  <a:cubicBezTo>
                    <a:pt x="49" y="75"/>
                    <a:pt x="27" y="96"/>
                    <a:pt x="1" y="96"/>
                  </a:cubicBezTo>
                  <a:lnTo>
                    <a:pt x="0" y="96"/>
                  </a:lnTo>
                  <a:lnTo>
                    <a:pt x="0" y="0"/>
                  </a:lnTo>
                  <a:close/>
                  <a:moveTo>
                    <a:pt x="289" y="0"/>
                  </a:moveTo>
                  <a:lnTo>
                    <a:pt x="289" y="0"/>
                  </a:lnTo>
                  <a:cubicBezTo>
                    <a:pt x="315" y="0"/>
                    <a:pt x="337" y="22"/>
                    <a:pt x="337" y="48"/>
                  </a:cubicBezTo>
                  <a:cubicBezTo>
                    <a:pt x="337" y="75"/>
                    <a:pt x="315" y="96"/>
                    <a:pt x="289" y="96"/>
                  </a:cubicBezTo>
                  <a:lnTo>
                    <a:pt x="289" y="96"/>
                  </a:lnTo>
                  <a:cubicBezTo>
                    <a:pt x="262" y="96"/>
                    <a:pt x="241" y="75"/>
                    <a:pt x="241" y="48"/>
                  </a:cubicBezTo>
                  <a:cubicBezTo>
                    <a:pt x="241" y="22"/>
                    <a:pt x="262" y="0"/>
                    <a:pt x="289" y="0"/>
                  </a:cubicBezTo>
                  <a:close/>
                  <a:moveTo>
                    <a:pt x="577" y="0"/>
                  </a:moveTo>
                  <a:lnTo>
                    <a:pt x="577" y="0"/>
                  </a:lnTo>
                  <a:cubicBezTo>
                    <a:pt x="603" y="0"/>
                    <a:pt x="625" y="22"/>
                    <a:pt x="625" y="48"/>
                  </a:cubicBezTo>
                  <a:cubicBezTo>
                    <a:pt x="625" y="75"/>
                    <a:pt x="603" y="96"/>
                    <a:pt x="577" y="96"/>
                  </a:cubicBezTo>
                  <a:lnTo>
                    <a:pt x="577" y="96"/>
                  </a:lnTo>
                  <a:cubicBezTo>
                    <a:pt x="550" y="96"/>
                    <a:pt x="529" y="75"/>
                    <a:pt x="529" y="48"/>
                  </a:cubicBezTo>
                  <a:cubicBezTo>
                    <a:pt x="529" y="22"/>
                    <a:pt x="550" y="0"/>
                    <a:pt x="577" y="0"/>
                  </a:cubicBezTo>
                  <a:close/>
                  <a:moveTo>
                    <a:pt x="865" y="0"/>
                  </a:moveTo>
                  <a:lnTo>
                    <a:pt x="865" y="0"/>
                  </a:lnTo>
                  <a:cubicBezTo>
                    <a:pt x="891" y="0"/>
                    <a:pt x="913" y="22"/>
                    <a:pt x="913" y="48"/>
                  </a:cubicBezTo>
                  <a:cubicBezTo>
                    <a:pt x="913" y="75"/>
                    <a:pt x="891" y="96"/>
                    <a:pt x="865" y="96"/>
                  </a:cubicBezTo>
                  <a:lnTo>
                    <a:pt x="865" y="96"/>
                  </a:lnTo>
                  <a:cubicBezTo>
                    <a:pt x="838" y="96"/>
                    <a:pt x="817" y="75"/>
                    <a:pt x="817" y="48"/>
                  </a:cubicBezTo>
                  <a:cubicBezTo>
                    <a:pt x="817" y="22"/>
                    <a:pt x="838" y="0"/>
                    <a:pt x="865" y="0"/>
                  </a:cubicBezTo>
                  <a:close/>
                  <a:moveTo>
                    <a:pt x="1153" y="0"/>
                  </a:moveTo>
                  <a:lnTo>
                    <a:pt x="1153" y="0"/>
                  </a:lnTo>
                  <a:cubicBezTo>
                    <a:pt x="1179" y="0"/>
                    <a:pt x="1201" y="22"/>
                    <a:pt x="1201" y="48"/>
                  </a:cubicBezTo>
                  <a:cubicBezTo>
                    <a:pt x="1201" y="75"/>
                    <a:pt x="1179" y="96"/>
                    <a:pt x="1153" y="96"/>
                  </a:cubicBezTo>
                  <a:lnTo>
                    <a:pt x="1153" y="96"/>
                  </a:lnTo>
                  <a:cubicBezTo>
                    <a:pt x="1126" y="96"/>
                    <a:pt x="1105" y="75"/>
                    <a:pt x="1105" y="48"/>
                  </a:cubicBezTo>
                  <a:cubicBezTo>
                    <a:pt x="1105" y="22"/>
                    <a:pt x="1126" y="0"/>
                    <a:pt x="1153" y="0"/>
                  </a:cubicBezTo>
                  <a:close/>
                  <a:moveTo>
                    <a:pt x="1441" y="0"/>
                  </a:moveTo>
                  <a:lnTo>
                    <a:pt x="1441" y="0"/>
                  </a:lnTo>
                  <a:cubicBezTo>
                    <a:pt x="1468" y="0"/>
                    <a:pt x="1489" y="22"/>
                    <a:pt x="1489" y="48"/>
                  </a:cubicBezTo>
                  <a:cubicBezTo>
                    <a:pt x="1489" y="75"/>
                    <a:pt x="1468" y="96"/>
                    <a:pt x="1441" y="96"/>
                  </a:cubicBezTo>
                  <a:lnTo>
                    <a:pt x="1441" y="96"/>
                  </a:lnTo>
                  <a:cubicBezTo>
                    <a:pt x="1414" y="96"/>
                    <a:pt x="1393" y="75"/>
                    <a:pt x="1393" y="48"/>
                  </a:cubicBezTo>
                  <a:cubicBezTo>
                    <a:pt x="1393" y="22"/>
                    <a:pt x="1414" y="0"/>
                    <a:pt x="1441" y="0"/>
                  </a:cubicBezTo>
                  <a:close/>
                  <a:moveTo>
                    <a:pt x="1729" y="0"/>
                  </a:moveTo>
                  <a:lnTo>
                    <a:pt x="1729" y="0"/>
                  </a:lnTo>
                  <a:cubicBezTo>
                    <a:pt x="1756" y="0"/>
                    <a:pt x="1777" y="22"/>
                    <a:pt x="1777" y="48"/>
                  </a:cubicBezTo>
                  <a:cubicBezTo>
                    <a:pt x="1777" y="75"/>
                    <a:pt x="1756" y="96"/>
                    <a:pt x="1729" y="96"/>
                  </a:cubicBezTo>
                  <a:lnTo>
                    <a:pt x="1729" y="96"/>
                  </a:lnTo>
                  <a:cubicBezTo>
                    <a:pt x="1703" y="96"/>
                    <a:pt x="1681" y="75"/>
                    <a:pt x="1681" y="48"/>
                  </a:cubicBezTo>
                  <a:cubicBezTo>
                    <a:pt x="1681" y="22"/>
                    <a:pt x="1703" y="0"/>
                    <a:pt x="1729" y="0"/>
                  </a:cubicBezTo>
                  <a:close/>
                  <a:moveTo>
                    <a:pt x="2017" y="0"/>
                  </a:moveTo>
                  <a:lnTo>
                    <a:pt x="2017" y="0"/>
                  </a:lnTo>
                  <a:lnTo>
                    <a:pt x="2017" y="96"/>
                  </a:lnTo>
                  <a:lnTo>
                    <a:pt x="2017" y="96"/>
                  </a:lnTo>
                  <a:cubicBezTo>
                    <a:pt x="1991" y="96"/>
                    <a:pt x="1969" y="75"/>
                    <a:pt x="1969" y="48"/>
                  </a:cubicBezTo>
                  <a:cubicBezTo>
                    <a:pt x="1969" y="22"/>
                    <a:pt x="1991" y="0"/>
                    <a:pt x="2017" y="0"/>
                  </a:cubicBezTo>
                  <a:close/>
                </a:path>
              </a:pathLst>
            </a:custGeom>
            <a:solidFill>
              <a:srgbClr val="000000"/>
            </a:solidFill>
            <a:ln w="12700" cap="flat">
              <a:solidFill>
                <a:srgbClr val="000000"/>
              </a:solidFill>
              <a:prstDash val="sysDot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90" name="Rectangle 243">
            <a:extLst>
              <a:ext uri="{FF2B5EF4-FFF2-40B4-BE49-F238E27FC236}">
                <a16:creationId xmlns:a16="http://schemas.microsoft.com/office/drawing/2014/main" id="{DD9D605B-7B3A-C265-826D-2C86A7734A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49692" y="4566721"/>
            <a:ext cx="214000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kumimoji="0" lang="en-US" altLang="ja-JP" sz="14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kelihood</a:t>
            </a:r>
            <a:r>
              <a:rPr kumimoji="0" lang="en-US" altLang="ja-JP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ratio test</a:t>
            </a:r>
            <a:r>
              <a:rPr kumimoji="0" lang="ja-JP" altLang="ja-JP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p &lt; 0.01</a:t>
            </a:r>
            <a:endParaRPr kumimoji="0" lang="ja-JP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9804A1E-3AEB-2F97-019E-4612823A0A3A}"/>
              </a:ext>
            </a:extLst>
          </p:cNvPr>
          <p:cNvSpPr txBox="1"/>
          <p:nvPr/>
        </p:nvSpPr>
        <p:spPr>
          <a:xfrm>
            <a:off x="2039506" y="5990681"/>
            <a:ext cx="8112989" cy="46294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  <a:buNone/>
            </a:pPr>
            <a:r>
              <a:rPr lang="en-US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Supplemental figures. Standardized population-averaged survival curves for (B) cardiovascular mortality</a:t>
            </a:r>
            <a:endParaRPr lang="ja-JP" altLang="ja-JP" sz="1600" kern="100" dirty="0">
              <a:latin typeface="游明朝" panose="02020400000000000000" pitchFamily="18" charset="-128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4" name="pl6">
            <a:extLst>
              <a:ext uri="{FF2B5EF4-FFF2-40B4-BE49-F238E27FC236}">
                <a16:creationId xmlns:a16="http://schemas.microsoft.com/office/drawing/2014/main" id="{643EB059-AFB5-71EC-A73C-18C028569623}"/>
              </a:ext>
            </a:extLst>
          </p:cNvPr>
          <p:cNvSpPr/>
          <p:nvPr/>
        </p:nvSpPr>
        <p:spPr>
          <a:xfrm flipV="1">
            <a:off x="3756847" y="4619123"/>
            <a:ext cx="5061378" cy="34438"/>
          </a:xfrm>
          <a:custGeom>
            <a:avLst/>
            <a:gdLst/>
            <a:ahLst/>
            <a:cxnLst/>
            <a:rect l="0" t="0" r="0" b="0"/>
            <a:pathLst>
              <a:path w="7667941">
                <a:moveTo>
                  <a:pt x="0" y="0"/>
                </a:moveTo>
                <a:lnTo>
                  <a:pt x="7667941" y="0"/>
                </a:lnTo>
                <a:lnTo>
                  <a:pt x="7667941" y="0"/>
                </a:lnTo>
              </a:path>
            </a:pathLst>
          </a:custGeom>
          <a:ln w="6775" cap="flat">
            <a:solidFill>
              <a:srgbClr val="EBEBEB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7" name="pl8">
            <a:extLst>
              <a:ext uri="{FF2B5EF4-FFF2-40B4-BE49-F238E27FC236}">
                <a16:creationId xmlns:a16="http://schemas.microsoft.com/office/drawing/2014/main" id="{D1E1BF3A-E086-E811-5B96-A503F031557A}"/>
              </a:ext>
            </a:extLst>
          </p:cNvPr>
          <p:cNvSpPr/>
          <p:nvPr/>
        </p:nvSpPr>
        <p:spPr>
          <a:xfrm flipV="1">
            <a:off x="3756847" y="3150919"/>
            <a:ext cx="5061378" cy="34438"/>
          </a:xfrm>
          <a:custGeom>
            <a:avLst/>
            <a:gdLst/>
            <a:ahLst/>
            <a:cxnLst/>
            <a:rect l="0" t="0" r="0" b="0"/>
            <a:pathLst>
              <a:path w="7667941">
                <a:moveTo>
                  <a:pt x="0" y="0"/>
                </a:moveTo>
                <a:lnTo>
                  <a:pt x="7667941" y="0"/>
                </a:lnTo>
                <a:lnTo>
                  <a:pt x="7667941" y="0"/>
                </a:lnTo>
              </a:path>
            </a:pathLst>
          </a:custGeom>
          <a:ln w="6775" cap="flat">
            <a:solidFill>
              <a:srgbClr val="EBEBEB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36" name="pl9">
            <a:extLst>
              <a:ext uri="{FF2B5EF4-FFF2-40B4-BE49-F238E27FC236}">
                <a16:creationId xmlns:a16="http://schemas.microsoft.com/office/drawing/2014/main" id="{812079F0-7948-C415-121C-824A78A43E2A}"/>
              </a:ext>
            </a:extLst>
          </p:cNvPr>
          <p:cNvSpPr/>
          <p:nvPr/>
        </p:nvSpPr>
        <p:spPr>
          <a:xfrm flipV="1">
            <a:off x="3756847" y="2416818"/>
            <a:ext cx="5061378" cy="34438"/>
          </a:xfrm>
          <a:custGeom>
            <a:avLst/>
            <a:gdLst/>
            <a:ahLst/>
            <a:cxnLst/>
            <a:rect l="0" t="0" r="0" b="0"/>
            <a:pathLst>
              <a:path w="7667941">
                <a:moveTo>
                  <a:pt x="0" y="0"/>
                </a:moveTo>
                <a:lnTo>
                  <a:pt x="7667941" y="0"/>
                </a:lnTo>
                <a:lnTo>
                  <a:pt x="7667941" y="0"/>
                </a:lnTo>
              </a:path>
            </a:pathLst>
          </a:custGeom>
          <a:ln w="6775" cap="flat">
            <a:solidFill>
              <a:srgbClr val="EBEBEB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37" name="pl10">
            <a:extLst>
              <a:ext uri="{FF2B5EF4-FFF2-40B4-BE49-F238E27FC236}">
                <a16:creationId xmlns:a16="http://schemas.microsoft.com/office/drawing/2014/main" id="{64B1726F-229D-C729-17EE-52A33F6FB652}"/>
              </a:ext>
            </a:extLst>
          </p:cNvPr>
          <p:cNvSpPr/>
          <p:nvPr/>
        </p:nvSpPr>
        <p:spPr>
          <a:xfrm flipV="1">
            <a:off x="3756847" y="1682715"/>
            <a:ext cx="5061378" cy="34438"/>
          </a:xfrm>
          <a:custGeom>
            <a:avLst/>
            <a:gdLst/>
            <a:ahLst/>
            <a:cxnLst/>
            <a:rect l="0" t="0" r="0" b="0"/>
            <a:pathLst>
              <a:path w="7667941">
                <a:moveTo>
                  <a:pt x="0" y="0"/>
                </a:moveTo>
                <a:lnTo>
                  <a:pt x="7667941" y="0"/>
                </a:lnTo>
                <a:lnTo>
                  <a:pt x="7667941" y="0"/>
                </a:lnTo>
              </a:path>
            </a:pathLst>
          </a:custGeom>
          <a:ln w="6775" cap="flat">
            <a:solidFill>
              <a:srgbClr val="EBEBEB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38" name="pl11">
            <a:extLst>
              <a:ext uri="{FF2B5EF4-FFF2-40B4-BE49-F238E27FC236}">
                <a16:creationId xmlns:a16="http://schemas.microsoft.com/office/drawing/2014/main" id="{46F13171-33C6-8223-6758-559C9AF8EF06}"/>
              </a:ext>
            </a:extLst>
          </p:cNvPr>
          <p:cNvSpPr/>
          <p:nvPr/>
        </p:nvSpPr>
        <p:spPr>
          <a:xfrm>
            <a:off x="5030631" y="1646857"/>
            <a:ext cx="36913" cy="3353007"/>
          </a:xfrm>
          <a:custGeom>
            <a:avLst/>
            <a:gdLst/>
            <a:ahLst/>
            <a:cxnLst/>
            <a:rect l="0" t="0" r="0" b="0"/>
            <a:pathLst>
              <a:path h="5734648">
                <a:moveTo>
                  <a:pt x="0" y="573464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ln w="6775" cap="flat">
            <a:solidFill>
              <a:srgbClr val="EBEBEB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39" name="pl12">
            <a:extLst>
              <a:ext uri="{FF2B5EF4-FFF2-40B4-BE49-F238E27FC236}">
                <a16:creationId xmlns:a16="http://schemas.microsoft.com/office/drawing/2014/main" id="{BD574FA1-7611-5656-A844-7D171F5EDDD7}"/>
              </a:ext>
            </a:extLst>
          </p:cNvPr>
          <p:cNvSpPr/>
          <p:nvPr/>
        </p:nvSpPr>
        <p:spPr>
          <a:xfrm>
            <a:off x="6448309" y="1646857"/>
            <a:ext cx="36913" cy="3353007"/>
          </a:xfrm>
          <a:custGeom>
            <a:avLst/>
            <a:gdLst/>
            <a:ahLst/>
            <a:cxnLst/>
            <a:rect l="0" t="0" r="0" b="0"/>
            <a:pathLst>
              <a:path h="5734648">
                <a:moveTo>
                  <a:pt x="0" y="573464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ln w="6775" cap="flat">
            <a:solidFill>
              <a:srgbClr val="EBEBEB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40" name="pl13">
            <a:extLst>
              <a:ext uri="{FF2B5EF4-FFF2-40B4-BE49-F238E27FC236}">
                <a16:creationId xmlns:a16="http://schemas.microsoft.com/office/drawing/2014/main" id="{466CBCC2-0AB8-A1C1-2623-5567149B45F0}"/>
              </a:ext>
            </a:extLst>
          </p:cNvPr>
          <p:cNvSpPr/>
          <p:nvPr/>
        </p:nvSpPr>
        <p:spPr>
          <a:xfrm>
            <a:off x="7865988" y="1646857"/>
            <a:ext cx="36913" cy="3353007"/>
          </a:xfrm>
          <a:custGeom>
            <a:avLst/>
            <a:gdLst/>
            <a:ahLst/>
            <a:cxnLst/>
            <a:rect l="0" t="0" r="0" b="0"/>
            <a:pathLst>
              <a:path h="5734648">
                <a:moveTo>
                  <a:pt x="0" y="573464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ln w="6775" cap="flat">
            <a:solidFill>
              <a:srgbClr val="EBEBEB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41" name="pl14">
            <a:extLst>
              <a:ext uri="{FF2B5EF4-FFF2-40B4-BE49-F238E27FC236}">
                <a16:creationId xmlns:a16="http://schemas.microsoft.com/office/drawing/2014/main" id="{9F17CE6F-8964-BBD5-03FE-3F65B25AC010}"/>
              </a:ext>
            </a:extLst>
          </p:cNvPr>
          <p:cNvSpPr/>
          <p:nvPr/>
        </p:nvSpPr>
        <p:spPr>
          <a:xfrm>
            <a:off x="3990763" y="1763357"/>
            <a:ext cx="4601254" cy="2214540"/>
          </a:xfrm>
          <a:custGeom>
            <a:avLst/>
            <a:gdLst/>
            <a:ahLst/>
            <a:cxnLst/>
            <a:rect l="0" t="0" r="0" b="0"/>
            <a:pathLst>
              <a:path w="6970856" h="3787528">
                <a:moveTo>
                  <a:pt x="0" y="0"/>
                </a:moveTo>
                <a:lnTo>
                  <a:pt x="164765" y="0"/>
                </a:lnTo>
                <a:lnTo>
                  <a:pt x="164765" y="0"/>
                </a:lnTo>
                <a:lnTo>
                  <a:pt x="196451" y="0"/>
                </a:lnTo>
                <a:lnTo>
                  <a:pt x="196451" y="0"/>
                </a:lnTo>
                <a:lnTo>
                  <a:pt x="252429" y="0"/>
                </a:lnTo>
                <a:lnTo>
                  <a:pt x="252429" y="17972"/>
                </a:lnTo>
                <a:lnTo>
                  <a:pt x="269328" y="17972"/>
                </a:lnTo>
                <a:lnTo>
                  <a:pt x="269328" y="35995"/>
                </a:lnTo>
                <a:lnTo>
                  <a:pt x="305239" y="35995"/>
                </a:lnTo>
                <a:lnTo>
                  <a:pt x="305239" y="35995"/>
                </a:lnTo>
                <a:lnTo>
                  <a:pt x="330587" y="35995"/>
                </a:lnTo>
                <a:lnTo>
                  <a:pt x="330587" y="35995"/>
                </a:lnTo>
                <a:lnTo>
                  <a:pt x="359104" y="35995"/>
                </a:lnTo>
                <a:lnTo>
                  <a:pt x="359104" y="35995"/>
                </a:lnTo>
                <a:lnTo>
                  <a:pt x="415082" y="35995"/>
                </a:lnTo>
                <a:lnTo>
                  <a:pt x="415082" y="35995"/>
                </a:lnTo>
                <a:lnTo>
                  <a:pt x="486903" y="35995"/>
                </a:lnTo>
                <a:lnTo>
                  <a:pt x="486903" y="35995"/>
                </a:lnTo>
                <a:lnTo>
                  <a:pt x="529151" y="35995"/>
                </a:lnTo>
                <a:lnTo>
                  <a:pt x="529151" y="54194"/>
                </a:lnTo>
                <a:lnTo>
                  <a:pt x="753063" y="54194"/>
                </a:lnTo>
                <a:lnTo>
                  <a:pt x="753063" y="72693"/>
                </a:lnTo>
                <a:lnTo>
                  <a:pt x="762569" y="72693"/>
                </a:lnTo>
                <a:lnTo>
                  <a:pt x="762569" y="72693"/>
                </a:lnTo>
                <a:lnTo>
                  <a:pt x="777356" y="72693"/>
                </a:lnTo>
                <a:lnTo>
                  <a:pt x="777356" y="72693"/>
                </a:lnTo>
                <a:lnTo>
                  <a:pt x="787918" y="72693"/>
                </a:lnTo>
                <a:lnTo>
                  <a:pt x="787918" y="72693"/>
                </a:lnTo>
                <a:lnTo>
                  <a:pt x="810097" y="72693"/>
                </a:lnTo>
                <a:lnTo>
                  <a:pt x="810097" y="72693"/>
                </a:lnTo>
                <a:lnTo>
                  <a:pt x="822772" y="72693"/>
                </a:lnTo>
                <a:lnTo>
                  <a:pt x="822772" y="72693"/>
                </a:lnTo>
                <a:lnTo>
                  <a:pt x="887199" y="72693"/>
                </a:lnTo>
                <a:lnTo>
                  <a:pt x="887199" y="91341"/>
                </a:lnTo>
                <a:lnTo>
                  <a:pt x="928391" y="91341"/>
                </a:lnTo>
                <a:lnTo>
                  <a:pt x="928391" y="91341"/>
                </a:lnTo>
                <a:lnTo>
                  <a:pt x="972751" y="91341"/>
                </a:lnTo>
                <a:lnTo>
                  <a:pt x="972751" y="91341"/>
                </a:lnTo>
                <a:lnTo>
                  <a:pt x="1051965" y="91341"/>
                </a:lnTo>
                <a:lnTo>
                  <a:pt x="1051965" y="91341"/>
                </a:lnTo>
                <a:lnTo>
                  <a:pt x="1097381" y="91341"/>
                </a:lnTo>
                <a:lnTo>
                  <a:pt x="1097381" y="91341"/>
                </a:lnTo>
                <a:lnTo>
                  <a:pt x="1112168" y="91341"/>
                </a:lnTo>
                <a:lnTo>
                  <a:pt x="1112168" y="91341"/>
                </a:lnTo>
                <a:lnTo>
                  <a:pt x="1125898" y="91341"/>
                </a:lnTo>
                <a:lnTo>
                  <a:pt x="1125898" y="110158"/>
                </a:lnTo>
                <a:lnTo>
                  <a:pt x="1182933" y="110158"/>
                </a:lnTo>
                <a:lnTo>
                  <a:pt x="1182933" y="110158"/>
                </a:lnTo>
                <a:lnTo>
                  <a:pt x="1200888" y="110158"/>
                </a:lnTo>
                <a:lnTo>
                  <a:pt x="1200888" y="129054"/>
                </a:lnTo>
                <a:lnTo>
                  <a:pt x="1215675" y="129054"/>
                </a:lnTo>
                <a:lnTo>
                  <a:pt x="1215675" y="129054"/>
                </a:lnTo>
                <a:lnTo>
                  <a:pt x="1277990" y="129054"/>
                </a:lnTo>
                <a:lnTo>
                  <a:pt x="1277990" y="129054"/>
                </a:lnTo>
                <a:lnTo>
                  <a:pt x="1279046" y="129054"/>
                </a:lnTo>
                <a:lnTo>
                  <a:pt x="1279046" y="129054"/>
                </a:lnTo>
                <a:lnTo>
                  <a:pt x="1347698" y="129054"/>
                </a:lnTo>
                <a:lnTo>
                  <a:pt x="1347698" y="129054"/>
                </a:lnTo>
                <a:lnTo>
                  <a:pt x="1358260" y="129054"/>
                </a:lnTo>
                <a:lnTo>
                  <a:pt x="1358260" y="129054"/>
                </a:lnTo>
                <a:lnTo>
                  <a:pt x="1371991" y="129054"/>
                </a:lnTo>
                <a:lnTo>
                  <a:pt x="1371991" y="129054"/>
                </a:lnTo>
                <a:lnTo>
                  <a:pt x="1374103" y="129054"/>
                </a:lnTo>
                <a:lnTo>
                  <a:pt x="1374103" y="129054"/>
                </a:lnTo>
                <a:lnTo>
                  <a:pt x="1412126" y="129054"/>
                </a:lnTo>
                <a:lnTo>
                  <a:pt x="1412126" y="129054"/>
                </a:lnTo>
                <a:lnTo>
                  <a:pt x="1436418" y="129054"/>
                </a:lnTo>
                <a:lnTo>
                  <a:pt x="1436418" y="129054"/>
                </a:lnTo>
                <a:lnTo>
                  <a:pt x="1453317" y="129054"/>
                </a:lnTo>
                <a:lnTo>
                  <a:pt x="1453317" y="148260"/>
                </a:lnTo>
                <a:lnTo>
                  <a:pt x="1475497" y="148260"/>
                </a:lnTo>
                <a:lnTo>
                  <a:pt x="1475497" y="148260"/>
                </a:lnTo>
                <a:lnTo>
                  <a:pt x="1481835" y="148260"/>
                </a:lnTo>
                <a:lnTo>
                  <a:pt x="1481835" y="148260"/>
                </a:lnTo>
                <a:lnTo>
                  <a:pt x="1527251" y="148260"/>
                </a:lnTo>
                <a:lnTo>
                  <a:pt x="1527251" y="148260"/>
                </a:lnTo>
                <a:lnTo>
                  <a:pt x="1551543" y="148260"/>
                </a:lnTo>
                <a:lnTo>
                  <a:pt x="1551543" y="148260"/>
                </a:lnTo>
                <a:lnTo>
                  <a:pt x="1610690" y="148260"/>
                </a:lnTo>
                <a:lnTo>
                  <a:pt x="1610690" y="148260"/>
                </a:lnTo>
                <a:lnTo>
                  <a:pt x="1668780" y="148260"/>
                </a:lnTo>
                <a:lnTo>
                  <a:pt x="1668780" y="167666"/>
                </a:lnTo>
                <a:lnTo>
                  <a:pt x="1676174" y="167666"/>
                </a:lnTo>
                <a:lnTo>
                  <a:pt x="1676174" y="167666"/>
                </a:lnTo>
                <a:lnTo>
                  <a:pt x="1695185" y="167666"/>
                </a:lnTo>
                <a:lnTo>
                  <a:pt x="1695185" y="167666"/>
                </a:lnTo>
                <a:lnTo>
                  <a:pt x="1703635" y="167666"/>
                </a:lnTo>
                <a:lnTo>
                  <a:pt x="1703635" y="167666"/>
                </a:lnTo>
                <a:lnTo>
                  <a:pt x="1722646" y="167666"/>
                </a:lnTo>
                <a:lnTo>
                  <a:pt x="1722646" y="167666"/>
                </a:lnTo>
                <a:lnTo>
                  <a:pt x="1745882" y="167666"/>
                </a:lnTo>
                <a:lnTo>
                  <a:pt x="1745882" y="187178"/>
                </a:lnTo>
                <a:lnTo>
                  <a:pt x="1779680" y="187178"/>
                </a:lnTo>
                <a:lnTo>
                  <a:pt x="1779680" y="187178"/>
                </a:lnTo>
                <a:lnTo>
                  <a:pt x="1797635" y="187178"/>
                </a:lnTo>
                <a:lnTo>
                  <a:pt x="1797635" y="187178"/>
                </a:lnTo>
                <a:lnTo>
                  <a:pt x="1799748" y="187178"/>
                </a:lnTo>
                <a:lnTo>
                  <a:pt x="1799748" y="206727"/>
                </a:lnTo>
                <a:lnTo>
                  <a:pt x="1829321" y="206727"/>
                </a:lnTo>
                <a:lnTo>
                  <a:pt x="1829321" y="206727"/>
                </a:lnTo>
                <a:lnTo>
                  <a:pt x="1841995" y="206727"/>
                </a:lnTo>
                <a:lnTo>
                  <a:pt x="1841995" y="206727"/>
                </a:lnTo>
                <a:lnTo>
                  <a:pt x="1866288" y="206727"/>
                </a:lnTo>
                <a:lnTo>
                  <a:pt x="1866288" y="226425"/>
                </a:lnTo>
                <a:lnTo>
                  <a:pt x="1915929" y="226425"/>
                </a:lnTo>
                <a:lnTo>
                  <a:pt x="1915929" y="226425"/>
                </a:lnTo>
                <a:lnTo>
                  <a:pt x="1945502" y="226425"/>
                </a:lnTo>
                <a:lnTo>
                  <a:pt x="1945502" y="226425"/>
                </a:lnTo>
                <a:lnTo>
                  <a:pt x="2046896" y="226425"/>
                </a:lnTo>
                <a:lnTo>
                  <a:pt x="2046896" y="226425"/>
                </a:lnTo>
                <a:lnTo>
                  <a:pt x="2047953" y="226425"/>
                </a:lnTo>
                <a:lnTo>
                  <a:pt x="2047953" y="226425"/>
                </a:lnTo>
                <a:lnTo>
                  <a:pt x="2055346" y="226425"/>
                </a:lnTo>
                <a:lnTo>
                  <a:pt x="2055346" y="226425"/>
                </a:lnTo>
                <a:lnTo>
                  <a:pt x="2082807" y="226425"/>
                </a:lnTo>
                <a:lnTo>
                  <a:pt x="2082807" y="226425"/>
                </a:lnTo>
                <a:lnTo>
                  <a:pt x="2100762" y="226425"/>
                </a:lnTo>
                <a:lnTo>
                  <a:pt x="2100762" y="226425"/>
                </a:lnTo>
                <a:lnTo>
                  <a:pt x="2111324" y="226425"/>
                </a:lnTo>
                <a:lnTo>
                  <a:pt x="2111324" y="226425"/>
                </a:lnTo>
                <a:lnTo>
                  <a:pt x="2122942" y="226425"/>
                </a:lnTo>
                <a:lnTo>
                  <a:pt x="2122942" y="226425"/>
                </a:lnTo>
                <a:lnTo>
                  <a:pt x="2130335" y="226425"/>
                </a:lnTo>
                <a:lnTo>
                  <a:pt x="2130335" y="226425"/>
                </a:lnTo>
                <a:lnTo>
                  <a:pt x="2134560" y="226425"/>
                </a:lnTo>
                <a:lnTo>
                  <a:pt x="2134560" y="226425"/>
                </a:lnTo>
                <a:lnTo>
                  <a:pt x="2148291" y="226425"/>
                </a:lnTo>
                <a:lnTo>
                  <a:pt x="2148291" y="226425"/>
                </a:lnTo>
                <a:lnTo>
                  <a:pt x="2188426" y="226425"/>
                </a:lnTo>
                <a:lnTo>
                  <a:pt x="2188426" y="226425"/>
                </a:lnTo>
                <a:lnTo>
                  <a:pt x="2192651" y="226425"/>
                </a:lnTo>
                <a:lnTo>
                  <a:pt x="2192651" y="246867"/>
                </a:lnTo>
                <a:lnTo>
                  <a:pt x="2224336" y="246867"/>
                </a:lnTo>
                <a:lnTo>
                  <a:pt x="2224336" y="246867"/>
                </a:lnTo>
                <a:lnTo>
                  <a:pt x="2228561" y="246867"/>
                </a:lnTo>
                <a:lnTo>
                  <a:pt x="2228561" y="246867"/>
                </a:lnTo>
                <a:lnTo>
                  <a:pt x="2343686" y="246867"/>
                </a:lnTo>
                <a:lnTo>
                  <a:pt x="2343686" y="267501"/>
                </a:lnTo>
                <a:lnTo>
                  <a:pt x="2360585" y="267501"/>
                </a:lnTo>
                <a:lnTo>
                  <a:pt x="2360585" y="288155"/>
                </a:lnTo>
                <a:lnTo>
                  <a:pt x="2393327" y="288155"/>
                </a:lnTo>
                <a:lnTo>
                  <a:pt x="2393327" y="288155"/>
                </a:lnTo>
                <a:lnTo>
                  <a:pt x="2428181" y="288155"/>
                </a:lnTo>
                <a:lnTo>
                  <a:pt x="2428181" y="288155"/>
                </a:lnTo>
                <a:lnTo>
                  <a:pt x="2455642" y="288155"/>
                </a:lnTo>
                <a:lnTo>
                  <a:pt x="2455642" y="288155"/>
                </a:lnTo>
                <a:lnTo>
                  <a:pt x="2467260" y="288155"/>
                </a:lnTo>
                <a:lnTo>
                  <a:pt x="2467260" y="288155"/>
                </a:lnTo>
                <a:lnTo>
                  <a:pt x="2500002" y="288155"/>
                </a:lnTo>
                <a:lnTo>
                  <a:pt x="2500002" y="288155"/>
                </a:lnTo>
                <a:lnTo>
                  <a:pt x="2545418" y="288155"/>
                </a:lnTo>
                <a:lnTo>
                  <a:pt x="2545418" y="309931"/>
                </a:lnTo>
                <a:lnTo>
                  <a:pt x="2557036" y="309931"/>
                </a:lnTo>
                <a:lnTo>
                  <a:pt x="2557036" y="309931"/>
                </a:lnTo>
                <a:lnTo>
                  <a:pt x="2709128" y="309931"/>
                </a:lnTo>
                <a:lnTo>
                  <a:pt x="2709128" y="332038"/>
                </a:lnTo>
                <a:lnTo>
                  <a:pt x="2726027" y="332038"/>
                </a:lnTo>
                <a:lnTo>
                  <a:pt x="2726027" y="332038"/>
                </a:lnTo>
                <a:lnTo>
                  <a:pt x="2735533" y="332038"/>
                </a:lnTo>
                <a:lnTo>
                  <a:pt x="2735533" y="332038"/>
                </a:lnTo>
                <a:lnTo>
                  <a:pt x="2742926" y="332038"/>
                </a:lnTo>
                <a:lnTo>
                  <a:pt x="2742926" y="354239"/>
                </a:lnTo>
                <a:lnTo>
                  <a:pt x="2780949" y="354239"/>
                </a:lnTo>
                <a:lnTo>
                  <a:pt x="2780949" y="354239"/>
                </a:lnTo>
                <a:lnTo>
                  <a:pt x="2786230" y="354239"/>
                </a:lnTo>
                <a:lnTo>
                  <a:pt x="2786230" y="376498"/>
                </a:lnTo>
                <a:lnTo>
                  <a:pt x="2795735" y="376498"/>
                </a:lnTo>
                <a:lnTo>
                  <a:pt x="2795735" y="376498"/>
                </a:lnTo>
                <a:lnTo>
                  <a:pt x="2797848" y="376498"/>
                </a:lnTo>
                <a:lnTo>
                  <a:pt x="2797848" y="376498"/>
                </a:lnTo>
                <a:lnTo>
                  <a:pt x="2826365" y="376498"/>
                </a:lnTo>
                <a:lnTo>
                  <a:pt x="2826365" y="398885"/>
                </a:lnTo>
                <a:lnTo>
                  <a:pt x="2846432" y="398885"/>
                </a:lnTo>
                <a:lnTo>
                  <a:pt x="2846432" y="398885"/>
                </a:lnTo>
                <a:lnTo>
                  <a:pt x="2868612" y="398885"/>
                </a:lnTo>
                <a:lnTo>
                  <a:pt x="2868612" y="398885"/>
                </a:lnTo>
                <a:lnTo>
                  <a:pt x="2874950" y="398885"/>
                </a:lnTo>
                <a:lnTo>
                  <a:pt x="2874950" y="398885"/>
                </a:lnTo>
                <a:lnTo>
                  <a:pt x="2955220" y="398885"/>
                </a:lnTo>
                <a:lnTo>
                  <a:pt x="2955220" y="398885"/>
                </a:lnTo>
                <a:lnTo>
                  <a:pt x="2993243" y="398885"/>
                </a:lnTo>
                <a:lnTo>
                  <a:pt x="2993243" y="398885"/>
                </a:lnTo>
                <a:lnTo>
                  <a:pt x="2994299" y="398885"/>
                </a:lnTo>
                <a:lnTo>
                  <a:pt x="2994299" y="398885"/>
                </a:lnTo>
                <a:lnTo>
                  <a:pt x="2999580" y="398885"/>
                </a:lnTo>
                <a:lnTo>
                  <a:pt x="2999580" y="398885"/>
                </a:lnTo>
                <a:lnTo>
                  <a:pt x="3019648" y="398885"/>
                </a:lnTo>
                <a:lnTo>
                  <a:pt x="3019648" y="398885"/>
                </a:lnTo>
                <a:lnTo>
                  <a:pt x="3073513" y="398885"/>
                </a:lnTo>
                <a:lnTo>
                  <a:pt x="3073513" y="398885"/>
                </a:lnTo>
                <a:lnTo>
                  <a:pt x="3089356" y="398885"/>
                </a:lnTo>
                <a:lnTo>
                  <a:pt x="3089356" y="398885"/>
                </a:lnTo>
                <a:lnTo>
                  <a:pt x="3127379" y="398885"/>
                </a:lnTo>
                <a:lnTo>
                  <a:pt x="3127379" y="422481"/>
                </a:lnTo>
                <a:lnTo>
                  <a:pt x="3165402" y="422481"/>
                </a:lnTo>
                <a:lnTo>
                  <a:pt x="3165402" y="422481"/>
                </a:lnTo>
                <a:lnTo>
                  <a:pt x="3246729" y="422481"/>
                </a:lnTo>
                <a:lnTo>
                  <a:pt x="3246729" y="422481"/>
                </a:lnTo>
                <a:lnTo>
                  <a:pt x="3267852" y="422481"/>
                </a:lnTo>
                <a:lnTo>
                  <a:pt x="3267852" y="422481"/>
                </a:lnTo>
                <a:lnTo>
                  <a:pt x="3310100" y="422481"/>
                </a:lnTo>
                <a:lnTo>
                  <a:pt x="3310100" y="422481"/>
                </a:lnTo>
                <a:lnTo>
                  <a:pt x="3335449" y="422481"/>
                </a:lnTo>
                <a:lnTo>
                  <a:pt x="3335449" y="422481"/>
                </a:lnTo>
                <a:lnTo>
                  <a:pt x="3336505" y="422481"/>
                </a:lnTo>
                <a:lnTo>
                  <a:pt x="3336505" y="422481"/>
                </a:lnTo>
                <a:lnTo>
                  <a:pt x="3352348" y="422481"/>
                </a:lnTo>
                <a:lnTo>
                  <a:pt x="3352348" y="422481"/>
                </a:lnTo>
                <a:lnTo>
                  <a:pt x="3400932" y="422481"/>
                </a:lnTo>
                <a:lnTo>
                  <a:pt x="3400932" y="446623"/>
                </a:lnTo>
                <a:lnTo>
                  <a:pt x="3415719" y="446623"/>
                </a:lnTo>
                <a:lnTo>
                  <a:pt x="3415719" y="470771"/>
                </a:lnTo>
                <a:lnTo>
                  <a:pt x="3422056" y="470771"/>
                </a:lnTo>
                <a:lnTo>
                  <a:pt x="3422056" y="494937"/>
                </a:lnTo>
                <a:lnTo>
                  <a:pt x="3425225" y="494937"/>
                </a:lnTo>
                <a:lnTo>
                  <a:pt x="3425225" y="519229"/>
                </a:lnTo>
                <a:lnTo>
                  <a:pt x="3426281" y="519229"/>
                </a:lnTo>
                <a:lnTo>
                  <a:pt x="3426281" y="543762"/>
                </a:lnTo>
                <a:lnTo>
                  <a:pt x="3435787" y="543762"/>
                </a:lnTo>
                <a:lnTo>
                  <a:pt x="3435787" y="543762"/>
                </a:lnTo>
                <a:lnTo>
                  <a:pt x="3437899" y="543762"/>
                </a:lnTo>
                <a:lnTo>
                  <a:pt x="3437899" y="543762"/>
                </a:lnTo>
                <a:lnTo>
                  <a:pt x="3481203" y="543762"/>
                </a:lnTo>
                <a:lnTo>
                  <a:pt x="3481203" y="543762"/>
                </a:lnTo>
                <a:lnTo>
                  <a:pt x="3483315" y="543762"/>
                </a:lnTo>
                <a:lnTo>
                  <a:pt x="3483315" y="568385"/>
                </a:lnTo>
                <a:lnTo>
                  <a:pt x="3491765" y="568385"/>
                </a:lnTo>
                <a:lnTo>
                  <a:pt x="3491765" y="593018"/>
                </a:lnTo>
                <a:lnTo>
                  <a:pt x="3501271" y="593018"/>
                </a:lnTo>
                <a:lnTo>
                  <a:pt x="3501271" y="593018"/>
                </a:lnTo>
                <a:lnTo>
                  <a:pt x="3507608" y="593018"/>
                </a:lnTo>
                <a:lnTo>
                  <a:pt x="3507608" y="593018"/>
                </a:lnTo>
                <a:lnTo>
                  <a:pt x="3508664" y="593018"/>
                </a:lnTo>
                <a:lnTo>
                  <a:pt x="3508664" y="593018"/>
                </a:lnTo>
                <a:lnTo>
                  <a:pt x="3525563" y="593018"/>
                </a:lnTo>
                <a:lnTo>
                  <a:pt x="3525563" y="617943"/>
                </a:lnTo>
                <a:lnTo>
                  <a:pt x="3530844" y="617943"/>
                </a:lnTo>
                <a:lnTo>
                  <a:pt x="3530844" y="617943"/>
                </a:lnTo>
                <a:lnTo>
                  <a:pt x="3569923" y="617943"/>
                </a:lnTo>
                <a:lnTo>
                  <a:pt x="3569923" y="617943"/>
                </a:lnTo>
                <a:lnTo>
                  <a:pt x="3572035" y="617943"/>
                </a:lnTo>
                <a:lnTo>
                  <a:pt x="3572035" y="617943"/>
                </a:lnTo>
                <a:lnTo>
                  <a:pt x="3624845" y="617943"/>
                </a:lnTo>
                <a:lnTo>
                  <a:pt x="3624845" y="643092"/>
                </a:lnTo>
                <a:lnTo>
                  <a:pt x="3636463" y="643092"/>
                </a:lnTo>
                <a:lnTo>
                  <a:pt x="3636463" y="668247"/>
                </a:lnTo>
                <a:lnTo>
                  <a:pt x="3649137" y="668247"/>
                </a:lnTo>
                <a:lnTo>
                  <a:pt x="3649137" y="668247"/>
                </a:lnTo>
                <a:lnTo>
                  <a:pt x="3657587" y="668247"/>
                </a:lnTo>
                <a:lnTo>
                  <a:pt x="3657587" y="668247"/>
                </a:lnTo>
                <a:lnTo>
                  <a:pt x="3674486" y="668247"/>
                </a:lnTo>
                <a:lnTo>
                  <a:pt x="3674486" y="668247"/>
                </a:lnTo>
                <a:lnTo>
                  <a:pt x="3681879" y="668247"/>
                </a:lnTo>
                <a:lnTo>
                  <a:pt x="3681879" y="668247"/>
                </a:lnTo>
                <a:lnTo>
                  <a:pt x="3692441" y="668247"/>
                </a:lnTo>
                <a:lnTo>
                  <a:pt x="3692441" y="668247"/>
                </a:lnTo>
                <a:lnTo>
                  <a:pt x="3699834" y="668247"/>
                </a:lnTo>
                <a:lnTo>
                  <a:pt x="3699834" y="668247"/>
                </a:lnTo>
                <a:lnTo>
                  <a:pt x="3724127" y="668247"/>
                </a:lnTo>
                <a:lnTo>
                  <a:pt x="3724127" y="668247"/>
                </a:lnTo>
                <a:lnTo>
                  <a:pt x="3757925" y="668247"/>
                </a:lnTo>
                <a:lnTo>
                  <a:pt x="3757925" y="668247"/>
                </a:lnTo>
                <a:lnTo>
                  <a:pt x="3767430" y="668247"/>
                </a:lnTo>
                <a:lnTo>
                  <a:pt x="3767430" y="668247"/>
                </a:lnTo>
                <a:lnTo>
                  <a:pt x="3773768" y="668247"/>
                </a:lnTo>
                <a:lnTo>
                  <a:pt x="3773768" y="720338"/>
                </a:lnTo>
                <a:lnTo>
                  <a:pt x="3774824" y="720338"/>
                </a:lnTo>
                <a:lnTo>
                  <a:pt x="3774824" y="720338"/>
                </a:lnTo>
                <a:lnTo>
                  <a:pt x="3775880" y="720338"/>
                </a:lnTo>
                <a:lnTo>
                  <a:pt x="3775880" y="720338"/>
                </a:lnTo>
                <a:lnTo>
                  <a:pt x="3784330" y="720338"/>
                </a:lnTo>
                <a:lnTo>
                  <a:pt x="3784330" y="720338"/>
                </a:lnTo>
                <a:lnTo>
                  <a:pt x="3790667" y="720338"/>
                </a:lnTo>
                <a:lnTo>
                  <a:pt x="3790667" y="720338"/>
                </a:lnTo>
                <a:lnTo>
                  <a:pt x="3791723" y="720338"/>
                </a:lnTo>
                <a:lnTo>
                  <a:pt x="3791723" y="720338"/>
                </a:lnTo>
                <a:lnTo>
                  <a:pt x="3799116" y="720338"/>
                </a:lnTo>
                <a:lnTo>
                  <a:pt x="3799116" y="720338"/>
                </a:lnTo>
                <a:lnTo>
                  <a:pt x="3804397" y="720338"/>
                </a:lnTo>
                <a:lnTo>
                  <a:pt x="3804397" y="720338"/>
                </a:lnTo>
                <a:lnTo>
                  <a:pt x="3807566" y="720338"/>
                </a:lnTo>
                <a:lnTo>
                  <a:pt x="3807566" y="747255"/>
                </a:lnTo>
                <a:lnTo>
                  <a:pt x="3812847" y="747255"/>
                </a:lnTo>
                <a:lnTo>
                  <a:pt x="3812847" y="747255"/>
                </a:lnTo>
                <a:lnTo>
                  <a:pt x="3813903" y="747255"/>
                </a:lnTo>
                <a:lnTo>
                  <a:pt x="3813903" y="747255"/>
                </a:lnTo>
                <a:lnTo>
                  <a:pt x="3816015" y="747255"/>
                </a:lnTo>
                <a:lnTo>
                  <a:pt x="3816015" y="774344"/>
                </a:lnTo>
                <a:lnTo>
                  <a:pt x="3839251" y="774344"/>
                </a:lnTo>
                <a:lnTo>
                  <a:pt x="3839251" y="774344"/>
                </a:lnTo>
                <a:lnTo>
                  <a:pt x="3844532" y="774344"/>
                </a:lnTo>
                <a:lnTo>
                  <a:pt x="3844532" y="774344"/>
                </a:lnTo>
                <a:lnTo>
                  <a:pt x="3845589" y="774344"/>
                </a:lnTo>
                <a:lnTo>
                  <a:pt x="3845589" y="774344"/>
                </a:lnTo>
                <a:lnTo>
                  <a:pt x="3851926" y="774344"/>
                </a:lnTo>
                <a:lnTo>
                  <a:pt x="3851926" y="774344"/>
                </a:lnTo>
                <a:lnTo>
                  <a:pt x="3852982" y="774344"/>
                </a:lnTo>
                <a:lnTo>
                  <a:pt x="3852982" y="774344"/>
                </a:lnTo>
                <a:lnTo>
                  <a:pt x="3874106" y="774344"/>
                </a:lnTo>
                <a:lnTo>
                  <a:pt x="3874106" y="774344"/>
                </a:lnTo>
                <a:lnTo>
                  <a:pt x="3910016" y="774344"/>
                </a:lnTo>
                <a:lnTo>
                  <a:pt x="3910016" y="801723"/>
                </a:lnTo>
                <a:lnTo>
                  <a:pt x="3923747" y="801723"/>
                </a:lnTo>
                <a:lnTo>
                  <a:pt x="3923747" y="801723"/>
                </a:lnTo>
                <a:lnTo>
                  <a:pt x="3927971" y="801723"/>
                </a:lnTo>
                <a:lnTo>
                  <a:pt x="3927971" y="801723"/>
                </a:lnTo>
                <a:lnTo>
                  <a:pt x="3932196" y="801723"/>
                </a:lnTo>
                <a:lnTo>
                  <a:pt x="3932196" y="801723"/>
                </a:lnTo>
                <a:lnTo>
                  <a:pt x="3950151" y="801723"/>
                </a:lnTo>
                <a:lnTo>
                  <a:pt x="3950151" y="801723"/>
                </a:lnTo>
                <a:lnTo>
                  <a:pt x="3964938" y="801723"/>
                </a:lnTo>
                <a:lnTo>
                  <a:pt x="3964938" y="829283"/>
                </a:lnTo>
                <a:lnTo>
                  <a:pt x="4094849" y="829283"/>
                </a:lnTo>
                <a:lnTo>
                  <a:pt x="4094849" y="829283"/>
                </a:lnTo>
                <a:lnTo>
                  <a:pt x="4118086" y="829283"/>
                </a:lnTo>
                <a:lnTo>
                  <a:pt x="4118086" y="829283"/>
                </a:lnTo>
                <a:lnTo>
                  <a:pt x="4151884" y="829283"/>
                </a:lnTo>
                <a:lnTo>
                  <a:pt x="4151884" y="829283"/>
                </a:lnTo>
                <a:lnTo>
                  <a:pt x="4164558" y="829283"/>
                </a:lnTo>
                <a:lnTo>
                  <a:pt x="4164558" y="829283"/>
                </a:lnTo>
                <a:lnTo>
                  <a:pt x="4180401" y="829283"/>
                </a:lnTo>
                <a:lnTo>
                  <a:pt x="4180401" y="858027"/>
                </a:lnTo>
                <a:lnTo>
                  <a:pt x="4199412" y="858027"/>
                </a:lnTo>
                <a:lnTo>
                  <a:pt x="4199412" y="858027"/>
                </a:lnTo>
                <a:lnTo>
                  <a:pt x="4203637" y="858027"/>
                </a:lnTo>
                <a:lnTo>
                  <a:pt x="4203637" y="886903"/>
                </a:lnTo>
                <a:lnTo>
                  <a:pt x="4227929" y="886903"/>
                </a:lnTo>
                <a:lnTo>
                  <a:pt x="4227929" y="886903"/>
                </a:lnTo>
                <a:lnTo>
                  <a:pt x="4237435" y="886903"/>
                </a:lnTo>
                <a:lnTo>
                  <a:pt x="4237435" y="886903"/>
                </a:lnTo>
                <a:lnTo>
                  <a:pt x="4240604" y="886903"/>
                </a:lnTo>
                <a:lnTo>
                  <a:pt x="4240604" y="886903"/>
                </a:lnTo>
                <a:lnTo>
                  <a:pt x="4272289" y="886903"/>
                </a:lnTo>
                <a:lnTo>
                  <a:pt x="4272289" y="886903"/>
                </a:lnTo>
                <a:lnTo>
                  <a:pt x="4275458" y="886903"/>
                </a:lnTo>
                <a:lnTo>
                  <a:pt x="4275458" y="886903"/>
                </a:lnTo>
                <a:lnTo>
                  <a:pt x="4279683" y="886903"/>
                </a:lnTo>
                <a:lnTo>
                  <a:pt x="4279683" y="916083"/>
                </a:lnTo>
                <a:lnTo>
                  <a:pt x="4301863" y="916083"/>
                </a:lnTo>
                <a:lnTo>
                  <a:pt x="4301863" y="916083"/>
                </a:lnTo>
                <a:lnTo>
                  <a:pt x="4344110" y="916083"/>
                </a:lnTo>
                <a:lnTo>
                  <a:pt x="4344110" y="945387"/>
                </a:lnTo>
                <a:lnTo>
                  <a:pt x="4347279" y="945387"/>
                </a:lnTo>
                <a:lnTo>
                  <a:pt x="4347279" y="945387"/>
                </a:lnTo>
                <a:lnTo>
                  <a:pt x="4350448" y="945387"/>
                </a:lnTo>
                <a:lnTo>
                  <a:pt x="4350448" y="974823"/>
                </a:lnTo>
                <a:lnTo>
                  <a:pt x="4406426" y="974823"/>
                </a:lnTo>
                <a:lnTo>
                  <a:pt x="4406426" y="974823"/>
                </a:lnTo>
                <a:lnTo>
                  <a:pt x="4426493" y="974823"/>
                </a:lnTo>
                <a:lnTo>
                  <a:pt x="4426493" y="974823"/>
                </a:lnTo>
                <a:lnTo>
                  <a:pt x="4443392" y="974823"/>
                </a:lnTo>
                <a:lnTo>
                  <a:pt x="4443392" y="974823"/>
                </a:lnTo>
                <a:lnTo>
                  <a:pt x="4445505" y="974823"/>
                </a:lnTo>
                <a:lnTo>
                  <a:pt x="4445505" y="974823"/>
                </a:lnTo>
                <a:lnTo>
                  <a:pt x="4460291" y="974823"/>
                </a:lnTo>
                <a:lnTo>
                  <a:pt x="4460291" y="974823"/>
                </a:lnTo>
                <a:lnTo>
                  <a:pt x="4475078" y="974823"/>
                </a:lnTo>
                <a:lnTo>
                  <a:pt x="4475078" y="974823"/>
                </a:lnTo>
                <a:lnTo>
                  <a:pt x="4482471" y="974823"/>
                </a:lnTo>
                <a:lnTo>
                  <a:pt x="4482471" y="974823"/>
                </a:lnTo>
                <a:lnTo>
                  <a:pt x="4487752" y="974823"/>
                </a:lnTo>
                <a:lnTo>
                  <a:pt x="4487752" y="974823"/>
                </a:lnTo>
                <a:lnTo>
                  <a:pt x="4513101" y="974823"/>
                </a:lnTo>
                <a:lnTo>
                  <a:pt x="4513101" y="974823"/>
                </a:lnTo>
                <a:lnTo>
                  <a:pt x="4534225" y="974823"/>
                </a:lnTo>
                <a:lnTo>
                  <a:pt x="4534225" y="1005228"/>
                </a:lnTo>
                <a:lnTo>
                  <a:pt x="4559573" y="1005228"/>
                </a:lnTo>
                <a:lnTo>
                  <a:pt x="4559573" y="1035666"/>
                </a:lnTo>
                <a:lnTo>
                  <a:pt x="4585978" y="1035666"/>
                </a:lnTo>
                <a:lnTo>
                  <a:pt x="4585978" y="1035666"/>
                </a:lnTo>
                <a:lnTo>
                  <a:pt x="4590203" y="1035666"/>
                </a:lnTo>
                <a:lnTo>
                  <a:pt x="4590203" y="1035666"/>
                </a:lnTo>
                <a:lnTo>
                  <a:pt x="4598652" y="1035666"/>
                </a:lnTo>
                <a:lnTo>
                  <a:pt x="4598652" y="1066440"/>
                </a:lnTo>
                <a:lnTo>
                  <a:pt x="4599708" y="1066440"/>
                </a:lnTo>
                <a:lnTo>
                  <a:pt x="4599708" y="1097323"/>
                </a:lnTo>
                <a:lnTo>
                  <a:pt x="4601821" y="1097323"/>
                </a:lnTo>
                <a:lnTo>
                  <a:pt x="4601821" y="1097323"/>
                </a:lnTo>
                <a:lnTo>
                  <a:pt x="4604989" y="1097323"/>
                </a:lnTo>
                <a:lnTo>
                  <a:pt x="4604989" y="1128307"/>
                </a:lnTo>
                <a:lnTo>
                  <a:pt x="4614495" y="1128307"/>
                </a:lnTo>
                <a:lnTo>
                  <a:pt x="4614495" y="1128307"/>
                </a:lnTo>
                <a:lnTo>
                  <a:pt x="4616608" y="1128307"/>
                </a:lnTo>
                <a:lnTo>
                  <a:pt x="4616608" y="1159373"/>
                </a:lnTo>
                <a:lnTo>
                  <a:pt x="4632450" y="1159373"/>
                </a:lnTo>
                <a:lnTo>
                  <a:pt x="4632450" y="1159373"/>
                </a:lnTo>
                <a:lnTo>
                  <a:pt x="4638788" y="1159373"/>
                </a:lnTo>
                <a:lnTo>
                  <a:pt x="4638788" y="1159373"/>
                </a:lnTo>
                <a:lnTo>
                  <a:pt x="4650406" y="1159373"/>
                </a:lnTo>
                <a:lnTo>
                  <a:pt x="4650406" y="1190604"/>
                </a:lnTo>
                <a:lnTo>
                  <a:pt x="4657799" y="1190604"/>
                </a:lnTo>
                <a:lnTo>
                  <a:pt x="4657799" y="1190604"/>
                </a:lnTo>
                <a:lnTo>
                  <a:pt x="4659911" y="1190604"/>
                </a:lnTo>
                <a:lnTo>
                  <a:pt x="4659911" y="1190604"/>
                </a:lnTo>
                <a:lnTo>
                  <a:pt x="4666248" y="1190604"/>
                </a:lnTo>
                <a:lnTo>
                  <a:pt x="4666248" y="1221895"/>
                </a:lnTo>
                <a:lnTo>
                  <a:pt x="4670473" y="1221895"/>
                </a:lnTo>
                <a:lnTo>
                  <a:pt x="4670473" y="1253329"/>
                </a:lnTo>
                <a:lnTo>
                  <a:pt x="4673642" y="1253329"/>
                </a:lnTo>
                <a:lnTo>
                  <a:pt x="4673642" y="1284790"/>
                </a:lnTo>
                <a:lnTo>
                  <a:pt x="4676810" y="1284790"/>
                </a:lnTo>
                <a:lnTo>
                  <a:pt x="4676810" y="1284790"/>
                </a:lnTo>
                <a:lnTo>
                  <a:pt x="4702159" y="1284790"/>
                </a:lnTo>
                <a:lnTo>
                  <a:pt x="4702159" y="1284790"/>
                </a:lnTo>
                <a:lnTo>
                  <a:pt x="4738069" y="1284790"/>
                </a:lnTo>
                <a:lnTo>
                  <a:pt x="4738069" y="1284790"/>
                </a:lnTo>
                <a:lnTo>
                  <a:pt x="4766587" y="1284790"/>
                </a:lnTo>
                <a:lnTo>
                  <a:pt x="4766587" y="1284790"/>
                </a:lnTo>
                <a:lnTo>
                  <a:pt x="4783486" y="1284790"/>
                </a:lnTo>
                <a:lnTo>
                  <a:pt x="4783486" y="1316942"/>
                </a:lnTo>
                <a:lnTo>
                  <a:pt x="4794047" y="1316942"/>
                </a:lnTo>
                <a:lnTo>
                  <a:pt x="4794047" y="1349158"/>
                </a:lnTo>
                <a:lnTo>
                  <a:pt x="4819396" y="1349158"/>
                </a:lnTo>
                <a:lnTo>
                  <a:pt x="4819396" y="1349158"/>
                </a:lnTo>
                <a:lnTo>
                  <a:pt x="4835239" y="1349158"/>
                </a:lnTo>
                <a:lnTo>
                  <a:pt x="4835239" y="1349158"/>
                </a:lnTo>
                <a:lnTo>
                  <a:pt x="4852138" y="1349158"/>
                </a:lnTo>
                <a:lnTo>
                  <a:pt x="4852138" y="1349158"/>
                </a:lnTo>
                <a:lnTo>
                  <a:pt x="4864812" y="1349158"/>
                </a:lnTo>
                <a:lnTo>
                  <a:pt x="4864812" y="1349158"/>
                </a:lnTo>
                <a:lnTo>
                  <a:pt x="4874318" y="1349158"/>
                </a:lnTo>
                <a:lnTo>
                  <a:pt x="4874318" y="1349158"/>
                </a:lnTo>
                <a:lnTo>
                  <a:pt x="4877487" y="1349158"/>
                </a:lnTo>
                <a:lnTo>
                  <a:pt x="4877487" y="1381640"/>
                </a:lnTo>
                <a:lnTo>
                  <a:pt x="4913397" y="1381640"/>
                </a:lnTo>
                <a:lnTo>
                  <a:pt x="4913397" y="1381640"/>
                </a:lnTo>
                <a:lnTo>
                  <a:pt x="4916566" y="1381640"/>
                </a:lnTo>
                <a:lnTo>
                  <a:pt x="4916566" y="1381640"/>
                </a:lnTo>
                <a:lnTo>
                  <a:pt x="4928184" y="1381640"/>
                </a:lnTo>
                <a:lnTo>
                  <a:pt x="4928184" y="1381640"/>
                </a:lnTo>
                <a:lnTo>
                  <a:pt x="4931352" y="1381640"/>
                </a:lnTo>
                <a:lnTo>
                  <a:pt x="4931352" y="1381640"/>
                </a:lnTo>
                <a:lnTo>
                  <a:pt x="4942970" y="1381640"/>
                </a:lnTo>
                <a:lnTo>
                  <a:pt x="4942970" y="1381640"/>
                </a:lnTo>
                <a:lnTo>
                  <a:pt x="4954588" y="1381640"/>
                </a:lnTo>
                <a:lnTo>
                  <a:pt x="4954588" y="1381640"/>
                </a:lnTo>
                <a:lnTo>
                  <a:pt x="4982049" y="1381640"/>
                </a:lnTo>
                <a:lnTo>
                  <a:pt x="4982049" y="1381640"/>
                </a:lnTo>
                <a:lnTo>
                  <a:pt x="4986274" y="1381640"/>
                </a:lnTo>
                <a:lnTo>
                  <a:pt x="4986274" y="1381640"/>
                </a:lnTo>
                <a:lnTo>
                  <a:pt x="4989443" y="1381640"/>
                </a:lnTo>
                <a:lnTo>
                  <a:pt x="4989443" y="1414980"/>
                </a:lnTo>
                <a:lnTo>
                  <a:pt x="4993667" y="1414980"/>
                </a:lnTo>
                <a:lnTo>
                  <a:pt x="4993667" y="1414980"/>
                </a:lnTo>
                <a:lnTo>
                  <a:pt x="5025353" y="1414980"/>
                </a:lnTo>
                <a:lnTo>
                  <a:pt x="5025353" y="1448399"/>
                </a:lnTo>
                <a:lnTo>
                  <a:pt x="5033803" y="1448399"/>
                </a:lnTo>
                <a:lnTo>
                  <a:pt x="5033803" y="1448399"/>
                </a:lnTo>
                <a:lnTo>
                  <a:pt x="5071826" y="1448399"/>
                </a:lnTo>
                <a:lnTo>
                  <a:pt x="5071826" y="1448399"/>
                </a:lnTo>
                <a:lnTo>
                  <a:pt x="5077107" y="1448399"/>
                </a:lnTo>
                <a:lnTo>
                  <a:pt x="5077107" y="1448399"/>
                </a:lnTo>
                <a:lnTo>
                  <a:pt x="5095062" y="1448399"/>
                </a:lnTo>
                <a:lnTo>
                  <a:pt x="5095062" y="1482044"/>
                </a:lnTo>
                <a:lnTo>
                  <a:pt x="5098230" y="1482044"/>
                </a:lnTo>
                <a:lnTo>
                  <a:pt x="5098230" y="1482044"/>
                </a:lnTo>
                <a:lnTo>
                  <a:pt x="5105624" y="1482044"/>
                </a:lnTo>
                <a:lnTo>
                  <a:pt x="5105624" y="1482044"/>
                </a:lnTo>
                <a:lnTo>
                  <a:pt x="5108792" y="1482044"/>
                </a:lnTo>
                <a:lnTo>
                  <a:pt x="5108792" y="1482044"/>
                </a:lnTo>
                <a:lnTo>
                  <a:pt x="5111961" y="1482044"/>
                </a:lnTo>
                <a:lnTo>
                  <a:pt x="5111961" y="1482044"/>
                </a:lnTo>
                <a:lnTo>
                  <a:pt x="5134141" y="1482044"/>
                </a:lnTo>
                <a:lnTo>
                  <a:pt x="5134141" y="1516057"/>
                </a:lnTo>
                <a:lnTo>
                  <a:pt x="5155265" y="1516057"/>
                </a:lnTo>
                <a:lnTo>
                  <a:pt x="5155265" y="1516057"/>
                </a:lnTo>
                <a:lnTo>
                  <a:pt x="5166883" y="1516057"/>
                </a:lnTo>
                <a:lnTo>
                  <a:pt x="5166883" y="1516057"/>
                </a:lnTo>
                <a:lnTo>
                  <a:pt x="5172164" y="1516057"/>
                </a:lnTo>
                <a:lnTo>
                  <a:pt x="5172164" y="1550394"/>
                </a:lnTo>
                <a:lnTo>
                  <a:pt x="5211243" y="1550394"/>
                </a:lnTo>
                <a:lnTo>
                  <a:pt x="5211243" y="1550394"/>
                </a:lnTo>
                <a:lnTo>
                  <a:pt x="5233423" y="1550394"/>
                </a:lnTo>
                <a:lnTo>
                  <a:pt x="5233423" y="1550394"/>
                </a:lnTo>
                <a:lnTo>
                  <a:pt x="5236591" y="1550394"/>
                </a:lnTo>
                <a:lnTo>
                  <a:pt x="5236591" y="1585257"/>
                </a:lnTo>
                <a:lnTo>
                  <a:pt x="5265108" y="1585257"/>
                </a:lnTo>
                <a:lnTo>
                  <a:pt x="5265108" y="1585257"/>
                </a:lnTo>
                <a:lnTo>
                  <a:pt x="5270389" y="1585257"/>
                </a:lnTo>
                <a:lnTo>
                  <a:pt x="5270389" y="1620197"/>
                </a:lnTo>
                <a:lnTo>
                  <a:pt x="5280951" y="1620197"/>
                </a:lnTo>
                <a:lnTo>
                  <a:pt x="5280951" y="1620197"/>
                </a:lnTo>
                <a:lnTo>
                  <a:pt x="5296794" y="1620197"/>
                </a:lnTo>
                <a:lnTo>
                  <a:pt x="5296794" y="1620197"/>
                </a:lnTo>
                <a:lnTo>
                  <a:pt x="5302075" y="1620197"/>
                </a:lnTo>
                <a:lnTo>
                  <a:pt x="5302075" y="1655615"/>
                </a:lnTo>
                <a:lnTo>
                  <a:pt x="5303131" y="1655615"/>
                </a:lnTo>
                <a:lnTo>
                  <a:pt x="5303131" y="1691260"/>
                </a:lnTo>
                <a:lnTo>
                  <a:pt x="5308412" y="1691260"/>
                </a:lnTo>
                <a:lnTo>
                  <a:pt x="5308412" y="1726989"/>
                </a:lnTo>
                <a:lnTo>
                  <a:pt x="5325311" y="1726989"/>
                </a:lnTo>
                <a:lnTo>
                  <a:pt x="5325311" y="1762788"/>
                </a:lnTo>
                <a:lnTo>
                  <a:pt x="5326367" y="1762788"/>
                </a:lnTo>
                <a:lnTo>
                  <a:pt x="5326367" y="1762788"/>
                </a:lnTo>
                <a:lnTo>
                  <a:pt x="5331648" y="1762788"/>
                </a:lnTo>
                <a:lnTo>
                  <a:pt x="5331648" y="1798720"/>
                </a:lnTo>
                <a:lnTo>
                  <a:pt x="5392907" y="1798720"/>
                </a:lnTo>
                <a:lnTo>
                  <a:pt x="5392907" y="1798720"/>
                </a:lnTo>
                <a:lnTo>
                  <a:pt x="5404526" y="1798720"/>
                </a:lnTo>
                <a:lnTo>
                  <a:pt x="5404526" y="1834722"/>
                </a:lnTo>
                <a:lnTo>
                  <a:pt x="5434099" y="1834722"/>
                </a:lnTo>
                <a:lnTo>
                  <a:pt x="5434099" y="1834722"/>
                </a:lnTo>
                <a:lnTo>
                  <a:pt x="5437267" y="1834722"/>
                </a:lnTo>
                <a:lnTo>
                  <a:pt x="5437267" y="1834722"/>
                </a:lnTo>
                <a:lnTo>
                  <a:pt x="5455223" y="1834722"/>
                </a:lnTo>
                <a:lnTo>
                  <a:pt x="5455223" y="1834722"/>
                </a:lnTo>
                <a:lnTo>
                  <a:pt x="5456279" y="1834722"/>
                </a:lnTo>
                <a:lnTo>
                  <a:pt x="5456279" y="1871148"/>
                </a:lnTo>
                <a:lnTo>
                  <a:pt x="5465785" y="1871148"/>
                </a:lnTo>
                <a:lnTo>
                  <a:pt x="5465785" y="1871148"/>
                </a:lnTo>
                <a:lnTo>
                  <a:pt x="5494302" y="1871148"/>
                </a:lnTo>
                <a:lnTo>
                  <a:pt x="5494302" y="1871148"/>
                </a:lnTo>
                <a:lnTo>
                  <a:pt x="5506976" y="1871148"/>
                </a:lnTo>
                <a:lnTo>
                  <a:pt x="5506976" y="1871148"/>
                </a:lnTo>
                <a:lnTo>
                  <a:pt x="5553448" y="1871148"/>
                </a:lnTo>
                <a:lnTo>
                  <a:pt x="5553448" y="1871148"/>
                </a:lnTo>
                <a:lnTo>
                  <a:pt x="5575628" y="1871148"/>
                </a:lnTo>
                <a:lnTo>
                  <a:pt x="5575628" y="1871148"/>
                </a:lnTo>
                <a:lnTo>
                  <a:pt x="5578797" y="1871148"/>
                </a:lnTo>
                <a:lnTo>
                  <a:pt x="5578797" y="1871148"/>
                </a:lnTo>
                <a:lnTo>
                  <a:pt x="5614707" y="1871148"/>
                </a:lnTo>
                <a:lnTo>
                  <a:pt x="5614707" y="1908019"/>
                </a:lnTo>
                <a:lnTo>
                  <a:pt x="5619988" y="1908019"/>
                </a:lnTo>
                <a:lnTo>
                  <a:pt x="5619988" y="1908019"/>
                </a:lnTo>
                <a:lnTo>
                  <a:pt x="5621045" y="1908019"/>
                </a:lnTo>
                <a:lnTo>
                  <a:pt x="5621045" y="1908019"/>
                </a:lnTo>
                <a:lnTo>
                  <a:pt x="5629494" y="1908019"/>
                </a:lnTo>
                <a:lnTo>
                  <a:pt x="5629494" y="1908019"/>
                </a:lnTo>
                <a:lnTo>
                  <a:pt x="5642168" y="1908019"/>
                </a:lnTo>
                <a:lnTo>
                  <a:pt x="5642168" y="1945022"/>
                </a:lnTo>
                <a:lnTo>
                  <a:pt x="5647449" y="1945022"/>
                </a:lnTo>
                <a:lnTo>
                  <a:pt x="5647449" y="1982615"/>
                </a:lnTo>
                <a:lnTo>
                  <a:pt x="5651674" y="1982615"/>
                </a:lnTo>
                <a:lnTo>
                  <a:pt x="5651674" y="1982615"/>
                </a:lnTo>
                <a:lnTo>
                  <a:pt x="5656955" y="1982615"/>
                </a:lnTo>
                <a:lnTo>
                  <a:pt x="5656955" y="1982615"/>
                </a:lnTo>
                <a:lnTo>
                  <a:pt x="5661180" y="1982615"/>
                </a:lnTo>
                <a:lnTo>
                  <a:pt x="5661180" y="1982615"/>
                </a:lnTo>
                <a:lnTo>
                  <a:pt x="5662236" y="1982615"/>
                </a:lnTo>
                <a:lnTo>
                  <a:pt x="5662236" y="1982615"/>
                </a:lnTo>
                <a:lnTo>
                  <a:pt x="5669629" y="1982615"/>
                </a:lnTo>
                <a:lnTo>
                  <a:pt x="5669629" y="2020439"/>
                </a:lnTo>
                <a:lnTo>
                  <a:pt x="5682304" y="2020439"/>
                </a:lnTo>
                <a:lnTo>
                  <a:pt x="5682304" y="2020439"/>
                </a:lnTo>
                <a:lnTo>
                  <a:pt x="5688641" y="2020439"/>
                </a:lnTo>
                <a:lnTo>
                  <a:pt x="5688641" y="2020439"/>
                </a:lnTo>
                <a:lnTo>
                  <a:pt x="5706596" y="2020439"/>
                </a:lnTo>
                <a:lnTo>
                  <a:pt x="5706596" y="2020439"/>
                </a:lnTo>
                <a:lnTo>
                  <a:pt x="5730888" y="2020439"/>
                </a:lnTo>
                <a:lnTo>
                  <a:pt x="5730888" y="2058783"/>
                </a:lnTo>
                <a:lnTo>
                  <a:pt x="5742506" y="2058783"/>
                </a:lnTo>
                <a:lnTo>
                  <a:pt x="5742506" y="2097279"/>
                </a:lnTo>
                <a:lnTo>
                  <a:pt x="5745675" y="2097279"/>
                </a:lnTo>
                <a:lnTo>
                  <a:pt x="5745675" y="2097279"/>
                </a:lnTo>
                <a:lnTo>
                  <a:pt x="5767855" y="2097279"/>
                </a:lnTo>
                <a:lnTo>
                  <a:pt x="5767855" y="2097279"/>
                </a:lnTo>
                <a:lnTo>
                  <a:pt x="5769967" y="2097279"/>
                </a:lnTo>
                <a:lnTo>
                  <a:pt x="5769967" y="2097279"/>
                </a:lnTo>
                <a:lnTo>
                  <a:pt x="5783698" y="2097279"/>
                </a:lnTo>
                <a:lnTo>
                  <a:pt x="5783698" y="2136080"/>
                </a:lnTo>
                <a:lnTo>
                  <a:pt x="5787923" y="2136080"/>
                </a:lnTo>
                <a:lnTo>
                  <a:pt x="5787923" y="2136080"/>
                </a:lnTo>
                <a:lnTo>
                  <a:pt x="5793204" y="2136080"/>
                </a:lnTo>
                <a:lnTo>
                  <a:pt x="5793204" y="2175045"/>
                </a:lnTo>
                <a:lnTo>
                  <a:pt x="5814327" y="2175045"/>
                </a:lnTo>
                <a:lnTo>
                  <a:pt x="5814327" y="2175045"/>
                </a:lnTo>
                <a:lnTo>
                  <a:pt x="5823833" y="2175045"/>
                </a:lnTo>
                <a:lnTo>
                  <a:pt x="5823833" y="2175045"/>
                </a:lnTo>
                <a:lnTo>
                  <a:pt x="5825945" y="2175045"/>
                </a:lnTo>
                <a:lnTo>
                  <a:pt x="5825945" y="2214149"/>
                </a:lnTo>
                <a:lnTo>
                  <a:pt x="5830170" y="2214149"/>
                </a:lnTo>
                <a:lnTo>
                  <a:pt x="5830170" y="2214149"/>
                </a:lnTo>
                <a:lnTo>
                  <a:pt x="5873474" y="2214149"/>
                </a:lnTo>
                <a:lnTo>
                  <a:pt x="5873474" y="2214149"/>
                </a:lnTo>
                <a:lnTo>
                  <a:pt x="5887205" y="2214149"/>
                </a:lnTo>
                <a:lnTo>
                  <a:pt x="5887205" y="2214149"/>
                </a:lnTo>
                <a:lnTo>
                  <a:pt x="5904104" y="2214149"/>
                </a:lnTo>
                <a:lnTo>
                  <a:pt x="5904104" y="2214149"/>
                </a:lnTo>
                <a:lnTo>
                  <a:pt x="5942126" y="2214149"/>
                </a:lnTo>
                <a:lnTo>
                  <a:pt x="5942126" y="2214149"/>
                </a:lnTo>
                <a:lnTo>
                  <a:pt x="5945295" y="2214149"/>
                </a:lnTo>
                <a:lnTo>
                  <a:pt x="5945295" y="2214149"/>
                </a:lnTo>
                <a:lnTo>
                  <a:pt x="5947407" y="2214149"/>
                </a:lnTo>
                <a:lnTo>
                  <a:pt x="5947407" y="2253802"/>
                </a:lnTo>
                <a:lnTo>
                  <a:pt x="5951632" y="2253802"/>
                </a:lnTo>
                <a:lnTo>
                  <a:pt x="5951632" y="2253802"/>
                </a:lnTo>
                <a:lnTo>
                  <a:pt x="6013947" y="2253802"/>
                </a:lnTo>
                <a:lnTo>
                  <a:pt x="6013947" y="2253802"/>
                </a:lnTo>
                <a:lnTo>
                  <a:pt x="6018172" y="2253802"/>
                </a:lnTo>
                <a:lnTo>
                  <a:pt x="6018172" y="2253802"/>
                </a:lnTo>
                <a:lnTo>
                  <a:pt x="6037184" y="2253802"/>
                </a:lnTo>
                <a:lnTo>
                  <a:pt x="6037184" y="2253802"/>
                </a:lnTo>
                <a:lnTo>
                  <a:pt x="6047745" y="2253802"/>
                </a:lnTo>
                <a:lnTo>
                  <a:pt x="6047745" y="2253802"/>
                </a:lnTo>
                <a:lnTo>
                  <a:pt x="6049858" y="2253802"/>
                </a:lnTo>
                <a:lnTo>
                  <a:pt x="6049858" y="2253802"/>
                </a:lnTo>
                <a:lnTo>
                  <a:pt x="6062532" y="2253802"/>
                </a:lnTo>
                <a:lnTo>
                  <a:pt x="6062532" y="2253802"/>
                </a:lnTo>
                <a:lnTo>
                  <a:pt x="6064644" y="2253802"/>
                </a:lnTo>
                <a:lnTo>
                  <a:pt x="6064644" y="2294727"/>
                </a:lnTo>
                <a:lnTo>
                  <a:pt x="6084712" y="2294727"/>
                </a:lnTo>
                <a:lnTo>
                  <a:pt x="6084712" y="2335859"/>
                </a:lnTo>
                <a:lnTo>
                  <a:pt x="6092105" y="2335859"/>
                </a:lnTo>
                <a:lnTo>
                  <a:pt x="6092105" y="2335859"/>
                </a:lnTo>
                <a:lnTo>
                  <a:pt x="6106892" y="2335859"/>
                </a:lnTo>
                <a:lnTo>
                  <a:pt x="6106892" y="2335859"/>
                </a:lnTo>
                <a:lnTo>
                  <a:pt x="6114285" y="2335859"/>
                </a:lnTo>
                <a:lnTo>
                  <a:pt x="6114285" y="2335859"/>
                </a:lnTo>
                <a:lnTo>
                  <a:pt x="6117454" y="2335859"/>
                </a:lnTo>
                <a:lnTo>
                  <a:pt x="6117454" y="2377109"/>
                </a:lnTo>
                <a:lnTo>
                  <a:pt x="6120623" y="2377109"/>
                </a:lnTo>
                <a:lnTo>
                  <a:pt x="6120623" y="2377109"/>
                </a:lnTo>
                <a:lnTo>
                  <a:pt x="6132241" y="2377109"/>
                </a:lnTo>
                <a:lnTo>
                  <a:pt x="6132241" y="2418469"/>
                </a:lnTo>
                <a:lnTo>
                  <a:pt x="6157589" y="2418469"/>
                </a:lnTo>
                <a:lnTo>
                  <a:pt x="6157589" y="2418469"/>
                </a:lnTo>
                <a:lnTo>
                  <a:pt x="6163926" y="2418469"/>
                </a:lnTo>
                <a:lnTo>
                  <a:pt x="6163926" y="2460516"/>
                </a:lnTo>
                <a:lnTo>
                  <a:pt x="6170264" y="2460516"/>
                </a:lnTo>
                <a:lnTo>
                  <a:pt x="6170264" y="2460516"/>
                </a:lnTo>
                <a:lnTo>
                  <a:pt x="6185050" y="2460516"/>
                </a:lnTo>
                <a:lnTo>
                  <a:pt x="6185050" y="2460516"/>
                </a:lnTo>
                <a:lnTo>
                  <a:pt x="6197724" y="2460516"/>
                </a:lnTo>
                <a:lnTo>
                  <a:pt x="6197724" y="2460516"/>
                </a:lnTo>
                <a:lnTo>
                  <a:pt x="6198781" y="2460516"/>
                </a:lnTo>
                <a:lnTo>
                  <a:pt x="6198781" y="2502888"/>
                </a:lnTo>
                <a:lnTo>
                  <a:pt x="6201949" y="2502888"/>
                </a:lnTo>
                <a:lnTo>
                  <a:pt x="6201949" y="2502888"/>
                </a:lnTo>
                <a:lnTo>
                  <a:pt x="6213567" y="2502888"/>
                </a:lnTo>
                <a:lnTo>
                  <a:pt x="6213567" y="2502888"/>
                </a:lnTo>
                <a:lnTo>
                  <a:pt x="6216736" y="2502888"/>
                </a:lnTo>
                <a:lnTo>
                  <a:pt x="6216736" y="2545617"/>
                </a:lnTo>
                <a:lnTo>
                  <a:pt x="6217792" y="2545617"/>
                </a:lnTo>
                <a:lnTo>
                  <a:pt x="6217792" y="2588457"/>
                </a:lnTo>
                <a:lnTo>
                  <a:pt x="6220961" y="2588457"/>
                </a:lnTo>
                <a:lnTo>
                  <a:pt x="6220961" y="2588457"/>
                </a:lnTo>
                <a:lnTo>
                  <a:pt x="6223073" y="2588457"/>
                </a:lnTo>
                <a:lnTo>
                  <a:pt x="6223073" y="2588457"/>
                </a:lnTo>
                <a:lnTo>
                  <a:pt x="6227298" y="2588457"/>
                </a:lnTo>
                <a:lnTo>
                  <a:pt x="6227298" y="2631522"/>
                </a:lnTo>
                <a:lnTo>
                  <a:pt x="6233635" y="2631522"/>
                </a:lnTo>
                <a:lnTo>
                  <a:pt x="6233635" y="2674603"/>
                </a:lnTo>
                <a:lnTo>
                  <a:pt x="6236804" y="2674603"/>
                </a:lnTo>
                <a:lnTo>
                  <a:pt x="6236804" y="2718116"/>
                </a:lnTo>
                <a:lnTo>
                  <a:pt x="6245253" y="2718116"/>
                </a:lnTo>
                <a:lnTo>
                  <a:pt x="6245253" y="2718116"/>
                </a:lnTo>
                <a:lnTo>
                  <a:pt x="6264264" y="2718116"/>
                </a:lnTo>
                <a:lnTo>
                  <a:pt x="6264264" y="2761723"/>
                </a:lnTo>
                <a:lnTo>
                  <a:pt x="6265321" y="2761723"/>
                </a:lnTo>
                <a:lnTo>
                  <a:pt x="6265321" y="2761723"/>
                </a:lnTo>
                <a:lnTo>
                  <a:pt x="6266377" y="2761723"/>
                </a:lnTo>
                <a:lnTo>
                  <a:pt x="6266377" y="2805762"/>
                </a:lnTo>
                <a:lnTo>
                  <a:pt x="6291725" y="2805762"/>
                </a:lnTo>
                <a:lnTo>
                  <a:pt x="6291725" y="2849850"/>
                </a:lnTo>
                <a:lnTo>
                  <a:pt x="6293838" y="2849850"/>
                </a:lnTo>
                <a:lnTo>
                  <a:pt x="6293838" y="2849850"/>
                </a:lnTo>
                <a:lnTo>
                  <a:pt x="6337142" y="2849850"/>
                </a:lnTo>
                <a:lnTo>
                  <a:pt x="6337142" y="2849850"/>
                </a:lnTo>
                <a:lnTo>
                  <a:pt x="6355097" y="2849850"/>
                </a:lnTo>
                <a:lnTo>
                  <a:pt x="6355097" y="2849850"/>
                </a:lnTo>
                <a:lnTo>
                  <a:pt x="6381502" y="2849850"/>
                </a:lnTo>
                <a:lnTo>
                  <a:pt x="6381502" y="2849850"/>
                </a:lnTo>
                <a:lnTo>
                  <a:pt x="6412131" y="2849850"/>
                </a:lnTo>
                <a:lnTo>
                  <a:pt x="6412131" y="2849850"/>
                </a:lnTo>
                <a:lnTo>
                  <a:pt x="6421637" y="2849850"/>
                </a:lnTo>
                <a:lnTo>
                  <a:pt x="6421637" y="2849850"/>
                </a:lnTo>
                <a:lnTo>
                  <a:pt x="6438536" y="2849850"/>
                </a:lnTo>
                <a:lnTo>
                  <a:pt x="6438536" y="2849850"/>
                </a:lnTo>
                <a:lnTo>
                  <a:pt x="6457547" y="2849850"/>
                </a:lnTo>
                <a:lnTo>
                  <a:pt x="6457547" y="2849850"/>
                </a:lnTo>
                <a:lnTo>
                  <a:pt x="6458603" y="2849850"/>
                </a:lnTo>
                <a:lnTo>
                  <a:pt x="6458603" y="2894938"/>
                </a:lnTo>
                <a:lnTo>
                  <a:pt x="6460716" y="2894938"/>
                </a:lnTo>
                <a:lnTo>
                  <a:pt x="6460716" y="2940151"/>
                </a:lnTo>
                <a:lnTo>
                  <a:pt x="6462828" y="2940151"/>
                </a:lnTo>
                <a:lnTo>
                  <a:pt x="6462828" y="2940151"/>
                </a:lnTo>
                <a:lnTo>
                  <a:pt x="6464941" y="2940151"/>
                </a:lnTo>
                <a:lnTo>
                  <a:pt x="6464941" y="2940151"/>
                </a:lnTo>
                <a:lnTo>
                  <a:pt x="6472334" y="2940151"/>
                </a:lnTo>
                <a:lnTo>
                  <a:pt x="6472334" y="2985726"/>
                </a:lnTo>
                <a:lnTo>
                  <a:pt x="6512469" y="2985726"/>
                </a:lnTo>
                <a:lnTo>
                  <a:pt x="6512469" y="3031406"/>
                </a:lnTo>
                <a:lnTo>
                  <a:pt x="6515638" y="3031406"/>
                </a:lnTo>
                <a:lnTo>
                  <a:pt x="6515638" y="3077296"/>
                </a:lnTo>
                <a:lnTo>
                  <a:pt x="6525143" y="3077296"/>
                </a:lnTo>
                <a:lnTo>
                  <a:pt x="6525143" y="3077296"/>
                </a:lnTo>
                <a:lnTo>
                  <a:pt x="6548380" y="3077296"/>
                </a:lnTo>
                <a:lnTo>
                  <a:pt x="6548380" y="3123480"/>
                </a:lnTo>
                <a:lnTo>
                  <a:pt x="6550492" y="3123480"/>
                </a:lnTo>
                <a:lnTo>
                  <a:pt x="6550492" y="3123480"/>
                </a:lnTo>
                <a:lnTo>
                  <a:pt x="6554717" y="3123480"/>
                </a:lnTo>
                <a:lnTo>
                  <a:pt x="6554717" y="3123480"/>
                </a:lnTo>
                <a:lnTo>
                  <a:pt x="6555773" y="3123480"/>
                </a:lnTo>
                <a:lnTo>
                  <a:pt x="6555773" y="3170107"/>
                </a:lnTo>
                <a:lnTo>
                  <a:pt x="6558942" y="3170107"/>
                </a:lnTo>
                <a:lnTo>
                  <a:pt x="6558942" y="3170107"/>
                </a:lnTo>
                <a:lnTo>
                  <a:pt x="6577953" y="3170107"/>
                </a:lnTo>
                <a:lnTo>
                  <a:pt x="6577953" y="3216801"/>
                </a:lnTo>
                <a:lnTo>
                  <a:pt x="6585346" y="3216801"/>
                </a:lnTo>
                <a:lnTo>
                  <a:pt x="6585346" y="3263641"/>
                </a:lnTo>
                <a:lnTo>
                  <a:pt x="6611751" y="3263641"/>
                </a:lnTo>
                <a:lnTo>
                  <a:pt x="6611751" y="3263641"/>
                </a:lnTo>
                <a:lnTo>
                  <a:pt x="6617032" y="3263641"/>
                </a:lnTo>
                <a:lnTo>
                  <a:pt x="6617032" y="3310643"/>
                </a:lnTo>
                <a:lnTo>
                  <a:pt x="6625482" y="3310643"/>
                </a:lnTo>
                <a:lnTo>
                  <a:pt x="6625482" y="3357727"/>
                </a:lnTo>
                <a:lnTo>
                  <a:pt x="6637100" y="3357727"/>
                </a:lnTo>
                <a:lnTo>
                  <a:pt x="6637100" y="3404932"/>
                </a:lnTo>
                <a:lnTo>
                  <a:pt x="6653999" y="3404932"/>
                </a:lnTo>
                <a:lnTo>
                  <a:pt x="6653999" y="3404932"/>
                </a:lnTo>
                <a:lnTo>
                  <a:pt x="6658223" y="3404932"/>
                </a:lnTo>
                <a:lnTo>
                  <a:pt x="6658223" y="3452442"/>
                </a:lnTo>
                <a:lnTo>
                  <a:pt x="6684628" y="3452442"/>
                </a:lnTo>
                <a:lnTo>
                  <a:pt x="6684628" y="3452442"/>
                </a:lnTo>
                <a:lnTo>
                  <a:pt x="6687797" y="3452442"/>
                </a:lnTo>
                <a:lnTo>
                  <a:pt x="6687797" y="3452442"/>
                </a:lnTo>
                <a:lnTo>
                  <a:pt x="6697303" y="3452442"/>
                </a:lnTo>
                <a:lnTo>
                  <a:pt x="6697303" y="3452442"/>
                </a:lnTo>
                <a:lnTo>
                  <a:pt x="6704696" y="3452442"/>
                </a:lnTo>
                <a:lnTo>
                  <a:pt x="6704696" y="3452442"/>
                </a:lnTo>
                <a:lnTo>
                  <a:pt x="6705752" y="3452442"/>
                </a:lnTo>
                <a:lnTo>
                  <a:pt x="6705752" y="3452442"/>
                </a:lnTo>
                <a:lnTo>
                  <a:pt x="6713145" y="3452442"/>
                </a:lnTo>
                <a:lnTo>
                  <a:pt x="6713145" y="3500932"/>
                </a:lnTo>
                <a:lnTo>
                  <a:pt x="6722651" y="3500932"/>
                </a:lnTo>
                <a:lnTo>
                  <a:pt x="6722651" y="3500932"/>
                </a:lnTo>
                <a:lnTo>
                  <a:pt x="6730044" y="3500932"/>
                </a:lnTo>
                <a:lnTo>
                  <a:pt x="6730044" y="3500932"/>
                </a:lnTo>
                <a:lnTo>
                  <a:pt x="6744831" y="3500932"/>
                </a:lnTo>
                <a:lnTo>
                  <a:pt x="6744831" y="3500932"/>
                </a:lnTo>
                <a:lnTo>
                  <a:pt x="6757505" y="3500932"/>
                </a:lnTo>
                <a:lnTo>
                  <a:pt x="6757505" y="3500932"/>
                </a:lnTo>
                <a:lnTo>
                  <a:pt x="6768067" y="3500932"/>
                </a:lnTo>
                <a:lnTo>
                  <a:pt x="6768067" y="3500932"/>
                </a:lnTo>
                <a:lnTo>
                  <a:pt x="6774404" y="3500932"/>
                </a:lnTo>
                <a:lnTo>
                  <a:pt x="6774404" y="3500932"/>
                </a:lnTo>
                <a:lnTo>
                  <a:pt x="6787079" y="3500932"/>
                </a:lnTo>
                <a:lnTo>
                  <a:pt x="6787079" y="3550334"/>
                </a:lnTo>
                <a:lnTo>
                  <a:pt x="6792360" y="3550334"/>
                </a:lnTo>
                <a:lnTo>
                  <a:pt x="6792360" y="3550334"/>
                </a:lnTo>
                <a:lnTo>
                  <a:pt x="6803978" y="3550334"/>
                </a:lnTo>
                <a:lnTo>
                  <a:pt x="6803978" y="3550334"/>
                </a:lnTo>
                <a:lnTo>
                  <a:pt x="6806090" y="3550334"/>
                </a:lnTo>
                <a:lnTo>
                  <a:pt x="6806090" y="3550334"/>
                </a:lnTo>
                <a:lnTo>
                  <a:pt x="6809259" y="3550334"/>
                </a:lnTo>
                <a:lnTo>
                  <a:pt x="6809259" y="3600105"/>
                </a:lnTo>
                <a:lnTo>
                  <a:pt x="6815596" y="3600105"/>
                </a:lnTo>
                <a:lnTo>
                  <a:pt x="6815596" y="3600105"/>
                </a:lnTo>
                <a:lnTo>
                  <a:pt x="6819821" y="3600105"/>
                </a:lnTo>
                <a:lnTo>
                  <a:pt x="6819821" y="3600105"/>
                </a:lnTo>
                <a:lnTo>
                  <a:pt x="6829326" y="3600105"/>
                </a:lnTo>
                <a:lnTo>
                  <a:pt x="6829326" y="3600105"/>
                </a:lnTo>
                <a:lnTo>
                  <a:pt x="6840944" y="3600105"/>
                </a:lnTo>
                <a:lnTo>
                  <a:pt x="6840944" y="3600105"/>
                </a:lnTo>
                <a:lnTo>
                  <a:pt x="6845169" y="3600105"/>
                </a:lnTo>
                <a:lnTo>
                  <a:pt x="6845169" y="3600105"/>
                </a:lnTo>
                <a:lnTo>
                  <a:pt x="6851506" y="3600105"/>
                </a:lnTo>
                <a:lnTo>
                  <a:pt x="6851506" y="3600105"/>
                </a:lnTo>
                <a:lnTo>
                  <a:pt x="6854675" y="3600105"/>
                </a:lnTo>
                <a:lnTo>
                  <a:pt x="6854675" y="3600105"/>
                </a:lnTo>
                <a:lnTo>
                  <a:pt x="6857843" y="3600105"/>
                </a:lnTo>
                <a:lnTo>
                  <a:pt x="6857843" y="3600105"/>
                </a:lnTo>
                <a:lnTo>
                  <a:pt x="6859956" y="3600105"/>
                </a:lnTo>
                <a:lnTo>
                  <a:pt x="6859956" y="3600105"/>
                </a:lnTo>
                <a:lnTo>
                  <a:pt x="6869462" y="3600105"/>
                </a:lnTo>
                <a:lnTo>
                  <a:pt x="6869462" y="3600105"/>
                </a:lnTo>
                <a:lnTo>
                  <a:pt x="6874742" y="3600105"/>
                </a:lnTo>
                <a:lnTo>
                  <a:pt x="6874742" y="3600105"/>
                </a:lnTo>
                <a:lnTo>
                  <a:pt x="6875799" y="3600105"/>
                </a:lnTo>
                <a:lnTo>
                  <a:pt x="6875799" y="3600105"/>
                </a:lnTo>
                <a:lnTo>
                  <a:pt x="6876855" y="3600105"/>
                </a:lnTo>
                <a:lnTo>
                  <a:pt x="6876855" y="3600105"/>
                </a:lnTo>
                <a:lnTo>
                  <a:pt x="6882136" y="3600105"/>
                </a:lnTo>
                <a:lnTo>
                  <a:pt x="6882136" y="3600105"/>
                </a:lnTo>
                <a:lnTo>
                  <a:pt x="6886361" y="3600105"/>
                </a:lnTo>
                <a:lnTo>
                  <a:pt x="6886361" y="3677369"/>
                </a:lnTo>
                <a:lnTo>
                  <a:pt x="6895866" y="3677369"/>
                </a:lnTo>
                <a:lnTo>
                  <a:pt x="6895866" y="3677369"/>
                </a:lnTo>
                <a:lnTo>
                  <a:pt x="6896922" y="3677369"/>
                </a:lnTo>
                <a:lnTo>
                  <a:pt x="6896922" y="3677369"/>
                </a:lnTo>
                <a:lnTo>
                  <a:pt x="6897979" y="3677369"/>
                </a:lnTo>
                <a:lnTo>
                  <a:pt x="6897979" y="3677369"/>
                </a:lnTo>
                <a:lnTo>
                  <a:pt x="6900091" y="3677369"/>
                </a:lnTo>
                <a:lnTo>
                  <a:pt x="6900091" y="3677369"/>
                </a:lnTo>
                <a:lnTo>
                  <a:pt x="6905372" y="3677369"/>
                </a:lnTo>
                <a:lnTo>
                  <a:pt x="6905372" y="3677369"/>
                </a:lnTo>
                <a:lnTo>
                  <a:pt x="6914878" y="3677369"/>
                </a:lnTo>
                <a:lnTo>
                  <a:pt x="6914878" y="3787528"/>
                </a:lnTo>
                <a:lnTo>
                  <a:pt x="6924383" y="3787528"/>
                </a:lnTo>
                <a:lnTo>
                  <a:pt x="6924383" y="3787528"/>
                </a:lnTo>
                <a:lnTo>
                  <a:pt x="6926496" y="3787528"/>
                </a:lnTo>
                <a:lnTo>
                  <a:pt x="6926496" y="3787528"/>
                </a:lnTo>
                <a:lnTo>
                  <a:pt x="6927552" y="3787528"/>
                </a:lnTo>
                <a:lnTo>
                  <a:pt x="6927552" y="3787528"/>
                </a:lnTo>
                <a:lnTo>
                  <a:pt x="6946563" y="3787528"/>
                </a:lnTo>
                <a:lnTo>
                  <a:pt x="6946563" y="3787528"/>
                </a:lnTo>
                <a:lnTo>
                  <a:pt x="6947620" y="3787528"/>
                </a:lnTo>
                <a:lnTo>
                  <a:pt x="6947620" y="3787528"/>
                </a:lnTo>
                <a:lnTo>
                  <a:pt x="6949732" y="3787528"/>
                </a:lnTo>
                <a:lnTo>
                  <a:pt x="6949732" y="3787528"/>
                </a:lnTo>
                <a:lnTo>
                  <a:pt x="6956069" y="3787528"/>
                </a:lnTo>
                <a:lnTo>
                  <a:pt x="6956069" y="3787528"/>
                </a:lnTo>
                <a:lnTo>
                  <a:pt x="6963462" y="3787528"/>
                </a:lnTo>
                <a:lnTo>
                  <a:pt x="6963462" y="3787528"/>
                </a:lnTo>
                <a:lnTo>
                  <a:pt x="6964519" y="3787528"/>
                </a:lnTo>
                <a:lnTo>
                  <a:pt x="6964519" y="3787528"/>
                </a:lnTo>
                <a:lnTo>
                  <a:pt x="6970856" y="3787528"/>
                </a:lnTo>
                <a:lnTo>
                  <a:pt x="6970856" y="3787528"/>
                </a:lnTo>
              </a:path>
            </a:pathLst>
          </a:custGeom>
          <a:ln w="21681" cap="flat">
            <a:solidFill>
              <a:srgbClr val="000000">
                <a:alpha val="100000"/>
              </a:srgbClr>
            </a:solidFill>
            <a:prstDash val="sysDash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42" name="pl15">
            <a:extLst>
              <a:ext uri="{FF2B5EF4-FFF2-40B4-BE49-F238E27FC236}">
                <a16:creationId xmlns:a16="http://schemas.microsoft.com/office/drawing/2014/main" id="{475E4D4D-464A-0C10-215A-FC6672BEE50D}"/>
              </a:ext>
            </a:extLst>
          </p:cNvPr>
          <p:cNvSpPr/>
          <p:nvPr/>
        </p:nvSpPr>
        <p:spPr>
          <a:xfrm>
            <a:off x="3990763" y="1793715"/>
            <a:ext cx="4601254" cy="3048188"/>
          </a:xfrm>
          <a:custGeom>
            <a:avLst/>
            <a:gdLst/>
            <a:ahLst/>
            <a:cxnLst/>
            <a:rect l="0" t="0" r="0" b="0"/>
            <a:pathLst>
              <a:path w="6970856" h="5213316">
                <a:moveTo>
                  <a:pt x="0" y="0"/>
                </a:moveTo>
                <a:lnTo>
                  <a:pt x="164765" y="0"/>
                </a:lnTo>
                <a:lnTo>
                  <a:pt x="164765" y="0"/>
                </a:lnTo>
                <a:lnTo>
                  <a:pt x="196451" y="0"/>
                </a:lnTo>
                <a:lnTo>
                  <a:pt x="196451" y="0"/>
                </a:lnTo>
                <a:lnTo>
                  <a:pt x="252429" y="0"/>
                </a:lnTo>
                <a:lnTo>
                  <a:pt x="252429" y="24759"/>
                </a:lnTo>
                <a:lnTo>
                  <a:pt x="269328" y="24759"/>
                </a:lnTo>
                <a:lnTo>
                  <a:pt x="269328" y="49586"/>
                </a:lnTo>
                <a:lnTo>
                  <a:pt x="305239" y="49586"/>
                </a:lnTo>
                <a:lnTo>
                  <a:pt x="305239" y="49586"/>
                </a:lnTo>
                <a:lnTo>
                  <a:pt x="330587" y="49586"/>
                </a:lnTo>
                <a:lnTo>
                  <a:pt x="330587" y="49586"/>
                </a:lnTo>
                <a:lnTo>
                  <a:pt x="359104" y="49586"/>
                </a:lnTo>
                <a:lnTo>
                  <a:pt x="359104" y="49586"/>
                </a:lnTo>
                <a:lnTo>
                  <a:pt x="415082" y="49586"/>
                </a:lnTo>
                <a:lnTo>
                  <a:pt x="415082" y="49586"/>
                </a:lnTo>
                <a:lnTo>
                  <a:pt x="486903" y="49586"/>
                </a:lnTo>
                <a:lnTo>
                  <a:pt x="486903" y="49586"/>
                </a:lnTo>
                <a:lnTo>
                  <a:pt x="529151" y="49586"/>
                </a:lnTo>
                <a:lnTo>
                  <a:pt x="529151" y="74656"/>
                </a:lnTo>
                <a:lnTo>
                  <a:pt x="753063" y="74656"/>
                </a:lnTo>
                <a:lnTo>
                  <a:pt x="753063" y="100140"/>
                </a:lnTo>
                <a:lnTo>
                  <a:pt x="762569" y="100140"/>
                </a:lnTo>
                <a:lnTo>
                  <a:pt x="762569" y="100140"/>
                </a:lnTo>
                <a:lnTo>
                  <a:pt x="777356" y="100140"/>
                </a:lnTo>
                <a:lnTo>
                  <a:pt x="777356" y="100140"/>
                </a:lnTo>
                <a:lnTo>
                  <a:pt x="787918" y="100140"/>
                </a:lnTo>
                <a:lnTo>
                  <a:pt x="787918" y="100140"/>
                </a:lnTo>
                <a:lnTo>
                  <a:pt x="810097" y="100140"/>
                </a:lnTo>
                <a:lnTo>
                  <a:pt x="810097" y="100140"/>
                </a:lnTo>
                <a:lnTo>
                  <a:pt x="822772" y="100140"/>
                </a:lnTo>
                <a:lnTo>
                  <a:pt x="822772" y="100140"/>
                </a:lnTo>
                <a:lnTo>
                  <a:pt x="887199" y="100140"/>
                </a:lnTo>
                <a:lnTo>
                  <a:pt x="887199" y="125829"/>
                </a:lnTo>
                <a:lnTo>
                  <a:pt x="928391" y="125829"/>
                </a:lnTo>
                <a:lnTo>
                  <a:pt x="928391" y="125829"/>
                </a:lnTo>
                <a:lnTo>
                  <a:pt x="972751" y="125829"/>
                </a:lnTo>
                <a:lnTo>
                  <a:pt x="972751" y="125829"/>
                </a:lnTo>
                <a:lnTo>
                  <a:pt x="1051965" y="125829"/>
                </a:lnTo>
                <a:lnTo>
                  <a:pt x="1051965" y="125829"/>
                </a:lnTo>
                <a:lnTo>
                  <a:pt x="1097381" y="125829"/>
                </a:lnTo>
                <a:lnTo>
                  <a:pt x="1097381" y="125829"/>
                </a:lnTo>
                <a:lnTo>
                  <a:pt x="1112168" y="125829"/>
                </a:lnTo>
                <a:lnTo>
                  <a:pt x="1112168" y="125829"/>
                </a:lnTo>
                <a:lnTo>
                  <a:pt x="1125898" y="125829"/>
                </a:lnTo>
                <a:lnTo>
                  <a:pt x="1125898" y="151750"/>
                </a:lnTo>
                <a:lnTo>
                  <a:pt x="1182933" y="151750"/>
                </a:lnTo>
                <a:lnTo>
                  <a:pt x="1182933" y="151750"/>
                </a:lnTo>
                <a:lnTo>
                  <a:pt x="1200888" y="151750"/>
                </a:lnTo>
                <a:lnTo>
                  <a:pt x="1200888" y="177779"/>
                </a:lnTo>
                <a:lnTo>
                  <a:pt x="1215675" y="177779"/>
                </a:lnTo>
                <a:lnTo>
                  <a:pt x="1215675" y="177779"/>
                </a:lnTo>
                <a:lnTo>
                  <a:pt x="1277990" y="177779"/>
                </a:lnTo>
                <a:lnTo>
                  <a:pt x="1277990" y="177779"/>
                </a:lnTo>
                <a:lnTo>
                  <a:pt x="1279046" y="177779"/>
                </a:lnTo>
                <a:lnTo>
                  <a:pt x="1279046" y="177779"/>
                </a:lnTo>
                <a:lnTo>
                  <a:pt x="1347698" y="177779"/>
                </a:lnTo>
                <a:lnTo>
                  <a:pt x="1347698" y="177779"/>
                </a:lnTo>
                <a:lnTo>
                  <a:pt x="1358260" y="177779"/>
                </a:lnTo>
                <a:lnTo>
                  <a:pt x="1358260" y="177779"/>
                </a:lnTo>
                <a:lnTo>
                  <a:pt x="1371991" y="177779"/>
                </a:lnTo>
                <a:lnTo>
                  <a:pt x="1371991" y="177779"/>
                </a:lnTo>
                <a:lnTo>
                  <a:pt x="1374103" y="177779"/>
                </a:lnTo>
                <a:lnTo>
                  <a:pt x="1374103" y="177779"/>
                </a:lnTo>
                <a:lnTo>
                  <a:pt x="1412126" y="177779"/>
                </a:lnTo>
                <a:lnTo>
                  <a:pt x="1412126" y="177779"/>
                </a:lnTo>
                <a:lnTo>
                  <a:pt x="1436418" y="177779"/>
                </a:lnTo>
                <a:lnTo>
                  <a:pt x="1436418" y="177779"/>
                </a:lnTo>
                <a:lnTo>
                  <a:pt x="1453317" y="177779"/>
                </a:lnTo>
                <a:lnTo>
                  <a:pt x="1453317" y="204235"/>
                </a:lnTo>
                <a:lnTo>
                  <a:pt x="1475497" y="204235"/>
                </a:lnTo>
                <a:lnTo>
                  <a:pt x="1475497" y="204235"/>
                </a:lnTo>
                <a:lnTo>
                  <a:pt x="1481835" y="204235"/>
                </a:lnTo>
                <a:lnTo>
                  <a:pt x="1481835" y="204235"/>
                </a:lnTo>
                <a:lnTo>
                  <a:pt x="1527251" y="204235"/>
                </a:lnTo>
                <a:lnTo>
                  <a:pt x="1527251" y="204235"/>
                </a:lnTo>
                <a:lnTo>
                  <a:pt x="1551543" y="204235"/>
                </a:lnTo>
                <a:lnTo>
                  <a:pt x="1551543" y="204235"/>
                </a:lnTo>
                <a:lnTo>
                  <a:pt x="1610690" y="204235"/>
                </a:lnTo>
                <a:lnTo>
                  <a:pt x="1610690" y="204235"/>
                </a:lnTo>
                <a:lnTo>
                  <a:pt x="1668780" y="204235"/>
                </a:lnTo>
                <a:lnTo>
                  <a:pt x="1668780" y="230967"/>
                </a:lnTo>
                <a:lnTo>
                  <a:pt x="1676174" y="230967"/>
                </a:lnTo>
                <a:lnTo>
                  <a:pt x="1676174" y="230967"/>
                </a:lnTo>
                <a:lnTo>
                  <a:pt x="1695185" y="230967"/>
                </a:lnTo>
                <a:lnTo>
                  <a:pt x="1695185" y="230967"/>
                </a:lnTo>
                <a:lnTo>
                  <a:pt x="1703635" y="230967"/>
                </a:lnTo>
                <a:lnTo>
                  <a:pt x="1703635" y="230967"/>
                </a:lnTo>
                <a:lnTo>
                  <a:pt x="1722646" y="230967"/>
                </a:lnTo>
                <a:lnTo>
                  <a:pt x="1722646" y="230967"/>
                </a:lnTo>
                <a:lnTo>
                  <a:pt x="1745882" y="230967"/>
                </a:lnTo>
                <a:lnTo>
                  <a:pt x="1745882" y="257844"/>
                </a:lnTo>
                <a:lnTo>
                  <a:pt x="1779680" y="257844"/>
                </a:lnTo>
                <a:lnTo>
                  <a:pt x="1779680" y="257844"/>
                </a:lnTo>
                <a:lnTo>
                  <a:pt x="1797635" y="257844"/>
                </a:lnTo>
                <a:lnTo>
                  <a:pt x="1797635" y="257844"/>
                </a:lnTo>
                <a:lnTo>
                  <a:pt x="1799748" y="257844"/>
                </a:lnTo>
                <a:lnTo>
                  <a:pt x="1799748" y="284773"/>
                </a:lnTo>
                <a:lnTo>
                  <a:pt x="1829321" y="284773"/>
                </a:lnTo>
                <a:lnTo>
                  <a:pt x="1829321" y="284773"/>
                </a:lnTo>
                <a:lnTo>
                  <a:pt x="1841995" y="284773"/>
                </a:lnTo>
                <a:lnTo>
                  <a:pt x="1841995" y="284773"/>
                </a:lnTo>
                <a:lnTo>
                  <a:pt x="1866288" y="284773"/>
                </a:lnTo>
                <a:lnTo>
                  <a:pt x="1866288" y="311906"/>
                </a:lnTo>
                <a:lnTo>
                  <a:pt x="1915929" y="311906"/>
                </a:lnTo>
                <a:lnTo>
                  <a:pt x="1915929" y="311906"/>
                </a:lnTo>
                <a:lnTo>
                  <a:pt x="1945502" y="311906"/>
                </a:lnTo>
                <a:lnTo>
                  <a:pt x="1945502" y="311906"/>
                </a:lnTo>
                <a:lnTo>
                  <a:pt x="2046896" y="311906"/>
                </a:lnTo>
                <a:lnTo>
                  <a:pt x="2046896" y="311906"/>
                </a:lnTo>
                <a:lnTo>
                  <a:pt x="2047953" y="311906"/>
                </a:lnTo>
                <a:lnTo>
                  <a:pt x="2047953" y="311906"/>
                </a:lnTo>
                <a:lnTo>
                  <a:pt x="2055346" y="311906"/>
                </a:lnTo>
                <a:lnTo>
                  <a:pt x="2055346" y="311906"/>
                </a:lnTo>
                <a:lnTo>
                  <a:pt x="2082807" y="311906"/>
                </a:lnTo>
                <a:lnTo>
                  <a:pt x="2082807" y="311906"/>
                </a:lnTo>
                <a:lnTo>
                  <a:pt x="2100762" y="311906"/>
                </a:lnTo>
                <a:lnTo>
                  <a:pt x="2100762" y="311906"/>
                </a:lnTo>
                <a:lnTo>
                  <a:pt x="2111324" y="311906"/>
                </a:lnTo>
                <a:lnTo>
                  <a:pt x="2111324" y="311906"/>
                </a:lnTo>
                <a:lnTo>
                  <a:pt x="2122942" y="311906"/>
                </a:lnTo>
                <a:lnTo>
                  <a:pt x="2122942" y="311906"/>
                </a:lnTo>
                <a:lnTo>
                  <a:pt x="2130335" y="311906"/>
                </a:lnTo>
                <a:lnTo>
                  <a:pt x="2130335" y="311906"/>
                </a:lnTo>
                <a:lnTo>
                  <a:pt x="2134560" y="311906"/>
                </a:lnTo>
                <a:lnTo>
                  <a:pt x="2134560" y="311906"/>
                </a:lnTo>
                <a:lnTo>
                  <a:pt x="2148291" y="311906"/>
                </a:lnTo>
                <a:lnTo>
                  <a:pt x="2148291" y="311906"/>
                </a:lnTo>
                <a:lnTo>
                  <a:pt x="2188426" y="311906"/>
                </a:lnTo>
                <a:lnTo>
                  <a:pt x="2188426" y="311906"/>
                </a:lnTo>
                <a:lnTo>
                  <a:pt x="2192651" y="311906"/>
                </a:lnTo>
                <a:lnTo>
                  <a:pt x="2192651" y="340064"/>
                </a:lnTo>
                <a:lnTo>
                  <a:pt x="2224336" y="340064"/>
                </a:lnTo>
                <a:lnTo>
                  <a:pt x="2224336" y="340064"/>
                </a:lnTo>
                <a:lnTo>
                  <a:pt x="2228561" y="340064"/>
                </a:lnTo>
                <a:lnTo>
                  <a:pt x="2228561" y="340064"/>
                </a:lnTo>
                <a:lnTo>
                  <a:pt x="2343686" y="340064"/>
                </a:lnTo>
                <a:lnTo>
                  <a:pt x="2343686" y="368485"/>
                </a:lnTo>
                <a:lnTo>
                  <a:pt x="2360585" y="368485"/>
                </a:lnTo>
                <a:lnTo>
                  <a:pt x="2360585" y="396934"/>
                </a:lnTo>
                <a:lnTo>
                  <a:pt x="2393327" y="396934"/>
                </a:lnTo>
                <a:lnTo>
                  <a:pt x="2393327" y="396934"/>
                </a:lnTo>
                <a:lnTo>
                  <a:pt x="2428181" y="396934"/>
                </a:lnTo>
                <a:lnTo>
                  <a:pt x="2428181" y="396934"/>
                </a:lnTo>
                <a:lnTo>
                  <a:pt x="2455642" y="396934"/>
                </a:lnTo>
                <a:lnTo>
                  <a:pt x="2455642" y="396934"/>
                </a:lnTo>
                <a:lnTo>
                  <a:pt x="2467260" y="396934"/>
                </a:lnTo>
                <a:lnTo>
                  <a:pt x="2467260" y="396934"/>
                </a:lnTo>
                <a:lnTo>
                  <a:pt x="2500002" y="396934"/>
                </a:lnTo>
                <a:lnTo>
                  <a:pt x="2500002" y="396934"/>
                </a:lnTo>
                <a:lnTo>
                  <a:pt x="2545418" y="396934"/>
                </a:lnTo>
                <a:lnTo>
                  <a:pt x="2545418" y="426929"/>
                </a:lnTo>
                <a:lnTo>
                  <a:pt x="2557036" y="426929"/>
                </a:lnTo>
                <a:lnTo>
                  <a:pt x="2557036" y="426929"/>
                </a:lnTo>
                <a:lnTo>
                  <a:pt x="2709128" y="426929"/>
                </a:lnTo>
                <a:lnTo>
                  <a:pt x="2709128" y="457380"/>
                </a:lnTo>
                <a:lnTo>
                  <a:pt x="2726027" y="457380"/>
                </a:lnTo>
                <a:lnTo>
                  <a:pt x="2726027" y="457380"/>
                </a:lnTo>
                <a:lnTo>
                  <a:pt x="2735533" y="457380"/>
                </a:lnTo>
                <a:lnTo>
                  <a:pt x="2735533" y="457380"/>
                </a:lnTo>
                <a:lnTo>
                  <a:pt x="2742926" y="457380"/>
                </a:lnTo>
                <a:lnTo>
                  <a:pt x="2742926" y="487958"/>
                </a:lnTo>
                <a:lnTo>
                  <a:pt x="2780949" y="487958"/>
                </a:lnTo>
                <a:lnTo>
                  <a:pt x="2780949" y="487958"/>
                </a:lnTo>
                <a:lnTo>
                  <a:pt x="2786230" y="487958"/>
                </a:lnTo>
                <a:lnTo>
                  <a:pt x="2786230" y="518618"/>
                </a:lnTo>
                <a:lnTo>
                  <a:pt x="2795735" y="518618"/>
                </a:lnTo>
                <a:lnTo>
                  <a:pt x="2795735" y="518618"/>
                </a:lnTo>
                <a:lnTo>
                  <a:pt x="2797848" y="518618"/>
                </a:lnTo>
                <a:lnTo>
                  <a:pt x="2797848" y="518618"/>
                </a:lnTo>
                <a:lnTo>
                  <a:pt x="2826365" y="518618"/>
                </a:lnTo>
                <a:lnTo>
                  <a:pt x="2826365" y="549452"/>
                </a:lnTo>
                <a:lnTo>
                  <a:pt x="2846432" y="549452"/>
                </a:lnTo>
                <a:lnTo>
                  <a:pt x="2846432" y="549452"/>
                </a:lnTo>
                <a:lnTo>
                  <a:pt x="2868612" y="549452"/>
                </a:lnTo>
                <a:lnTo>
                  <a:pt x="2868612" y="549452"/>
                </a:lnTo>
                <a:lnTo>
                  <a:pt x="2874950" y="549452"/>
                </a:lnTo>
                <a:lnTo>
                  <a:pt x="2874950" y="549452"/>
                </a:lnTo>
                <a:lnTo>
                  <a:pt x="2955220" y="549452"/>
                </a:lnTo>
                <a:lnTo>
                  <a:pt x="2955220" y="549452"/>
                </a:lnTo>
                <a:lnTo>
                  <a:pt x="2993243" y="549452"/>
                </a:lnTo>
                <a:lnTo>
                  <a:pt x="2993243" y="549452"/>
                </a:lnTo>
                <a:lnTo>
                  <a:pt x="2994299" y="549452"/>
                </a:lnTo>
                <a:lnTo>
                  <a:pt x="2994299" y="549452"/>
                </a:lnTo>
                <a:lnTo>
                  <a:pt x="2999580" y="549452"/>
                </a:lnTo>
                <a:lnTo>
                  <a:pt x="2999580" y="549452"/>
                </a:lnTo>
                <a:lnTo>
                  <a:pt x="3019648" y="549452"/>
                </a:lnTo>
                <a:lnTo>
                  <a:pt x="3019648" y="549452"/>
                </a:lnTo>
                <a:lnTo>
                  <a:pt x="3073513" y="549452"/>
                </a:lnTo>
                <a:lnTo>
                  <a:pt x="3073513" y="549452"/>
                </a:lnTo>
                <a:lnTo>
                  <a:pt x="3089356" y="549452"/>
                </a:lnTo>
                <a:lnTo>
                  <a:pt x="3089356" y="549452"/>
                </a:lnTo>
                <a:lnTo>
                  <a:pt x="3127379" y="549452"/>
                </a:lnTo>
                <a:lnTo>
                  <a:pt x="3127379" y="581952"/>
                </a:lnTo>
                <a:lnTo>
                  <a:pt x="3165402" y="581952"/>
                </a:lnTo>
                <a:lnTo>
                  <a:pt x="3165402" y="581952"/>
                </a:lnTo>
                <a:lnTo>
                  <a:pt x="3246729" y="581952"/>
                </a:lnTo>
                <a:lnTo>
                  <a:pt x="3246729" y="581952"/>
                </a:lnTo>
                <a:lnTo>
                  <a:pt x="3267852" y="581952"/>
                </a:lnTo>
                <a:lnTo>
                  <a:pt x="3267852" y="581952"/>
                </a:lnTo>
                <a:lnTo>
                  <a:pt x="3310100" y="581952"/>
                </a:lnTo>
                <a:lnTo>
                  <a:pt x="3310100" y="581952"/>
                </a:lnTo>
                <a:lnTo>
                  <a:pt x="3335449" y="581952"/>
                </a:lnTo>
                <a:lnTo>
                  <a:pt x="3335449" y="581952"/>
                </a:lnTo>
                <a:lnTo>
                  <a:pt x="3336505" y="581952"/>
                </a:lnTo>
                <a:lnTo>
                  <a:pt x="3336505" y="581952"/>
                </a:lnTo>
                <a:lnTo>
                  <a:pt x="3352348" y="581952"/>
                </a:lnTo>
                <a:lnTo>
                  <a:pt x="3352348" y="581952"/>
                </a:lnTo>
                <a:lnTo>
                  <a:pt x="3400932" y="581952"/>
                </a:lnTo>
                <a:lnTo>
                  <a:pt x="3400932" y="615204"/>
                </a:lnTo>
                <a:lnTo>
                  <a:pt x="3415719" y="615204"/>
                </a:lnTo>
                <a:lnTo>
                  <a:pt x="3415719" y="648462"/>
                </a:lnTo>
                <a:lnTo>
                  <a:pt x="3422056" y="648462"/>
                </a:lnTo>
                <a:lnTo>
                  <a:pt x="3422056" y="681747"/>
                </a:lnTo>
                <a:lnTo>
                  <a:pt x="3425225" y="681747"/>
                </a:lnTo>
                <a:lnTo>
                  <a:pt x="3425225" y="715203"/>
                </a:lnTo>
                <a:lnTo>
                  <a:pt x="3426281" y="715203"/>
                </a:lnTo>
                <a:lnTo>
                  <a:pt x="3426281" y="748992"/>
                </a:lnTo>
                <a:lnTo>
                  <a:pt x="3435787" y="748992"/>
                </a:lnTo>
                <a:lnTo>
                  <a:pt x="3435787" y="748992"/>
                </a:lnTo>
                <a:lnTo>
                  <a:pt x="3437899" y="748992"/>
                </a:lnTo>
                <a:lnTo>
                  <a:pt x="3437899" y="748992"/>
                </a:lnTo>
                <a:lnTo>
                  <a:pt x="3481203" y="748992"/>
                </a:lnTo>
                <a:lnTo>
                  <a:pt x="3481203" y="748992"/>
                </a:lnTo>
                <a:lnTo>
                  <a:pt x="3483315" y="748992"/>
                </a:lnTo>
                <a:lnTo>
                  <a:pt x="3483315" y="782904"/>
                </a:lnTo>
                <a:lnTo>
                  <a:pt x="3491765" y="782904"/>
                </a:lnTo>
                <a:lnTo>
                  <a:pt x="3491765" y="816830"/>
                </a:lnTo>
                <a:lnTo>
                  <a:pt x="3501271" y="816830"/>
                </a:lnTo>
                <a:lnTo>
                  <a:pt x="3501271" y="816830"/>
                </a:lnTo>
                <a:lnTo>
                  <a:pt x="3507608" y="816830"/>
                </a:lnTo>
                <a:lnTo>
                  <a:pt x="3507608" y="816830"/>
                </a:lnTo>
                <a:lnTo>
                  <a:pt x="3508664" y="816830"/>
                </a:lnTo>
                <a:lnTo>
                  <a:pt x="3508664" y="816830"/>
                </a:lnTo>
                <a:lnTo>
                  <a:pt x="3525563" y="816830"/>
                </a:lnTo>
                <a:lnTo>
                  <a:pt x="3525563" y="851156"/>
                </a:lnTo>
                <a:lnTo>
                  <a:pt x="3530844" y="851156"/>
                </a:lnTo>
                <a:lnTo>
                  <a:pt x="3530844" y="851156"/>
                </a:lnTo>
                <a:lnTo>
                  <a:pt x="3569923" y="851156"/>
                </a:lnTo>
                <a:lnTo>
                  <a:pt x="3569923" y="851156"/>
                </a:lnTo>
                <a:lnTo>
                  <a:pt x="3572035" y="851156"/>
                </a:lnTo>
                <a:lnTo>
                  <a:pt x="3572035" y="851156"/>
                </a:lnTo>
                <a:lnTo>
                  <a:pt x="3624845" y="851156"/>
                </a:lnTo>
                <a:lnTo>
                  <a:pt x="3624845" y="885792"/>
                </a:lnTo>
                <a:lnTo>
                  <a:pt x="3636463" y="885792"/>
                </a:lnTo>
                <a:lnTo>
                  <a:pt x="3636463" y="920436"/>
                </a:lnTo>
                <a:lnTo>
                  <a:pt x="3649137" y="920436"/>
                </a:lnTo>
                <a:lnTo>
                  <a:pt x="3649137" y="920436"/>
                </a:lnTo>
                <a:lnTo>
                  <a:pt x="3657587" y="920436"/>
                </a:lnTo>
                <a:lnTo>
                  <a:pt x="3657587" y="920436"/>
                </a:lnTo>
                <a:lnTo>
                  <a:pt x="3674486" y="920436"/>
                </a:lnTo>
                <a:lnTo>
                  <a:pt x="3674486" y="920436"/>
                </a:lnTo>
                <a:lnTo>
                  <a:pt x="3681879" y="920436"/>
                </a:lnTo>
                <a:lnTo>
                  <a:pt x="3681879" y="920436"/>
                </a:lnTo>
                <a:lnTo>
                  <a:pt x="3692441" y="920436"/>
                </a:lnTo>
                <a:lnTo>
                  <a:pt x="3692441" y="920436"/>
                </a:lnTo>
                <a:lnTo>
                  <a:pt x="3699834" y="920436"/>
                </a:lnTo>
                <a:lnTo>
                  <a:pt x="3699834" y="920436"/>
                </a:lnTo>
                <a:lnTo>
                  <a:pt x="3724127" y="920436"/>
                </a:lnTo>
                <a:lnTo>
                  <a:pt x="3724127" y="920436"/>
                </a:lnTo>
                <a:lnTo>
                  <a:pt x="3757925" y="920436"/>
                </a:lnTo>
                <a:lnTo>
                  <a:pt x="3757925" y="920436"/>
                </a:lnTo>
                <a:lnTo>
                  <a:pt x="3767430" y="920436"/>
                </a:lnTo>
                <a:lnTo>
                  <a:pt x="3767430" y="920436"/>
                </a:lnTo>
                <a:lnTo>
                  <a:pt x="3773768" y="920436"/>
                </a:lnTo>
                <a:lnTo>
                  <a:pt x="3773768" y="992173"/>
                </a:lnTo>
                <a:lnTo>
                  <a:pt x="3774824" y="992173"/>
                </a:lnTo>
                <a:lnTo>
                  <a:pt x="3774824" y="992173"/>
                </a:lnTo>
                <a:lnTo>
                  <a:pt x="3775880" y="992173"/>
                </a:lnTo>
                <a:lnTo>
                  <a:pt x="3775880" y="992173"/>
                </a:lnTo>
                <a:lnTo>
                  <a:pt x="3784330" y="992173"/>
                </a:lnTo>
                <a:lnTo>
                  <a:pt x="3784330" y="992173"/>
                </a:lnTo>
                <a:lnTo>
                  <a:pt x="3790667" y="992173"/>
                </a:lnTo>
                <a:lnTo>
                  <a:pt x="3790667" y="992173"/>
                </a:lnTo>
                <a:lnTo>
                  <a:pt x="3791723" y="992173"/>
                </a:lnTo>
                <a:lnTo>
                  <a:pt x="3791723" y="992173"/>
                </a:lnTo>
                <a:lnTo>
                  <a:pt x="3799116" y="992173"/>
                </a:lnTo>
                <a:lnTo>
                  <a:pt x="3799116" y="992173"/>
                </a:lnTo>
                <a:lnTo>
                  <a:pt x="3804397" y="992173"/>
                </a:lnTo>
                <a:lnTo>
                  <a:pt x="3804397" y="992173"/>
                </a:lnTo>
                <a:lnTo>
                  <a:pt x="3807566" y="992173"/>
                </a:lnTo>
                <a:lnTo>
                  <a:pt x="3807566" y="1029241"/>
                </a:lnTo>
                <a:lnTo>
                  <a:pt x="3812847" y="1029241"/>
                </a:lnTo>
                <a:lnTo>
                  <a:pt x="3812847" y="1029241"/>
                </a:lnTo>
                <a:lnTo>
                  <a:pt x="3813903" y="1029241"/>
                </a:lnTo>
                <a:lnTo>
                  <a:pt x="3813903" y="1029241"/>
                </a:lnTo>
                <a:lnTo>
                  <a:pt x="3816015" y="1029241"/>
                </a:lnTo>
                <a:lnTo>
                  <a:pt x="3816015" y="1066547"/>
                </a:lnTo>
                <a:lnTo>
                  <a:pt x="3839251" y="1066547"/>
                </a:lnTo>
                <a:lnTo>
                  <a:pt x="3839251" y="1066547"/>
                </a:lnTo>
                <a:lnTo>
                  <a:pt x="3844532" y="1066547"/>
                </a:lnTo>
                <a:lnTo>
                  <a:pt x="3844532" y="1066547"/>
                </a:lnTo>
                <a:lnTo>
                  <a:pt x="3845589" y="1066547"/>
                </a:lnTo>
                <a:lnTo>
                  <a:pt x="3845589" y="1066547"/>
                </a:lnTo>
                <a:lnTo>
                  <a:pt x="3851926" y="1066547"/>
                </a:lnTo>
                <a:lnTo>
                  <a:pt x="3851926" y="1066547"/>
                </a:lnTo>
                <a:lnTo>
                  <a:pt x="3852982" y="1066547"/>
                </a:lnTo>
                <a:lnTo>
                  <a:pt x="3852982" y="1066547"/>
                </a:lnTo>
                <a:lnTo>
                  <a:pt x="3874106" y="1066547"/>
                </a:lnTo>
                <a:lnTo>
                  <a:pt x="3874106" y="1066547"/>
                </a:lnTo>
                <a:lnTo>
                  <a:pt x="3910016" y="1066547"/>
                </a:lnTo>
                <a:lnTo>
                  <a:pt x="3910016" y="1104250"/>
                </a:lnTo>
                <a:lnTo>
                  <a:pt x="3923747" y="1104250"/>
                </a:lnTo>
                <a:lnTo>
                  <a:pt x="3923747" y="1104250"/>
                </a:lnTo>
                <a:lnTo>
                  <a:pt x="3927971" y="1104250"/>
                </a:lnTo>
                <a:lnTo>
                  <a:pt x="3927971" y="1104250"/>
                </a:lnTo>
                <a:lnTo>
                  <a:pt x="3932196" y="1104250"/>
                </a:lnTo>
                <a:lnTo>
                  <a:pt x="3932196" y="1104250"/>
                </a:lnTo>
                <a:lnTo>
                  <a:pt x="3950151" y="1104250"/>
                </a:lnTo>
                <a:lnTo>
                  <a:pt x="3950151" y="1104250"/>
                </a:lnTo>
                <a:lnTo>
                  <a:pt x="3964938" y="1104250"/>
                </a:lnTo>
                <a:lnTo>
                  <a:pt x="3964938" y="1142203"/>
                </a:lnTo>
                <a:lnTo>
                  <a:pt x="4094849" y="1142203"/>
                </a:lnTo>
                <a:lnTo>
                  <a:pt x="4094849" y="1142203"/>
                </a:lnTo>
                <a:lnTo>
                  <a:pt x="4118086" y="1142203"/>
                </a:lnTo>
                <a:lnTo>
                  <a:pt x="4118086" y="1142203"/>
                </a:lnTo>
                <a:lnTo>
                  <a:pt x="4151884" y="1142203"/>
                </a:lnTo>
                <a:lnTo>
                  <a:pt x="4151884" y="1142203"/>
                </a:lnTo>
                <a:lnTo>
                  <a:pt x="4164558" y="1142203"/>
                </a:lnTo>
                <a:lnTo>
                  <a:pt x="4164558" y="1142203"/>
                </a:lnTo>
                <a:lnTo>
                  <a:pt x="4180401" y="1142203"/>
                </a:lnTo>
                <a:lnTo>
                  <a:pt x="4180401" y="1181786"/>
                </a:lnTo>
                <a:lnTo>
                  <a:pt x="4199412" y="1181786"/>
                </a:lnTo>
                <a:lnTo>
                  <a:pt x="4199412" y="1181786"/>
                </a:lnTo>
                <a:lnTo>
                  <a:pt x="4203637" y="1181786"/>
                </a:lnTo>
                <a:lnTo>
                  <a:pt x="4203637" y="1221551"/>
                </a:lnTo>
                <a:lnTo>
                  <a:pt x="4227929" y="1221551"/>
                </a:lnTo>
                <a:lnTo>
                  <a:pt x="4227929" y="1221551"/>
                </a:lnTo>
                <a:lnTo>
                  <a:pt x="4237435" y="1221551"/>
                </a:lnTo>
                <a:lnTo>
                  <a:pt x="4237435" y="1221551"/>
                </a:lnTo>
                <a:lnTo>
                  <a:pt x="4240604" y="1221551"/>
                </a:lnTo>
                <a:lnTo>
                  <a:pt x="4240604" y="1221551"/>
                </a:lnTo>
                <a:lnTo>
                  <a:pt x="4272289" y="1221551"/>
                </a:lnTo>
                <a:lnTo>
                  <a:pt x="4272289" y="1221551"/>
                </a:lnTo>
                <a:lnTo>
                  <a:pt x="4275458" y="1221551"/>
                </a:lnTo>
                <a:lnTo>
                  <a:pt x="4275458" y="1221551"/>
                </a:lnTo>
                <a:lnTo>
                  <a:pt x="4279683" y="1221551"/>
                </a:lnTo>
                <a:lnTo>
                  <a:pt x="4279683" y="1261732"/>
                </a:lnTo>
                <a:lnTo>
                  <a:pt x="4301863" y="1261732"/>
                </a:lnTo>
                <a:lnTo>
                  <a:pt x="4301863" y="1261732"/>
                </a:lnTo>
                <a:lnTo>
                  <a:pt x="4344110" y="1261732"/>
                </a:lnTo>
                <a:lnTo>
                  <a:pt x="4344110" y="1302085"/>
                </a:lnTo>
                <a:lnTo>
                  <a:pt x="4347279" y="1302085"/>
                </a:lnTo>
                <a:lnTo>
                  <a:pt x="4347279" y="1302085"/>
                </a:lnTo>
                <a:lnTo>
                  <a:pt x="4350448" y="1302085"/>
                </a:lnTo>
                <a:lnTo>
                  <a:pt x="4350448" y="1342618"/>
                </a:lnTo>
                <a:lnTo>
                  <a:pt x="4406426" y="1342618"/>
                </a:lnTo>
                <a:lnTo>
                  <a:pt x="4406426" y="1342618"/>
                </a:lnTo>
                <a:lnTo>
                  <a:pt x="4426493" y="1342618"/>
                </a:lnTo>
                <a:lnTo>
                  <a:pt x="4426493" y="1342618"/>
                </a:lnTo>
                <a:lnTo>
                  <a:pt x="4443392" y="1342618"/>
                </a:lnTo>
                <a:lnTo>
                  <a:pt x="4443392" y="1342618"/>
                </a:lnTo>
                <a:lnTo>
                  <a:pt x="4445505" y="1342618"/>
                </a:lnTo>
                <a:lnTo>
                  <a:pt x="4445505" y="1342618"/>
                </a:lnTo>
                <a:lnTo>
                  <a:pt x="4460291" y="1342618"/>
                </a:lnTo>
                <a:lnTo>
                  <a:pt x="4460291" y="1342618"/>
                </a:lnTo>
                <a:lnTo>
                  <a:pt x="4475078" y="1342618"/>
                </a:lnTo>
                <a:lnTo>
                  <a:pt x="4475078" y="1342618"/>
                </a:lnTo>
                <a:lnTo>
                  <a:pt x="4482471" y="1342618"/>
                </a:lnTo>
                <a:lnTo>
                  <a:pt x="4482471" y="1342618"/>
                </a:lnTo>
                <a:lnTo>
                  <a:pt x="4487752" y="1342618"/>
                </a:lnTo>
                <a:lnTo>
                  <a:pt x="4487752" y="1342618"/>
                </a:lnTo>
                <a:lnTo>
                  <a:pt x="4513101" y="1342618"/>
                </a:lnTo>
                <a:lnTo>
                  <a:pt x="4513101" y="1342618"/>
                </a:lnTo>
                <a:lnTo>
                  <a:pt x="4534225" y="1342618"/>
                </a:lnTo>
                <a:lnTo>
                  <a:pt x="4534225" y="1384485"/>
                </a:lnTo>
                <a:lnTo>
                  <a:pt x="4559573" y="1384485"/>
                </a:lnTo>
                <a:lnTo>
                  <a:pt x="4559573" y="1426398"/>
                </a:lnTo>
                <a:lnTo>
                  <a:pt x="4585978" y="1426398"/>
                </a:lnTo>
                <a:lnTo>
                  <a:pt x="4585978" y="1426398"/>
                </a:lnTo>
                <a:lnTo>
                  <a:pt x="4590203" y="1426398"/>
                </a:lnTo>
                <a:lnTo>
                  <a:pt x="4590203" y="1426398"/>
                </a:lnTo>
                <a:lnTo>
                  <a:pt x="4598652" y="1426398"/>
                </a:lnTo>
                <a:lnTo>
                  <a:pt x="4598652" y="1468771"/>
                </a:lnTo>
                <a:lnTo>
                  <a:pt x="4599708" y="1468771"/>
                </a:lnTo>
                <a:lnTo>
                  <a:pt x="4599708" y="1511296"/>
                </a:lnTo>
                <a:lnTo>
                  <a:pt x="4601821" y="1511296"/>
                </a:lnTo>
                <a:lnTo>
                  <a:pt x="4601821" y="1511296"/>
                </a:lnTo>
                <a:lnTo>
                  <a:pt x="4604989" y="1511296"/>
                </a:lnTo>
                <a:lnTo>
                  <a:pt x="4604989" y="1553957"/>
                </a:lnTo>
                <a:lnTo>
                  <a:pt x="4614495" y="1553957"/>
                </a:lnTo>
                <a:lnTo>
                  <a:pt x="4614495" y="1553957"/>
                </a:lnTo>
                <a:lnTo>
                  <a:pt x="4616608" y="1553957"/>
                </a:lnTo>
                <a:lnTo>
                  <a:pt x="4616608" y="1596732"/>
                </a:lnTo>
                <a:lnTo>
                  <a:pt x="4632450" y="1596732"/>
                </a:lnTo>
                <a:lnTo>
                  <a:pt x="4632450" y="1596732"/>
                </a:lnTo>
                <a:lnTo>
                  <a:pt x="4638788" y="1596732"/>
                </a:lnTo>
                <a:lnTo>
                  <a:pt x="4638788" y="1596732"/>
                </a:lnTo>
                <a:lnTo>
                  <a:pt x="4650406" y="1596732"/>
                </a:lnTo>
                <a:lnTo>
                  <a:pt x="4650406" y="1639733"/>
                </a:lnTo>
                <a:lnTo>
                  <a:pt x="4657799" y="1639733"/>
                </a:lnTo>
                <a:lnTo>
                  <a:pt x="4657799" y="1639733"/>
                </a:lnTo>
                <a:lnTo>
                  <a:pt x="4659911" y="1639733"/>
                </a:lnTo>
                <a:lnTo>
                  <a:pt x="4659911" y="1639733"/>
                </a:lnTo>
                <a:lnTo>
                  <a:pt x="4666248" y="1639733"/>
                </a:lnTo>
                <a:lnTo>
                  <a:pt x="4666248" y="1682816"/>
                </a:lnTo>
                <a:lnTo>
                  <a:pt x="4670473" y="1682816"/>
                </a:lnTo>
                <a:lnTo>
                  <a:pt x="4670473" y="1726096"/>
                </a:lnTo>
                <a:lnTo>
                  <a:pt x="4673642" y="1726096"/>
                </a:lnTo>
                <a:lnTo>
                  <a:pt x="4673642" y="1769412"/>
                </a:lnTo>
                <a:lnTo>
                  <a:pt x="4676810" y="1769412"/>
                </a:lnTo>
                <a:lnTo>
                  <a:pt x="4676810" y="1769412"/>
                </a:lnTo>
                <a:lnTo>
                  <a:pt x="4702159" y="1769412"/>
                </a:lnTo>
                <a:lnTo>
                  <a:pt x="4702159" y="1769412"/>
                </a:lnTo>
                <a:lnTo>
                  <a:pt x="4738069" y="1769412"/>
                </a:lnTo>
                <a:lnTo>
                  <a:pt x="4738069" y="1769412"/>
                </a:lnTo>
                <a:lnTo>
                  <a:pt x="4766587" y="1769412"/>
                </a:lnTo>
                <a:lnTo>
                  <a:pt x="4766587" y="1769412"/>
                </a:lnTo>
                <a:lnTo>
                  <a:pt x="4783486" y="1769412"/>
                </a:lnTo>
                <a:lnTo>
                  <a:pt x="4783486" y="1813679"/>
                </a:lnTo>
                <a:lnTo>
                  <a:pt x="4794047" y="1813679"/>
                </a:lnTo>
                <a:lnTo>
                  <a:pt x="4794047" y="1858033"/>
                </a:lnTo>
                <a:lnTo>
                  <a:pt x="4819396" y="1858033"/>
                </a:lnTo>
                <a:lnTo>
                  <a:pt x="4819396" y="1858033"/>
                </a:lnTo>
                <a:lnTo>
                  <a:pt x="4835239" y="1858033"/>
                </a:lnTo>
                <a:lnTo>
                  <a:pt x="4835239" y="1858033"/>
                </a:lnTo>
                <a:lnTo>
                  <a:pt x="4852138" y="1858033"/>
                </a:lnTo>
                <a:lnTo>
                  <a:pt x="4852138" y="1858033"/>
                </a:lnTo>
                <a:lnTo>
                  <a:pt x="4864812" y="1858033"/>
                </a:lnTo>
                <a:lnTo>
                  <a:pt x="4864812" y="1858033"/>
                </a:lnTo>
                <a:lnTo>
                  <a:pt x="4874318" y="1858033"/>
                </a:lnTo>
                <a:lnTo>
                  <a:pt x="4874318" y="1858033"/>
                </a:lnTo>
                <a:lnTo>
                  <a:pt x="4877487" y="1858033"/>
                </a:lnTo>
                <a:lnTo>
                  <a:pt x="4877487" y="1902754"/>
                </a:lnTo>
                <a:lnTo>
                  <a:pt x="4913397" y="1902754"/>
                </a:lnTo>
                <a:lnTo>
                  <a:pt x="4913397" y="1902754"/>
                </a:lnTo>
                <a:lnTo>
                  <a:pt x="4916566" y="1902754"/>
                </a:lnTo>
                <a:lnTo>
                  <a:pt x="4916566" y="1902754"/>
                </a:lnTo>
                <a:lnTo>
                  <a:pt x="4928184" y="1902754"/>
                </a:lnTo>
                <a:lnTo>
                  <a:pt x="4928184" y="1902754"/>
                </a:lnTo>
                <a:lnTo>
                  <a:pt x="4931352" y="1902754"/>
                </a:lnTo>
                <a:lnTo>
                  <a:pt x="4931352" y="1902754"/>
                </a:lnTo>
                <a:lnTo>
                  <a:pt x="4942970" y="1902754"/>
                </a:lnTo>
                <a:lnTo>
                  <a:pt x="4942970" y="1902754"/>
                </a:lnTo>
                <a:lnTo>
                  <a:pt x="4954588" y="1902754"/>
                </a:lnTo>
                <a:lnTo>
                  <a:pt x="4954588" y="1902754"/>
                </a:lnTo>
                <a:lnTo>
                  <a:pt x="4982049" y="1902754"/>
                </a:lnTo>
                <a:lnTo>
                  <a:pt x="4982049" y="1902754"/>
                </a:lnTo>
                <a:lnTo>
                  <a:pt x="4986274" y="1902754"/>
                </a:lnTo>
                <a:lnTo>
                  <a:pt x="4986274" y="1902754"/>
                </a:lnTo>
                <a:lnTo>
                  <a:pt x="4989443" y="1902754"/>
                </a:lnTo>
                <a:lnTo>
                  <a:pt x="4989443" y="1948654"/>
                </a:lnTo>
                <a:lnTo>
                  <a:pt x="4993667" y="1948654"/>
                </a:lnTo>
                <a:lnTo>
                  <a:pt x="4993667" y="1948654"/>
                </a:lnTo>
                <a:lnTo>
                  <a:pt x="5025353" y="1948654"/>
                </a:lnTo>
                <a:lnTo>
                  <a:pt x="5025353" y="1994663"/>
                </a:lnTo>
                <a:lnTo>
                  <a:pt x="5033803" y="1994663"/>
                </a:lnTo>
                <a:lnTo>
                  <a:pt x="5033803" y="1994663"/>
                </a:lnTo>
                <a:lnTo>
                  <a:pt x="5071826" y="1994663"/>
                </a:lnTo>
                <a:lnTo>
                  <a:pt x="5071826" y="1994663"/>
                </a:lnTo>
                <a:lnTo>
                  <a:pt x="5077107" y="1994663"/>
                </a:lnTo>
                <a:lnTo>
                  <a:pt x="5077107" y="1994663"/>
                </a:lnTo>
                <a:lnTo>
                  <a:pt x="5095062" y="1994663"/>
                </a:lnTo>
                <a:lnTo>
                  <a:pt x="5095062" y="2040982"/>
                </a:lnTo>
                <a:lnTo>
                  <a:pt x="5098230" y="2040982"/>
                </a:lnTo>
                <a:lnTo>
                  <a:pt x="5098230" y="2040982"/>
                </a:lnTo>
                <a:lnTo>
                  <a:pt x="5105624" y="2040982"/>
                </a:lnTo>
                <a:lnTo>
                  <a:pt x="5105624" y="2040982"/>
                </a:lnTo>
                <a:lnTo>
                  <a:pt x="5108792" y="2040982"/>
                </a:lnTo>
                <a:lnTo>
                  <a:pt x="5108792" y="2040982"/>
                </a:lnTo>
                <a:lnTo>
                  <a:pt x="5111961" y="2040982"/>
                </a:lnTo>
                <a:lnTo>
                  <a:pt x="5111961" y="2040982"/>
                </a:lnTo>
                <a:lnTo>
                  <a:pt x="5134141" y="2040982"/>
                </a:lnTo>
                <a:lnTo>
                  <a:pt x="5134141" y="2087807"/>
                </a:lnTo>
                <a:lnTo>
                  <a:pt x="5155265" y="2087807"/>
                </a:lnTo>
                <a:lnTo>
                  <a:pt x="5155265" y="2087807"/>
                </a:lnTo>
                <a:lnTo>
                  <a:pt x="5166883" y="2087807"/>
                </a:lnTo>
                <a:lnTo>
                  <a:pt x="5166883" y="2087807"/>
                </a:lnTo>
                <a:lnTo>
                  <a:pt x="5172164" y="2087807"/>
                </a:lnTo>
                <a:lnTo>
                  <a:pt x="5172164" y="2135078"/>
                </a:lnTo>
                <a:lnTo>
                  <a:pt x="5211243" y="2135078"/>
                </a:lnTo>
                <a:lnTo>
                  <a:pt x="5211243" y="2135078"/>
                </a:lnTo>
                <a:lnTo>
                  <a:pt x="5233423" y="2135078"/>
                </a:lnTo>
                <a:lnTo>
                  <a:pt x="5233423" y="2135078"/>
                </a:lnTo>
                <a:lnTo>
                  <a:pt x="5236591" y="2135078"/>
                </a:lnTo>
                <a:lnTo>
                  <a:pt x="5236591" y="2183071"/>
                </a:lnTo>
                <a:lnTo>
                  <a:pt x="5265108" y="2183071"/>
                </a:lnTo>
                <a:lnTo>
                  <a:pt x="5265108" y="2183071"/>
                </a:lnTo>
                <a:lnTo>
                  <a:pt x="5270389" y="2183071"/>
                </a:lnTo>
                <a:lnTo>
                  <a:pt x="5270389" y="2231170"/>
                </a:lnTo>
                <a:lnTo>
                  <a:pt x="5280951" y="2231170"/>
                </a:lnTo>
                <a:lnTo>
                  <a:pt x="5280951" y="2231170"/>
                </a:lnTo>
                <a:lnTo>
                  <a:pt x="5296794" y="2231170"/>
                </a:lnTo>
                <a:lnTo>
                  <a:pt x="5296794" y="2231170"/>
                </a:lnTo>
                <a:lnTo>
                  <a:pt x="5302075" y="2231170"/>
                </a:lnTo>
                <a:lnTo>
                  <a:pt x="5302075" y="2279926"/>
                </a:lnTo>
                <a:lnTo>
                  <a:pt x="5303131" y="2279926"/>
                </a:lnTo>
                <a:lnTo>
                  <a:pt x="5303131" y="2328994"/>
                </a:lnTo>
                <a:lnTo>
                  <a:pt x="5308412" y="2328994"/>
                </a:lnTo>
                <a:lnTo>
                  <a:pt x="5308412" y="2378177"/>
                </a:lnTo>
                <a:lnTo>
                  <a:pt x="5325311" y="2378177"/>
                </a:lnTo>
                <a:lnTo>
                  <a:pt x="5325311" y="2427455"/>
                </a:lnTo>
                <a:lnTo>
                  <a:pt x="5326367" y="2427455"/>
                </a:lnTo>
                <a:lnTo>
                  <a:pt x="5326367" y="2427455"/>
                </a:lnTo>
                <a:lnTo>
                  <a:pt x="5331648" y="2427455"/>
                </a:lnTo>
                <a:lnTo>
                  <a:pt x="5331648" y="2476917"/>
                </a:lnTo>
                <a:lnTo>
                  <a:pt x="5392907" y="2476917"/>
                </a:lnTo>
                <a:lnTo>
                  <a:pt x="5392907" y="2476917"/>
                </a:lnTo>
                <a:lnTo>
                  <a:pt x="5404526" y="2476917"/>
                </a:lnTo>
                <a:lnTo>
                  <a:pt x="5404526" y="2526473"/>
                </a:lnTo>
                <a:lnTo>
                  <a:pt x="5434099" y="2526473"/>
                </a:lnTo>
                <a:lnTo>
                  <a:pt x="5434099" y="2526473"/>
                </a:lnTo>
                <a:lnTo>
                  <a:pt x="5437267" y="2526473"/>
                </a:lnTo>
                <a:lnTo>
                  <a:pt x="5437267" y="2526473"/>
                </a:lnTo>
                <a:lnTo>
                  <a:pt x="5455223" y="2526473"/>
                </a:lnTo>
                <a:lnTo>
                  <a:pt x="5455223" y="2526473"/>
                </a:lnTo>
                <a:lnTo>
                  <a:pt x="5456279" y="2526473"/>
                </a:lnTo>
                <a:lnTo>
                  <a:pt x="5456279" y="2576612"/>
                </a:lnTo>
                <a:lnTo>
                  <a:pt x="5465785" y="2576612"/>
                </a:lnTo>
                <a:lnTo>
                  <a:pt x="5465785" y="2576612"/>
                </a:lnTo>
                <a:lnTo>
                  <a:pt x="5494302" y="2576612"/>
                </a:lnTo>
                <a:lnTo>
                  <a:pt x="5494302" y="2576612"/>
                </a:lnTo>
                <a:lnTo>
                  <a:pt x="5506976" y="2576612"/>
                </a:lnTo>
                <a:lnTo>
                  <a:pt x="5506976" y="2576612"/>
                </a:lnTo>
                <a:lnTo>
                  <a:pt x="5553448" y="2576612"/>
                </a:lnTo>
                <a:lnTo>
                  <a:pt x="5553448" y="2576612"/>
                </a:lnTo>
                <a:lnTo>
                  <a:pt x="5575628" y="2576612"/>
                </a:lnTo>
                <a:lnTo>
                  <a:pt x="5575628" y="2576612"/>
                </a:lnTo>
                <a:lnTo>
                  <a:pt x="5578797" y="2576612"/>
                </a:lnTo>
                <a:lnTo>
                  <a:pt x="5578797" y="2576612"/>
                </a:lnTo>
                <a:lnTo>
                  <a:pt x="5614707" y="2576612"/>
                </a:lnTo>
                <a:lnTo>
                  <a:pt x="5614707" y="2627362"/>
                </a:lnTo>
                <a:lnTo>
                  <a:pt x="5619988" y="2627362"/>
                </a:lnTo>
                <a:lnTo>
                  <a:pt x="5619988" y="2627362"/>
                </a:lnTo>
                <a:lnTo>
                  <a:pt x="5621045" y="2627362"/>
                </a:lnTo>
                <a:lnTo>
                  <a:pt x="5621045" y="2627362"/>
                </a:lnTo>
                <a:lnTo>
                  <a:pt x="5629494" y="2627362"/>
                </a:lnTo>
                <a:lnTo>
                  <a:pt x="5629494" y="2627362"/>
                </a:lnTo>
                <a:lnTo>
                  <a:pt x="5642168" y="2627362"/>
                </a:lnTo>
                <a:lnTo>
                  <a:pt x="5642168" y="2678295"/>
                </a:lnTo>
                <a:lnTo>
                  <a:pt x="5647449" y="2678295"/>
                </a:lnTo>
                <a:lnTo>
                  <a:pt x="5647449" y="2730037"/>
                </a:lnTo>
                <a:lnTo>
                  <a:pt x="5651674" y="2730037"/>
                </a:lnTo>
                <a:lnTo>
                  <a:pt x="5651674" y="2730037"/>
                </a:lnTo>
                <a:lnTo>
                  <a:pt x="5656955" y="2730037"/>
                </a:lnTo>
                <a:lnTo>
                  <a:pt x="5656955" y="2730037"/>
                </a:lnTo>
                <a:lnTo>
                  <a:pt x="5661180" y="2730037"/>
                </a:lnTo>
                <a:lnTo>
                  <a:pt x="5661180" y="2730037"/>
                </a:lnTo>
                <a:lnTo>
                  <a:pt x="5662236" y="2730037"/>
                </a:lnTo>
                <a:lnTo>
                  <a:pt x="5662236" y="2730037"/>
                </a:lnTo>
                <a:lnTo>
                  <a:pt x="5669629" y="2730037"/>
                </a:lnTo>
                <a:lnTo>
                  <a:pt x="5669629" y="2782097"/>
                </a:lnTo>
                <a:lnTo>
                  <a:pt x="5682304" y="2782097"/>
                </a:lnTo>
                <a:lnTo>
                  <a:pt x="5682304" y="2782097"/>
                </a:lnTo>
                <a:lnTo>
                  <a:pt x="5688641" y="2782097"/>
                </a:lnTo>
                <a:lnTo>
                  <a:pt x="5688641" y="2782097"/>
                </a:lnTo>
                <a:lnTo>
                  <a:pt x="5706596" y="2782097"/>
                </a:lnTo>
                <a:lnTo>
                  <a:pt x="5706596" y="2782097"/>
                </a:lnTo>
                <a:lnTo>
                  <a:pt x="5730888" y="2782097"/>
                </a:lnTo>
                <a:lnTo>
                  <a:pt x="5730888" y="2834872"/>
                </a:lnTo>
                <a:lnTo>
                  <a:pt x="5742506" y="2834872"/>
                </a:lnTo>
                <a:lnTo>
                  <a:pt x="5742506" y="2887855"/>
                </a:lnTo>
                <a:lnTo>
                  <a:pt x="5745675" y="2887855"/>
                </a:lnTo>
                <a:lnTo>
                  <a:pt x="5745675" y="2887855"/>
                </a:lnTo>
                <a:lnTo>
                  <a:pt x="5767855" y="2887855"/>
                </a:lnTo>
                <a:lnTo>
                  <a:pt x="5767855" y="2887855"/>
                </a:lnTo>
                <a:lnTo>
                  <a:pt x="5769967" y="2887855"/>
                </a:lnTo>
                <a:lnTo>
                  <a:pt x="5769967" y="2887855"/>
                </a:lnTo>
                <a:lnTo>
                  <a:pt x="5783698" y="2887855"/>
                </a:lnTo>
                <a:lnTo>
                  <a:pt x="5783698" y="2941258"/>
                </a:lnTo>
                <a:lnTo>
                  <a:pt x="5787923" y="2941258"/>
                </a:lnTo>
                <a:lnTo>
                  <a:pt x="5787923" y="2941258"/>
                </a:lnTo>
                <a:lnTo>
                  <a:pt x="5793204" y="2941258"/>
                </a:lnTo>
                <a:lnTo>
                  <a:pt x="5793204" y="2994884"/>
                </a:lnTo>
                <a:lnTo>
                  <a:pt x="5814327" y="2994884"/>
                </a:lnTo>
                <a:lnTo>
                  <a:pt x="5814327" y="2994884"/>
                </a:lnTo>
                <a:lnTo>
                  <a:pt x="5823833" y="2994884"/>
                </a:lnTo>
                <a:lnTo>
                  <a:pt x="5823833" y="2994884"/>
                </a:lnTo>
                <a:lnTo>
                  <a:pt x="5825945" y="2994884"/>
                </a:lnTo>
                <a:lnTo>
                  <a:pt x="5825945" y="3048701"/>
                </a:lnTo>
                <a:lnTo>
                  <a:pt x="5830170" y="3048701"/>
                </a:lnTo>
                <a:lnTo>
                  <a:pt x="5830170" y="3048701"/>
                </a:lnTo>
                <a:lnTo>
                  <a:pt x="5873474" y="3048701"/>
                </a:lnTo>
                <a:lnTo>
                  <a:pt x="5873474" y="3048701"/>
                </a:lnTo>
                <a:lnTo>
                  <a:pt x="5887205" y="3048701"/>
                </a:lnTo>
                <a:lnTo>
                  <a:pt x="5887205" y="3048701"/>
                </a:lnTo>
                <a:lnTo>
                  <a:pt x="5904104" y="3048701"/>
                </a:lnTo>
                <a:lnTo>
                  <a:pt x="5904104" y="3048701"/>
                </a:lnTo>
                <a:lnTo>
                  <a:pt x="5942126" y="3048701"/>
                </a:lnTo>
                <a:lnTo>
                  <a:pt x="5942126" y="3048701"/>
                </a:lnTo>
                <a:lnTo>
                  <a:pt x="5945295" y="3048701"/>
                </a:lnTo>
                <a:lnTo>
                  <a:pt x="5945295" y="3048701"/>
                </a:lnTo>
                <a:lnTo>
                  <a:pt x="5947407" y="3048701"/>
                </a:lnTo>
                <a:lnTo>
                  <a:pt x="5947407" y="3103273"/>
                </a:lnTo>
                <a:lnTo>
                  <a:pt x="5951632" y="3103273"/>
                </a:lnTo>
                <a:lnTo>
                  <a:pt x="5951632" y="3103273"/>
                </a:lnTo>
                <a:lnTo>
                  <a:pt x="6013947" y="3103273"/>
                </a:lnTo>
                <a:lnTo>
                  <a:pt x="6013947" y="3103273"/>
                </a:lnTo>
                <a:lnTo>
                  <a:pt x="6018172" y="3103273"/>
                </a:lnTo>
                <a:lnTo>
                  <a:pt x="6018172" y="3103273"/>
                </a:lnTo>
                <a:lnTo>
                  <a:pt x="6037184" y="3103273"/>
                </a:lnTo>
                <a:lnTo>
                  <a:pt x="6037184" y="3103273"/>
                </a:lnTo>
                <a:lnTo>
                  <a:pt x="6047745" y="3103273"/>
                </a:lnTo>
                <a:lnTo>
                  <a:pt x="6047745" y="3103273"/>
                </a:lnTo>
                <a:lnTo>
                  <a:pt x="6049858" y="3103273"/>
                </a:lnTo>
                <a:lnTo>
                  <a:pt x="6049858" y="3103273"/>
                </a:lnTo>
                <a:lnTo>
                  <a:pt x="6062532" y="3103273"/>
                </a:lnTo>
                <a:lnTo>
                  <a:pt x="6062532" y="3103273"/>
                </a:lnTo>
                <a:lnTo>
                  <a:pt x="6064644" y="3103273"/>
                </a:lnTo>
                <a:lnTo>
                  <a:pt x="6064644" y="3159594"/>
                </a:lnTo>
                <a:lnTo>
                  <a:pt x="6084712" y="3159594"/>
                </a:lnTo>
                <a:lnTo>
                  <a:pt x="6084712" y="3216200"/>
                </a:lnTo>
                <a:lnTo>
                  <a:pt x="6092105" y="3216200"/>
                </a:lnTo>
                <a:lnTo>
                  <a:pt x="6092105" y="3216200"/>
                </a:lnTo>
                <a:lnTo>
                  <a:pt x="6106892" y="3216200"/>
                </a:lnTo>
                <a:lnTo>
                  <a:pt x="6106892" y="3216200"/>
                </a:lnTo>
                <a:lnTo>
                  <a:pt x="6114285" y="3216200"/>
                </a:lnTo>
                <a:lnTo>
                  <a:pt x="6114285" y="3216200"/>
                </a:lnTo>
                <a:lnTo>
                  <a:pt x="6117454" y="3216200"/>
                </a:lnTo>
                <a:lnTo>
                  <a:pt x="6117454" y="3272966"/>
                </a:lnTo>
                <a:lnTo>
                  <a:pt x="6120623" y="3272966"/>
                </a:lnTo>
                <a:lnTo>
                  <a:pt x="6120623" y="3272966"/>
                </a:lnTo>
                <a:lnTo>
                  <a:pt x="6132241" y="3272966"/>
                </a:lnTo>
                <a:lnTo>
                  <a:pt x="6132241" y="3329883"/>
                </a:lnTo>
                <a:lnTo>
                  <a:pt x="6157589" y="3329883"/>
                </a:lnTo>
                <a:lnTo>
                  <a:pt x="6157589" y="3329883"/>
                </a:lnTo>
                <a:lnTo>
                  <a:pt x="6163926" y="3329883"/>
                </a:lnTo>
                <a:lnTo>
                  <a:pt x="6163926" y="3387745"/>
                </a:lnTo>
                <a:lnTo>
                  <a:pt x="6170264" y="3387745"/>
                </a:lnTo>
                <a:lnTo>
                  <a:pt x="6170264" y="3387745"/>
                </a:lnTo>
                <a:lnTo>
                  <a:pt x="6185050" y="3387745"/>
                </a:lnTo>
                <a:lnTo>
                  <a:pt x="6185050" y="3387745"/>
                </a:lnTo>
                <a:lnTo>
                  <a:pt x="6197724" y="3387745"/>
                </a:lnTo>
                <a:lnTo>
                  <a:pt x="6197724" y="3387745"/>
                </a:lnTo>
                <a:lnTo>
                  <a:pt x="6198781" y="3387745"/>
                </a:lnTo>
                <a:lnTo>
                  <a:pt x="6198781" y="3446052"/>
                </a:lnTo>
                <a:lnTo>
                  <a:pt x="6201949" y="3446052"/>
                </a:lnTo>
                <a:lnTo>
                  <a:pt x="6201949" y="3446052"/>
                </a:lnTo>
                <a:lnTo>
                  <a:pt x="6213567" y="3446052"/>
                </a:lnTo>
                <a:lnTo>
                  <a:pt x="6213567" y="3446052"/>
                </a:lnTo>
                <a:lnTo>
                  <a:pt x="6216736" y="3446052"/>
                </a:lnTo>
                <a:lnTo>
                  <a:pt x="6216736" y="3504849"/>
                </a:lnTo>
                <a:lnTo>
                  <a:pt x="6217792" y="3504849"/>
                </a:lnTo>
                <a:lnTo>
                  <a:pt x="6217792" y="3563800"/>
                </a:lnTo>
                <a:lnTo>
                  <a:pt x="6220961" y="3563800"/>
                </a:lnTo>
                <a:lnTo>
                  <a:pt x="6220961" y="3563800"/>
                </a:lnTo>
                <a:lnTo>
                  <a:pt x="6223073" y="3563800"/>
                </a:lnTo>
                <a:lnTo>
                  <a:pt x="6223073" y="3563800"/>
                </a:lnTo>
                <a:lnTo>
                  <a:pt x="6227298" y="3563800"/>
                </a:lnTo>
                <a:lnTo>
                  <a:pt x="6227298" y="3623057"/>
                </a:lnTo>
                <a:lnTo>
                  <a:pt x="6233635" y="3623057"/>
                </a:lnTo>
                <a:lnTo>
                  <a:pt x="6233635" y="3682336"/>
                </a:lnTo>
                <a:lnTo>
                  <a:pt x="6236804" y="3682336"/>
                </a:lnTo>
                <a:lnTo>
                  <a:pt x="6236804" y="3742207"/>
                </a:lnTo>
                <a:lnTo>
                  <a:pt x="6245253" y="3742207"/>
                </a:lnTo>
                <a:lnTo>
                  <a:pt x="6245253" y="3742207"/>
                </a:lnTo>
                <a:lnTo>
                  <a:pt x="6264264" y="3742207"/>
                </a:lnTo>
                <a:lnTo>
                  <a:pt x="6264264" y="3802209"/>
                </a:lnTo>
                <a:lnTo>
                  <a:pt x="6265321" y="3802209"/>
                </a:lnTo>
                <a:lnTo>
                  <a:pt x="6265321" y="3802209"/>
                </a:lnTo>
                <a:lnTo>
                  <a:pt x="6266377" y="3802209"/>
                </a:lnTo>
                <a:lnTo>
                  <a:pt x="6266377" y="3862801"/>
                </a:lnTo>
                <a:lnTo>
                  <a:pt x="6291725" y="3862801"/>
                </a:lnTo>
                <a:lnTo>
                  <a:pt x="6291725" y="3923461"/>
                </a:lnTo>
                <a:lnTo>
                  <a:pt x="6293838" y="3923461"/>
                </a:lnTo>
                <a:lnTo>
                  <a:pt x="6293838" y="3923461"/>
                </a:lnTo>
                <a:lnTo>
                  <a:pt x="6337142" y="3923461"/>
                </a:lnTo>
                <a:lnTo>
                  <a:pt x="6337142" y="3923461"/>
                </a:lnTo>
                <a:lnTo>
                  <a:pt x="6355097" y="3923461"/>
                </a:lnTo>
                <a:lnTo>
                  <a:pt x="6355097" y="3923461"/>
                </a:lnTo>
                <a:lnTo>
                  <a:pt x="6381502" y="3923461"/>
                </a:lnTo>
                <a:lnTo>
                  <a:pt x="6381502" y="3923461"/>
                </a:lnTo>
                <a:lnTo>
                  <a:pt x="6412131" y="3923461"/>
                </a:lnTo>
                <a:lnTo>
                  <a:pt x="6412131" y="3923461"/>
                </a:lnTo>
                <a:lnTo>
                  <a:pt x="6421637" y="3923461"/>
                </a:lnTo>
                <a:lnTo>
                  <a:pt x="6421637" y="3923461"/>
                </a:lnTo>
                <a:lnTo>
                  <a:pt x="6438536" y="3923461"/>
                </a:lnTo>
                <a:lnTo>
                  <a:pt x="6438536" y="3923461"/>
                </a:lnTo>
                <a:lnTo>
                  <a:pt x="6457547" y="3923461"/>
                </a:lnTo>
                <a:lnTo>
                  <a:pt x="6457547" y="3923461"/>
                </a:lnTo>
                <a:lnTo>
                  <a:pt x="6458603" y="3923461"/>
                </a:lnTo>
                <a:lnTo>
                  <a:pt x="6458603" y="3985495"/>
                </a:lnTo>
                <a:lnTo>
                  <a:pt x="6460716" y="3985495"/>
                </a:lnTo>
                <a:lnTo>
                  <a:pt x="6460716" y="4047700"/>
                </a:lnTo>
                <a:lnTo>
                  <a:pt x="6462828" y="4047700"/>
                </a:lnTo>
                <a:lnTo>
                  <a:pt x="6462828" y="4047700"/>
                </a:lnTo>
                <a:lnTo>
                  <a:pt x="6464941" y="4047700"/>
                </a:lnTo>
                <a:lnTo>
                  <a:pt x="6464941" y="4047700"/>
                </a:lnTo>
                <a:lnTo>
                  <a:pt x="6472334" y="4047700"/>
                </a:lnTo>
                <a:lnTo>
                  <a:pt x="6472334" y="4110402"/>
                </a:lnTo>
                <a:lnTo>
                  <a:pt x="6512469" y="4110402"/>
                </a:lnTo>
                <a:lnTo>
                  <a:pt x="6512469" y="4173248"/>
                </a:lnTo>
                <a:lnTo>
                  <a:pt x="6515638" y="4173248"/>
                </a:lnTo>
                <a:lnTo>
                  <a:pt x="6515638" y="4236381"/>
                </a:lnTo>
                <a:lnTo>
                  <a:pt x="6525143" y="4236381"/>
                </a:lnTo>
                <a:lnTo>
                  <a:pt x="6525143" y="4236381"/>
                </a:lnTo>
                <a:lnTo>
                  <a:pt x="6548380" y="4236381"/>
                </a:lnTo>
                <a:lnTo>
                  <a:pt x="6548380" y="4299917"/>
                </a:lnTo>
                <a:lnTo>
                  <a:pt x="6550492" y="4299917"/>
                </a:lnTo>
                <a:lnTo>
                  <a:pt x="6550492" y="4299917"/>
                </a:lnTo>
                <a:lnTo>
                  <a:pt x="6554717" y="4299917"/>
                </a:lnTo>
                <a:lnTo>
                  <a:pt x="6554717" y="4299917"/>
                </a:lnTo>
                <a:lnTo>
                  <a:pt x="6555773" y="4299917"/>
                </a:lnTo>
                <a:lnTo>
                  <a:pt x="6555773" y="4364061"/>
                </a:lnTo>
                <a:lnTo>
                  <a:pt x="6558942" y="4364061"/>
                </a:lnTo>
                <a:lnTo>
                  <a:pt x="6558942" y="4364061"/>
                </a:lnTo>
                <a:lnTo>
                  <a:pt x="6577953" y="4364061"/>
                </a:lnTo>
                <a:lnTo>
                  <a:pt x="6577953" y="4428296"/>
                </a:lnTo>
                <a:lnTo>
                  <a:pt x="6585346" y="4428296"/>
                </a:lnTo>
                <a:lnTo>
                  <a:pt x="6585346" y="4492731"/>
                </a:lnTo>
                <a:lnTo>
                  <a:pt x="6611751" y="4492731"/>
                </a:lnTo>
                <a:lnTo>
                  <a:pt x="6611751" y="4492731"/>
                </a:lnTo>
                <a:lnTo>
                  <a:pt x="6617032" y="4492731"/>
                </a:lnTo>
                <a:lnTo>
                  <a:pt x="6617032" y="4557387"/>
                </a:lnTo>
                <a:lnTo>
                  <a:pt x="6625482" y="4557387"/>
                </a:lnTo>
                <a:lnTo>
                  <a:pt x="6625482" y="4622155"/>
                </a:lnTo>
                <a:lnTo>
                  <a:pt x="6637100" y="4622155"/>
                </a:lnTo>
                <a:lnTo>
                  <a:pt x="6637100" y="4687086"/>
                </a:lnTo>
                <a:lnTo>
                  <a:pt x="6653999" y="4687086"/>
                </a:lnTo>
                <a:lnTo>
                  <a:pt x="6653999" y="4687086"/>
                </a:lnTo>
                <a:lnTo>
                  <a:pt x="6658223" y="4687086"/>
                </a:lnTo>
                <a:lnTo>
                  <a:pt x="6658223" y="4752438"/>
                </a:lnTo>
                <a:lnTo>
                  <a:pt x="6684628" y="4752438"/>
                </a:lnTo>
                <a:lnTo>
                  <a:pt x="6684628" y="4752438"/>
                </a:lnTo>
                <a:lnTo>
                  <a:pt x="6687797" y="4752438"/>
                </a:lnTo>
                <a:lnTo>
                  <a:pt x="6687797" y="4752438"/>
                </a:lnTo>
                <a:lnTo>
                  <a:pt x="6697303" y="4752438"/>
                </a:lnTo>
                <a:lnTo>
                  <a:pt x="6697303" y="4752438"/>
                </a:lnTo>
                <a:lnTo>
                  <a:pt x="6704696" y="4752438"/>
                </a:lnTo>
                <a:lnTo>
                  <a:pt x="6704696" y="4752438"/>
                </a:lnTo>
                <a:lnTo>
                  <a:pt x="6705752" y="4752438"/>
                </a:lnTo>
                <a:lnTo>
                  <a:pt x="6705752" y="4752438"/>
                </a:lnTo>
                <a:lnTo>
                  <a:pt x="6713145" y="4752438"/>
                </a:lnTo>
                <a:lnTo>
                  <a:pt x="6713145" y="4819135"/>
                </a:lnTo>
                <a:lnTo>
                  <a:pt x="6722651" y="4819135"/>
                </a:lnTo>
                <a:lnTo>
                  <a:pt x="6722651" y="4819135"/>
                </a:lnTo>
                <a:lnTo>
                  <a:pt x="6730044" y="4819135"/>
                </a:lnTo>
                <a:lnTo>
                  <a:pt x="6730044" y="4819135"/>
                </a:lnTo>
                <a:lnTo>
                  <a:pt x="6744831" y="4819135"/>
                </a:lnTo>
                <a:lnTo>
                  <a:pt x="6744831" y="4819135"/>
                </a:lnTo>
                <a:lnTo>
                  <a:pt x="6757505" y="4819135"/>
                </a:lnTo>
                <a:lnTo>
                  <a:pt x="6757505" y="4819135"/>
                </a:lnTo>
                <a:lnTo>
                  <a:pt x="6768067" y="4819135"/>
                </a:lnTo>
                <a:lnTo>
                  <a:pt x="6768067" y="4819135"/>
                </a:lnTo>
                <a:lnTo>
                  <a:pt x="6774404" y="4819135"/>
                </a:lnTo>
                <a:lnTo>
                  <a:pt x="6774404" y="4819135"/>
                </a:lnTo>
                <a:lnTo>
                  <a:pt x="6787079" y="4819135"/>
                </a:lnTo>
                <a:lnTo>
                  <a:pt x="6787079" y="4887085"/>
                </a:lnTo>
                <a:lnTo>
                  <a:pt x="6792360" y="4887085"/>
                </a:lnTo>
                <a:lnTo>
                  <a:pt x="6792360" y="4887085"/>
                </a:lnTo>
                <a:lnTo>
                  <a:pt x="6803978" y="4887085"/>
                </a:lnTo>
                <a:lnTo>
                  <a:pt x="6803978" y="4887085"/>
                </a:lnTo>
                <a:lnTo>
                  <a:pt x="6806090" y="4887085"/>
                </a:lnTo>
                <a:lnTo>
                  <a:pt x="6806090" y="4887085"/>
                </a:lnTo>
                <a:lnTo>
                  <a:pt x="6809259" y="4887085"/>
                </a:lnTo>
                <a:lnTo>
                  <a:pt x="6809259" y="4955542"/>
                </a:lnTo>
                <a:lnTo>
                  <a:pt x="6815596" y="4955542"/>
                </a:lnTo>
                <a:lnTo>
                  <a:pt x="6815596" y="4955542"/>
                </a:lnTo>
                <a:lnTo>
                  <a:pt x="6819821" y="4955542"/>
                </a:lnTo>
                <a:lnTo>
                  <a:pt x="6819821" y="4955542"/>
                </a:lnTo>
                <a:lnTo>
                  <a:pt x="6829326" y="4955542"/>
                </a:lnTo>
                <a:lnTo>
                  <a:pt x="6829326" y="4955542"/>
                </a:lnTo>
                <a:lnTo>
                  <a:pt x="6840944" y="4955542"/>
                </a:lnTo>
                <a:lnTo>
                  <a:pt x="6840944" y="4955542"/>
                </a:lnTo>
                <a:lnTo>
                  <a:pt x="6845169" y="4955542"/>
                </a:lnTo>
                <a:lnTo>
                  <a:pt x="6845169" y="4955542"/>
                </a:lnTo>
                <a:lnTo>
                  <a:pt x="6851506" y="4955542"/>
                </a:lnTo>
                <a:lnTo>
                  <a:pt x="6851506" y="4955542"/>
                </a:lnTo>
                <a:lnTo>
                  <a:pt x="6854675" y="4955542"/>
                </a:lnTo>
                <a:lnTo>
                  <a:pt x="6854675" y="4955542"/>
                </a:lnTo>
                <a:lnTo>
                  <a:pt x="6857843" y="4955542"/>
                </a:lnTo>
                <a:lnTo>
                  <a:pt x="6857843" y="4955542"/>
                </a:lnTo>
                <a:lnTo>
                  <a:pt x="6859956" y="4955542"/>
                </a:lnTo>
                <a:lnTo>
                  <a:pt x="6859956" y="4955542"/>
                </a:lnTo>
                <a:lnTo>
                  <a:pt x="6869462" y="4955542"/>
                </a:lnTo>
                <a:lnTo>
                  <a:pt x="6869462" y="4955542"/>
                </a:lnTo>
                <a:lnTo>
                  <a:pt x="6874742" y="4955542"/>
                </a:lnTo>
                <a:lnTo>
                  <a:pt x="6874742" y="4955542"/>
                </a:lnTo>
                <a:lnTo>
                  <a:pt x="6875799" y="4955542"/>
                </a:lnTo>
                <a:lnTo>
                  <a:pt x="6875799" y="4955542"/>
                </a:lnTo>
                <a:lnTo>
                  <a:pt x="6876855" y="4955542"/>
                </a:lnTo>
                <a:lnTo>
                  <a:pt x="6876855" y="4955542"/>
                </a:lnTo>
                <a:lnTo>
                  <a:pt x="6882136" y="4955542"/>
                </a:lnTo>
                <a:lnTo>
                  <a:pt x="6882136" y="4955542"/>
                </a:lnTo>
                <a:lnTo>
                  <a:pt x="6886361" y="4955542"/>
                </a:lnTo>
                <a:lnTo>
                  <a:pt x="6886361" y="5061811"/>
                </a:lnTo>
                <a:lnTo>
                  <a:pt x="6895866" y="5061811"/>
                </a:lnTo>
                <a:lnTo>
                  <a:pt x="6895866" y="5061811"/>
                </a:lnTo>
                <a:lnTo>
                  <a:pt x="6896922" y="5061811"/>
                </a:lnTo>
                <a:lnTo>
                  <a:pt x="6896922" y="5061811"/>
                </a:lnTo>
                <a:lnTo>
                  <a:pt x="6897979" y="5061811"/>
                </a:lnTo>
                <a:lnTo>
                  <a:pt x="6897979" y="5061811"/>
                </a:lnTo>
                <a:lnTo>
                  <a:pt x="6900091" y="5061811"/>
                </a:lnTo>
                <a:lnTo>
                  <a:pt x="6900091" y="5061811"/>
                </a:lnTo>
                <a:lnTo>
                  <a:pt x="6905372" y="5061811"/>
                </a:lnTo>
                <a:lnTo>
                  <a:pt x="6905372" y="5061811"/>
                </a:lnTo>
                <a:lnTo>
                  <a:pt x="6914878" y="5061811"/>
                </a:lnTo>
                <a:lnTo>
                  <a:pt x="6914878" y="5213316"/>
                </a:lnTo>
                <a:lnTo>
                  <a:pt x="6924383" y="5213316"/>
                </a:lnTo>
                <a:lnTo>
                  <a:pt x="6924383" y="5213316"/>
                </a:lnTo>
                <a:lnTo>
                  <a:pt x="6926496" y="5213316"/>
                </a:lnTo>
                <a:lnTo>
                  <a:pt x="6926496" y="5213316"/>
                </a:lnTo>
                <a:lnTo>
                  <a:pt x="6927552" y="5213316"/>
                </a:lnTo>
                <a:lnTo>
                  <a:pt x="6927552" y="5213316"/>
                </a:lnTo>
                <a:lnTo>
                  <a:pt x="6946563" y="5213316"/>
                </a:lnTo>
                <a:lnTo>
                  <a:pt x="6946563" y="5213316"/>
                </a:lnTo>
                <a:lnTo>
                  <a:pt x="6947620" y="5213316"/>
                </a:lnTo>
                <a:lnTo>
                  <a:pt x="6947620" y="5213316"/>
                </a:lnTo>
                <a:lnTo>
                  <a:pt x="6949732" y="5213316"/>
                </a:lnTo>
                <a:lnTo>
                  <a:pt x="6949732" y="5213316"/>
                </a:lnTo>
                <a:lnTo>
                  <a:pt x="6956069" y="5213316"/>
                </a:lnTo>
                <a:lnTo>
                  <a:pt x="6956069" y="5213316"/>
                </a:lnTo>
                <a:lnTo>
                  <a:pt x="6963462" y="5213316"/>
                </a:lnTo>
                <a:lnTo>
                  <a:pt x="6963462" y="5213316"/>
                </a:lnTo>
                <a:lnTo>
                  <a:pt x="6964519" y="5213316"/>
                </a:lnTo>
                <a:lnTo>
                  <a:pt x="6964519" y="5213316"/>
                </a:lnTo>
                <a:lnTo>
                  <a:pt x="6970856" y="5213316"/>
                </a:lnTo>
                <a:lnTo>
                  <a:pt x="6970856" y="5213316"/>
                </a:lnTo>
              </a:path>
            </a:pathLst>
          </a:custGeom>
          <a:ln w="21681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44" name="pl16">
            <a:extLst>
              <a:ext uri="{FF2B5EF4-FFF2-40B4-BE49-F238E27FC236}">
                <a16:creationId xmlns:a16="http://schemas.microsoft.com/office/drawing/2014/main" id="{511A0D2D-1A45-6944-C2D4-1B7FB139DB0D}"/>
              </a:ext>
            </a:extLst>
          </p:cNvPr>
          <p:cNvSpPr/>
          <p:nvPr/>
        </p:nvSpPr>
        <p:spPr>
          <a:xfrm>
            <a:off x="3990763" y="1732597"/>
            <a:ext cx="4601254" cy="1369798"/>
          </a:xfrm>
          <a:custGeom>
            <a:avLst/>
            <a:gdLst/>
            <a:ahLst/>
            <a:cxnLst/>
            <a:rect l="0" t="0" r="0" b="0"/>
            <a:pathLst>
              <a:path w="6970856" h="2342766">
                <a:moveTo>
                  <a:pt x="0" y="0"/>
                </a:moveTo>
                <a:lnTo>
                  <a:pt x="164765" y="0"/>
                </a:lnTo>
                <a:lnTo>
                  <a:pt x="164765" y="0"/>
                </a:lnTo>
                <a:lnTo>
                  <a:pt x="196451" y="0"/>
                </a:lnTo>
                <a:lnTo>
                  <a:pt x="196451" y="0"/>
                </a:lnTo>
                <a:lnTo>
                  <a:pt x="252429" y="0"/>
                </a:lnTo>
                <a:lnTo>
                  <a:pt x="252429" y="11107"/>
                </a:lnTo>
                <a:lnTo>
                  <a:pt x="269328" y="11107"/>
                </a:lnTo>
                <a:lnTo>
                  <a:pt x="269328" y="22246"/>
                </a:lnTo>
                <a:lnTo>
                  <a:pt x="305239" y="22246"/>
                </a:lnTo>
                <a:lnTo>
                  <a:pt x="305239" y="22246"/>
                </a:lnTo>
                <a:lnTo>
                  <a:pt x="330587" y="22246"/>
                </a:lnTo>
                <a:lnTo>
                  <a:pt x="330587" y="22246"/>
                </a:lnTo>
                <a:lnTo>
                  <a:pt x="359104" y="22246"/>
                </a:lnTo>
                <a:lnTo>
                  <a:pt x="359104" y="22246"/>
                </a:lnTo>
                <a:lnTo>
                  <a:pt x="415082" y="22246"/>
                </a:lnTo>
                <a:lnTo>
                  <a:pt x="415082" y="22246"/>
                </a:lnTo>
                <a:lnTo>
                  <a:pt x="486903" y="22246"/>
                </a:lnTo>
                <a:lnTo>
                  <a:pt x="486903" y="22246"/>
                </a:lnTo>
                <a:lnTo>
                  <a:pt x="529151" y="22246"/>
                </a:lnTo>
                <a:lnTo>
                  <a:pt x="529151" y="33493"/>
                </a:lnTo>
                <a:lnTo>
                  <a:pt x="753063" y="33493"/>
                </a:lnTo>
                <a:lnTo>
                  <a:pt x="753063" y="44927"/>
                </a:lnTo>
                <a:lnTo>
                  <a:pt x="762569" y="44927"/>
                </a:lnTo>
                <a:lnTo>
                  <a:pt x="762569" y="44927"/>
                </a:lnTo>
                <a:lnTo>
                  <a:pt x="777356" y="44927"/>
                </a:lnTo>
                <a:lnTo>
                  <a:pt x="777356" y="44927"/>
                </a:lnTo>
                <a:lnTo>
                  <a:pt x="787918" y="44927"/>
                </a:lnTo>
                <a:lnTo>
                  <a:pt x="787918" y="44927"/>
                </a:lnTo>
                <a:lnTo>
                  <a:pt x="810097" y="44927"/>
                </a:lnTo>
                <a:lnTo>
                  <a:pt x="810097" y="44927"/>
                </a:lnTo>
                <a:lnTo>
                  <a:pt x="822772" y="44927"/>
                </a:lnTo>
                <a:lnTo>
                  <a:pt x="822772" y="44927"/>
                </a:lnTo>
                <a:lnTo>
                  <a:pt x="887199" y="44927"/>
                </a:lnTo>
                <a:lnTo>
                  <a:pt x="887199" y="56452"/>
                </a:lnTo>
                <a:lnTo>
                  <a:pt x="928391" y="56452"/>
                </a:lnTo>
                <a:lnTo>
                  <a:pt x="928391" y="56452"/>
                </a:lnTo>
                <a:lnTo>
                  <a:pt x="972751" y="56452"/>
                </a:lnTo>
                <a:lnTo>
                  <a:pt x="972751" y="56452"/>
                </a:lnTo>
                <a:lnTo>
                  <a:pt x="1051965" y="56452"/>
                </a:lnTo>
                <a:lnTo>
                  <a:pt x="1051965" y="56452"/>
                </a:lnTo>
                <a:lnTo>
                  <a:pt x="1097381" y="56452"/>
                </a:lnTo>
                <a:lnTo>
                  <a:pt x="1097381" y="56452"/>
                </a:lnTo>
                <a:lnTo>
                  <a:pt x="1112168" y="56452"/>
                </a:lnTo>
                <a:lnTo>
                  <a:pt x="1112168" y="56452"/>
                </a:lnTo>
                <a:lnTo>
                  <a:pt x="1125898" y="56452"/>
                </a:lnTo>
                <a:lnTo>
                  <a:pt x="1125898" y="68082"/>
                </a:lnTo>
                <a:lnTo>
                  <a:pt x="1182933" y="68082"/>
                </a:lnTo>
                <a:lnTo>
                  <a:pt x="1182933" y="68082"/>
                </a:lnTo>
                <a:lnTo>
                  <a:pt x="1200888" y="68082"/>
                </a:lnTo>
                <a:lnTo>
                  <a:pt x="1200888" y="79761"/>
                </a:lnTo>
                <a:lnTo>
                  <a:pt x="1215675" y="79761"/>
                </a:lnTo>
                <a:lnTo>
                  <a:pt x="1215675" y="79761"/>
                </a:lnTo>
                <a:lnTo>
                  <a:pt x="1277990" y="79761"/>
                </a:lnTo>
                <a:lnTo>
                  <a:pt x="1277990" y="79761"/>
                </a:lnTo>
                <a:lnTo>
                  <a:pt x="1279046" y="79761"/>
                </a:lnTo>
                <a:lnTo>
                  <a:pt x="1279046" y="79761"/>
                </a:lnTo>
                <a:lnTo>
                  <a:pt x="1347698" y="79761"/>
                </a:lnTo>
                <a:lnTo>
                  <a:pt x="1347698" y="79761"/>
                </a:lnTo>
                <a:lnTo>
                  <a:pt x="1358260" y="79761"/>
                </a:lnTo>
                <a:lnTo>
                  <a:pt x="1358260" y="79761"/>
                </a:lnTo>
                <a:lnTo>
                  <a:pt x="1371991" y="79761"/>
                </a:lnTo>
                <a:lnTo>
                  <a:pt x="1371991" y="79761"/>
                </a:lnTo>
                <a:lnTo>
                  <a:pt x="1374103" y="79761"/>
                </a:lnTo>
                <a:lnTo>
                  <a:pt x="1374103" y="79761"/>
                </a:lnTo>
                <a:lnTo>
                  <a:pt x="1412126" y="79761"/>
                </a:lnTo>
                <a:lnTo>
                  <a:pt x="1412126" y="79761"/>
                </a:lnTo>
                <a:lnTo>
                  <a:pt x="1436418" y="79761"/>
                </a:lnTo>
                <a:lnTo>
                  <a:pt x="1436418" y="79761"/>
                </a:lnTo>
                <a:lnTo>
                  <a:pt x="1453317" y="79761"/>
                </a:lnTo>
                <a:lnTo>
                  <a:pt x="1453317" y="91631"/>
                </a:lnTo>
                <a:lnTo>
                  <a:pt x="1475497" y="91631"/>
                </a:lnTo>
                <a:lnTo>
                  <a:pt x="1475497" y="91631"/>
                </a:lnTo>
                <a:lnTo>
                  <a:pt x="1481835" y="91631"/>
                </a:lnTo>
                <a:lnTo>
                  <a:pt x="1481835" y="91631"/>
                </a:lnTo>
                <a:lnTo>
                  <a:pt x="1527251" y="91631"/>
                </a:lnTo>
                <a:lnTo>
                  <a:pt x="1527251" y="91631"/>
                </a:lnTo>
                <a:lnTo>
                  <a:pt x="1551543" y="91631"/>
                </a:lnTo>
                <a:lnTo>
                  <a:pt x="1551543" y="91631"/>
                </a:lnTo>
                <a:lnTo>
                  <a:pt x="1610690" y="91631"/>
                </a:lnTo>
                <a:lnTo>
                  <a:pt x="1610690" y="91631"/>
                </a:lnTo>
                <a:lnTo>
                  <a:pt x="1668780" y="91631"/>
                </a:lnTo>
                <a:lnTo>
                  <a:pt x="1668780" y="103625"/>
                </a:lnTo>
                <a:lnTo>
                  <a:pt x="1676174" y="103625"/>
                </a:lnTo>
                <a:lnTo>
                  <a:pt x="1676174" y="103625"/>
                </a:lnTo>
                <a:lnTo>
                  <a:pt x="1695185" y="103625"/>
                </a:lnTo>
                <a:lnTo>
                  <a:pt x="1695185" y="103625"/>
                </a:lnTo>
                <a:lnTo>
                  <a:pt x="1703635" y="103625"/>
                </a:lnTo>
                <a:lnTo>
                  <a:pt x="1703635" y="103625"/>
                </a:lnTo>
                <a:lnTo>
                  <a:pt x="1722646" y="103625"/>
                </a:lnTo>
                <a:lnTo>
                  <a:pt x="1722646" y="103625"/>
                </a:lnTo>
                <a:lnTo>
                  <a:pt x="1745882" y="103625"/>
                </a:lnTo>
                <a:lnTo>
                  <a:pt x="1745882" y="115685"/>
                </a:lnTo>
                <a:lnTo>
                  <a:pt x="1779680" y="115685"/>
                </a:lnTo>
                <a:lnTo>
                  <a:pt x="1779680" y="115685"/>
                </a:lnTo>
                <a:lnTo>
                  <a:pt x="1797635" y="115685"/>
                </a:lnTo>
                <a:lnTo>
                  <a:pt x="1797635" y="115685"/>
                </a:lnTo>
                <a:lnTo>
                  <a:pt x="1799748" y="115685"/>
                </a:lnTo>
                <a:lnTo>
                  <a:pt x="1799748" y="127768"/>
                </a:lnTo>
                <a:lnTo>
                  <a:pt x="1829321" y="127768"/>
                </a:lnTo>
                <a:lnTo>
                  <a:pt x="1829321" y="127768"/>
                </a:lnTo>
                <a:lnTo>
                  <a:pt x="1841995" y="127768"/>
                </a:lnTo>
                <a:lnTo>
                  <a:pt x="1841995" y="127768"/>
                </a:lnTo>
                <a:lnTo>
                  <a:pt x="1866288" y="127768"/>
                </a:lnTo>
                <a:lnTo>
                  <a:pt x="1866288" y="139943"/>
                </a:lnTo>
                <a:lnTo>
                  <a:pt x="1915929" y="139943"/>
                </a:lnTo>
                <a:lnTo>
                  <a:pt x="1915929" y="139943"/>
                </a:lnTo>
                <a:lnTo>
                  <a:pt x="1945502" y="139943"/>
                </a:lnTo>
                <a:lnTo>
                  <a:pt x="1945502" y="139943"/>
                </a:lnTo>
                <a:lnTo>
                  <a:pt x="2046896" y="139943"/>
                </a:lnTo>
                <a:lnTo>
                  <a:pt x="2046896" y="139943"/>
                </a:lnTo>
                <a:lnTo>
                  <a:pt x="2047953" y="139943"/>
                </a:lnTo>
                <a:lnTo>
                  <a:pt x="2047953" y="139943"/>
                </a:lnTo>
                <a:lnTo>
                  <a:pt x="2055346" y="139943"/>
                </a:lnTo>
                <a:lnTo>
                  <a:pt x="2055346" y="139943"/>
                </a:lnTo>
                <a:lnTo>
                  <a:pt x="2082807" y="139943"/>
                </a:lnTo>
                <a:lnTo>
                  <a:pt x="2082807" y="139943"/>
                </a:lnTo>
                <a:lnTo>
                  <a:pt x="2100762" y="139943"/>
                </a:lnTo>
                <a:lnTo>
                  <a:pt x="2100762" y="139943"/>
                </a:lnTo>
                <a:lnTo>
                  <a:pt x="2111324" y="139943"/>
                </a:lnTo>
                <a:lnTo>
                  <a:pt x="2111324" y="139943"/>
                </a:lnTo>
                <a:lnTo>
                  <a:pt x="2122942" y="139943"/>
                </a:lnTo>
                <a:lnTo>
                  <a:pt x="2122942" y="139943"/>
                </a:lnTo>
                <a:lnTo>
                  <a:pt x="2130335" y="139943"/>
                </a:lnTo>
                <a:lnTo>
                  <a:pt x="2130335" y="139943"/>
                </a:lnTo>
                <a:lnTo>
                  <a:pt x="2134560" y="139943"/>
                </a:lnTo>
                <a:lnTo>
                  <a:pt x="2134560" y="139943"/>
                </a:lnTo>
                <a:lnTo>
                  <a:pt x="2148291" y="139943"/>
                </a:lnTo>
                <a:lnTo>
                  <a:pt x="2148291" y="139943"/>
                </a:lnTo>
                <a:lnTo>
                  <a:pt x="2188426" y="139943"/>
                </a:lnTo>
                <a:lnTo>
                  <a:pt x="2188426" y="139943"/>
                </a:lnTo>
                <a:lnTo>
                  <a:pt x="2192651" y="139943"/>
                </a:lnTo>
                <a:lnTo>
                  <a:pt x="2192651" y="152578"/>
                </a:lnTo>
                <a:lnTo>
                  <a:pt x="2224336" y="152578"/>
                </a:lnTo>
                <a:lnTo>
                  <a:pt x="2224336" y="152578"/>
                </a:lnTo>
                <a:lnTo>
                  <a:pt x="2228561" y="152578"/>
                </a:lnTo>
                <a:lnTo>
                  <a:pt x="2228561" y="152578"/>
                </a:lnTo>
                <a:lnTo>
                  <a:pt x="2343686" y="152578"/>
                </a:lnTo>
                <a:lnTo>
                  <a:pt x="2343686" y="165332"/>
                </a:lnTo>
                <a:lnTo>
                  <a:pt x="2360585" y="165332"/>
                </a:lnTo>
                <a:lnTo>
                  <a:pt x="2360585" y="178098"/>
                </a:lnTo>
                <a:lnTo>
                  <a:pt x="2393327" y="178098"/>
                </a:lnTo>
                <a:lnTo>
                  <a:pt x="2393327" y="178098"/>
                </a:lnTo>
                <a:lnTo>
                  <a:pt x="2428181" y="178098"/>
                </a:lnTo>
                <a:lnTo>
                  <a:pt x="2428181" y="178098"/>
                </a:lnTo>
                <a:lnTo>
                  <a:pt x="2455642" y="178098"/>
                </a:lnTo>
                <a:lnTo>
                  <a:pt x="2455642" y="178098"/>
                </a:lnTo>
                <a:lnTo>
                  <a:pt x="2467260" y="178098"/>
                </a:lnTo>
                <a:lnTo>
                  <a:pt x="2467260" y="178098"/>
                </a:lnTo>
                <a:lnTo>
                  <a:pt x="2500002" y="178098"/>
                </a:lnTo>
                <a:lnTo>
                  <a:pt x="2500002" y="178098"/>
                </a:lnTo>
                <a:lnTo>
                  <a:pt x="2545418" y="178098"/>
                </a:lnTo>
                <a:lnTo>
                  <a:pt x="2545418" y="191558"/>
                </a:lnTo>
                <a:lnTo>
                  <a:pt x="2557036" y="191558"/>
                </a:lnTo>
                <a:lnTo>
                  <a:pt x="2557036" y="191558"/>
                </a:lnTo>
                <a:lnTo>
                  <a:pt x="2709128" y="191558"/>
                </a:lnTo>
                <a:lnTo>
                  <a:pt x="2709128" y="205223"/>
                </a:lnTo>
                <a:lnTo>
                  <a:pt x="2726027" y="205223"/>
                </a:lnTo>
                <a:lnTo>
                  <a:pt x="2726027" y="205223"/>
                </a:lnTo>
                <a:lnTo>
                  <a:pt x="2735533" y="205223"/>
                </a:lnTo>
                <a:lnTo>
                  <a:pt x="2735533" y="205223"/>
                </a:lnTo>
                <a:lnTo>
                  <a:pt x="2742926" y="205223"/>
                </a:lnTo>
                <a:lnTo>
                  <a:pt x="2742926" y="218945"/>
                </a:lnTo>
                <a:lnTo>
                  <a:pt x="2780949" y="218945"/>
                </a:lnTo>
                <a:lnTo>
                  <a:pt x="2780949" y="218945"/>
                </a:lnTo>
                <a:lnTo>
                  <a:pt x="2786230" y="218945"/>
                </a:lnTo>
                <a:lnTo>
                  <a:pt x="2786230" y="232705"/>
                </a:lnTo>
                <a:lnTo>
                  <a:pt x="2795735" y="232705"/>
                </a:lnTo>
                <a:lnTo>
                  <a:pt x="2795735" y="232705"/>
                </a:lnTo>
                <a:lnTo>
                  <a:pt x="2797848" y="232705"/>
                </a:lnTo>
                <a:lnTo>
                  <a:pt x="2797848" y="232705"/>
                </a:lnTo>
                <a:lnTo>
                  <a:pt x="2826365" y="232705"/>
                </a:lnTo>
                <a:lnTo>
                  <a:pt x="2826365" y="246542"/>
                </a:lnTo>
                <a:lnTo>
                  <a:pt x="2846432" y="246542"/>
                </a:lnTo>
                <a:lnTo>
                  <a:pt x="2846432" y="246542"/>
                </a:lnTo>
                <a:lnTo>
                  <a:pt x="2868612" y="246542"/>
                </a:lnTo>
                <a:lnTo>
                  <a:pt x="2868612" y="246542"/>
                </a:lnTo>
                <a:lnTo>
                  <a:pt x="2874950" y="246542"/>
                </a:lnTo>
                <a:lnTo>
                  <a:pt x="2874950" y="246542"/>
                </a:lnTo>
                <a:lnTo>
                  <a:pt x="2955220" y="246542"/>
                </a:lnTo>
                <a:lnTo>
                  <a:pt x="2955220" y="246542"/>
                </a:lnTo>
                <a:lnTo>
                  <a:pt x="2993243" y="246542"/>
                </a:lnTo>
                <a:lnTo>
                  <a:pt x="2993243" y="246542"/>
                </a:lnTo>
                <a:lnTo>
                  <a:pt x="2994299" y="246542"/>
                </a:lnTo>
                <a:lnTo>
                  <a:pt x="2994299" y="246542"/>
                </a:lnTo>
                <a:lnTo>
                  <a:pt x="2999580" y="246542"/>
                </a:lnTo>
                <a:lnTo>
                  <a:pt x="2999580" y="246542"/>
                </a:lnTo>
                <a:lnTo>
                  <a:pt x="3019648" y="246542"/>
                </a:lnTo>
                <a:lnTo>
                  <a:pt x="3019648" y="246542"/>
                </a:lnTo>
                <a:lnTo>
                  <a:pt x="3073513" y="246542"/>
                </a:lnTo>
                <a:lnTo>
                  <a:pt x="3073513" y="246542"/>
                </a:lnTo>
                <a:lnTo>
                  <a:pt x="3089356" y="246542"/>
                </a:lnTo>
                <a:lnTo>
                  <a:pt x="3089356" y="246542"/>
                </a:lnTo>
                <a:lnTo>
                  <a:pt x="3127379" y="246542"/>
                </a:lnTo>
                <a:lnTo>
                  <a:pt x="3127379" y="261128"/>
                </a:lnTo>
                <a:lnTo>
                  <a:pt x="3165402" y="261128"/>
                </a:lnTo>
                <a:lnTo>
                  <a:pt x="3165402" y="261128"/>
                </a:lnTo>
                <a:lnTo>
                  <a:pt x="3246729" y="261128"/>
                </a:lnTo>
                <a:lnTo>
                  <a:pt x="3246729" y="261128"/>
                </a:lnTo>
                <a:lnTo>
                  <a:pt x="3267852" y="261128"/>
                </a:lnTo>
                <a:lnTo>
                  <a:pt x="3267852" y="261128"/>
                </a:lnTo>
                <a:lnTo>
                  <a:pt x="3310100" y="261128"/>
                </a:lnTo>
                <a:lnTo>
                  <a:pt x="3310100" y="261128"/>
                </a:lnTo>
                <a:lnTo>
                  <a:pt x="3335449" y="261128"/>
                </a:lnTo>
                <a:lnTo>
                  <a:pt x="3335449" y="261128"/>
                </a:lnTo>
                <a:lnTo>
                  <a:pt x="3336505" y="261128"/>
                </a:lnTo>
                <a:lnTo>
                  <a:pt x="3336505" y="261128"/>
                </a:lnTo>
                <a:lnTo>
                  <a:pt x="3352348" y="261128"/>
                </a:lnTo>
                <a:lnTo>
                  <a:pt x="3352348" y="261128"/>
                </a:lnTo>
                <a:lnTo>
                  <a:pt x="3400932" y="261128"/>
                </a:lnTo>
                <a:lnTo>
                  <a:pt x="3400932" y="276052"/>
                </a:lnTo>
                <a:lnTo>
                  <a:pt x="3415719" y="276052"/>
                </a:lnTo>
                <a:lnTo>
                  <a:pt x="3415719" y="290978"/>
                </a:lnTo>
                <a:lnTo>
                  <a:pt x="3422056" y="290978"/>
                </a:lnTo>
                <a:lnTo>
                  <a:pt x="3422056" y="305917"/>
                </a:lnTo>
                <a:lnTo>
                  <a:pt x="3425225" y="305917"/>
                </a:lnTo>
                <a:lnTo>
                  <a:pt x="3425225" y="320933"/>
                </a:lnTo>
                <a:lnTo>
                  <a:pt x="3426281" y="320933"/>
                </a:lnTo>
                <a:lnTo>
                  <a:pt x="3426281" y="336099"/>
                </a:lnTo>
                <a:lnTo>
                  <a:pt x="3435787" y="336099"/>
                </a:lnTo>
                <a:lnTo>
                  <a:pt x="3435787" y="336099"/>
                </a:lnTo>
                <a:lnTo>
                  <a:pt x="3437899" y="336099"/>
                </a:lnTo>
                <a:lnTo>
                  <a:pt x="3437899" y="336099"/>
                </a:lnTo>
                <a:lnTo>
                  <a:pt x="3481203" y="336099"/>
                </a:lnTo>
                <a:lnTo>
                  <a:pt x="3481203" y="336099"/>
                </a:lnTo>
                <a:lnTo>
                  <a:pt x="3483315" y="336099"/>
                </a:lnTo>
                <a:lnTo>
                  <a:pt x="3483315" y="351320"/>
                </a:lnTo>
                <a:lnTo>
                  <a:pt x="3491765" y="351320"/>
                </a:lnTo>
                <a:lnTo>
                  <a:pt x="3491765" y="366548"/>
                </a:lnTo>
                <a:lnTo>
                  <a:pt x="3501271" y="366548"/>
                </a:lnTo>
                <a:lnTo>
                  <a:pt x="3501271" y="366548"/>
                </a:lnTo>
                <a:lnTo>
                  <a:pt x="3507608" y="366548"/>
                </a:lnTo>
                <a:lnTo>
                  <a:pt x="3507608" y="366548"/>
                </a:lnTo>
                <a:lnTo>
                  <a:pt x="3508664" y="366548"/>
                </a:lnTo>
                <a:lnTo>
                  <a:pt x="3508664" y="366548"/>
                </a:lnTo>
                <a:lnTo>
                  <a:pt x="3525563" y="366548"/>
                </a:lnTo>
                <a:lnTo>
                  <a:pt x="3525563" y="381956"/>
                </a:lnTo>
                <a:lnTo>
                  <a:pt x="3530844" y="381956"/>
                </a:lnTo>
                <a:lnTo>
                  <a:pt x="3530844" y="381956"/>
                </a:lnTo>
                <a:lnTo>
                  <a:pt x="3569923" y="381956"/>
                </a:lnTo>
                <a:lnTo>
                  <a:pt x="3569923" y="381956"/>
                </a:lnTo>
                <a:lnTo>
                  <a:pt x="3572035" y="381956"/>
                </a:lnTo>
                <a:lnTo>
                  <a:pt x="3572035" y="381956"/>
                </a:lnTo>
                <a:lnTo>
                  <a:pt x="3624845" y="381956"/>
                </a:lnTo>
                <a:lnTo>
                  <a:pt x="3624845" y="397504"/>
                </a:lnTo>
                <a:lnTo>
                  <a:pt x="3636463" y="397504"/>
                </a:lnTo>
                <a:lnTo>
                  <a:pt x="3636463" y="413055"/>
                </a:lnTo>
                <a:lnTo>
                  <a:pt x="3649137" y="413055"/>
                </a:lnTo>
                <a:lnTo>
                  <a:pt x="3649137" y="413055"/>
                </a:lnTo>
                <a:lnTo>
                  <a:pt x="3657587" y="413055"/>
                </a:lnTo>
                <a:lnTo>
                  <a:pt x="3657587" y="413055"/>
                </a:lnTo>
                <a:lnTo>
                  <a:pt x="3674486" y="413055"/>
                </a:lnTo>
                <a:lnTo>
                  <a:pt x="3674486" y="413055"/>
                </a:lnTo>
                <a:lnTo>
                  <a:pt x="3681879" y="413055"/>
                </a:lnTo>
                <a:lnTo>
                  <a:pt x="3681879" y="413055"/>
                </a:lnTo>
                <a:lnTo>
                  <a:pt x="3692441" y="413055"/>
                </a:lnTo>
                <a:lnTo>
                  <a:pt x="3692441" y="413055"/>
                </a:lnTo>
                <a:lnTo>
                  <a:pt x="3699834" y="413055"/>
                </a:lnTo>
                <a:lnTo>
                  <a:pt x="3699834" y="413055"/>
                </a:lnTo>
                <a:lnTo>
                  <a:pt x="3724127" y="413055"/>
                </a:lnTo>
                <a:lnTo>
                  <a:pt x="3724127" y="413055"/>
                </a:lnTo>
                <a:lnTo>
                  <a:pt x="3757925" y="413055"/>
                </a:lnTo>
                <a:lnTo>
                  <a:pt x="3757925" y="413055"/>
                </a:lnTo>
                <a:lnTo>
                  <a:pt x="3767430" y="413055"/>
                </a:lnTo>
                <a:lnTo>
                  <a:pt x="3767430" y="413055"/>
                </a:lnTo>
                <a:lnTo>
                  <a:pt x="3773768" y="413055"/>
                </a:lnTo>
                <a:lnTo>
                  <a:pt x="3773768" y="445258"/>
                </a:lnTo>
                <a:lnTo>
                  <a:pt x="3774824" y="445258"/>
                </a:lnTo>
                <a:lnTo>
                  <a:pt x="3774824" y="445258"/>
                </a:lnTo>
                <a:lnTo>
                  <a:pt x="3775880" y="445258"/>
                </a:lnTo>
                <a:lnTo>
                  <a:pt x="3775880" y="445258"/>
                </a:lnTo>
                <a:lnTo>
                  <a:pt x="3784330" y="445258"/>
                </a:lnTo>
                <a:lnTo>
                  <a:pt x="3784330" y="445258"/>
                </a:lnTo>
                <a:lnTo>
                  <a:pt x="3790667" y="445258"/>
                </a:lnTo>
                <a:lnTo>
                  <a:pt x="3790667" y="445258"/>
                </a:lnTo>
                <a:lnTo>
                  <a:pt x="3791723" y="445258"/>
                </a:lnTo>
                <a:lnTo>
                  <a:pt x="3791723" y="445258"/>
                </a:lnTo>
                <a:lnTo>
                  <a:pt x="3799116" y="445258"/>
                </a:lnTo>
                <a:lnTo>
                  <a:pt x="3799116" y="445258"/>
                </a:lnTo>
                <a:lnTo>
                  <a:pt x="3804397" y="445258"/>
                </a:lnTo>
                <a:lnTo>
                  <a:pt x="3804397" y="445258"/>
                </a:lnTo>
                <a:lnTo>
                  <a:pt x="3807566" y="445258"/>
                </a:lnTo>
                <a:lnTo>
                  <a:pt x="3807566" y="461899"/>
                </a:lnTo>
                <a:lnTo>
                  <a:pt x="3812847" y="461899"/>
                </a:lnTo>
                <a:lnTo>
                  <a:pt x="3812847" y="461899"/>
                </a:lnTo>
                <a:lnTo>
                  <a:pt x="3813903" y="461899"/>
                </a:lnTo>
                <a:lnTo>
                  <a:pt x="3813903" y="461899"/>
                </a:lnTo>
                <a:lnTo>
                  <a:pt x="3816015" y="461899"/>
                </a:lnTo>
                <a:lnTo>
                  <a:pt x="3816015" y="478647"/>
                </a:lnTo>
                <a:lnTo>
                  <a:pt x="3839251" y="478647"/>
                </a:lnTo>
                <a:lnTo>
                  <a:pt x="3839251" y="478647"/>
                </a:lnTo>
                <a:lnTo>
                  <a:pt x="3844532" y="478647"/>
                </a:lnTo>
                <a:lnTo>
                  <a:pt x="3844532" y="478647"/>
                </a:lnTo>
                <a:lnTo>
                  <a:pt x="3845589" y="478647"/>
                </a:lnTo>
                <a:lnTo>
                  <a:pt x="3845589" y="478647"/>
                </a:lnTo>
                <a:lnTo>
                  <a:pt x="3851926" y="478647"/>
                </a:lnTo>
                <a:lnTo>
                  <a:pt x="3851926" y="478647"/>
                </a:lnTo>
                <a:lnTo>
                  <a:pt x="3852982" y="478647"/>
                </a:lnTo>
                <a:lnTo>
                  <a:pt x="3852982" y="478647"/>
                </a:lnTo>
                <a:lnTo>
                  <a:pt x="3874106" y="478647"/>
                </a:lnTo>
                <a:lnTo>
                  <a:pt x="3874106" y="478647"/>
                </a:lnTo>
                <a:lnTo>
                  <a:pt x="3910016" y="478647"/>
                </a:lnTo>
                <a:lnTo>
                  <a:pt x="3910016" y="495573"/>
                </a:lnTo>
                <a:lnTo>
                  <a:pt x="3923747" y="495573"/>
                </a:lnTo>
                <a:lnTo>
                  <a:pt x="3923747" y="495573"/>
                </a:lnTo>
                <a:lnTo>
                  <a:pt x="3927971" y="495573"/>
                </a:lnTo>
                <a:lnTo>
                  <a:pt x="3927971" y="495573"/>
                </a:lnTo>
                <a:lnTo>
                  <a:pt x="3932196" y="495573"/>
                </a:lnTo>
                <a:lnTo>
                  <a:pt x="3932196" y="495573"/>
                </a:lnTo>
                <a:lnTo>
                  <a:pt x="3950151" y="495573"/>
                </a:lnTo>
                <a:lnTo>
                  <a:pt x="3950151" y="495573"/>
                </a:lnTo>
                <a:lnTo>
                  <a:pt x="3964938" y="495573"/>
                </a:lnTo>
                <a:lnTo>
                  <a:pt x="3964938" y="512612"/>
                </a:lnTo>
                <a:lnTo>
                  <a:pt x="4094849" y="512612"/>
                </a:lnTo>
                <a:lnTo>
                  <a:pt x="4094849" y="512612"/>
                </a:lnTo>
                <a:lnTo>
                  <a:pt x="4118086" y="512612"/>
                </a:lnTo>
                <a:lnTo>
                  <a:pt x="4118086" y="512612"/>
                </a:lnTo>
                <a:lnTo>
                  <a:pt x="4151884" y="512612"/>
                </a:lnTo>
                <a:lnTo>
                  <a:pt x="4151884" y="512612"/>
                </a:lnTo>
                <a:lnTo>
                  <a:pt x="4164558" y="512612"/>
                </a:lnTo>
                <a:lnTo>
                  <a:pt x="4164558" y="512612"/>
                </a:lnTo>
                <a:lnTo>
                  <a:pt x="4180401" y="512612"/>
                </a:lnTo>
                <a:lnTo>
                  <a:pt x="4180401" y="530383"/>
                </a:lnTo>
                <a:lnTo>
                  <a:pt x="4199412" y="530383"/>
                </a:lnTo>
                <a:lnTo>
                  <a:pt x="4199412" y="530383"/>
                </a:lnTo>
                <a:lnTo>
                  <a:pt x="4203637" y="530383"/>
                </a:lnTo>
                <a:lnTo>
                  <a:pt x="4203637" y="548237"/>
                </a:lnTo>
                <a:lnTo>
                  <a:pt x="4227929" y="548237"/>
                </a:lnTo>
                <a:lnTo>
                  <a:pt x="4227929" y="548237"/>
                </a:lnTo>
                <a:lnTo>
                  <a:pt x="4237435" y="548237"/>
                </a:lnTo>
                <a:lnTo>
                  <a:pt x="4237435" y="548237"/>
                </a:lnTo>
                <a:lnTo>
                  <a:pt x="4240604" y="548237"/>
                </a:lnTo>
                <a:lnTo>
                  <a:pt x="4240604" y="548237"/>
                </a:lnTo>
                <a:lnTo>
                  <a:pt x="4272289" y="548237"/>
                </a:lnTo>
                <a:lnTo>
                  <a:pt x="4272289" y="548237"/>
                </a:lnTo>
                <a:lnTo>
                  <a:pt x="4275458" y="548237"/>
                </a:lnTo>
                <a:lnTo>
                  <a:pt x="4275458" y="548237"/>
                </a:lnTo>
                <a:lnTo>
                  <a:pt x="4279683" y="548237"/>
                </a:lnTo>
                <a:lnTo>
                  <a:pt x="4279683" y="566278"/>
                </a:lnTo>
                <a:lnTo>
                  <a:pt x="4301863" y="566278"/>
                </a:lnTo>
                <a:lnTo>
                  <a:pt x="4301863" y="566278"/>
                </a:lnTo>
                <a:lnTo>
                  <a:pt x="4344110" y="566278"/>
                </a:lnTo>
                <a:lnTo>
                  <a:pt x="4344110" y="584396"/>
                </a:lnTo>
                <a:lnTo>
                  <a:pt x="4347279" y="584396"/>
                </a:lnTo>
                <a:lnTo>
                  <a:pt x="4347279" y="584396"/>
                </a:lnTo>
                <a:lnTo>
                  <a:pt x="4350448" y="584396"/>
                </a:lnTo>
                <a:lnTo>
                  <a:pt x="4350448" y="602596"/>
                </a:lnTo>
                <a:lnTo>
                  <a:pt x="4406426" y="602596"/>
                </a:lnTo>
                <a:lnTo>
                  <a:pt x="4406426" y="602596"/>
                </a:lnTo>
                <a:lnTo>
                  <a:pt x="4426493" y="602596"/>
                </a:lnTo>
                <a:lnTo>
                  <a:pt x="4426493" y="602596"/>
                </a:lnTo>
                <a:lnTo>
                  <a:pt x="4443392" y="602596"/>
                </a:lnTo>
                <a:lnTo>
                  <a:pt x="4443392" y="602596"/>
                </a:lnTo>
                <a:lnTo>
                  <a:pt x="4445505" y="602596"/>
                </a:lnTo>
                <a:lnTo>
                  <a:pt x="4445505" y="602596"/>
                </a:lnTo>
                <a:lnTo>
                  <a:pt x="4460291" y="602596"/>
                </a:lnTo>
                <a:lnTo>
                  <a:pt x="4460291" y="602596"/>
                </a:lnTo>
                <a:lnTo>
                  <a:pt x="4475078" y="602596"/>
                </a:lnTo>
                <a:lnTo>
                  <a:pt x="4475078" y="602596"/>
                </a:lnTo>
                <a:lnTo>
                  <a:pt x="4482471" y="602596"/>
                </a:lnTo>
                <a:lnTo>
                  <a:pt x="4482471" y="602596"/>
                </a:lnTo>
                <a:lnTo>
                  <a:pt x="4487752" y="602596"/>
                </a:lnTo>
                <a:lnTo>
                  <a:pt x="4487752" y="602596"/>
                </a:lnTo>
                <a:lnTo>
                  <a:pt x="4513101" y="602596"/>
                </a:lnTo>
                <a:lnTo>
                  <a:pt x="4513101" y="602596"/>
                </a:lnTo>
                <a:lnTo>
                  <a:pt x="4534225" y="602596"/>
                </a:lnTo>
                <a:lnTo>
                  <a:pt x="4534225" y="621395"/>
                </a:lnTo>
                <a:lnTo>
                  <a:pt x="4559573" y="621395"/>
                </a:lnTo>
                <a:lnTo>
                  <a:pt x="4559573" y="640215"/>
                </a:lnTo>
                <a:lnTo>
                  <a:pt x="4585978" y="640215"/>
                </a:lnTo>
                <a:lnTo>
                  <a:pt x="4585978" y="640215"/>
                </a:lnTo>
                <a:lnTo>
                  <a:pt x="4590203" y="640215"/>
                </a:lnTo>
                <a:lnTo>
                  <a:pt x="4590203" y="640215"/>
                </a:lnTo>
                <a:lnTo>
                  <a:pt x="4598652" y="640215"/>
                </a:lnTo>
                <a:lnTo>
                  <a:pt x="4598652" y="659243"/>
                </a:lnTo>
                <a:lnTo>
                  <a:pt x="4599708" y="659243"/>
                </a:lnTo>
                <a:lnTo>
                  <a:pt x="4599708" y="678339"/>
                </a:lnTo>
                <a:lnTo>
                  <a:pt x="4601821" y="678339"/>
                </a:lnTo>
                <a:lnTo>
                  <a:pt x="4601821" y="678339"/>
                </a:lnTo>
                <a:lnTo>
                  <a:pt x="4604989" y="678339"/>
                </a:lnTo>
                <a:lnTo>
                  <a:pt x="4604989" y="697497"/>
                </a:lnTo>
                <a:lnTo>
                  <a:pt x="4614495" y="697497"/>
                </a:lnTo>
                <a:lnTo>
                  <a:pt x="4614495" y="697497"/>
                </a:lnTo>
                <a:lnTo>
                  <a:pt x="4616608" y="697497"/>
                </a:lnTo>
                <a:lnTo>
                  <a:pt x="4616608" y="716707"/>
                </a:lnTo>
                <a:lnTo>
                  <a:pt x="4632450" y="716707"/>
                </a:lnTo>
                <a:lnTo>
                  <a:pt x="4632450" y="716707"/>
                </a:lnTo>
                <a:lnTo>
                  <a:pt x="4638788" y="716707"/>
                </a:lnTo>
                <a:lnTo>
                  <a:pt x="4638788" y="716707"/>
                </a:lnTo>
                <a:lnTo>
                  <a:pt x="4650406" y="716707"/>
                </a:lnTo>
                <a:lnTo>
                  <a:pt x="4650406" y="736018"/>
                </a:lnTo>
                <a:lnTo>
                  <a:pt x="4657799" y="736018"/>
                </a:lnTo>
                <a:lnTo>
                  <a:pt x="4657799" y="736018"/>
                </a:lnTo>
                <a:lnTo>
                  <a:pt x="4659911" y="736018"/>
                </a:lnTo>
                <a:lnTo>
                  <a:pt x="4659911" y="736018"/>
                </a:lnTo>
                <a:lnTo>
                  <a:pt x="4666248" y="736018"/>
                </a:lnTo>
                <a:lnTo>
                  <a:pt x="4666248" y="755367"/>
                </a:lnTo>
                <a:lnTo>
                  <a:pt x="4670473" y="755367"/>
                </a:lnTo>
                <a:lnTo>
                  <a:pt x="4670473" y="774805"/>
                </a:lnTo>
                <a:lnTo>
                  <a:pt x="4673642" y="774805"/>
                </a:lnTo>
                <a:lnTo>
                  <a:pt x="4673642" y="794260"/>
                </a:lnTo>
                <a:lnTo>
                  <a:pt x="4676810" y="794260"/>
                </a:lnTo>
                <a:lnTo>
                  <a:pt x="4676810" y="794260"/>
                </a:lnTo>
                <a:lnTo>
                  <a:pt x="4702159" y="794260"/>
                </a:lnTo>
                <a:lnTo>
                  <a:pt x="4702159" y="794260"/>
                </a:lnTo>
                <a:lnTo>
                  <a:pt x="4738069" y="794260"/>
                </a:lnTo>
                <a:lnTo>
                  <a:pt x="4738069" y="794260"/>
                </a:lnTo>
                <a:lnTo>
                  <a:pt x="4766587" y="794260"/>
                </a:lnTo>
                <a:lnTo>
                  <a:pt x="4766587" y="794260"/>
                </a:lnTo>
                <a:lnTo>
                  <a:pt x="4783486" y="794260"/>
                </a:lnTo>
                <a:lnTo>
                  <a:pt x="4783486" y="814142"/>
                </a:lnTo>
                <a:lnTo>
                  <a:pt x="4794047" y="814142"/>
                </a:lnTo>
                <a:lnTo>
                  <a:pt x="4794047" y="834064"/>
                </a:lnTo>
                <a:lnTo>
                  <a:pt x="4819396" y="834064"/>
                </a:lnTo>
                <a:lnTo>
                  <a:pt x="4819396" y="834064"/>
                </a:lnTo>
                <a:lnTo>
                  <a:pt x="4835239" y="834064"/>
                </a:lnTo>
                <a:lnTo>
                  <a:pt x="4835239" y="834064"/>
                </a:lnTo>
                <a:lnTo>
                  <a:pt x="4852138" y="834064"/>
                </a:lnTo>
                <a:lnTo>
                  <a:pt x="4852138" y="834064"/>
                </a:lnTo>
                <a:lnTo>
                  <a:pt x="4864812" y="834064"/>
                </a:lnTo>
                <a:lnTo>
                  <a:pt x="4864812" y="834064"/>
                </a:lnTo>
                <a:lnTo>
                  <a:pt x="4874318" y="834064"/>
                </a:lnTo>
                <a:lnTo>
                  <a:pt x="4874318" y="834064"/>
                </a:lnTo>
                <a:lnTo>
                  <a:pt x="4877487" y="834064"/>
                </a:lnTo>
                <a:lnTo>
                  <a:pt x="4877487" y="854151"/>
                </a:lnTo>
                <a:lnTo>
                  <a:pt x="4913397" y="854151"/>
                </a:lnTo>
                <a:lnTo>
                  <a:pt x="4913397" y="854151"/>
                </a:lnTo>
                <a:lnTo>
                  <a:pt x="4916566" y="854151"/>
                </a:lnTo>
                <a:lnTo>
                  <a:pt x="4916566" y="854151"/>
                </a:lnTo>
                <a:lnTo>
                  <a:pt x="4928184" y="854151"/>
                </a:lnTo>
                <a:lnTo>
                  <a:pt x="4928184" y="854151"/>
                </a:lnTo>
                <a:lnTo>
                  <a:pt x="4931352" y="854151"/>
                </a:lnTo>
                <a:lnTo>
                  <a:pt x="4931352" y="854151"/>
                </a:lnTo>
                <a:lnTo>
                  <a:pt x="4942970" y="854151"/>
                </a:lnTo>
                <a:lnTo>
                  <a:pt x="4942970" y="854151"/>
                </a:lnTo>
                <a:lnTo>
                  <a:pt x="4954588" y="854151"/>
                </a:lnTo>
                <a:lnTo>
                  <a:pt x="4954588" y="854151"/>
                </a:lnTo>
                <a:lnTo>
                  <a:pt x="4982049" y="854151"/>
                </a:lnTo>
                <a:lnTo>
                  <a:pt x="4982049" y="854151"/>
                </a:lnTo>
                <a:lnTo>
                  <a:pt x="4986274" y="854151"/>
                </a:lnTo>
                <a:lnTo>
                  <a:pt x="4986274" y="854151"/>
                </a:lnTo>
                <a:lnTo>
                  <a:pt x="4989443" y="854151"/>
                </a:lnTo>
                <a:lnTo>
                  <a:pt x="4989443" y="874769"/>
                </a:lnTo>
                <a:lnTo>
                  <a:pt x="4993667" y="874769"/>
                </a:lnTo>
                <a:lnTo>
                  <a:pt x="4993667" y="874769"/>
                </a:lnTo>
                <a:lnTo>
                  <a:pt x="5025353" y="874769"/>
                </a:lnTo>
                <a:lnTo>
                  <a:pt x="5025353" y="895436"/>
                </a:lnTo>
                <a:lnTo>
                  <a:pt x="5033803" y="895436"/>
                </a:lnTo>
                <a:lnTo>
                  <a:pt x="5033803" y="895436"/>
                </a:lnTo>
                <a:lnTo>
                  <a:pt x="5071826" y="895436"/>
                </a:lnTo>
                <a:lnTo>
                  <a:pt x="5071826" y="895436"/>
                </a:lnTo>
                <a:lnTo>
                  <a:pt x="5077107" y="895436"/>
                </a:lnTo>
                <a:lnTo>
                  <a:pt x="5077107" y="895436"/>
                </a:lnTo>
                <a:lnTo>
                  <a:pt x="5095062" y="895436"/>
                </a:lnTo>
                <a:lnTo>
                  <a:pt x="5095062" y="916243"/>
                </a:lnTo>
                <a:lnTo>
                  <a:pt x="5098230" y="916243"/>
                </a:lnTo>
                <a:lnTo>
                  <a:pt x="5098230" y="916243"/>
                </a:lnTo>
                <a:lnTo>
                  <a:pt x="5105624" y="916243"/>
                </a:lnTo>
                <a:lnTo>
                  <a:pt x="5105624" y="916243"/>
                </a:lnTo>
                <a:lnTo>
                  <a:pt x="5108792" y="916243"/>
                </a:lnTo>
                <a:lnTo>
                  <a:pt x="5108792" y="916243"/>
                </a:lnTo>
                <a:lnTo>
                  <a:pt x="5111961" y="916243"/>
                </a:lnTo>
                <a:lnTo>
                  <a:pt x="5111961" y="916243"/>
                </a:lnTo>
                <a:lnTo>
                  <a:pt x="5134141" y="916243"/>
                </a:lnTo>
                <a:lnTo>
                  <a:pt x="5134141" y="937278"/>
                </a:lnTo>
                <a:lnTo>
                  <a:pt x="5155265" y="937278"/>
                </a:lnTo>
                <a:lnTo>
                  <a:pt x="5155265" y="937278"/>
                </a:lnTo>
                <a:lnTo>
                  <a:pt x="5166883" y="937278"/>
                </a:lnTo>
                <a:lnTo>
                  <a:pt x="5166883" y="937278"/>
                </a:lnTo>
                <a:lnTo>
                  <a:pt x="5172164" y="937278"/>
                </a:lnTo>
                <a:lnTo>
                  <a:pt x="5172164" y="958514"/>
                </a:lnTo>
                <a:lnTo>
                  <a:pt x="5211243" y="958514"/>
                </a:lnTo>
                <a:lnTo>
                  <a:pt x="5211243" y="958514"/>
                </a:lnTo>
                <a:lnTo>
                  <a:pt x="5233423" y="958514"/>
                </a:lnTo>
                <a:lnTo>
                  <a:pt x="5233423" y="958514"/>
                </a:lnTo>
                <a:lnTo>
                  <a:pt x="5236591" y="958514"/>
                </a:lnTo>
                <a:lnTo>
                  <a:pt x="5236591" y="980075"/>
                </a:lnTo>
                <a:lnTo>
                  <a:pt x="5265108" y="980075"/>
                </a:lnTo>
                <a:lnTo>
                  <a:pt x="5265108" y="980075"/>
                </a:lnTo>
                <a:lnTo>
                  <a:pt x="5270389" y="980075"/>
                </a:lnTo>
                <a:lnTo>
                  <a:pt x="5270389" y="1001685"/>
                </a:lnTo>
                <a:lnTo>
                  <a:pt x="5280951" y="1001685"/>
                </a:lnTo>
                <a:lnTo>
                  <a:pt x="5280951" y="1001685"/>
                </a:lnTo>
                <a:lnTo>
                  <a:pt x="5296794" y="1001685"/>
                </a:lnTo>
                <a:lnTo>
                  <a:pt x="5296794" y="1001685"/>
                </a:lnTo>
                <a:lnTo>
                  <a:pt x="5302075" y="1001685"/>
                </a:lnTo>
                <a:lnTo>
                  <a:pt x="5302075" y="1023590"/>
                </a:lnTo>
                <a:lnTo>
                  <a:pt x="5303131" y="1023590"/>
                </a:lnTo>
                <a:lnTo>
                  <a:pt x="5303131" y="1045636"/>
                </a:lnTo>
                <a:lnTo>
                  <a:pt x="5308412" y="1045636"/>
                </a:lnTo>
                <a:lnTo>
                  <a:pt x="5308412" y="1067734"/>
                </a:lnTo>
                <a:lnTo>
                  <a:pt x="5325311" y="1067734"/>
                </a:lnTo>
                <a:lnTo>
                  <a:pt x="5325311" y="1089876"/>
                </a:lnTo>
                <a:lnTo>
                  <a:pt x="5326367" y="1089876"/>
                </a:lnTo>
                <a:lnTo>
                  <a:pt x="5326367" y="1089876"/>
                </a:lnTo>
                <a:lnTo>
                  <a:pt x="5331648" y="1089876"/>
                </a:lnTo>
                <a:lnTo>
                  <a:pt x="5331648" y="1112101"/>
                </a:lnTo>
                <a:lnTo>
                  <a:pt x="5392907" y="1112101"/>
                </a:lnTo>
                <a:lnTo>
                  <a:pt x="5392907" y="1112101"/>
                </a:lnTo>
                <a:lnTo>
                  <a:pt x="5404526" y="1112101"/>
                </a:lnTo>
                <a:lnTo>
                  <a:pt x="5404526" y="1134369"/>
                </a:lnTo>
                <a:lnTo>
                  <a:pt x="5434099" y="1134369"/>
                </a:lnTo>
                <a:lnTo>
                  <a:pt x="5434099" y="1134369"/>
                </a:lnTo>
                <a:lnTo>
                  <a:pt x="5437267" y="1134369"/>
                </a:lnTo>
                <a:lnTo>
                  <a:pt x="5437267" y="1134369"/>
                </a:lnTo>
                <a:lnTo>
                  <a:pt x="5455223" y="1134369"/>
                </a:lnTo>
                <a:lnTo>
                  <a:pt x="5455223" y="1134369"/>
                </a:lnTo>
                <a:lnTo>
                  <a:pt x="5456279" y="1134369"/>
                </a:lnTo>
                <a:lnTo>
                  <a:pt x="5456279" y="1156900"/>
                </a:lnTo>
                <a:lnTo>
                  <a:pt x="5465785" y="1156900"/>
                </a:lnTo>
                <a:lnTo>
                  <a:pt x="5465785" y="1156900"/>
                </a:lnTo>
                <a:lnTo>
                  <a:pt x="5494302" y="1156900"/>
                </a:lnTo>
                <a:lnTo>
                  <a:pt x="5494302" y="1156900"/>
                </a:lnTo>
                <a:lnTo>
                  <a:pt x="5506976" y="1156900"/>
                </a:lnTo>
                <a:lnTo>
                  <a:pt x="5506976" y="1156900"/>
                </a:lnTo>
                <a:lnTo>
                  <a:pt x="5553448" y="1156900"/>
                </a:lnTo>
                <a:lnTo>
                  <a:pt x="5553448" y="1156900"/>
                </a:lnTo>
                <a:lnTo>
                  <a:pt x="5575628" y="1156900"/>
                </a:lnTo>
                <a:lnTo>
                  <a:pt x="5575628" y="1156900"/>
                </a:lnTo>
                <a:lnTo>
                  <a:pt x="5578797" y="1156900"/>
                </a:lnTo>
                <a:lnTo>
                  <a:pt x="5578797" y="1156900"/>
                </a:lnTo>
                <a:lnTo>
                  <a:pt x="5614707" y="1156900"/>
                </a:lnTo>
                <a:lnTo>
                  <a:pt x="5614707" y="1179706"/>
                </a:lnTo>
                <a:lnTo>
                  <a:pt x="5619988" y="1179706"/>
                </a:lnTo>
                <a:lnTo>
                  <a:pt x="5619988" y="1179706"/>
                </a:lnTo>
                <a:lnTo>
                  <a:pt x="5621045" y="1179706"/>
                </a:lnTo>
                <a:lnTo>
                  <a:pt x="5621045" y="1179706"/>
                </a:lnTo>
                <a:lnTo>
                  <a:pt x="5629494" y="1179706"/>
                </a:lnTo>
                <a:lnTo>
                  <a:pt x="5629494" y="1179706"/>
                </a:lnTo>
                <a:lnTo>
                  <a:pt x="5642168" y="1179706"/>
                </a:lnTo>
                <a:lnTo>
                  <a:pt x="5642168" y="1202595"/>
                </a:lnTo>
                <a:lnTo>
                  <a:pt x="5647449" y="1202595"/>
                </a:lnTo>
                <a:lnTo>
                  <a:pt x="5647449" y="1225848"/>
                </a:lnTo>
                <a:lnTo>
                  <a:pt x="5651674" y="1225848"/>
                </a:lnTo>
                <a:lnTo>
                  <a:pt x="5651674" y="1225848"/>
                </a:lnTo>
                <a:lnTo>
                  <a:pt x="5656955" y="1225848"/>
                </a:lnTo>
                <a:lnTo>
                  <a:pt x="5656955" y="1225848"/>
                </a:lnTo>
                <a:lnTo>
                  <a:pt x="5661180" y="1225848"/>
                </a:lnTo>
                <a:lnTo>
                  <a:pt x="5661180" y="1225848"/>
                </a:lnTo>
                <a:lnTo>
                  <a:pt x="5662236" y="1225848"/>
                </a:lnTo>
                <a:lnTo>
                  <a:pt x="5662236" y="1225848"/>
                </a:lnTo>
                <a:lnTo>
                  <a:pt x="5669629" y="1225848"/>
                </a:lnTo>
                <a:lnTo>
                  <a:pt x="5669629" y="1249245"/>
                </a:lnTo>
                <a:lnTo>
                  <a:pt x="5682304" y="1249245"/>
                </a:lnTo>
                <a:lnTo>
                  <a:pt x="5682304" y="1249245"/>
                </a:lnTo>
                <a:lnTo>
                  <a:pt x="5688641" y="1249245"/>
                </a:lnTo>
                <a:lnTo>
                  <a:pt x="5688641" y="1249245"/>
                </a:lnTo>
                <a:lnTo>
                  <a:pt x="5706596" y="1249245"/>
                </a:lnTo>
                <a:lnTo>
                  <a:pt x="5706596" y="1249245"/>
                </a:lnTo>
                <a:lnTo>
                  <a:pt x="5730888" y="1249245"/>
                </a:lnTo>
                <a:lnTo>
                  <a:pt x="5730888" y="1272965"/>
                </a:lnTo>
                <a:lnTo>
                  <a:pt x="5742506" y="1272965"/>
                </a:lnTo>
                <a:lnTo>
                  <a:pt x="5742506" y="1296778"/>
                </a:lnTo>
                <a:lnTo>
                  <a:pt x="5745675" y="1296778"/>
                </a:lnTo>
                <a:lnTo>
                  <a:pt x="5745675" y="1296778"/>
                </a:lnTo>
                <a:lnTo>
                  <a:pt x="5767855" y="1296778"/>
                </a:lnTo>
                <a:lnTo>
                  <a:pt x="5767855" y="1296778"/>
                </a:lnTo>
                <a:lnTo>
                  <a:pt x="5769967" y="1296778"/>
                </a:lnTo>
                <a:lnTo>
                  <a:pt x="5769967" y="1296778"/>
                </a:lnTo>
                <a:lnTo>
                  <a:pt x="5783698" y="1296778"/>
                </a:lnTo>
                <a:lnTo>
                  <a:pt x="5783698" y="1320781"/>
                </a:lnTo>
                <a:lnTo>
                  <a:pt x="5787923" y="1320781"/>
                </a:lnTo>
                <a:lnTo>
                  <a:pt x="5787923" y="1320781"/>
                </a:lnTo>
                <a:lnTo>
                  <a:pt x="5793204" y="1320781"/>
                </a:lnTo>
                <a:lnTo>
                  <a:pt x="5793204" y="1344885"/>
                </a:lnTo>
                <a:lnTo>
                  <a:pt x="5814327" y="1344885"/>
                </a:lnTo>
                <a:lnTo>
                  <a:pt x="5814327" y="1344885"/>
                </a:lnTo>
                <a:lnTo>
                  <a:pt x="5823833" y="1344885"/>
                </a:lnTo>
                <a:lnTo>
                  <a:pt x="5823833" y="1344885"/>
                </a:lnTo>
                <a:lnTo>
                  <a:pt x="5825945" y="1344885"/>
                </a:lnTo>
                <a:lnTo>
                  <a:pt x="5825945" y="1369076"/>
                </a:lnTo>
                <a:lnTo>
                  <a:pt x="5830170" y="1369076"/>
                </a:lnTo>
                <a:lnTo>
                  <a:pt x="5830170" y="1369076"/>
                </a:lnTo>
                <a:lnTo>
                  <a:pt x="5873474" y="1369076"/>
                </a:lnTo>
                <a:lnTo>
                  <a:pt x="5873474" y="1369076"/>
                </a:lnTo>
                <a:lnTo>
                  <a:pt x="5887205" y="1369076"/>
                </a:lnTo>
                <a:lnTo>
                  <a:pt x="5887205" y="1369076"/>
                </a:lnTo>
                <a:lnTo>
                  <a:pt x="5904104" y="1369076"/>
                </a:lnTo>
                <a:lnTo>
                  <a:pt x="5904104" y="1369076"/>
                </a:lnTo>
                <a:lnTo>
                  <a:pt x="5942126" y="1369076"/>
                </a:lnTo>
                <a:lnTo>
                  <a:pt x="5942126" y="1369076"/>
                </a:lnTo>
                <a:lnTo>
                  <a:pt x="5945295" y="1369076"/>
                </a:lnTo>
                <a:lnTo>
                  <a:pt x="5945295" y="1369076"/>
                </a:lnTo>
                <a:lnTo>
                  <a:pt x="5947407" y="1369076"/>
                </a:lnTo>
                <a:lnTo>
                  <a:pt x="5947407" y="1393607"/>
                </a:lnTo>
                <a:lnTo>
                  <a:pt x="5951632" y="1393607"/>
                </a:lnTo>
                <a:lnTo>
                  <a:pt x="5951632" y="1393607"/>
                </a:lnTo>
                <a:lnTo>
                  <a:pt x="6013947" y="1393607"/>
                </a:lnTo>
                <a:lnTo>
                  <a:pt x="6013947" y="1393607"/>
                </a:lnTo>
                <a:lnTo>
                  <a:pt x="6018172" y="1393607"/>
                </a:lnTo>
                <a:lnTo>
                  <a:pt x="6018172" y="1393607"/>
                </a:lnTo>
                <a:lnTo>
                  <a:pt x="6037184" y="1393607"/>
                </a:lnTo>
                <a:lnTo>
                  <a:pt x="6037184" y="1393607"/>
                </a:lnTo>
                <a:lnTo>
                  <a:pt x="6047745" y="1393607"/>
                </a:lnTo>
                <a:lnTo>
                  <a:pt x="6047745" y="1393607"/>
                </a:lnTo>
                <a:lnTo>
                  <a:pt x="6049858" y="1393607"/>
                </a:lnTo>
                <a:lnTo>
                  <a:pt x="6049858" y="1393607"/>
                </a:lnTo>
                <a:lnTo>
                  <a:pt x="6062532" y="1393607"/>
                </a:lnTo>
                <a:lnTo>
                  <a:pt x="6062532" y="1393607"/>
                </a:lnTo>
                <a:lnTo>
                  <a:pt x="6064644" y="1393607"/>
                </a:lnTo>
                <a:lnTo>
                  <a:pt x="6064644" y="1418926"/>
                </a:lnTo>
                <a:lnTo>
                  <a:pt x="6084712" y="1418926"/>
                </a:lnTo>
                <a:lnTo>
                  <a:pt x="6084712" y="1444373"/>
                </a:lnTo>
                <a:lnTo>
                  <a:pt x="6092105" y="1444373"/>
                </a:lnTo>
                <a:lnTo>
                  <a:pt x="6092105" y="1444373"/>
                </a:lnTo>
                <a:lnTo>
                  <a:pt x="6106892" y="1444373"/>
                </a:lnTo>
                <a:lnTo>
                  <a:pt x="6106892" y="1444373"/>
                </a:lnTo>
                <a:lnTo>
                  <a:pt x="6114285" y="1444373"/>
                </a:lnTo>
                <a:lnTo>
                  <a:pt x="6114285" y="1444373"/>
                </a:lnTo>
                <a:lnTo>
                  <a:pt x="6117454" y="1444373"/>
                </a:lnTo>
                <a:lnTo>
                  <a:pt x="6117454" y="1469893"/>
                </a:lnTo>
                <a:lnTo>
                  <a:pt x="6120623" y="1469893"/>
                </a:lnTo>
                <a:lnTo>
                  <a:pt x="6120623" y="1469893"/>
                </a:lnTo>
                <a:lnTo>
                  <a:pt x="6132241" y="1469893"/>
                </a:lnTo>
                <a:lnTo>
                  <a:pt x="6132241" y="1495482"/>
                </a:lnTo>
                <a:lnTo>
                  <a:pt x="6157589" y="1495482"/>
                </a:lnTo>
                <a:lnTo>
                  <a:pt x="6157589" y="1495482"/>
                </a:lnTo>
                <a:lnTo>
                  <a:pt x="6163926" y="1495482"/>
                </a:lnTo>
                <a:lnTo>
                  <a:pt x="6163926" y="1521496"/>
                </a:lnTo>
                <a:lnTo>
                  <a:pt x="6170264" y="1521496"/>
                </a:lnTo>
                <a:lnTo>
                  <a:pt x="6170264" y="1521496"/>
                </a:lnTo>
                <a:lnTo>
                  <a:pt x="6185050" y="1521496"/>
                </a:lnTo>
                <a:lnTo>
                  <a:pt x="6185050" y="1521496"/>
                </a:lnTo>
                <a:lnTo>
                  <a:pt x="6197724" y="1521496"/>
                </a:lnTo>
                <a:lnTo>
                  <a:pt x="6197724" y="1521496"/>
                </a:lnTo>
                <a:lnTo>
                  <a:pt x="6198781" y="1521496"/>
                </a:lnTo>
                <a:lnTo>
                  <a:pt x="6198781" y="1547712"/>
                </a:lnTo>
                <a:lnTo>
                  <a:pt x="6201949" y="1547712"/>
                </a:lnTo>
                <a:lnTo>
                  <a:pt x="6201949" y="1547712"/>
                </a:lnTo>
                <a:lnTo>
                  <a:pt x="6213567" y="1547712"/>
                </a:lnTo>
                <a:lnTo>
                  <a:pt x="6213567" y="1547712"/>
                </a:lnTo>
                <a:lnTo>
                  <a:pt x="6216736" y="1547712"/>
                </a:lnTo>
                <a:lnTo>
                  <a:pt x="6216736" y="1574149"/>
                </a:lnTo>
                <a:lnTo>
                  <a:pt x="6217792" y="1574149"/>
                </a:lnTo>
                <a:lnTo>
                  <a:pt x="6217792" y="1600656"/>
                </a:lnTo>
                <a:lnTo>
                  <a:pt x="6220961" y="1600656"/>
                </a:lnTo>
                <a:lnTo>
                  <a:pt x="6220961" y="1600656"/>
                </a:lnTo>
                <a:lnTo>
                  <a:pt x="6223073" y="1600656"/>
                </a:lnTo>
                <a:lnTo>
                  <a:pt x="6223073" y="1600656"/>
                </a:lnTo>
                <a:lnTo>
                  <a:pt x="6227298" y="1600656"/>
                </a:lnTo>
                <a:lnTo>
                  <a:pt x="6227298" y="1627302"/>
                </a:lnTo>
                <a:lnTo>
                  <a:pt x="6233635" y="1627302"/>
                </a:lnTo>
                <a:lnTo>
                  <a:pt x="6233635" y="1653959"/>
                </a:lnTo>
                <a:lnTo>
                  <a:pt x="6236804" y="1653959"/>
                </a:lnTo>
                <a:lnTo>
                  <a:pt x="6236804" y="1680883"/>
                </a:lnTo>
                <a:lnTo>
                  <a:pt x="6245253" y="1680883"/>
                </a:lnTo>
                <a:lnTo>
                  <a:pt x="6245253" y="1680883"/>
                </a:lnTo>
                <a:lnTo>
                  <a:pt x="6264264" y="1680883"/>
                </a:lnTo>
                <a:lnTo>
                  <a:pt x="6264264" y="1707867"/>
                </a:lnTo>
                <a:lnTo>
                  <a:pt x="6265321" y="1707867"/>
                </a:lnTo>
                <a:lnTo>
                  <a:pt x="6265321" y="1707867"/>
                </a:lnTo>
                <a:lnTo>
                  <a:pt x="6266377" y="1707867"/>
                </a:lnTo>
                <a:lnTo>
                  <a:pt x="6266377" y="1735118"/>
                </a:lnTo>
                <a:lnTo>
                  <a:pt x="6291725" y="1735118"/>
                </a:lnTo>
                <a:lnTo>
                  <a:pt x="6291725" y="1762400"/>
                </a:lnTo>
                <a:lnTo>
                  <a:pt x="6293838" y="1762400"/>
                </a:lnTo>
                <a:lnTo>
                  <a:pt x="6293838" y="1762400"/>
                </a:lnTo>
                <a:lnTo>
                  <a:pt x="6337142" y="1762400"/>
                </a:lnTo>
                <a:lnTo>
                  <a:pt x="6337142" y="1762400"/>
                </a:lnTo>
                <a:lnTo>
                  <a:pt x="6355097" y="1762400"/>
                </a:lnTo>
                <a:lnTo>
                  <a:pt x="6355097" y="1762400"/>
                </a:lnTo>
                <a:lnTo>
                  <a:pt x="6381502" y="1762400"/>
                </a:lnTo>
                <a:lnTo>
                  <a:pt x="6381502" y="1762400"/>
                </a:lnTo>
                <a:lnTo>
                  <a:pt x="6412131" y="1762400"/>
                </a:lnTo>
                <a:lnTo>
                  <a:pt x="6412131" y="1762400"/>
                </a:lnTo>
                <a:lnTo>
                  <a:pt x="6421637" y="1762400"/>
                </a:lnTo>
                <a:lnTo>
                  <a:pt x="6421637" y="1762400"/>
                </a:lnTo>
                <a:lnTo>
                  <a:pt x="6438536" y="1762400"/>
                </a:lnTo>
                <a:lnTo>
                  <a:pt x="6438536" y="1762400"/>
                </a:lnTo>
                <a:lnTo>
                  <a:pt x="6457547" y="1762400"/>
                </a:lnTo>
                <a:lnTo>
                  <a:pt x="6457547" y="1762400"/>
                </a:lnTo>
                <a:lnTo>
                  <a:pt x="6458603" y="1762400"/>
                </a:lnTo>
                <a:lnTo>
                  <a:pt x="6458603" y="1790301"/>
                </a:lnTo>
                <a:lnTo>
                  <a:pt x="6460716" y="1790301"/>
                </a:lnTo>
                <a:lnTo>
                  <a:pt x="6460716" y="1818280"/>
                </a:lnTo>
                <a:lnTo>
                  <a:pt x="6462828" y="1818280"/>
                </a:lnTo>
                <a:lnTo>
                  <a:pt x="6462828" y="1818280"/>
                </a:lnTo>
                <a:lnTo>
                  <a:pt x="6464941" y="1818280"/>
                </a:lnTo>
                <a:lnTo>
                  <a:pt x="6464941" y="1818280"/>
                </a:lnTo>
                <a:lnTo>
                  <a:pt x="6472334" y="1818280"/>
                </a:lnTo>
                <a:lnTo>
                  <a:pt x="6472334" y="1846484"/>
                </a:lnTo>
                <a:lnTo>
                  <a:pt x="6512469" y="1846484"/>
                </a:lnTo>
                <a:lnTo>
                  <a:pt x="6512469" y="1874753"/>
                </a:lnTo>
                <a:lnTo>
                  <a:pt x="6515638" y="1874753"/>
                </a:lnTo>
                <a:lnTo>
                  <a:pt x="6515638" y="1903153"/>
                </a:lnTo>
                <a:lnTo>
                  <a:pt x="6525143" y="1903153"/>
                </a:lnTo>
                <a:lnTo>
                  <a:pt x="6525143" y="1903153"/>
                </a:lnTo>
                <a:lnTo>
                  <a:pt x="6548380" y="1903153"/>
                </a:lnTo>
                <a:lnTo>
                  <a:pt x="6548380" y="1931736"/>
                </a:lnTo>
                <a:lnTo>
                  <a:pt x="6550492" y="1931736"/>
                </a:lnTo>
                <a:lnTo>
                  <a:pt x="6550492" y="1931736"/>
                </a:lnTo>
                <a:lnTo>
                  <a:pt x="6554717" y="1931736"/>
                </a:lnTo>
                <a:lnTo>
                  <a:pt x="6554717" y="1931736"/>
                </a:lnTo>
                <a:lnTo>
                  <a:pt x="6555773" y="1931736"/>
                </a:lnTo>
                <a:lnTo>
                  <a:pt x="6555773" y="1960592"/>
                </a:lnTo>
                <a:lnTo>
                  <a:pt x="6558942" y="1960592"/>
                </a:lnTo>
                <a:lnTo>
                  <a:pt x="6558942" y="1960592"/>
                </a:lnTo>
                <a:lnTo>
                  <a:pt x="6577953" y="1960592"/>
                </a:lnTo>
                <a:lnTo>
                  <a:pt x="6577953" y="1989492"/>
                </a:lnTo>
                <a:lnTo>
                  <a:pt x="6585346" y="1989492"/>
                </a:lnTo>
                <a:lnTo>
                  <a:pt x="6585346" y="2018482"/>
                </a:lnTo>
                <a:lnTo>
                  <a:pt x="6611751" y="2018482"/>
                </a:lnTo>
                <a:lnTo>
                  <a:pt x="6611751" y="2018482"/>
                </a:lnTo>
                <a:lnTo>
                  <a:pt x="6617032" y="2018482"/>
                </a:lnTo>
                <a:lnTo>
                  <a:pt x="6617032" y="2047573"/>
                </a:lnTo>
                <a:lnTo>
                  <a:pt x="6625482" y="2047573"/>
                </a:lnTo>
                <a:lnTo>
                  <a:pt x="6625482" y="2076715"/>
                </a:lnTo>
                <a:lnTo>
                  <a:pt x="6637100" y="2076715"/>
                </a:lnTo>
                <a:lnTo>
                  <a:pt x="6637100" y="2105933"/>
                </a:lnTo>
                <a:lnTo>
                  <a:pt x="6653999" y="2105933"/>
                </a:lnTo>
                <a:lnTo>
                  <a:pt x="6653999" y="2105933"/>
                </a:lnTo>
                <a:lnTo>
                  <a:pt x="6658223" y="2105933"/>
                </a:lnTo>
                <a:lnTo>
                  <a:pt x="6658223" y="2135340"/>
                </a:lnTo>
                <a:lnTo>
                  <a:pt x="6684628" y="2135340"/>
                </a:lnTo>
                <a:lnTo>
                  <a:pt x="6684628" y="2135340"/>
                </a:lnTo>
                <a:lnTo>
                  <a:pt x="6687797" y="2135340"/>
                </a:lnTo>
                <a:lnTo>
                  <a:pt x="6687797" y="2135340"/>
                </a:lnTo>
                <a:lnTo>
                  <a:pt x="6697303" y="2135340"/>
                </a:lnTo>
                <a:lnTo>
                  <a:pt x="6697303" y="2135340"/>
                </a:lnTo>
                <a:lnTo>
                  <a:pt x="6704696" y="2135340"/>
                </a:lnTo>
                <a:lnTo>
                  <a:pt x="6704696" y="2135340"/>
                </a:lnTo>
                <a:lnTo>
                  <a:pt x="6705752" y="2135340"/>
                </a:lnTo>
                <a:lnTo>
                  <a:pt x="6705752" y="2135340"/>
                </a:lnTo>
                <a:lnTo>
                  <a:pt x="6713145" y="2135340"/>
                </a:lnTo>
                <a:lnTo>
                  <a:pt x="6713145" y="2165355"/>
                </a:lnTo>
                <a:lnTo>
                  <a:pt x="6722651" y="2165355"/>
                </a:lnTo>
                <a:lnTo>
                  <a:pt x="6722651" y="2165355"/>
                </a:lnTo>
                <a:lnTo>
                  <a:pt x="6730044" y="2165355"/>
                </a:lnTo>
                <a:lnTo>
                  <a:pt x="6730044" y="2165355"/>
                </a:lnTo>
                <a:lnTo>
                  <a:pt x="6744831" y="2165355"/>
                </a:lnTo>
                <a:lnTo>
                  <a:pt x="6744831" y="2165355"/>
                </a:lnTo>
                <a:lnTo>
                  <a:pt x="6757505" y="2165355"/>
                </a:lnTo>
                <a:lnTo>
                  <a:pt x="6757505" y="2165355"/>
                </a:lnTo>
                <a:lnTo>
                  <a:pt x="6768067" y="2165355"/>
                </a:lnTo>
                <a:lnTo>
                  <a:pt x="6768067" y="2165355"/>
                </a:lnTo>
                <a:lnTo>
                  <a:pt x="6774404" y="2165355"/>
                </a:lnTo>
                <a:lnTo>
                  <a:pt x="6774404" y="2165355"/>
                </a:lnTo>
                <a:lnTo>
                  <a:pt x="6787079" y="2165355"/>
                </a:lnTo>
                <a:lnTo>
                  <a:pt x="6787079" y="2195934"/>
                </a:lnTo>
                <a:lnTo>
                  <a:pt x="6792360" y="2195934"/>
                </a:lnTo>
                <a:lnTo>
                  <a:pt x="6792360" y="2195934"/>
                </a:lnTo>
                <a:lnTo>
                  <a:pt x="6803978" y="2195934"/>
                </a:lnTo>
                <a:lnTo>
                  <a:pt x="6803978" y="2195934"/>
                </a:lnTo>
                <a:lnTo>
                  <a:pt x="6806090" y="2195934"/>
                </a:lnTo>
                <a:lnTo>
                  <a:pt x="6806090" y="2195934"/>
                </a:lnTo>
                <a:lnTo>
                  <a:pt x="6809259" y="2195934"/>
                </a:lnTo>
                <a:lnTo>
                  <a:pt x="6809259" y="2226743"/>
                </a:lnTo>
                <a:lnTo>
                  <a:pt x="6815596" y="2226743"/>
                </a:lnTo>
                <a:lnTo>
                  <a:pt x="6815596" y="2226743"/>
                </a:lnTo>
                <a:lnTo>
                  <a:pt x="6819821" y="2226743"/>
                </a:lnTo>
                <a:lnTo>
                  <a:pt x="6819821" y="2226743"/>
                </a:lnTo>
                <a:lnTo>
                  <a:pt x="6829326" y="2226743"/>
                </a:lnTo>
                <a:lnTo>
                  <a:pt x="6829326" y="2226743"/>
                </a:lnTo>
                <a:lnTo>
                  <a:pt x="6840944" y="2226743"/>
                </a:lnTo>
                <a:lnTo>
                  <a:pt x="6840944" y="2226743"/>
                </a:lnTo>
                <a:lnTo>
                  <a:pt x="6845169" y="2226743"/>
                </a:lnTo>
                <a:lnTo>
                  <a:pt x="6845169" y="2226743"/>
                </a:lnTo>
                <a:lnTo>
                  <a:pt x="6851506" y="2226743"/>
                </a:lnTo>
                <a:lnTo>
                  <a:pt x="6851506" y="2226743"/>
                </a:lnTo>
                <a:lnTo>
                  <a:pt x="6854675" y="2226743"/>
                </a:lnTo>
                <a:lnTo>
                  <a:pt x="6854675" y="2226743"/>
                </a:lnTo>
                <a:lnTo>
                  <a:pt x="6857843" y="2226743"/>
                </a:lnTo>
                <a:lnTo>
                  <a:pt x="6857843" y="2226743"/>
                </a:lnTo>
                <a:lnTo>
                  <a:pt x="6859956" y="2226743"/>
                </a:lnTo>
                <a:lnTo>
                  <a:pt x="6859956" y="2226743"/>
                </a:lnTo>
                <a:lnTo>
                  <a:pt x="6869462" y="2226743"/>
                </a:lnTo>
                <a:lnTo>
                  <a:pt x="6869462" y="2226743"/>
                </a:lnTo>
                <a:lnTo>
                  <a:pt x="6874742" y="2226743"/>
                </a:lnTo>
                <a:lnTo>
                  <a:pt x="6874742" y="2226743"/>
                </a:lnTo>
                <a:lnTo>
                  <a:pt x="6875799" y="2226743"/>
                </a:lnTo>
                <a:lnTo>
                  <a:pt x="6875799" y="2226743"/>
                </a:lnTo>
                <a:lnTo>
                  <a:pt x="6876855" y="2226743"/>
                </a:lnTo>
                <a:lnTo>
                  <a:pt x="6876855" y="2226743"/>
                </a:lnTo>
                <a:lnTo>
                  <a:pt x="6882136" y="2226743"/>
                </a:lnTo>
                <a:lnTo>
                  <a:pt x="6882136" y="2226743"/>
                </a:lnTo>
                <a:lnTo>
                  <a:pt x="6886361" y="2226743"/>
                </a:lnTo>
                <a:lnTo>
                  <a:pt x="6886361" y="2274572"/>
                </a:lnTo>
                <a:lnTo>
                  <a:pt x="6895866" y="2274572"/>
                </a:lnTo>
                <a:lnTo>
                  <a:pt x="6895866" y="2274572"/>
                </a:lnTo>
                <a:lnTo>
                  <a:pt x="6896922" y="2274572"/>
                </a:lnTo>
                <a:lnTo>
                  <a:pt x="6896922" y="2274572"/>
                </a:lnTo>
                <a:lnTo>
                  <a:pt x="6897979" y="2274572"/>
                </a:lnTo>
                <a:lnTo>
                  <a:pt x="6897979" y="2274572"/>
                </a:lnTo>
                <a:lnTo>
                  <a:pt x="6900091" y="2274572"/>
                </a:lnTo>
                <a:lnTo>
                  <a:pt x="6900091" y="2274572"/>
                </a:lnTo>
                <a:lnTo>
                  <a:pt x="6905372" y="2274572"/>
                </a:lnTo>
                <a:lnTo>
                  <a:pt x="6905372" y="2274572"/>
                </a:lnTo>
                <a:lnTo>
                  <a:pt x="6914878" y="2274572"/>
                </a:lnTo>
                <a:lnTo>
                  <a:pt x="6914878" y="2342766"/>
                </a:lnTo>
                <a:lnTo>
                  <a:pt x="6924383" y="2342766"/>
                </a:lnTo>
                <a:lnTo>
                  <a:pt x="6924383" y="2342766"/>
                </a:lnTo>
                <a:lnTo>
                  <a:pt x="6926496" y="2342766"/>
                </a:lnTo>
                <a:lnTo>
                  <a:pt x="6926496" y="2342766"/>
                </a:lnTo>
                <a:lnTo>
                  <a:pt x="6927552" y="2342766"/>
                </a:lnTo>
                <a:lnTo>
                  <a:pt x="6927552" y="2342766"/>
                </a:lnTo>
                <a:lnTo>
                  <a:pt x="6946563" y="2342766"/>
                </a:lnTo>
                <a:lnTo>
                  <a:pt x="6946563" y="2342766"/>
                </a:lnTo>
                <a:lnTo>
                  <a:pt x="6947620" y="2342766"/>
                </a:lnTo>
                <a:lnTo>
                  <a:pt x="6947620" y="2342766"/>
                </a:lnTo>
                <a:lnTo>
                  <a:pt x="6949732" y="2342766"/>
                </a:lnTo>
                <a:lnTo>
                  <a:pt x="6949732" y="2342766"/>
                </a:lnTo>
                <a:lnTo>
                  <a:pt x="6956069" y="2342766"/>
                </a:lnTo>
                <a:lnTo>
                  <a:pt x="6956069" y="2342766"/>
                </a:lnTo>
                <a:lnTo>
                  <a:pt x="6963462" y="2342766"/>
                </a:lnTo>
                <a:lnTo>
                  <a:pt x="6963462" y="2342766"/>
                </a:lnTo>
                <a:lnTo>
                  <a:pt x="6964519" y="2342766"/>
                </a:lnTo>
                <a:lnTo>
                  <a:pt x="6964519" y="2342766"/>
                </a:lnTo>
                <a:lnTo>
                  <a:pt x="6970856" y="2342766"/>
                </a:lnTo>
                <a:lnTo>
                  <a:pt x="6970856" y="2342766"/>
                </a:lnTo>
              </a:path>
            </a:pathLst>
          </a:custGeom>
          <a:ln w="21681" cap="flat">
            <a:solidFill>
              <a:srgbClr val="000000">
                <a:alpha val="100000"/>
              </a:srgbClr>
            </a:solidFill>
            <a:prstDash val="sysDot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55" name="rc17">
            <a:extLst>
              <a:ext uri="{FF2B5EF4-FFF2-40B4-BE49-F238E27FC236}">
                <a16:creationId xmlns:a16="http://schemas.microsoft.com/office/drawing/2014/main" id="{326ED7CB-5AFE-E59F-D1D7-E003CF94F1D8}"/>
              </a:ext>
            </a:extLst>
          </p:cNvPr>
          <p:cNvSpPr/>
          <p:nvPr/>
        </p:nvSpPr>
        <p:spPr>
          <a:xfrm>
            <a:off x="3756847" y="1646857"/>
            <a:ext cx="5061378" cy="3353007"/>
          </a:xfrm>
          <a:prstGeom prst="rect">
            <a:avLst/>
          </a:prstGeom>
          <a:ln w="18478" cap="rnd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56" name="tx18">
            <a:extLst>
              <a:ext uri="{FF2B5EF4-FFF2-40B4-BE49-F238E27FC236}">
                <a16:creationId xmlns:a16="http://schemas.microsoft.com/office/drawing/2014/main" id="{C19AEB7E-CD44-7093-79A0-FAE972C7A2CC}"/>
              </a:ext>
            </a:extLst>
          </p:cNvPr>
          <p:cNvSpPr/>
          <p:nvPr/>
        </p:nvSpPr>
        <p:spPr>
          <a:xfrm>
            <a:off x="3083336" y="4565657"/>
            <a:ext cx="606040" cy="108556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2000"/>
              </a:lnSpc>
            </a:pPr>
            <a:r>
              <a:rPr sz="1400">
                <a:solidFill>
                  <a:srgbClr val="4D4D4D">
                    <a:alpha val="100000"/>
                  </a:srgbClr>
                </a:solidFill>
                <a:latin typeface="Times"/>
                <a:cs typeface="Times"/>
              </a:rPr>
              <a:t>0.99900</a:t>
            </a:r>
          </a:p>
        </p:txBody>
      </p:sp>
      <p:sp>
        <p:nvSpPr>
          <p:cNvPr id="57" name="tx19">
            <a:extLst>
              <a:ext uri="{FF2B5EF4-FFF2-40B4-BE49-F238E27FC236}">
                <a16:creationId xmlns:a16="http://schemas.microsoft.com/office/drawing/2014/main" id="{5451C03E-CE95-D663-4071-7CBE2F55E1AE}"/>
              </a:ext>
            </a:extLst>
          </p:cNvPr>
          <p:cNvSpPr/>
          <p:nvPr/>
        </p:nvSpPr>
        <p:spPr>
          <a:xfrm>
            <a:off x="3083336" y="3831556"/>
            <a:ext cx="606040" cy="108556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2000"/>
              </a:lnSpc>
            </a:pPr>
            <a:r>
              <a:rPr sz="1400">
                <a:solidFill>
                  <a:srgbClr val="4D4D4D">
                    <a:alpha val="100000"/>
                  </a:srgbClr>
                </a:solidFill>
                <a:latin typeface="Times"/>
                <a:cs typeface="Times"/>
              </a:rPr>
              <a:t>0.99925</a:t>
            </a:r>
          </a:p>
        </p:txBody>
      </p:sp>
      <p:sp>
        <p:nvSpPr>
          <p:cNvPr id="58" name="tx20">
            <a:extLst>
              <a:ext uri="{FF2B5EF4-FFF2-40B4-BE49-F238E27FC236}">
                <a16:creationId xmlns:a16="http://schemas.microsoft.com/office/drawing/2014/main" id="{6F7D35E9-3440-84A0-9D0D-41BFC3414C4B}"/>
              </a:ext>
            </a:extLst>
          </p:cNvPr>
          <p:cNvSpPr/>
          <p:nvPr/>
        </p:nvSpPr>
        <p:spPr>
          <a:xfrm>
            <a:off x="3083336" y="3097454"/>
            <a:ext cx="606040" cy="108556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2000"/>
              </a:lnSpc>
            </a:pPr>
            <a:r>
              <a:rPr sz="1400" dirty="0">
                <a:solidFill>
                  <a:srgbClr val="4D4D4D">
                    <a:alpha val="100000"/>
                  </a:srgbClr>
                </a:solidFill>
                <a:latin typeface="Times"/>
                <a:cs typeface="Times"/>
              </a:rPr>
              <a:t>0.99950</a:t>
            </a:r>
          </a:p>
        </p:txBody>
      </p:sp>
      <p:sp>
        <p:nvSpPr>
          <p:cNvPr id="59" name="tx21">
            <a:extLst>
              <a:ext uri="{FF2B5EF4-FFF2-40B4-BE49-F238E27FC236}">
                <a16:creationId xmlns:a16="http://schemas.microsoft.com/office/drawing/2014/main" id="{B5A56B26-CABB-63EE-9C4D-583A0748F576}"/>
              </a:ext>
            </a:extLst>
          </p:cNvPr>
          <p:cNvSpPr/>
          <p:nvPr/>
        </p:nvSpPr>
        <p:spPr>
          <a:xfrm>
            <a:off x="3083336" y="2363352"/>
            <a:ext cx="606040" cy="108556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2000"/>
              </a:lnSpc>
            </a:pPr>
            <a:r>
              <a:rPr sz="1400">
                <a:solidFill>
                  <a:srgbClr val="4D4D4D">
                    <a:alpha val="100000"/>
                  </a:srgbClr>
                </a:solidFill>
                <a:latin typeface="Times"/>
                <a:cs typeface="Times"/>
              </a:rPr>
              <a:t>0.99975</a:t>
            </a:r>
          </a:p>
        </p:txBody>
      </p:sp>
      <p:sp>
        <p:nvSpPr>
          <p:cNvPr id="60" name="tx22">
            <a:extLst>
              <a:ext uri="{FF2B5EF4-FFF2-40B4-BE49-F238E27FC236}">
                <a16:creationId xmlns:a16="http://schemas.microsoft.com/office/drawing/2014/main" id="{43D98941-5670-13D0-4F9E-BD584C2C1510}"/>
              </a:ext>
            </a:extLst>
          </p:cNvPr>
          <p:cNvSpPr/>
          <p:nvPr/>
        </p:nvSpPr>
        <p:spPr>
          <a:xfrm>
            <a:off x="3083336" y="1629250"/>
            <a:ext cx="606040" cy="108556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2000"/>
              </a:lnSpc>
            </a:pPr>
            <a:r>
              <a:rPr sz="1400">
                <a:solidFill>
                  <a:srgbClr val="4D4D4D">
                    <a:alpha val="100000"/>
                  </a:srgbClr>
                </a:solidFill>
                <a:latin typeface="Times"/>
                <a:cs typeface="Times"/>
              </a:rPr>
              <a:t>1.00000</a:t>
            </a:r>
          </a:p>
        </p:txBody>
      </p:sp>
      <p:sp>
        <p:nvSpPr>
          <p:cNvPr id="61" name="pl23">
            <a:extLst>
              <a:ext uri="{FF2B5EF4-FFF2-40B4-BE49-F238E27FC236}">
                <a16:creationId xmlns:a16="http://schemas.microsoft.com/office/drawing/2014/main" id="{38DF672D-2719-569E-8056-070B2EF3B36C}"/>
              </a:ext>
            </a:extLst>
          </p:cNvPr>
          <p:cNvSpPr/>
          <p:nvPr/>
        </p:nvSpPr>
        <p:spPr>
          <a:xfrm flipV="1">
            <a:off x="3725004" y="4619123"/>
            <a:ext cx="36913" cy="34438"/>
          </a:xfrm>
          <a:custGeom>
            <a:avLst/>
            <a:gdLst/>
            <a:ahLst/>
            <a:cxnLst/>
            <a:rect l="0" t="0" r="0" b="0"/>
            <a:pathLst>
              <a:path w="47447">
                <a:moveTo>
                  <a:pt x="0" y="0"/>
                </a:moveTo>
                <a:lnTo>
                  <a:pt x="47447" y="0"/>
                </a:lnTo>
              </a:path>
            </a:pathLst>
          </a:custGeom>
          <a:ln w="18478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62" name="pl24">
            <a:extLst>
              <a:ext uri="{FF2B5EF4-FFF2-40B4-BE49-F238E27FC236}">
                <a16:creationId xmlns:a16="http://schemas.microsoft.com/office/drawing/2014/main" id="{F86B8A5E-CC7A-E3F9-6BD4-1F646955640B}"/>
              </a:ext>
            </a:extLst>
          </p:cNvPr>
          <p:cNvSpPr/>
          <p:nvPr/>
        </p:nvSpPr>
        <p:spPr>
          <a:xfrm flipV="1">
            <a:off x="3725004" y="3885021"/>
            <a:ext cx="36913" cy="34438"/>
          </a:xfrm>
          <a:custGeom>
            <a:avLst/>
            <a:gdLst/>
            <a:ahLst/>
            <a:cxnLst/>
            <a:rect l="0" t="0" r="0" b="0"/>
            <a:pathLst>
              <a:path w="47447">
                <a:moveTo>
                  <a:pt x="0" y="0"/>
                </a:moveTo>
                <a:lnTo>
                  <a:pt x="47447" y="0"/>
                </a:lnTo>
              </a:path>
            </a:pathLst>
          </a:custGeom>
          <a:ln w="18478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63" name="pl25">
            <a:extLst>
              <a:ext uri="{FF2B5EF4-FFF2-40B4-BE49-F238E27FC236}">
                <a16:creationId xmlns:a16="http://schemas.microsoft.com/office/drawing/2014/main" id="{25B26195-860B-85A1-E886-8A5DA0915E41}"/>
              </a:ext>
            </a:extLst>
          </p:cNvPr>
          <p:cNvSpPr/>
          <p:nvPr/>
        </p:nvSpPr>
        <p:spPr>
          <a:xfrm flipV="1">
            <a:off x="3725004" y="3150919"/>
            <a:ext cx="36913" cy="34438"/>
          </a:xfrm>
          <a:custGeom>
            <a:avLst/>
            <a:gdLst/>
            <a:ahLst/>
            <a:cxnLst/>
            <a:rect l="0" t="0" r="0" b="0"/>
            <a:pathLst>
              <a:path w="47447">
                <a:moveTo>
                  <a:pt x="0" y="0"/>
                </a:moveTo>
                <a:lnTo>
                  <a:pt x="47447" y="0"/>
                </a:lnTo>
              </a:path>
            </a:pathLst>
          </a:custGeom>
          <a:ln w="18478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64" name="pl26">
            <a:extLst>
              <a:ext uri="{FF2B5EF4-FFF2-40B4-BE49-F238E27FC236}">
                <a16:creationId xmlns:a16="http://schemas.microsoft.com/office/drawing/2014/main" id="{0E24CFCA-3EF5-262D-E64B-5F9C313515FE}"/>
              </a:ext>
            </a:extLst>
          </p:cNvPr>
          <p:cNvSpPr/>
          <p:nvPr/>
        </p:nvSpPr>
        <p:spPr>
          <a:xfrm flipV="1">
            <a:off x="3725004" y="2416818"/>
            <a:ext cx="36913" cy="34438"/>
          </a:xfrm>
          <a:custGeom>
            <a:avLst/>
            <a:gdLst/>
            <a:ahLst/>
            <a:cxnLst/>
            <a:rect l="0" t="0" r="0" b="0"/>
            <a:pathLst>
              <a:path w="47447">
                <a:moveTo>
                  <a:pt x="0" y="0"/>
                </a:moveTo>
                <a:lnTo>
                  <a:pt x="47447" y="0"/>
                </a:lnTo>
              </a:path>
            </a:pathLst>
          </a:custGeom>
          <a:ln w="18478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65" name="pl27">
            <a:extLst>
              <a:ext uri="{FF2B5EF4-FFF2-40B4-BE49-F238E27FC236}">
                <a16:creationId xmlns:a16="http://schemas.microsoft.com/office/drawing/2014/main" id="{97AAB5E3-68AC-ACAF-E5D5-31AF0A59CFCE}"/>
              </a:ext>
            </a:extLst>
          </p:cNvPr>
          <p:cNvSpPr/>
          <p:nvPr/>
        </p:nvSpPr>
        <p:spPr>
          <a:xfrm flipV="1">
            <a:off x="3725004" y="1682715"/>
            <a:ext cx="36913" cy="34438"/>
          </a:xfrm>
          <a:custGeom>
            <a:avLst/>
            <a:gdLst/>
            <a:ahLst/>
            <a:cxnLst/>
            <a:rect l="0" t="0" r="0" b="0"/>
            <a:pathLst>
              <a:path w="47447">
                <a:moveTo>
                  <a:pt x="0" y="0"/>
                </a:moveTo>
                <a:lnTo>
                  <a:pt x="47447" y="0"/>
                </a:lnTo>
              </a:path>
            </a:pathLst>
          </a:custGeom>
          <a:ln w="18478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66" name="pl28">
            <a:extLst>
              <a:ext uri="{FF2B5EF4-FFF2-40B4-BE49-F238E27FC236}">
                <a16:creationId xmlns:a16="http://schemas.microsoft.com/office/drawing/2014/main" id="{2BD8E303-AE0D-3C14-F993-F52758C0BCA0}"/>
              </a:ext>
            </a:extLst>
          </p:cNvPr>
          <p:cNvSpPr/>
          <p:nvPr/>
        </p:nvSpPr>
        <p:spPr>
          <a:xfrm>
            <a:off x="5030631" y="4994179"/>
            <a:ext cx="36913" cy="34438"/>
          </a:xfrm>
          <a:custGeom>
            <a:avLst/>
            <a:gdLst/>
            <a:ahLst/>
            <a:cxnLst/>
            <a:rect l="0" t="0" r="0" b="0"/>
            <a:pathLst>
              <a:path h="47447">
                <a:moveTo>
                  <a:pt x="0" y="47447"/>
                </a:moveTo>
                <a:lnTo>
                  <a:pt x="0" y="0"/>
                </a:lnTo>
              </a:path>
            </a:pathLst>
          </a:custGeom>
          <a:ln w="18478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67" name="pl29">
            <a:extLst>
              <a:ext uri="{FF2B5EF4-FFF2-40B4-BE49-F238E27FC236}">
                <a16:creationId xmlns:a16="http://schemas.microsoft.com/office/drawing/2014/main" id="{A07D710F-0B0E-9A59-C5F0-54626C9DEC0B}"/>
              </a:ext>
            </a:extLst>
          </p:cNvPr>
          <p:cNvSpPr/>
          <p:nvPr/>
        </p:nvSpPr>
        <p:spPr>
          <a:xfrm>
            <a:off x="6448309" y="4994179"/>
            <a:ext cx="36913" cy="34438"/>
          </a:xfrm>
          <a:custGeom>
            <a:avLst/>
            <a:gdLst/>
            <a:ahLst/>
            <a:cxnLst/>
            <a:rect l="0" t="0" r="0" b="0"/>
            <a:pathLst>
              <a:path h="47447">
                <a:moveTo>
                  <a:pt x="0" y="47447"/>
                </a:moveTo>
                <a:lnTo>
                  <a:pt x="0" y="0"/>
                </a:lnTo>
              </a:path>
            </a:pathLst>
          </a:custGeom>
          <a:ln w="18478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68" name="pl30">
            <a:extLst>
              <a:ext uri="{FF2B5EF4-FFF2-40B4-BE49-F238E27FC236}">
                <a16:creationId xmlns:a16="http://schemas.microsoft.com/office/drawing/2014/main" id="{C8F32688-43A9-8B47-30FE-620DDC80AE61}"/>
              </a:ext>
            </a:extLst>
          </p:cNvPr>
          <p:cNvSpPr/>
          <p:nvPr/>
        </p:nvSpPr>
        <p:spPr>
          <a:xfrm>
            <a:off x="7865988" y="4994179"/>
            <a:ext cx="36913" cy="34438"/>
          </a:xfrm>
          <a:custGeom>
            <a:avLst/>
            <a:gdLst/>
            <a:ahLst/>
            <a:cxnLst/>
            <a:rect l="0" t="0" r="0" b="0"/>
            <a:pathLst>
              <a:path h="47447">
                <a:moveTo>
                  <a:pt x="0" y="47447"/>
                </a:moveTo>
                <a:lnTo>
                  <a:pt x="0" y="0"/>
                </a:lnTo>
              </a:path>
            </a:pathLst>
          </a:custGeom>
          <a:ln w="18478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sp>
        <p:nvSpPr>
          <p:cNvPr id="69" name="tx31">
            <a:extLst>
              <a:ext uri="{FF2B5EF4-FFF2-40B4-BE49-F238E27FC236}">
                <a16:creationId xmlns:a16="http://schemas.microsoft.com/office/drawing/2014/main" id="{C680D68A-4513-0861-094E-87043B56B2F6}"/>
              </a:ext>
            </a:extLst>
          </p:cNvPr>
          <p:cNvSpPr/>
          <p:nvPr/>
        </p:nvSpPr>
        <p:spPr>
          <a:xfrm>
            <a:off x="4841021" y="5091266"/>
            <a:ext cx="372973" cy="108556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2000"/>
              </a:lnSpc>
            </a:pPr>
            <a:r>
              <a:rPr sz="1400">
                <a:solidFill>
                  <a:srgbClr val="4D4D4D">
                    <a:alpha val="100000"/>
                  </a:srgbClr>
                </a:solidFill>
                <a:latin typeface="Times"/>
                <a:cs typeface="Times"/>
              </a:rPr>
              <a:t>2000</a:t>
            </a:r>
          </a:p>
        </p:txBody>
      </p:sp>
      <p:sp>
        <p:nvSpPr>
          <p:cNvPr id="70" name="tx32">
            <a:extLst>
              <a:ext uri="{FF2B5EF4-FFF2-40B4-BE49-F238E27FC236}">
                <a16:creationId xmlns:a16="http://schemas.microsoft.com/office/drawing/2014/main" id="{107E1A8D-58B5-73F8-7164-CE82E36C0D92}"/>
              </a:ext>
            </a:extLst>
          </p:cNvPr>
          <p:cNvSpPr/>
          <p:nvPr/>
        </p:nvSpPr>
        <p:spPr>
          <a:xfrm>
            <a:off x="6258699" y="5091266"/>
            <a:ext cx="372973" cy="108556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2000"/>
              </a:lnSpc>
            </a:pPr>
            <a:r>
              <a:rPr sz="1400">
                <a:solidFill>
                  <a:srgbClr val="4D4D4D">
                    <a:alpha val="100000"/>
                  </a:srgbClr>
                </a:solidFill>
                <a:latin typeface="Times"/>
                <a:cs typeface="Times"/>
              </a:rPr>
              <a:t>4000</a:t>
            </a:r>
          </a:p>
        </p:txBody>
      </p:sp>
      <p:sp>
        <p:nvSpPr>
          <p:cNvPr id="71" name="tx33">
            <a:extLst>
              <a:ext uri="{FF2B5EF4-FFF2-40B4-BE49-F238E27FC236}">
                <a16:creationId xmlns:a16="http://schemas.microsoft.com/office/drawing/2014/main" id="{0D514830-01BE-6E4F-4F32-BAF5EAF773AF}"/>
              </a:ext>
            </a:extLst>
          </p:cNvPr>
          <p:cNvSpPr/>
          <p:nvPr/>
        </p:nvSpPr>
        <p:spPr>
          <a:xfrm>
            <a:off x="7676377" y="5091266"/>
            <a:ext cx="372973" cy="108556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2000"/>
              </a:lnSpc>
            </a:pPr>
            <a:r>
              <a:rPr sz="1400">
                <a:solidFill>
                  <a:srgbClr val="4D4D4D">
                    <a:alpha val="100000"/>
                  </a:srgbClr>
                </a:solidFill>
                <a:latin typeface="Times"/>
                <a:cs typeface="Times"/>
              </a:rPr>
              <a:t>6000</a:t>
            </a:r>
          </a:p>
        </p:txBody>
      </p:sp>
      <p:sp>
        <p:nvSpPr>
          <p:cNvPr id="72" name="tx34">
            <a:extLst>
              <a:ext uri="{FF2B5EF4-FFF2-40B4-BE49-F238E27FC236}">
                <a16:creationId xmlns:a16="http://schemas.microsoft.com/office/drawing/2014/main" id="{58B8425C-5841-466D-0468-D6C2C3931C3D}"/>
              </a:ext>
            </a:extLst>
          </p:cNvPr>
          <p:cNvSpPr/>
          <p:nvPr/>
        </p:nvSpPr>
        <p:spPr>
          <a:xfrm>
            <a:off x="8489116" y="5084556"/>
            <a:ext cx="381978" cy="13756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2000"/>
              </a:lnSpc>
            </a:pPr>
            <a:r>
              <a:rPr sz="1400" dirty="0">
                <a:solidFill>
                  <a:srgbClr val="000000">
                    <a:alpha val="100000"/>
                  </a:srgbClr>
                </a:solidFill>
                <a:latin typeface="Times"/>
                <a:cs typeface="Times"/>
              </a:rPr>
              <a:t>Days</a:t>
            </a:r>
          </a:p>
        </p:txBody>
      </p:sp>
      <p:sp>
        <p:nvSpPr>
          <p:cNvPr id="73" name="tx35">
            <a:extLst>
              <a:ext uri="{FF2B5EF4-FFF2-40B4-BE49-F238E27FC236}">
                <a16:creationId xmlns:a16="http://schemas.microsoft.com/office/drawing/2014/main" id="{0BAB8726-CF15-8199-3A76-CC7475BB28A4}"/>
              </a:ext>
            </a:extLst>
          </p:cNvPr>
          <p:cNvSpPr/>
          <p:nvPr/>
        </p:nvSpPr>
        <p:spPr>
          <a:xfrm rot="16200000">
            <a:off x="2269060" y="3200371"/>
            <a:ext cx="1246397" cy="157343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2000"/>
              </a:lnSpc>
            </a:pPr>
            <a:r>
              <a:rPr sz="1400" dirty="0">
                <a:solidFill>
                  <a:srgbClr val="000000">
                    <a:alpha val="100000"/>
                  </a:srgbClr>
                </a:solidFill>
                <a:latin typeface="Times"/>
                <a:cs typeface="Times"/>
              </a:rPr>
              <a:t>Survival probability</a:t>
            </a:r>
          </a:p>
        </p:txBody>
      </p:sp>
      <p:sp>
        <p:nvSpPr>
          <p:cNvPr id="74" name="tx43">
            <a:extLst>
              <a:ext uri="{FF2B5EF4-FFF2-40B4-BE49-F238E27FC236}">
                <a16:creationId xmlns:a16="http://schemas.microsoft.com/office/drawing/2014/main" id="{4C19CBC6-00EE-6B96-5CC5-BA61496AE012}"/>
              </a:ext>
            </a:extLst>
          </p:cNvPr>
          <p:cNvSpPr/>
          <p:nvPr/>
        </p:nvSpPr>
        <p:spPr>
          <a:xfrm>
            <a:off x="3374074" y="1270024"/>
            <a:ext cx="5674255" cy="14445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2000"/>
              </a:lnSpc>
            </a:pPr>
            <a:r>
              <a:rPr sz="1600" dirty="0">
                <a:solidFill>
                  <a:srgbClr val="000000">
                    <a:alpha val="100000"/>
                  </a:srgbClr>
                </a:solidFill>
                <a:latin typeface="Times"/>
                <a:cs typeface="Times"/>
              </a:rPr>
              <a:t>Standardized survival (population-averaged): </a:t>
            </a:r>
            <a:r>
              <a:rPr lang="en-US" sz="1600" dirty="0">
                <a:solidFill>
                  <a:srgbClr val="000000">
                    <a:alpha val="100000"/>
                  </a:srgbClr>
                </a:solidFill>
                <a:latin typeface="Times"/>
                <a:cs typeface="Times"/>
              </a:rPr>
              <a:t>(B) C</a:t>
            </a:r>
            <a:r>
              <a:rPr sz="1600" dirty="0">
                <a:solidFill>
                  <a:srgbClr val="000000">
                    <a:alpha val="100000"/>
                  </a:srgbClr>
                </a:solidFill>
                <a:latin typeface="Times"/>
                <a:cs typeface="Times"/>
              </a:rPr>
              <a:t>ardiovascular mortality</a:t>
            </a:r>
          </a:p>
        </p:txBody>
      </p:sp>
      <p:sp>
        <p:nvSpPr>
          <p:cNvPr id="76" name="Rectangle 128">
            <a:extLst>
              <a:ext uri="{FF2B5EF4-FFF2-40B4-BE49-F238E27FC236}">
                <a16:creationId xmlns:a16="http://schemas.microsoft.com/office/drawing/2014/main" id="{C0402C90-42AC-DFDA-C7AF-86B82B7F1D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23836" y="5064402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sz="140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pl28">
            <a:extLst>
              <a:ext uri="{FF2B5EF4-FFF2-40B4-BE49-F238E27FC236}">
                <a16:creationId xmlns:a16="http://schemas.microsoft.com/office/drawing/2014/main" id="{E4621C4B-0F06-DBB9-697B-CDE2358C60B9}"/>
              </a:ext>
            </a:extLst>
          </p:cNvPr>
          <p:cNvSpPr/>
          <p:nvPr/>
        </p:nvSpPr>
        <p:spPr>
          <a:xfrm>
            <a:off x="3759402" y="5003706"/>
            <a:ext cx="36913" cy="34438"/>
          </a:xfrm>
          <a:custGeom>
            <a:avLst/>
            <a:gdLst/>
            <a:ahLst/>
            <a:cxnLst/>
            <a:rect l="0" t="0" r="0" b="0"/>
            <a:pathLst>
              <a:path h="47447">
                <a:moveTo>
                  <a:pt x="0" y="47447"/>
                </a:moveTo>
                <a:lnTo>
                  <a:pt x="0" y="0"/>
                </a:lnTo>
              </a:path>
            </a:pathLst>
          </a:custGeom>
          <a:ln w="18478" cap="flat">
            <a:solidFill>
              <a:srgbClr val="333333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00"/>
          </a:p>
        </p:txBody>
      </p:sp>
      <p:grpSp>
        <p:nvGrpSpPr>
          <p:cNvPr id="85" name="グループ化 84">
            <a:extLst>
              <a:ext uri="{FF2B5EF4-FFF2-40B4-BE49-F238E27FC236}">
                <a16:creationId xmlns:a16="http://schemas.microsoft.com/office/drawing/2014/main" id="{448CBF00-9F85-3A3D-653B-714729AEDEC5}"/>
              </a:ext>
            </a:extLst>
          </p:cNvPr>
          <p:cNvGrpSpPr/>
          <p:nvPr/>
        </p:nvGrpSpPr>
        <p:grpSpPr>
          <a:xfrm>
            <a:off x="4013054" y="4001034"/>
            <a:ext cx="1928465" cy="790928"/>
            <a:chOff x="7148661" y="38880"/>
            <a:chExt cx="1928465" cy="790928"/>
          </a:xfrm>
        </p:grpSpPr>
        <p:sp>
          <p:nvSpPr>
            <p:cNvPr id="86" name="Rectangle 233">
              <a:extLst>
                <a:ext uri="{FF2B5EF4-FFF2-40B4-BE49-F238E27FC236}">
                  <a16:creationId xmlns:a16="http://schemas.microsoft.com/office/drawing/2014/main" id="{282FBFE8-EA05-8F02-F278-CE47992AD6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96336" y="38880"/>
              <a:ext cx="111402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ja-JP" altLang="ja-JP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GFRdiff &lt; </a:t>
              </a:r>
              <a:r>
                <a:rPr kumimoji="0" lang="en-US" altLang="ja-JP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ja-JP" altLang="ja-JP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ja-JP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Line 234">
              <a:extLst>
                <a:ext uri="{FF2B5EF4-FFF2-40B4-BE49-F238E27FC236}">
                  <a16:creationId xmlns:a16="http://schemas.microsoft.com/office/drawing/2014/main" id="{AB2940F7-1D56-F7C6-E0DF-9179BAADFA1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48661" y="161117"/>
              <a:ext cx="285750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Rectangle 237">
              <a:extLst>
                <a:ext uri="{FF2B5EF4-FFF2-40B4-BE49-F238E27FC236}">
                  <a16:creationId xmlns:a16="http://schemas.microsoft.com/office/drawing/2014/main" id="{729AA466-57F0-A719-AA2A-5DACAFA26B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92809" y="332335"/>
              <a:ext cx="148431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ja-JP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ja-JP" altLang="ja-JP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r>
                <a:rPr kumimoji="0" lang="ja-JP" altLang="ja-JP" sz="1400" u="sng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&lt;</a:t>
              </a:r>
              <a:r>
                <a:rPr kumimoji="0" lang="ja-JP" altLang="ja-JP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eGFRdiff &lt; 10</a:t>
              </a:r>
              <a:endParaRPr kumimoji="0" lang="ja-JP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Freeform 238">
              <a:extLst>
                <a:ext uri="{FF2B5EF4-FFF2-40B4-BE49-F238E27FC236}">
                  <a16:creationId xmlns:a16="http://schemas.microsoft.com/office/drawing/2014/main" id="{24070AC0-64BD-7803-EDED-561A1C40E88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7148661" y="448222"/>
              <a:ext cx="285750" cy="12700"/>
            </a:xfrm>
            <a:custGeom>
              <a:avLst/>
              <a:gdLst>
                <a:gd name="T0" fmla="*/ 0 w 2048"/>
                <a:gd name="T1" fmla="*/ 0 h 96"/>
                <a:gd name="T2" fmla="*/ 192 w 2048"/>
                <a:gd name="T3" fmla="*/ 0 h 96"/>
                <a:gd name="T4" fmla="*/ 240 w 2048"/>
                <a:gd name="T5" fmla="*/ 48 h 96"/>
                <a:gd name="T6" fmla="*/ 192 w 2048"/>
                <a:gd name="T7" fmla="*/ 96 h 96"/>
                <a:gd name="T8" fmla="*/ 0 w 2048"/>
                <a:gd name="T9" fmla="*/ 96 h 96"/>
                <a:gd name="T10" fmla="*/ 0 w 2048"/>
                <a:gd name="T11" fmla="*/ 0 h 96"/>
                <a:gd name="T12" fmla="*/ 480 w 2048"/>
                <a:gd name="T13" fmla="*/ 0 h 96"/>
                <a:gd name="T14" fmla="*/ 672 w 2048"/>
                <a:gd name="T15" fmla="*/ 0 h 96"/>
                <a:gd name="T16" fmla="*/ 720 w 2048"/>
                <a:gd name="T17" fmla="*/ 48 h 96"/>
                <a:gd name="T18" fmla="*/ 672 w 2048"/>
                <a:gd name="T19" fmla="*/ 96 h 96"/>
                <a:gd name="T20" fmla="*/ 480 w 2048"/>
                <a:gd name="T21" fmla="*/ 96 h 96"/>
                <a:gd name="T22" fmla="*/ 432 w 2048"/>
                <a:gd name="T23" fmla="*/ 48 h 96"/>
                <a:gd name="T24" fmla="*/ 480 w 2048"/>
                <a:gd name="T25" fmla="*/ 0 h 96"/>
                <a:gd name="T26" fmla="*/ 960 w 2048"/>
                <a:gd name="T27" fmla="*/ 0 h 96"/>
                <a:gd name="T28" fmla="*/ 1152 w 2048"/>
                <a:gd name="T29" fmla="*/ 0 h 96"/>
                <a:gd name="T30" fmla="*/ 1200 w 2048"/>
                <a:gd name="T31" fmla="*/ 48 h 96"/>
                <a:gd name="T32" fmla="*/ 1152 w 2048"/>
                <a:gd name="T33" fmla="*/ 96 h 96"/>
                <a:gd name="T34" fmla="*/ 960 w 2048"/>
                <a:gd name="T35" fmla="*/ 96 h 96"/>
                <a:gd name="T36" fmla="*/ 912 w 2048"/>
                <a:gd name="T37" fmla="*/ 48 h 96"/>
                <a:gd name="T38" fmla="*/ 960 w 2048"/>
                <a:gd name="T39" fmla="*/ 0 h 96"/>
                <a:gd name="T40" fmla="*/ 1440 w 2048"/>
                <a:gd name="T41" fmla="*/ 0 h 96"/>
                <a:gd name="T42" fmla="*/ 1632 w 2048"/>
                <a:gd name="T43" fmla="*/ 0 h 96"/>
                <a:gd name="T44" fmla="*/ 1680 w 2048"/>
                <a:gd name="T45" fmla="*/ 48 h 96"/>
                <a:gd name="T46" fmla="*/ 1632 w 2048"/>
                <a:gd name="T47" fmla="*/ 96 h 96"/>
                <a:gd name="T48" fmla="*/ 1440 w 2048"/>
                <a:gd name="T49" fmla="*/ 96 h 96"/>
                <a:gd name="T50" fmla="*/ 1392 w 2048"/>
                <a:gd name="T51" fmla="*/ 48 h 96"/>
                <a:gd name="T52" fmla="*/ 1440 w 2048"/>
                <a:gd name="T53" fmla="*/ 0 h 96"/>
                <a:gd name="T54" fmla="*/ 1920 w 2048"/>
                <a:gd name="T55" fmla="*/ 0 h 96"/>
                <a:gd name="T56" fmla="*/ 2048 w 2048"/>
                <a:gd name="T57" fmla="*/ 0 h 96"/>
                <a:gd name="T58" fmla="*/ 2048 w 2048"/>
                <a:gd name="T59" fmla="*/ 96 h 96"/>
                <a:gd name="T60" fmla="*/ 1920 w 2048"/>
                <a:gd name="T61" fmla="*/ 96 h 96"/>
                <a:gd name="T62" fmla="*/ 1872 w 2048"/>
                <a:gd name="T63" fmla="*/ 48 h 96"/>
                <a:gd name="T64" fmla="*/ 1920 w 2048"/>
                <a:gd name="T65" fmla="*/ 0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2048" h="96">
                  <a:moveTo>
                    <a:pt x="0" y="0"/>
                  </a:moveTo>
                  <a:lnTo>
                    <a:pt x="192" y="0"/>
                  </a:lnTo>
                  <a:cubicBezTo>
                    <a:pt x="219" y="0"/>
                    <a:pt x="240" y="22"/>
                    <a:pt x="240" y="48"/>
                  </a:cubicBezTo>
                  <a:cubicBezTo>
                    <a:pt x="240" y="75"/>
                    <a:pt x="219" y="96"/>
                    <a:pt x="192" y="96"/>
                  </a:cubicBezTo>
                  <a:lnTo>
                    <a:pt x="0" y="96"/>
                  </a:lnTo>
                  <a:lnTo>
                    <a:pt x="0" y="0"/>
                  </a:lnTo>
                  <a:close/>
                  <a:moveTo>
                    <a:pt x="480" y="0"/>
                  </a:moveTo>
                  <a:lnTo>
                    <a:pt x="672" y="0"/>
                  </a:lnTo>
                  <a:cubicBezTo>
                    <a:pt x="699" y="0"/>
                    <a:pt x="720" y="22"/>
                    <a:pt x="720" y="48"/>
                  </a:cubicBezTo>
                  <a:cubicBezTo>
                    <a:pt x="720" y="75"/>
                    <a:pt x="699" y="96"/>
                    <a:pt x="672" y="96"/>
                  </a:cubicBezTo>
                  <a:lnTo>
                    <a:pt x="480" y="96"/>
                  </a:lnTo>
                  <a:cubicBezTo>
                    <a:pt x="454" y="96"/>
                    <a:pt x="432" y="75"/>
                    <a:pt x="432" y="48"/>
                  </a:cubicBezTo>
                  <a:cubicBezTo>
                    <a:pt x="432" y="22"/>
                    <a:pt x="454" y="0"/>
                    <a:pt x="480" y="0"/>
                  </a:cubicBezTo>
                  <a:close/>
                  <a:moveTo>
                    <a:pt x="960" y="0"/>
                  </a:moveTo>
                  <a:lnTo>
                    <a:pt x="1152" y="0"/>
                  </a:lnTo>
                  <a:cubicBezTo>
                    <a:pt x="1179" y="0"/>
                    <a:pt x="1200" y="22"/>
                    <a:pt x="1200" y="48"/>
                  </a:cubicBezTo>
                  <a:cubicBezTo>
                    <a:pt x="1200" y="75"/>
                    <a:pt x="1179" y="96"/>
                    <a:pt x="1152" y="96"/>
                  </a:cubicBezTo>
                  <a:lnTo>
                    <a:pt x="960" y="96"/>
                  </a:lnTo>
                  <a:cubicBezTo>
                    <a:pt x="934" y="96"/>
                    <a:pt x="912" y="75"/>
                    <a:pt x="912" y="48"/>
                  </a:cubicBezTo>
                  <a:cubicBezTo>
                    <a:pt x="912" y="22"/>
                    <a:pt x="934" y="0"/>
                    <a:pt x="960" y="0"/>
                  </a:cubicBezTo>
                  <a:close/>
                  <a:moveTo>
                    <a:pt x="1440" y="0"/>
                  </a:moveTo>
                  <a:lnTo>
                    <a:pt x="1632" y="0"/>
                  </a:lnTo>
                  <a:cubicBezTo>
                    <a:pt x="1659" y="0"/>
                    <a:pt x="1680" y="22"/>
                    <a:pt x="1680" y="48"/>
                  </a:cubicBezTo>
                  <a:cubicBezTo>
                    <a:pt x="1680" y="75"/>
                    <a:pt x="1659" y="96"/>
                    <a:pt x="1632" y="96"/>
                  </a:cubicBezTo>
                  <a:lnTo>
                    <a:pt x="1440" y="96"/>
                  </a:lnTo>
                  <a:cubicBezTo>
                    <a:pt x="1414" y="96"/>
                    <a:pt x="1392" y="75"/>
                    <a:pt x="1392" y="48"/>
                  </a:cubicBezTo>
                  <a:cubicBezTo>
                    <a:pt x="1392" y="22"/>
                    <a:pt x="1414" y="0"/>
                    <a:pt x="1440" y="0"/>
                  </a:cubicBezTo>
                  <a:close/>
                  <a:moveTo>
                    <a:pt x="1920" y="0"/>
                  </a:moveTo>
                  <a:lnTo>
                    <a:pt x="2048" y="0"/>
                  </a:lnTo>
                  <a:lnTo>
                    <a:pt x="2048" y="96"/>
                  </a:lnTo>
                  <a:lnTo>
                    <a:pt x="1920" y="96"/>
                  </a:lnTo>
                  <a:cubicBezTo>
                    <a:pt x="1894" y="96"/>
                    <a:pt x="1872" y="75"/>
                    <a:pt x="1872" y="48"/>
                  </a:cubicBezTo>
                  <a:cubicBezTo>
                    <a:pt x="1872" y="22"/>
                    <a:pt x="1894" y="0"/>
                    <a:pt x="1920" y="0"/>
                  </a:cubicBezTo>
                  <a:close/>
                </a:path>
              </a:pathLst>
            </a:custGeom>
            <a:solidFill>
              <a:srgbClr val="000000"/>
            </a:solidFill>
            <a:ln w="19050" cap="flat">
              <a:solidFill>
                <a:srgbClr val="000000"/>
              </a:solidFill>
              <a:prstDash val="sysDash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Rectangle 240">
              <a:extLst>
                <a:ext uri="{FF2B5EF4-FFF2-40B4-BE49-F238E27FC236}">
                  <a16:creationId xmlns:a16="http://schemas.microsoft.com/office/drawing/2014/main" id="{845616F0-EA98-6541-8E9D-3BB9718D2E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96336" y="614364"/>
              <a:ext cx="105471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ja-JP" altLang="ja-JP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GFRdiff </a:t>
              </a:r>
              <a:r>
                <a:rPr kumimoji="0" lang="ja-JP" altLang="ja-JP" sz="1400" u="sng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&gt;</a:t>
              </a:r>
              <a:r>
                <a:rPr kumimoji="0" lang="ja-JP" altLang="ja-JP" sz="1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10</a:t>
              </a:r>
              <a:endParaRPr kumimoji="0" lang="ja-JP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Freeform 241">
              <a:extLst>
                <a:ext uri="{FF2B5EF4-FFF2-40B4-BE49-F238E27FC236}">
                  <a16:creationId xmlns:a16="http://schemas.microsoft.com/office/drawing/2014/main" id="{DAAD2C64-7BF4-10C5-1BC1-FA1BF8136E4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7148661" y="730251"/>
              <a:ext cx="282575" cy="14288"/>
            </a:xfrm>
            <a:custGeom>
              <a:avLst/>
              <a:gdLst>
                <a:gd name="T0" fmla="*/ 0 w 2017"/>
                <a:gd name="T1" fmla="*/ 0 h 96"/>
                <a:gd name="T2" fmla="*/ 1 w 2017"/>
                <a:gd name="T3" fmla="*/ 0 h 96"/>
                <a:gd name="T4" fmla="*/ 49 w 2017"/>
                <a:gd name="T5" fmla="*/ 48 h 96"/>
                <a:gd name="T6" fmla="*/ 1 w 2017"/>
                <a:gd name="T7" fmla="*/ 96 h 96"/>
                <a:gd name="T8" fmla="*/ 0 w 2017"/>
                <a:gd name="T9" fmla="*/ 96 h 96"/>
                <a:gd name="T10" fmla="*/ 0 w 2017"/>
                <a:gd name="T11" fmla="*/ 0 h 96"/>
                <a:gd name="T12" fmla="*/ 289 w 2017"/>
                <a:gd name="T13" fmla="*/ 0 h 96"/>
                <a:gd name="T14" fmla="*/ 289 w 2017"/>
                <a:gd name="T15" fmla="*/ 0 h 96"/>
                <a:gd name="T16" fmla="*/ 337 w 2017"/>
                <a:gd name="T17" fmla="*/ 48 h 96"/>
                <a:gd name="T18" fmla="*/ 289 w 2017"/>
                <a:gd name="T19" fmla="*/ 96 h 96"/>
                <a:gd name="T20" fmla="*/ 289 w 2017"/>
                <a:gd name="T21" fmla="*/ 96 h 96"/>
                <a:gd name="T22" fmla="*/ 241 w 2017"/>
                <a:gd name="T23" fmla="*/ 48 h 96"/>
                <a:gd name="T24" fmla="*/ 289 w 2017"/>
                <a:gd name="T25" fmla="*/ 0 h 96"/>
                <a:gd name="T26" fmla="*/ 577 w 2017"/>
                <a:gd name="T27" fmla="*/ 0 h 96"/>
                <a:gd name="T28" fmla="*/ 577 w 2017"/>
                <a:gd name="T29" fmla="*/ 0 h 96"/>
                <a:gd name="T30" fmla="*/ 625 w 2017"/>
                <a:gd name="T31" fmla="*/ 48 h 96"/>
                <a:gd name="T32" fmla="*/ 577 w 2017"/>
                <a:gd name="T33" fmla="*/ 96 h 96"/>
                <a:gd name="T34" fmla="*/ 577 w 2017"/>
                <a:gd name="T35" fmla="*/ 96 h 96"/>
                <a:gd name="T36" fmla="*/ 529 w 2017"/>
                <a:gd name="T37" fmla="*/ 48 h 96"/>
                <a:gd name="T38" fmla="*/ 577 w 2017"/>
                <a:gd name="T39" fmla="*/ 0 h 96"/>
                <a:gd name="T40" fmla="*/ 865 w 2017"/>
                <a:gd name="T41" fmla="*/ 0 h 96"/>
                <a:gd name="T42" fmla="*/ 865 w 2017"/>
                <a:gd name="T43" fmla="*/ 0 h 96"/>
                <a:gd name="T44" fmla="*/ 913 w 2017"/>
                <a:gd name="T45" fmla="*/ 48 h 96"/>
                <a:gd name="T46" fmla="*/ 865 w 2017"/>
                <a:gd name="T47" fmla="*/ 96 h 96"/>
                <a:gd name="T48" fmla="*/ 865 w 2017"/>
                <a:gd name="T49" fmla="*/ 96 h 96"/>
                <a:gd name="T50" fmla="*/ 817 w 2017"/>
                <a:gd name="T51" fmla="*/ 48 h 96"/>
                <a:gd name="T52" fmla="*/ 865 w 2017"/>
                <a:gd name="T53" fmla="*/ 0 h 96"/>
                <a:gd name="T54" fmla="*/ 1153 w 2017"/>
                <a:gd name="T55" fmla="*/ 0 h 96"/>
                <a:gd name="T56" fmla="*/ 1153 w 2017"/>
                <a:gd name="T57" fmla="*/ 0 h 96"/>
                <a:gd name="T58" fmla="*/ 1201 w 2017"/>
                <a:gd name="T59" fmla="*/ 48 h 96"/>
                <a:gd name="T60" fmla="*/ 1153 w 2017"/>
                <a:gd name="T61" fmla="*/ 96 h 96"/>
                <a:gd name="T62" fmla="*/ 1153 w 2017"/>
                <a:gd name="T63" fmla="*/ 96 h 96"/>
                <a:gd name="T64" fmla="*/ 1105 w 2017"/>
                <a:gd name="T65" fmla="*/ 48 h 96"/>
                <a:gd name="T66" fmla="*/ 1153 w 2017"/>
                <a:gd name="T67" fmla="*/ 0 h 96"/>
                <a:gd name="T68" fmla="*/ 1441 w 2017"/>
                <a:gd name="T69" fmla="*/ 0 h 96"/>
                <a:gd name="T70" fmla="*/ 1441 w 2017"/>
                <a:gd name="T71" fmla="*/ 0 h 96"/>
                <a:gd name="T72" fmla="*/ 1489 w 2017"/>
                <a:gd name="T73" fmla="*/ 48 h 96"/>
                <a:gd name="T74" fmla="*/ 1441 w 2017"/>
                <a:gd name="T75" fmla="*/ 96 h 96"/>
                <a:gd name="T76" fmla="*/ 1441 w 2017"/>
                <a:gd name="T77" fmla="*/ 96 h 96"/>
                <a:gd name="T78" fmla="*/ 1393 w 2017"/>
                <a:gd name="T79" fmla="*/ 48 h 96"/>
                <a:gd name="T80" fmla="*/ 1441 w 2017"/>
                <a:gd name="T81" fmla="*/ 0 h 96"/>
                <a:gd name="T82" fmla="*/ 1729 w 2017"/>
                <a:gd name="T83" fmla="*/ 0 h 96"/>
                <a:gd name="T84" fmla="*/ 1729 w 2017"/>
                <a:gd name="T85" fmla="*/ 0 h 96"/>
                <a:gd name="T86" fmla="*/ 1777 w 2017"/>
                <a:gd name="T87" fmla="*/ 48 h 96"/>
                <a:gd name="T88" fmla="*/ 1729 w 2017"/>
                <a:gd name="T89" fmla="*/ 96 h 96"/>
                <a:gd name="T90" fmla="*/ 1729 w 2017"/>
                <a:gd name="T91" fmla="*/ 96 h 96"/>
                <a:gd name="T92" fmla="*/ 1681 w 2017"/>
                <a:gd name="T93" fmla="*/ 48 h 96"/>
                <a:gd name="T94" fmla="*/ 1729 w 2017"/>
                <a:gd name="T95" fmla="*/ 0 h 96"/>
                <a:gd name="T96" fmla="*/ 2017 w 2017"/>
                <a:gd name="T97" fmla="*/ 0 h 96"/>
                <a:gd name="T98" fmla="*/ 2017 w 2017"/>
                <a:gd name="T99" fmla="*/ 0 h 96"/>
                <a:gd name="T100" fmla="*/ 2017 w 2017"/>
                <a:gd name="T101" fmla="*/ 96 h 96"/>
                <a:gd name="T102" fmla="*/ 2017 w 2017"/>
                <a:gd name="T103" fmla="*/ 96 h 96"/>
                <a:gd name="T104" fmla="*/ 1969 w 2017"/>
                <a:gd name="T105" fmla="*/ 48 h 96"/>
                <a:gd name="T106" fmla="*/ 2017 w 2017"/>
                <a:gd name="T107" fmla="*/ 0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</a:cxnLst>
              <a:rect l="0" t="0" r="r" b="b"/>
              <a:pathLst>
                <a:path w="2017" h="96">
                  <a:moveTo>
                    <a:pt x="0" y="0"/>
                  </a:moveTo>
                  <a:lnTo>
                    <a:pt x="1" y="0"/>
                  </a:lnTo>
                  <a:cubicBezTo>
                    <a:pt x="27" y="0"/>
                    <a:pt x="49" y="22"/>
                    <a:pt x="49" y="48"/>
                  </a:cubicBezTo>
                  <a:cubicBezTo>
                    <a:pt x="49" y="75"/>
                    <a:pt x="27" y="96"/>
                    <a:pt x="1" y="96"/>
                  </a:cubicBezTo>
                  <a:lnTo>
                    <a:pt x="0" y="96"/>
                  </a:lnTo>
                  <a:lnTo>
                    <a:pt x="0" y="0"/>
                  </a:lnTo>
                  <a:close/>
                  <a:moveTo>
                    <a:pt x="289" y="0"/>
                  </a:moveTo>
                  <a:lnTo>
                    <a:pt x="289" y="0"/>
                  </a:lnTo>
                  <a:cubicBezTo>
                    <a:pt x="315" y="0"/>
                    <a:pt x="337" y="22"/>
                    <a:pt x="337" y="48"/>
                  </a:cubicBezTo>
                  <a:cubicBezTo>
                    <a:pt x="337" y="75"/>
                    <a:pt x="315" y="96"/>
                    <a:pt x="289" y="96"/>
                  </a:cubicBezTo>
                  <a:lnTo>
                    <a:pt x="289" y="96"/>
                  </a:lnTo>
                  <a:cubicBezTo>
                    <a:pt x="262" y="96"/>
                    <a:pt x="241" y="75"/>
                    <a:pt x="241" y="48"/>
                  </a:cubicBezTo>
                  <a:cubicBezTo>
                    <a:pt x="241" y="22"/>
                    <a:pt x="262" y="0"/>
                    <a:pt x="289" y="0"/>
                  </a:cubicBezTo>
                  <a:close/>
                  <a:moveTo>
                    <a:pt x="577" y="0"/>
                  </a:moveTo>
                  <a:lnTo>
                    <a:pt x="577" y="0"/>
                  </a:lnTo>
                  <a:cubicBezTo>
                    <a:pt x="603" y="0"/>
                    <a:pt x="625" y="22"/>
                    <a:pt x="625" y="48"/>
                  </a:cubicBezTo>
                  <a:cubicBezTo>
                    <a:pt x="625" y="75"/>
                    <a:pt x="603" y="96"/>
                    <a:pt x="577" y="96"/>
                  </a:cubicBezTo>
                  <a:lnTo>
                    <a:pt x="577" y="96"/>
                  </a:lnTo>
                  <a:cubicBezTo>
                    <a:pt x="550" y="96"/>
                    <a:pt x="529" y="75"/>
                    <a:pt x="529" y="48"/>
                  </a:cubicBezTo>
                  <a:cubicBezTo>
                    <a:pt x="529" y="22"/>
                    <a:pt x="550" y="0"/>
                    <a:pt x="577" y="0"/>
                  </a:cubicBezTo>
                  <a:close/>
                  <a:moveTo>
                    <a:pt x="865" y="0"/>
                  </a:moveTo>
                  <a:lnTo>
                    <a:pt x="865" y="0"/>
                  </a:lnTo>
                  <a:cubicBezTo>
                    <a:pt x="891" y="0"/>
                    <a:pt x="913" y="22"/>
                    <a:pt x="913" y="48"/>
                  </a:cubicBezTo>
                  <a:cubicBezTo>
                    <a:pt x="913" y="75"/>
                    <a:pt x="891" y="96"/>
                    <a:pt x="865" y="96"/>
                  </a:cubicBezTo>
                  <a:lnTo>
                    <a:pt x="865" y="96"/>
                  </a:lnTo>
                  <a:cubicBezTo>
                    <a:pt x="838" y="96"/>
                    <a:pt x="817" y="75"/>
                    <a:pt x="817" y="48"/>
                  </a:cubicBezTo>
                  <a:cubicBezTo>
                    <a:pt x="817" y="22"/>
                    <a:pt x="838" y="0"/>
                    <a:pt x="865" y="0"/>
                  </a:cubicBezTo>
                  <a:close/>
                  <a:moveTo>
                    <a:pt x="1153" y="0"/>
                  </a:moveTo>
                  <a:lnTo>
                    <a:pt x="1153" y="0"/>
                  </a:lnTo>
                  <a:cubicBezTo>
                    <a:pt x="1179" y="0"/>
                    <a:pt x="1201" y="22"/>
                    <a:pt x="1201" y="48"/>
                  </a:cubicBezTo>
                  <a:cubicBezTo>
                    <a:pt x="1201" y="75"/>
                    <a:pt x="1179" y="96"/>
                    <a:pt x="1153" y="96"/>
                  </a:cubicBezTo>
                  <a:lnTo>
                    <a:pt x="1153" y="96"/>
                  </a:lnTo>
                  <a:cubicBezTo>
                    <a:pt x="1126" y="96"/>
                    <a:pt x="1105" y="75"/>
                    <a:pt x="1105" y="48"/>
                  </a:cubicBezTo>
                  <a:cubicBezTo>
                    <a:pt x="1105" y="22"/>
                    <a:pt x="1126" y="0"/>
                    <a:pt x="1153" y="0"/>
                  </a:cubicBezTo>
                  <a:close/>
                  <a:moveTo>
                    <a:pt x="1441" y="0"/>
                  </a:moveTo>
                  <a:lnTo>
                    <a:pt x="1441" y="0"/>
                  </a:lnTo>
                  <a:cubicBezTo>
                    <a:pt x="1468" y="0"/>
                    <a:pt x="1489" y="22"/>
                    <a:pt x="1489" y="48"/>
                  </a:cubicBezTo>
                  <a:cubicBezTo>
                    <a:pt x="1489" y="75"/>
                    <a:pt x="1468" y="96"/>
                    <a:pt x="1441" y="96"/>
                  </a:cubicBezTo>
                  <a:lnTo>
                    <a:pt x="1441" y="96"/>
                  </a:lnTo>
                  <a:cubicBezTo>
                    <a:pt x="1414" y="96"/>
                    <a:pt x="1393" y="75"/>
                    <a:pt x="1393" y="48"/>
                  </a:cubicBezTo>
                  <a:cubicBezTo>
                    <a:pt x="1393" y="22"/>
                    <a:pt x="1414" y="0"/>
                    <a:pt x="1441" y="0"/>
                  </a:cubicBezTo>
                  <a:close/>
                  <a:moveTo>
                    <a:pt x="1729" y="0"/>
                  </a:moveTo>
                  <a:lnTo>
                    <a:pt x="1729" y="0"/>
                  </a:lnTo>
                  <a:cubicBezTo>
                    <a:pt x="1756" y="0"/>
                    <a:pt x="1777" y="22"/>
                    <a:pt x="1777" y="48"/>
                  </a:cubicBezTo>
                  <a:cubicBezTo>
                    <a:pt x="1777" y="75"/>
                    <a:pt x="1756" y="96"/>
                    <a:pt x="1729" y="96"/>
                  </a:cubicBezTo>
                  <a:lnTo>
                    <a:pt x="1729" y="96"/>
                  </a:lnTo>
                  <a:cubicBezTo>
                    <a:pt x="1703" y="96"/>
                    <a:pt x="1681" y="75"/>
                    <a:pt x="1681" y="48"/>
                  </a:cubicBezTo>
                  <a:cubicBezTo>
                    <a:pt x="1681" y="22"/>
                    <a:pt x="1703" y="0"/>
                    <a:pt x="1729" y="0"/>
                  </a:cubicBezTo>
                  <a:close/>
                  <a:moveTo>
                    <a:pt x="2017" y="0"/>
                  </a:moveTo>
                  <a:lnTo>
                    <a:pt x="2017" y="0"/>
                  </a:lnTo>
                  <a:lnTo>
                    <a:pt x="2017" y="96"/>
                  </a:lnTo>
                  <a:lnTo>
                    <a:pt x="2017" y="96"/>
                  </a:lnTo>
                  <a:cubicBezTo>
                    <a:pt x="1991" y="96"/>
                    <a:pt x="1969" y="75"/>
                    <a:pt x="1969" y="48"/>
                  </a:cubicBezTo>
                  <a:cubicBezTo>
                    <a:pt x="1969" y="22"/>
                    <a:pt x="1991" y="0"/>
                    <a:pt x="2017" y="0"/>
                  </a:cubicBezTo>
                  <a:close/>
                </a:path>
              </a:pathLst>
            </a:custGeom>
            <a:solidFill>
              <a:srgbClr val="000000"/>
            </a:solidFill>
            <a:ln w="12700" cap="flat">
              <a:solidFill>
                <a:srgbClr val="000000"/>
              </a:solidFill>
              <a:prstDash val="sysDot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92" name="Rectangle 243">
            <a:extLst>
              <a:ext uri="{FF2B5EF4-FFF2-40B4-BE49-F238E27FC236}">
                <a16:creationId xmlns:a16="http://schemas.microsoft.com/office/drawing/2014/main" id="{F4F50631-8E98-63B1-FE04-09603F0999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49692" y="4566721"/>
            <a:ext cx="214000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kumimoji="0" lang="en-US" altLang="ja-JP" sz="14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kelihood</a:t>
            </a:r>
            <a:r>
              <a:rPr kumimoji="0" lang="en-US" altLang="ja-JP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ratio test</a:t>
            </a:r>
            <a:r>
              <a:rPr kumimoji="0" lang="ja-JP" altLang="ja-JP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p </a:t>
            </a:r>
            <a:r>
              <a:rPr kumimoji="0" lang="en-US" altLang="ja-JP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= 0.18</a:t>
            </a:r>
            <a:endParaRPr kumimoji="0" lang="ja-JP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10</Words>
  <Application>Microsoft Office PowerPoint</Application>
  <PresentationFormat>ワイド画面</PresentationFormat>
  <Paragraphs>33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9" baseType="lpstr">
      <vt:lpstr>游ゴシック</vt:lpstr>
      <vt:lpstr>游ゴシック Light</vt:lpstr>
      <vt:lpstr>游明朝</vt:lpstr>
      <vt:lpstr>Arial</vt:lpstr>
      <vt:lpstr>Times</vt:lpstr>
      <vt:lpstr>Times New Roman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貴也 鈴木</dc:creator>
  <cp:lastModifiedBy>貴也 鈴木</cp:lastModifiedBy>
  <cp:revision>1</cp:revision>
  <dcterms:created xsi:type="dcterms:W3CDTF">2026-02-20T13:45:22Z</dcterms:created>
  <dcterms:modified xsi:type="dcterms:W3CDTF">2026-02-20T13:47:38Z</dcterms:modified>
</cp:coreProperties>
</file>